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9" r:id="rId6"/>
    <p:sldId id="260" r:id="rId7"/>
    <p:sldId id="261" r:id="rId8"/>
    <p:sldId id="262" r:id="rId9"/>
    <p:sldId id="263" r:id="rId10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6" userDrawn="1">
          <p15:clr>
            <a:srgbClr val="A4A3A4"/>
          </p15:clr>
        </p15:guide>
        <p15:guide id="2" pos="35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A6306"/>
    <a:srgbClr val="704744"/>
    <a:srgbClr val="EF19C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9BC932A-0D65-4FC5-AAED-2AD352209D35}" v="54" dt="2020-11-24T02:36:06.8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481" autoAdjust="0"/>
    <p:restoredTop sz="94660"/>
  </p:normalViewPr>
  <p:slideViewPr>
    <p:cSldViewPr snapToGrid="0">
      <p:cViewPr varScale="1">
        <p:scale>
          <a:sx n="72" d="100"/>
          <a:sy n="72" d="100"/>
        </p:scale>
        <p:origin x="1050" y="78"/>
      </p:cViewPr>
      <p:guideLst>
        <p:guide orient="horz" pos="96"/>
        <p:guide pos="35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sther Walker" userId="f1e11e33-ab63-4053-bc81-f884cbad8747" providerId="ADAL" clId="{19BC932A-0D65-4FC5-AAED-2AD352209D35}"/>
    <pc:docChg chg="undo custSel modSld sldOrd">
      <pc:chgData name="Esther Walker" userId="f1e11e33-ab63-4053-bc81-f884cbad8747" providerId="ADAL" clId="{19BC932A-0D65-4FC5-AAED-2AD352209D35}" dt="2020-11-24T02:38:23.088" v="2332" actId="1038"/>
      <pc:docMkLst>
        <pc:docMk/>
      </pc:docMkLst>
      <pc:sldChg chg="addSp modSp">
        <pc:chgData name="Esther Walker" userId="f1e11e33-ab63-4053-bc81-f884cbad8747" providerId="ADAL" clId="{19BC932A-0D65-4FC5-AAED-2AD352209D35}" dt="2020-11-24T02:37:39.237" v="2267" actId="1036"/>
        <pc:sldMkLst>
          <pc:docMk/>
          <pc:sldMk cId="362538574" sldId="256"/>
        </pc:sldMkLst>
        <pc:spChg chg="mod">
          <ac:chgData name="Esther Walker" userId="f1e11e33-ab63-4053-bc81-f884cbad8747" providerId="ADAL" clId="{19BC932A-0D65-4FC5-AAED-2AD352209D35}" dt="2020-10-30T02:32:36.623" v="1956"/>
          <ac:spMkLst>
            <pc:docMk/>
            <pc:sldMk cId="362538574" sldId="256"/>
            <ac:spMk id="4" creationId="{212DD19F-A09D-48EB-B49D-9C1F3310EAE8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08" creationId="{FA80C75A-7AE0-493E-B845-44ADC315CFF5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10" creationId="{88C5C78E-DDE4-4E7B-B8ED-4837739562CC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29" creationId="{2D97C4E0-D716-455B-A532-0DCCBECF1B97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31" creationId="{B4F347EC-AC26-4074-91E8-D66007F215CB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33" creationId="{7B9B7F74-12CC-488F-98D2-9C33A4E8301C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37" creationId="{7A523E7C-8656-4A7E-BFFD-4C7224686AF9}"/>
          </ac:spMkLst>
        </pc:spChg>
        <pc:spChg chg="add mod">
          <ac:chgData name="Esther Walker" userId="f1e11e33-ab63-4053-bc81-f884cbad8747" providerId="ADAL" clId="{19BC932A-0D65-4FC5-AAED-2AD352209D35}" dt="2020-11-24T02:35:49.932" v="2189" actId="20577"/>
          <ac:spMkLst>
            <pc:docMk/>
            <pc:sldMk cId="362538574" sldId="256"/>
            <ac:spMk id="138" creationId="{D7E92174-631C-4E7A-ACEF-37F8AD189749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39" creationId="{47AB46E4-6140-4DB5-9980-553FB4F1145E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41" creationId="{C78C7EC0-F350-4970-BF86-B4A0CD125507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43" creationId="{5ACB1FA9-D36F-445A-B837-A74A45DE18BF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51" creationId="{CF7054E3-87ED-4440-92F1-CBF4A1C9A633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63" creationId="{DD562CB2-4659-44E9-A83E-82B9BA74F3A9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64" creationId="{D838CD79-D1F9-4AE8-B1EF-79022405006B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65" creationId="{20AC1288-B9E3-43A5-8DAF-2E712E3088F2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66" creationId="{F35FFC27-1A91-473D-9B7F-373B1EBB2381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67" creationId="{4EB976A8-F8F2-4D11-94A3-941F6E79E896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68" creationId="{3387566F-23A2-4891-A4BD-19E650C1F23C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70" creationId="{6A9E6460-EB9C-4AC0-B9D1-8260F9DB2C56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73" creationId="{14F98618-EFFB-4D5F-9693-183C10A4F260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75" creationId="{99814871-C10A-43B8-867A-5C3BF3B64AA2}"/>
          </ac:spMkLst>
        </pc:spChg>
        <pc:spChg chg="add">
          <ac:chgData name="Esther Walker" userId="f1e11e33-ab63-4053-bc81-f884cbad8747" providerId="ADAL" clId="{19BC932A-0D65-4FC5-AAED-2AD352209D35}" dt="2020-10-29T05:45:35.891" v="0"/>
          <ac:spMkLst>
            <pc:docMk/>
            <pc:sldMk cId="362538574" sldId="256"/>
            <ac:spMk id="177" creationId="{573AACAA-1885-40FF-8C21-3C81891C7B6C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84" creationId="{82F3802C-9C88-431C-94A8-F22C3BFF554F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86" creationId="{F9B2A8FB-532E-478A-806A-B71D8E005D18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88" creationId="{A443F439-3121-421F-961A-37233E7662D0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90" creationId="{9728386F-D3C7-4931-B007-E3D7D10629DE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193" creationId="{08AE9C97-0CDF-4EFE-B32B-22836B0E05FF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224" creationId="{A8DA1F68-721D-4B69-A83A-C23E8B71BC3B}"/>
          </ac:spMkLst>
        </pc:spChg>
        <pc:spChg chg="mod">
          <ac:chgData name="Esther Walker" userId="f1e11e33-ab63-4053-bc81-f884cbad8747" providerId="ADAL" clId="{19BC932A-0D65-4FC5-AAED-2AD352209D35}" dt="2020-11-24T02:37:39.237" v="2267" actId="1036"/>
          <ac:spMkLst>
            <pc:docMk/>
            <pc:sldMk cId="362538574" sldId="256"/>
            <ac:spMk id="284" creationId="{1CE5D623-AF9C-4C94-9070-0414924141CB}"/>
          </ac:spMkLst>
        </pc:spChg>
        <pc:spChg chg="mod">
          <ac:chgData name="Esther Walker" userId="f1e11e33-ab63-4053-bc81-f884cbad8747" providerId="ADAL" clId="{19BC932A-0D65-4FC5-AAED-2AD352209D35}" dt="2020-10-30T02:16:43.612" v="1460" actId="1038"/>
          <ac:spMkLst>
            <pc:docMk/>
            <pc:sldMk cId="362538574" sldId="256"/>
            <ac:spMk id="401" creationId="{679974BA-0E25-4299-89FF-4AB55D781DA4}"/>
          </ac:spMkLst>
        </pc:s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10" creationId="{0B6A3162-19CB-40B5-BF6A-D80C6800AF98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92" creationId="{D6875899-0527-4B63-82AE-E17DC000786E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96" creationId="{98BE8EA3-1486-466C-9756-8747F10FA225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99" creationId="{613E0CEE-6D4C-4C52-B528-5C1AF8C7D08C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102" creationId="{46467102-C16F-4108-A719-B85EA42FCE05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105" creationId="{A4710523-2A62-4674-A4F9-F1DACA554591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134" creationId="{CACDBAA6-C6CA-4BAA-9756-FECE2FE2EE2C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135" creationId="{437D25D6-6350-494F-95BF-13062D121CD9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157" creationId="{00305680-163B-4AAF-B984-910D3D8D0CDF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255" creationId="{626C0087-A174-45AD-A79E-6DB7BDD663E1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288" creationId="{BD631ED1-3DC2-46EC-B47A-DE8ECBBC42BF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339" creationId="{037AA0B9-CE3A-4412-B130-186C7D8C7A36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385" creationId="{FD9896B1-4564-41A1-8C84-B101538C3106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388" creationId="{13E88C7E-B358-4D47-99A1-BB6A20DC0ACE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400" creationId="{D21118BE-38AB-451E-90F6-4910254CB9F8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457" creationId="{9C90C557-7F74-40A2-8C06-506E427462A0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508" creationId="{60F3D974-F440-4909-B450-4F896F909D3D}"/>
          </ac:grpSpMkLst>
        </pc:grpChg>
        <pc:grpChg chg="mod">
          <ac:chgData name="Esther Walker" userId="f1e11e33-ab63-4053-bc81-f884cbad8747" providerId="ADAL" clId="{19BC932A-0D65-4FC5-AAED-2AD352209D35}" dt="2020-11-24T02:37:39.237" v="2267" actId="1036"/>
          <ac:grpSpMkLst>
            <pc:docMk/>
            <pc:sldMk cId="362538574" sldId="256"/>
            <ac:grpSpMk id="612" creationId="{AE07F9BE-1CA9-4EF0-B378-C0B87037B4F1}"/>
          </ac:grpSpMkLst>
        </pc:grpChg>
        <pc:cxnChg chg="add mod">
          <ac:chgData name="Esther Walker" userId="f1e11e33-ab63-4053-bc81-f884cbad8747" providerId="ADAL" clId="{19BC932A-0D65-4FC5-AAED-2AD352209D35}" dt="2020-10-29T05:45:52.710" v="1" actId="11529"/>
          <ac:cxnSpMkLst>
            <pc:docMk/>
            <pc:sldMk cId="362538574" sldId="256"/>
            <ac:cxnSpMk id="6" creationId="{771B3AEE-6D10-42EB-997D-17937D6DD767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09" creationId="{A5FBC704-3266-486C-86C0-46AE5043907C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25" creationId="{FD6AC263-03BC-4EA2-ACB6-BCBD16AC13E7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27" creationId="{C5A284DE-F20D-49F1-9551-4486A326D084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30" creationId="{28A55B4D-582B-48CA-8F75-A481B2CD2D89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32" creationId="{2D570ECE-F4A4-4570-AF64-5557E5699D27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36" creationId="{A8C380BD-629E-4551-86AD-B2AAD25DD02A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40" creationId="{7EB2D6D5-5787-4AC2-851D-18F272D4623E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42" creationId="{D912E77D-6801-4E48-9EDE-765BC65EC35B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44" creationId="{45EB3121-F6A9-47FC-847C-4FE5276429E5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45" creationId="{76E230C2-8F16-49F5-B0EB-58CCE43199A2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46" creationId="{195E6C8A-6E7F-40C1-ADA3-1F3BECB0D1A0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48" creationId="{ECA145CE-591F-437D-BEB5-AF3B5F02A7FA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49" creationId="{65542558-32CA-42C5-AC7B-5630769ECAF2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50" creationId="{4C7E173A-7425-4152-A744-0E9AD2BD6FAD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52" creationId="{A4BA70F4-F9FB-4B76-BD02-097FB5FE4267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53" creationId="{3B8C0CAC-28B4-4EC8-83BA-ED872DDBE5CF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55" creationId="{36FFE469-EA95-47DC-8279-8781D84DA690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56" creationId="{803FC693-4FBA-4856-A7AE-AB7EF4B254DC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71" creationId="{B93DFEF6-7937-4096-8381-F6551CBA102E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74" creationId="{485C32A7-CBC1-4A6A-AE1C-A4DC77A41732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76" creationId="{E0D73BBB-1109-4228-B866-77FA586EB0B8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85" creationId="{5995684C-E1B2-498B-BD8D-0F24D786929F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87" creationId="{CDFA193A-176C-4543-9660-5505C0831B53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89" creationId="{EEE26F7D-6AA3-4B74-A88C-F00208FE6CF6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91" creationId="{97141FA1-2187-41AC-A6CD-936B0B9DE14A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94" creationId="{08C85EFF-B4CF-4753-8AC6-0023306E3D64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95" creationId="{AF432005-43AA-4364-906E-643F2044AF9A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196" creationId="{FC798F4A-26D6-465D-A957-D90E099F0679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237" creationId="{7775041E-7B71-4EF5-AD43-AEA5E23681FC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252" creationId="{F25CBB24-9ECF-41AC-901D-CE528F7AAAA5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309" creationId="{654150C6-ED78-49B5-A105-F2053CB2E3DC}"/>
          </ac:cxnSpMkLst>
        </pc:cxnChg>
        <pc:cxnChg chg="mod">
          <ac:chgData name="Esther Walker" userId="f1e11e33-ab63-4053-bc81-f884cbad8747" providerId="ADAL" clId="{19BC932A-0D65-4FC5-AAED-2AD352209D35}" dt="2020-11-24T02:37:39.237" v="2267" actId="1036"/>
          <ac:cxnSpMkLst>
            <pc:docMk/>
            <pc:sldMk cId="362538574" sldId="256"/>
            <ac:cxnSpMk id="310" creationId="{3A87BD9F-A894-4BCC-96F5-CEF543C57D99}"/>
          </ac:cxnSpMkLst>
        </pc:cxnChg>
      </pc:sldChg>
      <pc:sldChg chg="addSp delSp modSp ord">
        <pc:chgData name="Esther Walker" userId="f1e11e33-ab63-4053-bc81-f884cbad8747" providerId="ADAL" clId="{19BC932A-0D65-4FC5-AAED-2AD352209D35}" dt="2020-11-24T02:34:39.319" v="2127"/>
        <pc:sldMkLst>
          <pc:docMk/>
          <pc:sldMk cId="3901562394" sldId="258"/>
        </pc:sldMkLst>
        <pc:spChg chg="add mod">
          <ac:chgData name="Esther Walker" userId="f1e11e33-ab63-4053-bc81-f884cbad8747" providerId="ADAL" clId="{19BC932A-0D65-4FC5-AAED-2AD352209D35}" dt="2020-11-24T02:33:00.207" v="2078" actId="1035"/>
          <ac:spMkLst>
            <pc:docMk/>
            <pc:sldMk cId="3901562394" sldId="258"/>
            <ac:spMk id="3" creationId="{873C6066-FE28-4935-B3E6-5121F73F7440}"/>
          </ac:spMkLst>
        </pc:spChg>
        <pc:spChg chg="del mod">
          <ac:chgData name="Esther Walker" userId="f1e11e33-ab63-4053-bc81-f884cbad8747" providerId="ADAL" clId="{19BC932A-0D65-4FC5-AAED-2AD352209D35}" dt="2020-10-30T02:29:34.893" v="1795" actId="478"/>
          <ac:spMkLst>
            <pc:docMk/>
            <pc:sldMk cId="3901562394" sldId="258"/>
            <ac:spMk id="4" creationId="{212DD19F-A09D-48EB-B49D-9C1F3310EAE8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63" creationId="{DD562CB2-4659-44E9-A83E-82B9BA74F3A9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64" creationId="{D838CD79-D1F9-4AE8-B1EF-79022405006B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65" creationId="{20AC1288-B9E3-43A5-8DAF-2E712E3088F2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66" creationId="{F35FFC27-1A91-473D-9B7F-373B1EBB2381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67" creationId="{4EB976A8-F8F2-4D11-94A3-941F6E79E896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68" creationId="{3387566F-23A2-4891-A4BD-19E650C1F23C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70" creationId="{6A9E6460-EB9C-4AC0-B9D1-8260F9DB2C56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74" creationId="{F9978D52-8A65-4B67-ACBB-815BA1F54B36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80" creationId="{E99358DB-7611-486A-9CA1-177509062C9D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81" creationId="{39C84112-F8BF-4871-A7D9-A0DF6D1211E7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82" creationId="{F0BE66C8-B940-4C85-A797-A88EC8EAD2F7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84" creationId="{14D20B6F-9D8E-4180-A2BD-C9379C082AC4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85" creationId="{825B7D7A-78A2-4D2C-BC96-8D7E13E30FB8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87" creationId="{C0D59DE9-DC46-45A0-BBEE-DD75DB7103FD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89" creationId="{CC9AD697-EF21-4677-8EB0-13DBF8CB84F2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91" creationId="{BCD2F5E5-DE2A-440E-9922-CAB8E38B3921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94" creationId="{4E1F1AFE-C418-47E1-A322-67807E083ABB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96" creationId="{177D99BF-AD40-4A19-ACEF-3FFA64796AA1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198" creationId="{F6724948-36C8-4DB4-8764-C33BF7BD0CE4}"/>
          </ac:spMkLst>
        </pc:spChg>
        <pc:spChg chg="mod">
          <ac:chgData name="Esther Walker" userId="f1e11e33-ab63-4053-bc81-f884cbad8747" providerId="ADAL" clId="{19BC932A-0D65-4FC5-AAED-2AD352209D35}" dt="2020-11-24T02:34:17.166" v="2126" actId="1037"/>
          <ac:spMkLst>
            <pc:docMk/>
            <pc:sldMk cId="3901562394" sldId="258"/>
            <ac:spMk id="222" creationId="{7A2E7783-1BDE-4E08-8A83-48DF477EE672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224" creationId="{A8DA1F68-721D-4B69-A83A-C23E8B71BC3B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232" creationId="{20EEF9B0-4ED7-4CF1-9981-1D497426330D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234" creationId="{016C2A06-67DC-426E-B0A5-9EEAA4B55F7D}"/>
          </ac:spMkLst>
        </pc:spChg>
        <pc:spChg chg="mod">
          <ac:chgData name="Esther Walker" userId="f1e11e33-ab63-4053-bc81-f884cbad8747" providerId="ADAL" clId="{19BC932A-0D65-4FC5-AAED-2AD352209D35}" dt="2020-10-30T02:32:54.643" v="1961" actId="1037"/>
          <ac:spMkLst>
            <pc:docMk/>
            <pc:sldMk cId="3901562394" sldId="258"/>
            <ac:spMk id="235" creationId="{036ABC3C-9FAA-43EA-A6A4-7338B8CE01F6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241" creationId="{5B434C0E-3DC7-4F2D-BC06-AE120D374052}"/>
          </ac:spMkLst>
        </pc:spChg>
        <pc:spChg chg="add 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245" creationId="{A09FBA33-7A57-4540-844A-C98FD9989774}"/>
          </ac:spMkLst>
        </pc:spChg>
        <pc:spChg chg="add del mod">
          <ac:chgData name="Esther Walker" userId="f1e11e33-ab63-4053-bc81-f884cbad8747" providerId="ADAL" clId="{19BC932A-0D65-4FC5-AAED-2AD352209D35}" dt="2020-10-30T02:24:32.254" v="1674" actId="478"/>
          <ac:spMkLst>
            <pc:docMk/>
            <pc:sldMk cId="3901562394" sldId="258"/>
            <ac:spMk id="247" creationId="{0F52795E-AD13-4052-9D82-D1298963D8A9}"/>
          </ac:spMkLst>
        </pc:spChg>
        <pc:spChg chg="add mod">
          <ac:chgData name="Esther Walker" userId="f1e11e33-ab63-4053-bc81-f884cbad8747" providerId="ADAL" clId="{19BC932A-0D65-4FC5-AAED-2AD352209D35}" dt="2020-10-30T02:25:54.680" v="1684" actId="164"/>
          <ac:spMkLst>
            <pc:docMk/>
            <pc:sldMk cId="3901562394" sldId="258"/>
            <ac:spMk id="248" creationId="{ABCFB887-84AE-4784-8A39-F91D156C125B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261" creationId="{02AA528C-01CF-4081-99E2-637732122D4A}"/>
          </ac:spMkLst>
        </pc:spChg>
        <pc:spChg chg="add mod">
          <ac:chgData name="Esther Walker" userId="f1e11e33-ab63-4053-bc81-f884cbad8747" providerId="ADAL" clId="{19BC932A-0D65-4FC5-AAED-2AD352209D35}" dt="2020-10-30T02:31:51.448" v="1947" actId="164"/>
          <ac:spMkLst>
            <pc:docMk/>
            <pc:sldMk cId="3901562394" sldId="258"/>
            <ac:spMk id="272" creationId="{CAF277F8-9738-4CED-AD20-828B4F8DB1B3}"/>
          </ac:spMkLst>
        </pc:spChg>
        <pc:spChg chg="add mod">
          <ac:chgData name="Esther Walker" userId="f1e11e33-ab63-4053-bc81-f884cbad8747" providerId="ADAL" clId="{19BC932A-0D65-4FC5-AAED-2AD352209D35}" dt="2020-10-30T02:31:51.448" v="1947" actId="164"/>
          <ac:spMkLst>
            <pc:docMk/>
            <pc:sldMk cId="3901562394" sldId="258"/>
            <ac:spMk id="273" creationId="{DB574F8C-261A-44D0-8ECF-CAAAF1ED5B66}"/>
          </ac:spMkLst>
        </pc:spChg>
        <pc:spChg chg="add mod">
          <ac:chgData name="Esther Walker" userId="f1e11e33-ab63-4053-bc81-f884cbad8747" providerId="ADAL" clId="{19BC932A-0D65-4FC5-AAED-2AD352209D35}" dt="2020-10-30T02:31:51.448" v="1947" actId="164"/>
          <ac:spMkLst>
            <pc:docMk/>
            <pc:sldMk cId="3901562394" sldId="258"/>
            <ac:spMk id="274" creationId="{C860FB77-1B86-4E8D-851D-A9E69787D469}"/>
          </ac:spMkLst>
        </pc:spChg>
        <pc:spChg chg="add mod">
          <ac:chgData name="Esther Walker" userId="f1e11e33-ab63-4053-bc81-f884cbad8747" providerId="ADAL" clId="{19BC932A-0D65-4FC5-AAED-2AD352209D35}" dt="2020-10-30T02:31:51.448" v="1947" actId="164"/>
          <ac:spMkLst>
            <pc:docMk/>
            <pc:sldMk cId="3901562394" sldId="258"/>
            <ac:spMk id="275" creationId="{BF15A0D0-CB9F-418F-906A-FCFE0B91F60E}"/>
          </ac:spMkLst>
        </pc:spChg>
        <pc:spChg chg="add mod">
          <ac:chgData name="Esther Walker" userId="f1e11e33-ab63-4053-bc81-f884cbad8747" providerId="ADAL" clId="{19BC932A-0D65-4FC5-AAED-2AD352209D35}" dt="2020-10-30T02:31:51.448" v="1947" actId="164"/>
          <ac:spMkLst>
            <pc:docMk/>
            <pc:sldMk cId="3901562394" sldId="258"/>
            <ac:spMk id="276" creationId="{E3E2623A-54C9-421E-B3E2-4172CCB9ABD3}"/>
          </ac:spMkLst>
        </pc:spChg>
        <pc:spChg chg="add mod">
          <ac:chgData name="Esther Walker" userId="f1e11e33-ab63-4053-bc81-f884cbad8747" providerId="ADAL" clId="{19BC932A-0D65-4FC5-AAED-2AD352209D35}" dt="2020-10-30T02:31:51.448" v="1947" actId="164"/>
          <ac:spMkLst>
            <pc:docMk/>
            <pc:sldMk cId="3901562394" sldId="258"/>
            <ac:spMk id="277" creationId="{89D1F64C-FD0D-4C17-8147-E7CFF8887732}"/>
          </ac:spMkLst>
        </pc:spChg>
        <pc:spChg chg="add mod">
          <ac:chgData name="Esther Walker" userId="f1e11e33-ab63-4053-bc81-f884cbad8747" providerId="ADAL" clId="{19BC932A-0D65-4FC5-AAED-2AD352209D35}" dt="2020-10-30T02:31:51.448" v="1947" actId="164"/>
          <ac:spMkLst>
            <pc:docMk/>
            <pc:sldMk cId="3901562394" sldId="258"/>
            <ac:spMk id="278" creationId="{74A10609-12AC-46FD-9D55-D216E2C9F89D}"/>
          </ac:spMkLst>
        </pc:spChg>
        <pc:spChg chg="add mod">
          <ac:chgData name="Esther Walker" userId="f1e11e33-ab63-4053-bc81-f884cbad8747" providerId="ADAL" clId="{19BC932A-0D65-4FC5-AAED-2AD352209D35}" dt="2020-10-30T02:31:51.448" v="1947" actId="164"/>
          <ac:spMkLst>
            <pc:docMk/>
            <pc:sldMk cId="3901562394" sldId="258"/>
            <ac:spMk id="279" creationId="{A51ED9AD-264A-4FA2-89DE-D0689404AEB3}"/>
          </ac:spMkLst>
        </pc:spChg>
        <pc:spChg chg="add mod">
          <ac:chgData name="Esther Walker" userId="f1e11e33-ab63-4053-bc81-f884cbad8747" providerId="ADAL" clId="{19BC932A-0D65-4FC5-AAED-2AD352209D35}" dt="2020-10-30T02:31:51.448" v="1947" actId="164"/>
          <ac:spMkLst>
            <pc:docMk/>
            <pc:sldMk cId="3901562394" sldId="258"/>
            <ac:spMk id="280" creationId="{946443E7-DEBF-474F-9393-A8A95298BF0D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311" creationId="{7E053283-3CCE-4541-8908-0087793E4543}"/>
          </ac:spMkLst>
        </pc:spChg>
        <pc:spChg chg="mod">
          <ac:chgData name="Esther Walker" userId="f1e11e33-ab63-4053-bc81-f884cbad8747" providerId="ADAL" clId="{19BC932A-0D65-4FC5-AAED-2AD352209D35}" dt="2020-11-24T02:33:13.430" v="2087" actId="1036"/>
          <ac:spMkLst>
            <pc:docMk/>
            <pc:sldMk cId="3901562394" sldId="258"/>
            <ac:spMk id="318" creationId="{7DB0C3EA-CFBF-4A5D-B73E-DE24EDAA5BA0}"/>
          </ac:spMkLst>
        </pc:spChg>
        <pc:spChg chg="mod">
          <ac:chgData name="Esther Walker" userId="f1e11e33-ab63-4053-bc81-f884cbad8747" providerId="ADAL" clId="{19BC932A-0D65-4FC5-AAED-2AD352209D35}" dt="2020-11-24T02:34:02.781" v="2115" actId="1035"/>
          <ac:spMkLst>
            <pc:docMk/>
            <pc:sldMk cId="3901562394" sldId="258"/>
            <ac:spMk id="334" creationId="{157001D1-6526-4562-8563-B9AA42BCCAC3}"/>
          </ac:spMkLst>
        </pc:spChg>
        <pc:spChg chg="mod">
          <ac:chgData name="Esther Walker" userId="f1e11e33-ab63-4053-bc81-f884cbad8747" providerId="ADAL" clId="{19BC932A-0D65-4FC5-AAED-2AD352209D35}" dt="2020-11-24T02:33:30.021" v="2102" actId="1035"/>
          <ac:spMkLst>
            <pc:docMk/>
            <pc:sldMk cId="3901562394" sldId="258"/>
            <ac:spMk id="343" creationId="{BF58B7D2-69F1-4F9C-90FE-D71E204695E9}"/>
          </ac:spMkLst>
        </pc:s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2" creationId="{9215B44A-052C-4E0C-BEA8-601A52489DE2}"/>
          </ac:grpSpMkLst>
        </pc:grpChg>
        <pc:grpChg chg="add mod">
          <ac:chgData name="Esther Walker" userId="f1e11e33-ab63-4053-bc81-f884cbad8747" providerId="ADAL" clId="{19BC932A-0D65-4FC5-AAED-2AD352209D35}" dt="2020-10-30T02:26:31.260" v="1729" actId="164"/>
          <ac:grpSpMkLst>
            <pc:docMk/>
            <pc:sldMk cId="3901562394" sldId="258"/>
            <ac:grpSpMk id="6" creationId="{3E556AB9-97DD-4D98-8171-55A66F238338}"/>
          </ac:grpSpMkLst>
        </pc:grpChg>
        <pc:grpChg chg="add mod">
          <ac:chgData name="Esther Walker" userId="f1e11e33-ab63-4053-bc81-f884cbad8747" providerId="ADAL" clId="{19BC932A-0D65-4FC5-AAED-2AD352209D35}" dt="2020-10-30T02:31:51.448" v="1947" actId="164"/>
          <ac:grpSpMkLst>
            <pc:docMk/>
            <pc:sldMk cId="3901562394" sldId="258"/>
            <ac:grpSpMk id="7" creationId="{A9A6F202-9653-430B-B731-1499B494CD6D}"/>
          </ac:grpSpMkLst>
        </pc:grpChg>
        <pc:grpChg chg="add 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8" creationId="{9992EB0C-6796-4612-9181-2899B7A04364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10" creationId="{0B6A3162-19CB-40B5-BF6A-D80C6800AF98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134" creationId="{CACDBAA6-C6CA-4BAA-9756-FECE2FE2EE2C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135" creationId="{437D25D6-6350-494F-95BF-13062D121CD9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136" creationId="{CDDFC386-6DB5-4E46-963D-A4DC29EFFDAC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137" creationId="{5D96CE6F-60CA-4FED-8E33-6EA7578FEB38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138" creationId="{DA5E282F-E46E-4118-97D0-6103D473EFD3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139" creationId="{8651B97F-350D-4C38-B06D-12AC9AD5BE55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140" creationId="{FF38E283-ACF8-477E-BE83-1FDBB9DF4965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141" creationId="{3B68C668-D13F-4665-935D-C0099A2E17A8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142" creationId="{909103F9-0116-4B95-8C84-B2454A64DA1F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143" creationId="{35BD7DFE-F52A-4AD5-B8B6-682B5B44B788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157" creationId="{00305680-163B-4AAF-B984-910D3D8D0CDF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217" creationId="{8797159F-718A-44E6-8280-5A2934A0FD51}"/>
          </ac:grpSpMkLst>
        </pc:grpChg>
        <pc:grpChg chg="mod">
          <ac:chgData name="Esther Walker" userId="f1e11e33-ab63-4053-bc81-f884cbad8747" providerId="ADAL" clId="{19BC932A-0D65-4FC5-AAED-2AD352209D35}" dt="2020-11-24T02:33:20.115" v="2094" actId="1036"/>
          <ac:grpSpMkLst>
            <pc:docMk/>
            <pc:sldMk cId="3901562394" sldId="258"/>
            <ac:grpSpMk id="236" creationId="{4318E914-3872-4D13-97B4-01F7EF6AFFAF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238" creationId="{E6D681AF-5A80-4C99-9478-9B77A1D0D910}"/>
          </ac:grpSpMkLst>
        </pc:grpChg>
        <pc:grpChg chg="del">
          <ac:chgData name="Esther Walker" userId="f1e11e33-ab63-4053-bc81-f884cbad8747" providerId="ADAL" clId="{19BC932A-0D65-4FC5-AAED-2AD352209D35}" dt="2020-10-30T02:19:37.740" v="1587" actId="478"/>
          <ac:grpSpMkLst>
            <pc:docMk/>
            <pc:sldMk cId="3901562394" sldId="258"/>
            <ac:grpSpMk id="242" creationId="{C6421EAC-5D41-4078-A3DB-F5086CE9EA12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255" creationId="{5529C9AA-CB3D-4514-BE3C-B38F18EA05AD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258" creationId="{A3EC1E11-21DD-4A7B-B199-1DB642E0D20D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269" creationId="{D6A45EFC-7C65-4408-B6E2-5B267BF12FCD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285" creationId="{936365C0-C5F0-4797-8794-2B64E96F545B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288" creationId="{BD631ED1-3DC2-46EC-B47A-DE8ECBBC42BF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294" creationId="{CE662405-5AD6-4241-9BED-88C4EC6CE1E3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297" creationId="{F95839A2-6F38-4720-B7EB-7059FAD4252B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330" creationId="{E39F4017-DEB3-455D-84E8-ACDFE4B6403F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333" creationId="{5646F796-2910-4B9B-B91D-950BDCC68AE6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339" creationId="{037AA0B9-CE3A-4412-B130-186C7D8C7A36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342" creationId="{848EA136-7B1F-4754-8746-E5B069B97B3C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356" creationId="{C407992D-DD42-4A54-A29B-F337F34EAB2E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359" creationId="{A5BDB542-997E-4717-A50D-AB436F26699D}"/>
          </ac:grpSpMkLst>
        </pc:grpChg>
        <pc:grpChg chg="mod">
          <ac:chgData name="Esther Walker" userId="f1e11e33-ab63-4053-bc81-f884cbad8747" providerId="ADAL" clId="{19BC932A-0D65-4FC5-AAED-2AD352209D35}" dt="2020-11-24T02:33:13.430" v="2087" actId="1036"/>
          <ac:grpSpMkLst>
            <pc:docMk/>
            <pc:sldMk cId="3901562394" sldId="258"/>
            <ac:grpSpMk id="362" creationId="{3E169D3A-23BE-4D1A-8114-00D9702F09F3}"/>
          </ac:grpSpMkLst>
        </pc:grpChg>
        <pc:cxnChg chg="del mod">
          <ac:chgData name="Esther Walker" userId="f1e11e33-ab63-4053-bc81-f884cbad8747" providerId="ADAL" clId="{19BC932A-0D65-4FC5-AAED-2AD352209D35}" dt="2020-10-30T02:29:34.893" v="1795" actId="478"/>
          <ac:cxnSpMkLst>
            <pc:docMk/>
            <pc:sldMk cId="3901562394" sldId="258"/>
            <ac:cxnSpMk id="3" creationId="{44DF8E6C-651D-4748-A813-74A4770A7B0C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45" creationId="{76E230C2-8F16-49F5-B0EB-58CCE43199A2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46" creationId="{195E6C8A-6E7F-40C1-ADA3-1F3BECB0D1A0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48" creationId="{ECA145CE-591F-437D-BEB5-AF3B5F02A7FA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49" creationId="{65542558-32CA-42C5-AC7B-5630769ECAF2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50" creationId="{4C7E173A-7425-4152-A744-0E9AD2BD6FAD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52" creationId="{A4BA70F4-F9FB-4B76-BD02-097FB5FE4267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71" creationId="{B93DFEF6-7937-4096-8381-F6551CBA102E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73" creationId="{3EBFE3E0-D463-4973-A6FF-85BAF01FA920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75" creationId="{44F33903-1F4A-46FC-B38F-706265724DE8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76" creationId="{F1F9D945-B7C9-4565-812F-9E8B447F2B0B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77" creationId="{D5769CE9-7EF0-46B2-ABD5-BDA49E78A9CB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78" creationId="{1AB4BB9A-E0D3-49B9-80A8-4508B7A9B402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79" creationId="{AABF5FCB-8FD1-47CE-9728-93EA117FC412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86" creationId="{EFC59CA7-4F68-4766-B2F6-3EE5C053D47A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88" creationId="{3A322D93-5131-4481-8A94-3F49984E10F1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90" creationId="{DC329E3C-4872-4C64-9169-E11F38E3C4C1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93" creationId="{24F224A2-1C65-465E-9E3C-69BF3D0D0D32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95" creationId="{16F2F5C7-9567-4CD3-89DD-EDB15587BEF3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197" creationId="{1048A9EF-52B0-4253-918E-9F60E8523FD3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221" creationId="{C50465B7-25A4-4583-9EB8-7436330B7E8D}"/>
          </ac:cxnSpMkLst>
        </pc:cxnChg>
        <pc:cxnChg chg="mod">
          <ac:chgData name="Esther Walker" userId="f1e11e33-ab63-4053-bc81-f884cbad8747" providerId="ADAL" clId="{19BC932A-0D65-4FC5-AAED-2AD352209D35}" dt="2020-11-24T02:34:12.224" v="2122" actId="1038"/>
          <ac:cxnSpMkLst>
            <pc:docMk/>
            <pc:sldMk cId="3901562394" sldId="258"/>
            <ac:cxnSpMk id="223" creationId="{EAB7E70C-FE51-4197-988A-1D857903A64C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231" creationId="{B963777B-40D8-4695-827A-3036933D8BFC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233" creationId="{715D7554-3AF7-4EFA-B39E-5862CFEC9589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237" creationId="{7775041E-7B71-4EF5-AD43-AEA5E23681FC}"/>
          </ac:cxnSpMkLst>
        </pc:cxnChg>
        <pc:cxnChg chg="add 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246" creationId="{7C53E2E6-7F88-4B02-BBC1-CA0A28D4B659}"/>
          </ac:cxnSpMkLst>
        </pc:cxnChg>
        <pc:cxnChg chg="add mod">
          <ac:chgData name="Esther Walker" userId="f1e11e33-ab63-4053-bc81-f884cbad8747" providerId="ADAL" clId="{19BC932A-0D65-4FC5-AAED-2AD352209D35}" dt="2020-10-30T02:27:08.018" v="1733" actId="14100"/>
          <ac:cxnSpMkLst>
            <pc:docMk/>
            <pc:sldMk cId="3901562394" sldId="258"/>
            <ac:cxnSpMk id="249" creationId="{19A6F5AF-FE2B-4255-AC63-E1CEB2CE84D8}"/>
          </ac:cxnSpMkLst>
        </pc:cxnChg>
        <pc:cxnChg chg="add mod">
          <ac:chgData name="Esther Walker" userId="f1e11e33-ab63-4053-bc81-f884cbad8747" providerId="ADAL" clId="{19BC932A-0D65-4FC5-AAED-2AD352209D35}" dt="2020-10-30T02:27:08.018" v="1733" actId="14100"/>
          <ac:cxnSpMkLst>
            <pc:docMk/>
            <pc:sldMk cId="3901562394" sldId="258"/>
            <ac:cxnSpMk id="250" creationId="{5D794B27-72C5-4DDD-98AD-6FDAC9BECE2F}"/>
          </ac:cxnSpMkLst>
        </pc:cxnChg>
        <pc:cxnChg chg="add mod">
          <ac:chgData name="Esther Walker" userId="f1e11e33-ab63-4053-bc81-f884cbad8747" providerId="ADAL" clId="{19BC932A-0D65-4FC5-AAED-2AD352209D35}" dt="2020-10-30T02:27:08.018" v="1733" actId="14100"/>
          <ac:cxnSpMkLst>
            <pc:docMk/>
            <pc:sldMk cId="3901562394" sldId="258"/>
            <ac:cxnSpMk id="251" creationId="{438B5743-4D9C-4246-8E2A-989176EF5585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252" creationId="{F25CBB24-9ECF-41AC-901D-CE528F7AAAA5}"/>
          </ac:cxnSpMkLst>
        </pc:cxnChg>
        <pc:cxnChg chg="add mod">
          <ac:chgData name="Esther Walker" userId="f1e11e33-ab63-4053-bc81-f884cbad8747" providerId="ADAL" clId="{19BC932A-0D65-4FC5-AAED-2AD352209D35}" dt="2020-10-30T02:27:08.018" v="1733" actId="14100"/>
          <ac:cxnSpMkLst>
            <pc:docMk/>
            <pc:sldMk cId="3901562394" sldId="258"/>
            <ac:cxnSpMk id="253" creationId="{DB94FA58-F803-4030-88D9-47B07DE9963F}"/>
          </ac:cxnSpMkLst>
        </pc:cxnChg>
        <pc:cxnChg chg="add mod">
          <ac:chgData name="Esther Walker" userId="f1e11e33-ab63-4053-bc81-f884cbad8747" providerId="ADAL" clId="{19BC932A-0D65-4FC5-AAED-2AD352209D35}" dt="2020-10-30T02:27:08.018" v="1733" actId="14100"/>
          <ac:cxnSpMkLst>
            <pc:docMk/>
            <pc:sldMk cId="3901562394" sldId="258"/>
            <ac:cxnSpMk id="254" creationId="{EBB2AE69-84BD-4F55-B59A-965C45951F11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262" creationId="{C70DE0C4-C8E9-423B-81DD-00E6CC326E35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263" creationId="{92F85860-52FB-4547-84A7-498E44A9DC2E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264" creationId="{E21936A0-D425-42B0-85F5-E88CE24D832D}"/>
          </ac:cxnSpMkLst>
        </pc:cxnChg>
        <pc:cxnChg chg="add mod">
          <ac:chgData name="Esther Walker" userId="f1e11e33-ab63-4053-bc81-f884cbad8747" providerId="ADAL" clId="{19BC932A-0D65-4FC5-AAED-2AD352209D35}" dt="2020-10-30T02:27:08.018" v="1733" actId="14100"/>
          <ac:cxnSpMkLst>
            <pc:docMk/>
            <pc:sldMk cId="3901562394" sldId="258"/>
            <ac:cxnSpMk id="265" creationId="{B5A83D7F-CCB8-428E-A3FB-5DA68BED4E73}"/>
          </ac:cxnSpMkLst>
        </pc:cxnChg>
        <pc:cxnChg chg="add mod">
          <ac:chgData name="Esther Walker" userId="f1e11e33-ab63-4053-bc81-f884cbad8747" providerId="ADAL" clId="{19BC932A-0D65-4FC5-AAED-2AD352209D35}" dt="2020-10-30T02:27:08.018" v="1733" actId="14100"/>
          <ac:cxnSpMkLst>
            <pc:docMk/>
            <pc:sldMk cId="3901562394" sldId="258"/>
            <ac:cxnSpMk id="266" creationId="{CCA1095D-B37C-425B-92B4-839B84F2E2B8}"/>
          </ac:cxnSpMkLst>
        </pc:cxnChg>
        <pc:cxnChg chg="add mod">
          <ac:chgData name="Esther Walker" userId="f1e11e33-ab63-4053-bc81-f884cbad8747" providerId="ADAL" clId="{19BC932A-0D65-4FC5-AAED-2AD352209D35}" dt="2020-10-30T02:27:08.018" v="1733" actId="14100"/>
          <ac:cxnSpMkLst>
            <pc:docMk/>
            <pc:sldMk cId="3901562394" sldId="258"/>
            <ac:cxnSpMk id="267" creationId="{28B96C52-10D4-449B-92A4-5D7535D6A48F}"/>
          </ac:cxnSpMkLst>
        </pc:cxnChg>
        <pc:cxnChg chg="add mod">
          <ac:chgData name="Esther Walker" userId="f1e11e33-ab63-4053-bc81-f884cbad8747" providerId="ADAL" clId="{19BC932A-0D65-4FC5-AAED-2AD352209D35}" dt="2020-10-30T02:27:08.018" v="1733" actId="14100"/>
          <ac:cxnSpMkLst>
            <pc:docMk/>
            <pc:sldMk cId="3901562394" sldId="258"/>
            <ac:cxnSpMk id="268" creationId="{4D423FF5-3A52-4DE3-96FD-49304EF5A8BA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312" creationId="{03F619E3-3126-4FF1-9A30-81DDE5F5144C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316" creationId="{E03A411A-B066-479A-8709-065B38B61503}"/>
          </ac:cxnSpMkLst>
        </pc:cxnChg>
        <pc:cxnChg chg="mod">
          <ac:chgData name="Esther Walker" userId="f1e11e33-ab63-4053-bc81-f884cbad8747" providerId="ADAL" clId="{19BC932A-0D65-4FC5-AAED-2AD352209D35}" dt="2020-11-24T02:33:13.430" v="2087" actId="1036"/>
          <ac:cxnSpMkLst>
            <pc:docMk/>
            <pc:sldMk cId="3901562394" sldId="258"/>
            <ac:cxnSpMk id="317" creationId="{B97F382E-AA1E-42C6-84B1-4204C84CF7F6}"/>
          </ac:cxnSpMkLst>
        </pc:cxnChg>
      </pc:sldChg>
      <pc:sldChg chg="addSp modSp">
        <pc:chgData name="Esther Walker" userId="f1e11e33-ab63-4053-bc81-f884cbad8747" providerId="ADAL" clId="{19BC932A-0D65-4FC5-AAED-2AD352209D35}" dt="2020-11-24T02:38:23.088" v="2332" actId="1038"/>
        <pc:sldMkLst>
          <pc:docMk/>
          <pc:sldMk cId="1423815540" sldId="259"/>
        </pc:sldMkLst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13" creationId="{B2DF3E5A-D6AF-47C7-A43D-02081E087DC1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14" creationId="{BFB2EB1B-38AF-4C15-9649-D549A83FB39C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15" creationId="{8319DBB1-E199-41F9-BC9E-25BFAE4D9B40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16" creationId="{2F72D106-7398-4A97-8DE0-832DD378FDD0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17" creationId="{208C4C31-FDD2-4B5B-8E90-211FE920B177}"/>
          </ac:spMkLst>
        </pc:spChg>
        <pc:spChg chg="mod">
          <ac:chgData name="Esther Walker" userId="f1e11e33-ab63-4053-bc81-f884cbad8747" providerId="ADAL" clId="{19BC932A-0D65-4FC5-AAED-2AD352209D35}" dt="2020-10-30T02:32:36.623" v="1956"/>
          <ac:spMkLst>
            <pc:docMk/>
            <pc:sldMk cId="1423815540" sldId="259"/>
            <ac:spMk id="119" creationId="{146250BF-0D9B-4C6F-9591-74830FE30C6F}"/>
          </ac:spMkLst>
        </pc:spChg>
        <pc:spChg chg="mod">
          <ac:chgData name="Esther Walker" userId="f1e11e33-ab63-4053-bc81-f884cbad8747" providerId="ADAL" clId="{19BC932A-0D65-4FC5-AAED-2AD352209D35}" dt="2020-10-30T02:15:40.585" v="1408" actId="1035"/>
          <ac:spMkLst>
            <pc:docMk/>
            <pc:sldMk cId="1423815540" sldId="259"/>
            <ac:spMk id="124" creationId="{07568E09-C04D-425B-A484-974EBCA01940}"/>
          </ac:spMkLst>
        </pc:spChg>
        <pc:spChg chg="mod">
          <ac:chgData name="Esther Walker" userId="f1e11e33-ab63-4053-bc81-f884cbad8747" providerId="ADAL" clId="{19BC932A-0D65-4FC5-AAED-2AD352209D35}" dt="2020-11-24T02:38:02.041" v="2298" actId="1035"/>
          <ac:spMkLst>
            <pc:docMk/>
            <pc:sldMk cId="1423815540" sldId="259"/>
            <ac:spMk id="127" creationId="{499C627E-0C6D-4E48-AF12-C811F768CB0B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30" creationId="{C246643E-FF9F-4A1E-BDFD-B2F4D8B7F0EE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31" creationId="{56F01360-4C65-4CFE-A80F-5C3FC442AEE3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33" creationId="{E970A328-242E-4064-87B3-6CD063DF6F81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35" creationId="{F13E2728-2A39-45FB-AAE7-EA24934BF5FC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37" creationId="{794F2EB9-7609-4767-8BF9-42E9583F5AA7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41" creationId="{4CDCE845-1AF4-47AD-931B-27A514A5DE68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43" creationId="{2E53D6C6-88D0-4E67-BC4C-AA1BBE241943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45" creationId="{9D5B2F97-C4C2-46E7-B2B7-68BE8B4F4EDB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47" creationId="{57BD0209-B15B-4A6D-B182-0C8E2E7D9494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49" creationId="{E3C12CA3-166A-46BA-BDF0-9EF02B4B169E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51" creationId="{4FFF589D-14AD-4E96-9A6D-C4DB0E5D9382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53" creationId="{AC79A9C7-BB73-42B2-B9E3-C0C7D3B48E03}"/>
          </ac:spMkLst>
        </pc:spChg>
        <pc:spChg chg="mod">
          <ac:chgData name="Esther Walker" userId="f1e11e33-ab63-4053-bc81-f884cbad8747" providerId="ADAL" clId="{19BC932A-0D65-4FC5-AAED-2AD352209D35}" dt="2020-11-24T02:37:55.278" v="2284" actId="1035"/>
          <ac:spMkLst>
            <pc:docMk/>
            <pc:sldMk cId="1423815540" sldId="259"/>
            <ac:spMk id="155" creationId="{8B137C98-22E3-41A0-8BE1-6BEB627764C3}"/>
          </ac:spMkLst>
        </pc:spChg>
        <pc:spChg chg="add">
          <ac:chgData name="Esther Walker" userId="f1e11e33-ab63-4053-bc81-f884cbad8747" providerId="ADAL" clId="{19BC932A-0D65-4FC5-AAED-2AD352209D35}" dt="2020-11-24T02:35:59.913" v="2190"/>
          <ac:spMkLst>
            <pc:docMk/>
            <pc:sldMk cId="1423815540" sldId="259"/>
            <ac:spMk id="160" creationId="{6409E12F-416D-4920-AAFE-4DFE983F7D48}"/>
          </ac:spMkLst>
        </pc:spChg>
        <pc:spChg chg="mod">
          <ac:chgData name="Esther Walker" userId="f1e11e33-ab63-4053-bc81-f884cbad8747" providerId="ADAL" clId="{19BC932A-0D65-4FC5-AAED-2AD352209D35}" dt="2020-10-30T02:15:46.209" v="1412" actId="1035"/>
          <ac:spMkLst>
            <pc:docMk/>
            <pc:sldMk cId="1423815540" sldId="259"/>
            <ac:spMk id="244" creationId="{FA2B96A2-E44F-4F6E-BCA3-FF52AF20F9B4}"/>
          </ac:spMkLst>
        </pc:spChg>
        <pc:spChg chg="mod">
          <ac:chgData name="Esther Walker" userId="f1e11e33-ab63-4053-bc81-f884cbad8747" providerId="ADAL" clId="{19BC932A-0D65-4FC5-AAED-2AD352209D35}" dt="2020-11-24T02:38:16.200" v="2329" actId="1035"/>
          <ac:spMkLst>
            <pc:docMk/>
            <pc:sldMk cId="1423815540" sldId="259"/>
            <ac:spMk id="316" creationId="{13AE772B-85DC-45F0-BB75-8EE4398B4C34}"/>
          </ac:spMkLst>
        </pc:spChg>
        <pc:spChg chg="mod">
          <ac:chgData name="Esther Walker" userId="f1e11e33-ab63-4053-bc81-f884cbad8747" providerId="ADAL" clId="{19BC932A-0D65-4FC5-AAED-2AD352209D35}" dt="2020-11-24T02:38:23.088" v="2332" actId="1038"/>
          <ac:spMkLst>
            <pc:docMk/>
            <pc:sldMk cId="1423815540" sldId="259"/>
            <ac:spMk id="412" creationId="{6319764F-5566-43E7-9A03-A82EC9E66916}"/>
          </ac:spMkLst>
        </pc:s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12" creationId="{7AB99ED0-499D-4FA0-9901-22553F0114CC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26" creationId="{439ECF47-7BE8-4F28-855E-4E1490929DC0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120" creationId="{C9C4948C-7EC8-4BCF-9FC2-8706B6BA7436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123" creationId="{9ED12080-3881-42C2-BC83-2F8385A1D187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126" creationId="{15E1BC05-95BE-43F1-BF84-EA128BF8AB4E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156" creationId="{5EBEA71B-860F-4988-822F-723640453C93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171" creationId="{A6D45BBE-78D5-4DB7-B4EE-5ADF706A93F2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177" creationId="{400221B6-2973-435E-A515-558B8FB0D8E3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183" creationId="{AB1DB979-72C8-4E52-880B-EED5AC63687B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235" creationId="{26F7637D-BA91-4E4E-BB0B-80AE83B1323B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243" creationId="{BFCE9074-CD1D-415A-A63E-4C7E325DBBE9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261" creationId="{F40B608F-AA1F-41A4-AF8F-A3E75C835E58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270" creationId="{74C85084-F0C7-4A5B-B596-2689EDDB9BEA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273" creationId="{01BEDBA4-8B92-4FF2-8ECB-47EF2F3EA7BB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282" creationId="{85BA8555-2E0F-41FF-AA4A-AE9456AAE3DF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291" creationId="{F1543C13-03AC-46A2-AEB9-43C255FB5B67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297" creationId="{8D7B6729-5861-4D50-B898-CC2276754BCF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306" creationId="{B183E376-9CA2-4D73-A362-7EF9FC7699E2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309" creationId="{A17649C9-3458-4672-BB46-10735B2B0E24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312" creationId="{1FF4A272-5317-4186-9125-B75A8314D1EC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315" creationId="{8BFEDC81-FD6F-4652-B255-6CC3505E5554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324" creationId="{48ED22A8-AFFC-49DF-93E9-C2588EEDC706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327" creationId="{A21CD8BF-2F0C-4076-8031-674B3EABAC3E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330" creationId="{390B3F26-8968-4781-9071-4BE840C26094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351" creationId="{2FE94297-4ED4-416C-B8DD-160C3245A43B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381" creationId="{FA8E57A6-082B-4831-A583-600747CBBAD6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393" creationId="{C0EBFE80-3129-4FBD-9D65-4A86851F7A76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396" creationId="{ECC63E71-9B44-4699-960E-672AD1D92837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411" creationId="{A6408926-7C94-4800-AC68-9945C8273ECC}"/>
          </ac:grpSpMkLst>
        </pc:grpChg>
        <pc:grpChg chg="mod">
          <ac:chgData name="Esther Walker" userId="f1e11e33-ab63-4053-bc81-f884cbad8747" providerId="ADAL" clId="{19BC932A-0D65-4FC5-AAED-2AD352209D35}" dt="2020-11-24T02:37:55.278" v="2284" actId="1035"/>
          <ac:grpSpMkLst>
            <pc:docMk/>
            <pc:sldMk cId="1423815540" sldId="259"/>
            <ac:grpSpMk id="447" creationId="{9A34B016-8E2A-40CD-AC91-F57D7AA5C5E3}"/>
          </ac:grpSpMkLst>
        </pc:grp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38" creationId="{754CF5FE-9319-4356-8101-F51C5AC352A3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09" creationId="{A9D9F2AD-02F6-40FD-A55E-3D3BF49CD8AA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10" creationId="{69EE231E-3048-46C5-A21C-3112BA35AC89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11" creationId="{643541A1-AB5E-47CA-8ED5-6D7A2C25EB91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12" creationId="{66B666C7-F012-4791-95F2-689BD3377578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29" creationId="{CB506827-A4D7-4964-909F-E0F9B5855532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32" creationId="{B004AD38-EB26-40D8-B3C3-78E5DB9FA62F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34" creationId="{436432AC-C2D3-421B-BA72-1383DEA00C07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36" creationId="{FB41C832-153C-4864-BFAE-ADEAA85098F2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38" creationId="{5D22C475-E38A-4946-B267-CA30FC6D6ECB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42" creationId="{F32B5D34-08FB-4696-8389-08250B3C2E2E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44" creationId="{33399657-97EB-45C1-A8C9-93DDB5A35328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46" creationId="{EFE2BD5D-9153-4392-84A0-4B636CADF458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48" creationId="{1862A7C9-7747-4FD4-96EF-11DE0E542325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50" creationId="{CE01C65B-AE7F-40F1-9C2B-3DB9BD178C09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52" creationId="{14B853F8-24C8-474E-8729-904AEC85E647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54" creationId="{EB912048-435E-4EC4-B479-F25901FEEA5A}"/>
          </ac:cxnSpMkLst>
        </pc:cxnChg>
        <pc:cxnChg chg="mod">
          <ac:chgData name="Esther Walker" userId="f1e11e33-ab63-4053-bc81-f884cbad8747" providerId="ADAL" clId="{19BC932A-0D65-4FC5-AAED-2AD352209D35}" dt="2020-11-24T02:37:55.278" v="2284" actId="1035"/>
          <ac:cxnSpMkLst>
            <pc:docMk/>
            <pc:sldMk cId="1423815540" sldId="259"/>
            <ac:cxnSpMk id="159" creationId="{3848ABCE-FFA9-4F5D-A6C6-A9D27D99958E}"/>
          </ac:cxnSpMkLst>
        </pc:cxnChg>
      </pc:sldChg>
      <pc:sldChg chg="addSp modSp">
        <pc:chgData name="Esther Walker" userId="f1e11e33-ab63-4053-bc81-f884cbad8747" providerId="ADAL" clId="{19BC932A-0D65-4FC5-AAED-2AD352209D35}" dt="2020-11-24T02:36:01.753" v="2191"/>
        <pc:sldMkLst>
          <pc:docMk/>
          <pc:sldMk cId="803600176" sldId="260"/>
        </pc:sldMkLst>
        <pc:spChg chg="add mod">
          <ac:chgData name="Esther Walker" userId="f1e11e33-ab63-4053-bc81-f884cbad8747" providerId="ADAL" clId="{19BC932A-0D65-4FC5-AAED-2AD352209D35}" dt="2020-10-30T01:36:42.822" v="561" actId="1035"/>
          <ac:spMkLst>
            <pc:docMk/>
            <pc:sldMk cId="803600176" sldId="260"/>
            <ac:spMk id="203" creationId="{D0C2479E-8C78-4203-B7F1-331502CA8F37}"/>
          </ac:spMkLst>
        </pc:spChg>
        <pc:spChg chg="add">
          <ac:chgData name="Esther Walker" userId="f1e11e33-ab63-4053-bc81-f884cbad8747" providerId="ADAL" clId="{19BC932A-0D65-4FC5-AAED-2AD352209D35}" dt="2020-11-24T02:36:01.753" v="2191"/>
          <ac:spMkLst>
            <pc:docMk/>
            <pc:sldMk cId="803600176" sldId="260"/>
            <ac:spMk id="205" creationId="{F34A5DBA-6700-4985-9072-457938E3CA70}"/>
          </ac:spMkLst>
        </pc:spChg>
        <pc:spChg chg="mod">
          <ac:chgData name="Esther Walker" userId="f1e11e33-ab63-4053-bc81-f884cbad8747" providerId="ADAL" clId="{19BC932A-0D65-4FC5-AAED-2AD352209D35}" dt="2020-10-30T01:14:01.397" v="486" actId="1036"/>
          <ac:spMkLst>
            <pc:docMk/>
            <pc:sldMk cId="803600176" sldId="260"/>
            <ac:spMk id="219" creationId="{A543E7D2-B372-4FCD-8908-5BFFDC67497F}"/>
          </ac:spMkLst>
        </pc:spChg>
        <pc:spChg chg="mod">
          <ac:chgData name="Esther Walker" userId="f1e11e33-ab63-4053-bc81-f884cbad8747" providerId="ADAL" clId="{19BC932A-0D65-4FC5-AAED-2AD352209D35}" dt="2020-10-30T01:14:09.731" v="507" actId="1035"/>
          <ac:spMkLst>
            <pc:docMk/>
            <pc:sldMk cId="803600176" sldId="260"/>
            <ac:spMk id="222" creationId="{97DFE4A9-6CA2-4322-AD69-3DE91E33CFBC}"/>
          </ac:spMkLst>
        </pc:spChg>
        <pc:spChg chg="mod">
          <ac:chgData name="Esther Walker" userId="f1e11e33-ab63-4053-bc81-f884cbad8747" providerId="ADAL" clId="{19BC932A-0D65-4FC5-AAED-2AD352209D35}" dt="2020-10-30T02:32:36.623" v="1956"/>
          <ac:spMkLst>
            <pc:docMk/>
            <pc:sldMk cId="803600176" sldId="260"/>
            <ac:spMk id="234" creationId="{78B88447-E994-42F2-9805-2DDE8354CCBB}"/>
          </ac:spMkLst>
        </pc:spChg>
        <pc:spChg chg="mod">
          <ac:chgData name="Esther Walker" userId="f1e11e33-ab63-4053-bc81-f884cbad8747" providerId="ADAL" clId="{19BC932A-0D65-4FC5-AAED-2AD352209D35}" dt="2020-10-30T02:04:02.661" v="608" actId="1076"/>
          <ac:spMkLst>
            <pc:docMk/>
            <pc:sldMk cId="803600176" sldId="260"/>
            <ac:spMk id="250" creationId="{44023138-5B7C-4539-8A54-F69801E82B1B}"/>
          </ac:spMkLst>
        </pc:spChg>
        <pc:spChg chg="mod">
          <ac:chgData name="Esther Walker" userId="f1e11e33-ab63-4053-bc81-f884cbad8747" providerId="ADAL" clId="{19BC932A-0D65-4FC5-AAED-2AD352209D35}" dt="2020-10-30T02:15:25.905" v="1405" actId="1035"/>
          <ac:spMkLst>
            <pc:docMk/>
            <pc:sldMk cId="803600176" sldId="260"/>
            <ac:spMk id="254" creationId="{73A80B89-0E42-4DA4-9B88-25B5E277C6B6}"/>
          </ac:spMkLst>
        </pc:spChg>
        <pc:spChg chg="mod">
          <ac:chgData name="Esther Walker" userId="f1e11e33-ab63-4053-bc81-f884cbad8747" providerId="ADAL" clId="{19BC932A-0D65-4FC5-AAED-2AD352209D35}" dt="2020-10-30T02:14:37.263" v="1316" actId="1036"/>
          <ac:spMkLst>
            <pc:docMk/>
            <pc:sldMk cId="803600176" sldId="260"/>
            <ac:spMk id="260" creationId="{8EC96764-8677-4350-8997-6F69229A5771}"/>
          </ac:spMkLst>
        </pc:spChg>
        <pc:spChg chg="mod">
          <ac:chgData name="Esther Walker" userId="f1e11e33-ab63-4053-bc81-f884cbad8747" providerId="ADAL" clId="{19BC932A-0D65-4FC5-AAED-2AD352209D35}" dt="2020-10-30T01:41:06.727" v="563"/>
          <ac:spMkLst>
            <pc:docMk/>
            <pc:sldMk cId="803600176" sldId="260"/>
            <ac:spMk id="277" creationId="{A1FEA16C-44CA-438D-8725-0B41B6732F44}"/>
          </ac:spMkLst>
        </pc:spChg>
        <pc:spChg chg="mod">
          <ac:chgData name="Esther Walker" userId="f1e11e33-ab63-4053-bc81-f884cbad8747" providerId="ADAL" clId="{19BC932A-0D65-4FC5-AAED-2AD352209D35}" dt="2020-10-30T01:41:06.727" v="563"/>
          <ac:spMkLst>
            <pc:docMk/>
            <pc:sldMk cId="803600176" sldId="260"/>
            <ac:spMk id="285" creationId="{C28D3141-3952-4F8D-B014-2DAC62CFB166}"/>
          </ac:spMkLst>
        </pc:spChg>
        <pc:spChg chg="mod">
          <ac:chgData name="Esther Walker" userId="f1e11e33-ab63-4053-bc81-f884cbad8747" providerId="ADAL" clId="{19BC932A-0D65-4FC5-AAED-2AD352209D35}" dt="2020-10-30T02:04:30.739" v="622" actId="1038"/>
          <ac:spMkLst>
            <pc:docMk/>
            <pc:sldMk cId="803600176" sldId="260"/>
            <ac:spMk id="289" creationId="{FE6DB039-A3AD-4608-B15B-26176ACA1990}"/>
          </ac:spMkLst>
        </pc:spChg>
        <pc:spChg chg="mod">
          <ac:chgData name="Esther Walker" userId="f1e11e33-ab63-4053-bc81-f884cbad8747" providerId="ADAL" clId="{19BC932A-0D65-4FC5-AAED-2AD352209D35}" dt="2020-10-30T02:15:20.436" v="1404" actId="1076"/>
          <ac:spMkLst>
            <pc:docMk/>
            <pc:sldMk cId="803600176" sldId="260"/>
            <ac:spMk id="310" creationId="{97B689D4-C2CA-493C-A0E0-3C671925B503}"/>
          </ac:spMkLst>
        </pc:spChg>
        <pc:spChg chg="mod">
          <ac:chgData name="Esther Walker" userId="f1e11e33-ab63-4053-bc81-f884cbad8747" providerId="ADAL" clId="{19BC932A-0D65-4FC5-AAED-2AD352209D35}" dt="2020-10-30T02:04:30.739" v="622" actId="1038"/>
          <ac:spMkLst>
            <pc:docMk/>
            <pc:sldMk cId="803600176" sldId="260"/>
            <ac:spMk id="314" creationId="{505AADD8-40F0-46E0-8B12-F8248EC7EB60}"/>
          </ac:spMkLst>
        </pc:spChg>
        <pc:grpChg chg="mod">
          <ac:chgData name="Esther Walker" userId="f1e11e33-ab63-4053-bc81-f884cbad8747" providerId="ADAL" clId="{19BC932A-0D65-4FC5-AAED-2AD352209D35}" dt="2020-10-30T02:14:17.705" v="1304" actId="1038"/>
          <ac:grpSpMkLst>
            <pc:docMk/>
            <pc:sldMk cId="803600176" sldId="260"/>
            <ac:grpSpMk id="154" creationId="{0084EB7C-EC0C-44D1-A1DC-DFE9269F540A}"/>
          </ac:grpSpMkLst>
        </pc:grpChg>
        <pc:grpChg chg="mod">
          <ac:chgData name="Esther Walker" userId="f1e11e33-ab63-4053-bc81-f884cbad8747" providerId="ADAL" clId="{19BC932A-0D65-4FC5-AAED-2AD352209D35}" dt="2020-10-30T02:14:13.535" v="1296" actId="1038"/>
          <ac:grpSpMkLst>
            <pc:docMk/>
            <pc:sldMk cId="803600176" sldId="260"/>
            <ac:grpSpMk id="163" creationId="{ECA54C36-BEBF-4BB0-B596-05129EA1ED7E}"/>
          </ac:grpSpMkLst>
        </pc:grpChg>
        <pc:grpChg chg="mod">
          <ac:chgData name="Esther Walker" userId="f1e11e33-ab63-4053-bc81-f884cbad8747" providerId="ADAL" clId="{19BC932A-0D65-4FC5-AAED-2AD352209D35}" dt="2020-10-30T02:14:13.535" v="1296" actId="1038"/>
          <ac:grpSpMkLst>
            <pc:docMk/>
            <pc:sldMk cId="803600176" sldId="260"/>
            <ac:grpSpMk id="168" creationId="{1CA0D4C4-E6EB-4320-AE23-DDF5F34A7B04}"/>
          </ac:grpSpMkLst>
        </pc:grpChg>
        <pc:grpChg chg="mod">
          <ac:chgData name="Esther Walker" userId="f1e11e33-ab63-4053-bc81-f884cbad8747" providerId="ADAL" clId="{19BC932A-0D65-4FC5-AAED-2AD352209D35}" dt="2020-10-30T02:14:13.535" v="1296" actId="1038"/>
          <ac:grpSpMkLst>
            <pc:docMk/>
            <pc:sldMk cId="803600176" sldId="260"/>
            <ac:grpSpMk id="171" creationId="{71250EF6-74ED-4D90-A2BC-71A49994C248}"/>
          </ac:grpSpMkLst>
        </pc:grpChg>
        <pc:grpChg chg="mod">
          <ac:chgData name="Esther Walker" userId="f1e11e33-ab63-4053-bc81-f884cbad8747" providerId="ADAL" clId="{19BC932A-0D65-4FC5-AAED-2AD352209D35}" dt="2020-10-30T02:13:54.302" v="1275" actId="1037"/>
          <ac:grpSpMkLst>
            <pc:docMk/>
            <pc:sldMk cId="803600176" sldId="260"/>
            <ac:grpSpMk id="176" creationId="{3114A960-FE16-4DEF-8B66-CCB19334C05D}"/>
          </ac:grpSpMkLst>
        </pc:grpChg>
        <pc:grpChg chg="mod">
          <ac:chgData name="Esther Walker" userId="f1e11e33-ab63-4053-bc81-f884cbad8747" providerId="ADAL" clId="{19BC932A-0D65-4FC5-AAED-2AD352209D35}" dt="2020-10-30T02:14:23.480" v="1314" actId="1038"/>
          <ac:grpSpMkLst>
            <pc:docMk/>
            <pc:sldMk cId="803600176" sldId="260"/>
            <ac:grpSpMk id="179" creationId="{39A1D9E8-EEAD-46EF-9028-318DDF1F46AF}"/>
          </ac:grpSpMkLst>
        </pc:grpChg>
        <pc:grpChg chg="mod">
          <ac:chgData name="Esther Walker" userId="f1e11e33-ab63-4053-bc81-f884cbad8747" providerId="ADAL" clId="{19BC932A-0D65-4FC5-AAED-2AD352209D35}" dt="2020-10-30T02:15:06.183" v="1402" actId="1037"/>
          <ac:grpSpMkLst>
            <pc:docMk/>
            <pc:sldMk cId="803600176" sldId="260"/>
            <ac:grpSpMk id="182" creationId="{E095877A-E811-48CE-B81A-D7BF35B29941}"/>
          </ac:grpSpMkLst>
        </pc:grpChg>
        <pc:grpChg chg="mod">
          <ac:chgData name="Esther Walker" userId="f1e11e33-ab63-4053-bc81-f884cbad8747" providerId="ADAL" clId="{19BC932A-0D65-4FC5-AAED-2AD352209D35}" dt="2020-10-30T02:13:54.302" v="1275" actId="1037"/>
          <ac:grpSpMkLst>
            <pc:docMk/>
            <pc:sldMk cId="803600176" sldId="260"/>
            <ac:grpSpMk id="185" creationId="{DD1DDA4F-4F53-47E5-98D5-8B69DBAB592A}"/>
          </ac:grpSpMkLst>
        </pc:grpChg>
        <pc:grpChg chg="mod">
          <ac:chgData name="Esther Walker" userId="f1e11e33-ab63-4053-bc81-f884cbad8747" providerId="ADAL" clId="{19BC932A-0D65-4FC5-AAED-2AD352209D35}" dt="2020-10-30T02:13:54.302" v="1275" actId="1037"/>
          <ac:grpSpMkLst>
            <pc:docMk/>
            <pc:sldMk cId="803600176" sldId="260"/>
            <ac:grpSpMk id="188" creationId="{F16A150F-3F13-48B8-BE8F-BE8A2AACF471}"/>
          </ac:grpSpMkLst>
        </pc:grpChg>
        <pc:grpChg chg="mod">
          <ac:chgData name="Esther Walker" userId="f1e11e33-ab63-4053-bc81-f884cbad8747" providerId="ADAL" clId="{19BC932A-0D65-4FC5-AAED-2AD352209D35}" dt="2020-10-30T02:13:54.302" v="1275" actId="1037"/>
          <ac:grpSpMkLst>
            <pc:docMk/>
            <pc:sldMk cId="803600176" sldId="260"/>
            <ac:grpSpMk id="191" creationId="{0578323E-C405-44B2-897C-E4469F46A889}"/>
          </ac:grpSpMkLst>
        </pc:grpChg>
        <pc:grpChg chg="mod">
          <ac:chgData name="Esther Walker" userId="f1e11e33-ab63-4053-bc81-f884cbad8747" providerId="ADAL" clId="{19BC932A-0D65-4FC5-AAED-2AD352209D35}" dt="2020-10-30T02:14:23.480" v="1314" actId="1038"/>
          <ac:grpSpMkLst>
            <pc:docMk/>
            <pc:sldMk cId="803600176" sldId="260"/>
            <ac:grpSpMk id="200" creationId="{DAD0A1A7-DEA8-428A-BF34-3C42AAEF9D37}"/>
          </ac:grpSpMkLst>
        </pc:grpChg>
        <pc:grpChg chg="mod">
          <ac:chgData name="Esther Walker" userId="f1e11e33-ab63-4053-bc81-f884cbad8747" providerId="ADAL" clId="{19BC932A-0D65-4FC5-AAED-2AD352209D35}" dt="2020-10-30T02:13:54.302" v="1275" actId="1037"/>
          <ac:grpSpMkLst>
            <pc:docMk/>
            <pc:sldMk cId="803600176" sldId="260"/>
            <ac:grpSpMk id="209" creationId="{16675313-86D9-479E-90CF-59B56604C921}"/>
          </ac:grpSpMkLst>
        </pc:grpChg>
        <pc:grpChg chg="mod">
          <ac:chgData name="Esther Walker" userId="f1e11e33-ab63-4053-bc81-f884cbad8747" providerId="ADAL" clId="{19BC932A-0D65-4FC5-AAED-2AD352209D35}" dt="2020-10-30T02:14:23.480" v="1314" actId="1038"/>
          <ac:grpSpMkLst>
            <pc:docMk/>
            <pc:sldMk cId="803600176" sldId="260"/>
            <ac:grpSpMk id="212" creationId="{19E6E5DD-810F-4C94-BA3C-BBD5616020F4}"/>
          </ac:grpSpMkLst>
        </pc:grpChg>
        <pc:grpChg chg="mod">
          <ac:chgData name="Esther Walker" userId="f1e11e33-ab63-4053-bc81-f884cbad8747" providerId="ADAL" clId="{19BC932A-0D65-4FC5-AAED-2AD352209D35}" dt="2020-10-30T02:14:13.535" v="1296" actId="1038"/>
          <ac:grpSpMkLst>
            <pc:docMk/>
            <pc:sldMk cId="803600176" sldId="260"/>
            <ac:grpSpMk id="218" creationId="{C87F7BAC-987E-4693-A7F0-229003FD8219}"/>
          </ac:grpSpMkLst>
        </pc:grpChg>
        <pc:grpChg chg="mod">
          <ac:chgData name="Esther Walker" userId="f1e11e33-ab63-4053-bc81-f884cbad8747" providerId="ADAL" clId="{19BC932A-0D65-4FC5-AAED-2AD352209D35}" dt="2020-10-30T02:14:13.535" v="1296" actId="1038"/>
          <ac:grpSpMkLst>
            <pc:docMk/>
            <pc:sldMk cId="803600176" sldId="260"/>
            <ac:grpSpMk id="221" creationId="{8C522E8B-3F60-4690-8D64-2EC654D377B4}"/>
          </ac:grpSpMkLst>
        </pc:grpChg>
        <pc:grpChg chg="mod">
          <ac:chgData name="Esther Walker" userId="f1e11e33-ab63-4053-bc81-f884cbad8747" providerId="ADAL" clId="{19BC932A-0D65-4FC5-AAED-2AD352209D35}" dt="2020-10-30T02:13:54.302" v="1275" actId="1037"/>
          <ac:grpSpMkLst>
            <pc:docMk/>
            <pc:sldMk cId="803600176" sldId="260"/>
            <ac:grpSpMk id="227" creationId="{F0E5C4E1-B2E8-4BF3-AD88-91DB83C5A537}"/>
          </ac:grpSpMkLst>
        </pc:grpChg>
        <pc:grpChg chg="mod">
          <ac:chgData name="Esther Walker" userId="f1e11e33-ab63-4053-bc81-f884cbad8747" providerId="ADAL" clId="{19BC932A-0D65-4FC5-AAED-2AD352209D35}" dt="2020-10-30T02:15:06.183" v="1402" actId="1037"/>
          <ac:grpSpMkLst>
            <pc:docMk/>
            <pc:sldMk cId="803600176" sldId="260"/>
            <ac:grpSpMk id="235" creationId="{86DFE07A-F7A0-4B52-9B7D-B4A048D244E3}"/>
          </ac:grpSpMkLst>
        </pc:grpChg>
        <pc:grpChg chg="mod">
          <ac:chgData name="Esther Walker" userId="f1e11e33-ab63-4053-bc81-f884cbad8747" providerId="ADAL" clId="{19BC932A-0D65-4FC5-AAED-2AD352209D35}" dt="2020-10-30T02:13:59.401" v="1287" actId="1038"/>
          <ac:grpSpMkLst>
            <pc:docMk/>
            <pc:sldMk cId="803600176" sldId="260"/>
            <ac:grpSpMk id="241" creationId="{12F97629-767E-49AF-9A89-93CEE3FE20F8}"/>
          </ac:grpSpMkLst>
        </pc:grpChg>
        <pc:grpChg chg="mod">
          <ac:chgData name="Esther Walker" userId="f1e11e33-ab63-4053-bc81-f884cbad8747" providerId="ADAL" clId="{19BC932A-0D65-4FC5-AAED-2AD352209D35}" dt="2020-10-30T02:15:06.183" v="1402" actId="1037"/>
          <ac:grpSpMkLst>
            <pc:docMk/>
            <pc:sldMk cId="803600176" sldId="260"/>
            <ac:grpSpMk id="256" creationId="{9926D4FB-805E-48D3-BD29-3D63E19B4A27}"/>
          </ac:grpSpMkLst>
        </pc:grpChg>
        <pc:cxnChg chg="mod">
          <ac:chgData name="Esther Walker" userId="f1e11e33-ab63-4053-bc81-f884cbad8747" providerId="ADAL" clId="{19BC932A-0D65-4FC5-AAED-2AD352209D35}" dt="2020-10-30T02:05:01.600" v="625" actId="1038"/>
          <ac:cxnSpMkLst>
            <pc:docMk/>
            <pc:sldMk cId="803600176" sldId="260"/>
            <ac:cxnSpMk id="152" creationId="{27507037-0C97-4671-9541-D4CDBFC79FDB}"/>
          </ac:cxnSpMkLst>
        </pc:cxnChg>
        <pc:cxnChg chg="mod">
          <ac:chgData name="Esther Walker" userId="f1e11e33-ab63-4053-bc81-f884cbad8747" providerId="ADAL" clId="{19BC932A-0D65-4FC5-AAED-2AD352209D35}" dt="2020-10-30T02:05:11.956" v="627" actId="1038"/>
          <ac:cxnSpMkLst>
            <pc:docMk/>
            <pc:sldMk cId="803600176" sldId="260"/>
            <ac:cxnSpMk id="153" creationId="{6896A6BF-1323-4E3E-B27E-250DC41F28F5}"/>
          </ac:cxnSpMkLst>
        </pc:cxnChg>
        <pc:cxnChg chg="mod">
          <ac:chgData name="Esther Walker" userId="f1e11e33-ab63-4053-bc81-f884cbad8747" providerId="ADAL" clId="{19BC932A-0D65-4FC5-AAED-2AD352209D35}" dt="2020-10-30T02:05:01.600" v="625" actId="1038"/>
          <ac:cxnSpMkLst>
            <pc:docMk/>
            <pc:sldMk cId="803600176" sldId="260"/>
            <ac:cxnSpMk id="157" creationId="{9E27DBB6-6E43-48DE-9190-A02FC37896BA}"/>
          </ac:cxnSpMkLst>
        </pc:cxnChg>
        <pc:cxnChg chg="mod">
          <ac:chgData name="Esther Walker" userId="f1e11e33-ab63-4053-bc81-f884cbad8747" providerId="ADAL" clId="{19BC932A-0D65-4FC5-AAED-2AD352209D35}" dt="2020-10-30T02:05:08.857" v="626" actId="1038"/>
          <ac:cxnSpMkLst>
            <pc:docMk/>
            <pc:sldMk cId="803600176" sldId="260"/>
            <ac:cxnSpMk id="158" creationId="{055CB6E7-DFC8-4742-9B51-D94549C7032E}"/>
          </ac:cxnSpMkLst>
        </pc:cxnChg>
        <pc:cxnChg chg="mod">
          <ac:chgData name="Esther Walker" userId="f1e11e33-ab63-4053-bc81-f884cbad8747" providerId="ADAL" clId="{19BC932A-0D65-4FC5-AAED-2AD352209D35}" dt="2020-10-30T02:05:01.600" v="625" actId="1038"/>
          <ac:cxnSpMkLst>
            <pc:docMk/>
            <pc:sldMk cId="803600176" sldId="260"/>
            <ac:cxnSpMk id="167" creationId="{F8DBCE98-FF3A-4C04-B97E-D64B5C646A24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175" creationId="{D29CE0EF-51B2-46C6-A45F-27B54128704E}"/>
          </ac:cxnSpMkLst>
        </pc:cxnChg>
        <pc:cxnChg chg="add mod">
          <ac:chgData name="Esther Walker" userId="f1e11e33-ab63-4053-bc81-f884cbad8747" providerId="ADAL" clId="{19BC932A-0D65-4FC5-AAED-2AD352209D35}" dt="2020-10-30T02:05:01.600" v="625" actId="1038"/>
          <ac:cxnSpMkLst>
            <pc:docMk/>
            <pc:sldMk cId="803600176" sldId="260"/>
            <ac:cxnSpMk id="204" creationId="{81D7B0A8-68F7-4D15-ADF8-5877DD2A2552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231" creationId="{C1207E42-82B3-44CD-9925-BA80CB30011A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236" creationId="{834BEAC1-B896-4549-BD82-C5CB557FFFA6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238" creationId="{544D178D-711C-4837-B267-9CAFCB7001A3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243" creationId="{2CFF3026-5464-41E0-A558-56275A0051C2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245" creationId="{464CAA5D-A224-47C8-BB67-17F6927E38AF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247" creationId="{234D789D-CBFA-47C2-A0CE-76F9F55ADDA0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251" creationId="{221CA852-721A-446A-A54B-FE370BE13A6F}"/>
          </ac:cxnSpMkLst>
        </pc:cxnChg>
        <pc:cxnChg chg="mod">
          <ac:chgData name="Esther Walker" userId="f1e11e33-ab63-4053-bc81-f884cbad8747" providerId="ADAL" clId="{19BC932A-0D65-4FC5-AAED-2AD352209D35}" dt="2020-10-30T02:04:00.065" v="606" actId="1037"/>
          <ac:cxnSpMkLst>
            <pc:docMk/>
            <pc:sldMk cId="803600176" sldId="260"/>
            <ac:cxnSpMk id="252" creationId="{8EE9B327-F4E6-4A0F-84CC-6C5AE92B60E7}"/>
          </ac:cxnSpMkLst>
        </pc:cxnChg>
        <pc:cxnChg chg="mod">
          <ac:chgData name="Esther Walker" userId="f1e11e33-ab63-4053-bc81-f884cbad8747" providerId="ADAL" clId="{19BC932A-0D65-4FC5-AAED-2AD352209D35}" dt="2020-10-30T02:05:01.600" v="625" actId="1038"/>
          <ac:cxnSpMkLst>
            <pc:docMk/>
            <pc:sldMk cId="803600176" sldId="260"/>
            <ac:cxnSpMk id="266" creationId="{DCF99884-8E59-4998-9845-0F673A23E7B5}"/>
          </ac:cxnSpMkLst>
        </pc:cxnChg>
        <pc:cxnChg chg="mod">
          <ac:chgData name="Esther Walker" userId="f1e11e33-ab63-4053-bc81-f884cbad8747" providerId="ADAL" clId="{19BC932A-0D65-4FC5-AAED-2AD352209D35}" dt="2020-10-30T02:05:01.600" v="625" actId="1038"/>
          <ac:cxnSpMkLst>
            <pc:docMk/>
            <pc:sldMk cId="803600176" sldId="260"/>
            <ac:cxnSpMk id="268" creationId="{B90395FF-EE9F-4BED-BB41-88190AC156D2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270" creationId="{9897E914-DD89-4A61-9186-9E13BC89C595}"/>
          </ac:cxnSpMkLst>
        </pc:cxnChg>
        <pc:cxnChg chg="mod">
          <ac:chgData name="Esther Walker" userId="f1e11e33-ab63-4053-bc81-f884cbad8747" providerId="ADAL" clId="{19BC932A-0D65-4FC5-AAED-2AD352209D35}" dt="2020-10-30T02:05:01.600" v="625" actId="1038"/>
          <ac:cxnSpMkLst>
            <pc:docMk/>
            <pc:sldMk cId="803600176" sldId="260"/>
            <ac:cxnSpMk id="272" creationId="{BB38A1FB-2220-4BB0-9E33-C4A2A3FE31BD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278" creationId="{D4AD7242-8621-4942-A6AD-7073A581253E}"/>
          </ac:cxnSpMkLst>
        </pc:cxnChg>
        <pc:cxnChg chg="mod">
          <ac:chgData name="Esther Walker" userId="f1e11e33-ab63-4053-bc81-f884cbad8747" providerId="ADAL" clId="{19BC932A-0D65-4FC5-AAED-2AD352209D35}" dt="2020-10-30T02:05:01.600" v="625" actId="1038"/>
          <ac:cxnSpMkLst>
            <pc:docMk/>
            <pc:sldMk cId="803600176" sldId="260"/>
            <ac:cxnSpMk id="286" creationId="{3FABCBB3-335C-4E0C-8BC9-4C28F1D90495}"/>
          </ac:cxnSpMkLst>
        </pc:cxnChg>
        <pc:cxnChg chg="mod">
          <ac:chgData name="Esther Walker" userId="f1e11e33-ab63-4053-bc81-f884cbad8747" providerId="ADAL" clId="{19BC932A-0D65-4FC5-AAED-2AD352209D35}" dt="2020-10-30T02:05:01.600" v="625" actId="1038"/>
          <ac:cxnSpMkLst>
            <pc:docMk/>
            <pc:sldMk cId="803600176" sldId="260"/>
            <ac:cxnSpMk id="288" creationId="{B43837D2-8D32-44BB-8453-64721B0DD1CB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290" creationId="{B769663A-EE40-4780-8BD9-03FE7BA7D6EC}"/>
          </ac:cxnSpMkLst>
        </pc:cxnChg>
        <pc:cxnChg chg="mod">
          <ac:chgData name="Esther Walker" userId="f1e11e33-ab63-4053-bc81-f884cbad8747" providerId="ADAL" clId="{19BC932A-0D65-4FC5-AAED-2AD352209D35}" dt="2020-10-30T02:04:15.388" v="614" actId="1035"/>
          <ac:cxnSpMkLst>
            <pc:docMk/>
            <pc:sldMk cId="803600176" sldId="260"/>
            <ac:cxnSpMk id="291" creationId="{CC1DC92E-DE7C-48F5-AC70-90BE77E97B1C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293" creationId="{BFCB59C1-ABB4-4708-BD5C-C9E0169EF657}"/>
          </ac:cxnSpMkLst>
        </pc:cxnChg>
        <pc:cxnChg chg="mod">
          <ac:chgData name="Esther Walker" userId="f1e11e33-ab63-4053-bc81-f884cbad8747" providerId="ADAL" clId="{19BC932A-0D65-4FC5-AAED-2AD352209D35}" dt="2020-10-30T02:05:01.600" v="625" actId="1038"/>
          <ac:cxnSpMkLst>
            <pc:docMk/>
            <pc:sldMk cId="803600176" sldId="260"/>
            <ac:cxnSpMk id="295" creationId="{575B20C0-11F7-4D1B-BF0C-5C0A460A3E14}"/>
          </ac:cxnSpMkLst>
        </pc:cxnChg>
        <pc:cxnChg chg="mod">
          <ac:chgData name="Esther Walker" userId="f1e11e33-ab63-4053-bc81-f884cbad8747" providerId="ADAL" clId="{19BC932A-0D65-4FC5-AAED-2AD352209D35}" dt="2020-10-30T02:03:53.769" v="602" actId="1035"/>
          <ac:cxnSpMkLst>
            <pc:docMk/>
            <pc:sldMk cId="803600176" sldId="260"/>
            <ac:cxnSpMk id="296" creationId="{6CC42B9F-AFC0-4623-B299-96990FB02A9D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299" creationId="{AF291778-4D4B-4CC6-BA32-5123EE2EDC04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301" creationId="{90E02712-2EBE-4E02-B69C-CDC8A9EB56AF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307" creationId="{DAA8CEBF-E258-4678-833E-BCF15A50B461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309" creationId="{3F0ABCAF-0D94-46BC-A9CB-117C4D9ECD5F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311" creationId="{72C96852-EC38-4758-909D-3FDCAB0BAEFC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313" creationId="{A189B527-A0DB-4530-8CD0-C983AB313100}"/>
          </ac:cxnSpMkLst>
        </pc:cxnChg>
        <pc:cxnChg chg="mod">
          <ac:chgData name="Esther Walker" userId="f1e11e33-ab63-4053-bc81-f884cbad8747" providerId="ADAL" clId="{19BC932A-0D65-4FC5-AAED-2AD352209D35}" dt="2020-10-30T02:03:40.063" v="596" actId="1038"/>
          <ac:cxnSpMkLst>
            <pc:docMk/>
            <pc:sldMk cId="803600176" sldId="260"/>
            <ac:cxnSpMk id="315" creationId="{26EA24F5-4A0D-48D1-BEF5-45877E1A2645}"/>
          </ac:cxnSpMkLst>
        </pc:cxnChg>
        <pc:cxnChg chg="mod">
          <ac:chgData name="Esther Walker" userId="f1e11e33-ab63-4053-bc81-f884cbad8747" providerId="ADAL" clId="{19BC932A-0D65-4FC5-AAED-2AD352209D35}" dt="2020-10-30T02:04:10.929" v="611" actId="1035"/>
          <ac:cxnSpMkLst>
            <pc:docMk/>
            <pc:sldMk cId="803600176" sldId="260"/>
            <ac:cxnSpMk id="316" creationId="{500CEB80-E746-411F-A3BA-A3D4549898E6}"/>
          </ac:cxnSpMkLst>
        </pc:cxnChg>
        <pc:cxnChg chg="mod">
          <ac:chgData name="Esther Walker" userId="f1e11e33-ab63-4053-bc81-f884cbad8747" providerId="ADAL" clId="{19BC932A-0D65-4FC5-AAED-2AD352209D35}" dt="2020-10-30T02:03:47.333" v="599" actId="1035"/>
          <ac:cxnSpMkLst>
            <pc:docMk/>
            <pc:sldMk cId="803600176" sldId="260"/>
            <ac:cxnSpMk id="318" creationId="{27EEBF1F-BED7-4FC1-AF81-6AB37D491395}"/>
          </ac:cxnSpMkLst>
        </pc:cxnChg>
      </pc:sldChg>
      <pc:sldChg chg="addSp modSp">
        <pc:chgData name="Esther Walker" userId="f1e11e33-ab63-4053-bc81-f884cbad8747" providerId="ADAL" clId="{19BC932A-0D65-4FC5-AAED-2AD352209D35}" dt="2020-11-24T02:37:27.168" v="2259" actId="1036"/>
        <pc:sldMkLst>
          <pc:docMk/>
          <pc:sldMk cId="837198665" sldId="261"/>
        </pc:sldMkLst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21" creationId="{DDE8A63D-DC18-493D-B119-543A6B977863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50" creationId="{96D4DF8F-0CA8-47B6-BC57-1171DC47B06F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52" creationId="{18889C8C-15B7-4E8B-94E1-CE404876C58A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57" creationId="{66772BD4-0C60-4CAC-86B6-D94B8F454271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59" creationId="{137DF6D3-49D2-4F99-83C3-557FB99FC91C}"/>
          </ac:spMkLst>
        </pc:spChg>
        <pc:spChg chg="mod">
          <ac:chgData name="Esther Walker" userId="f1e11e33-ab63-4053-bc81-f884cbad8747" providerId="ADAL" clId="{19BC932A-0D65-4FC5-AAED-2AD352209D35}" dt="2020-10-30T02:12:36.038" v="1087" actId="1035"/>
          <ac:spMkLst>
            <pc:docMk/>
            <pc:sldMk cId="837198665" sldId="261"/>
            <ac:spMk id="70" creationId="{914E1C63-2210-41C1-9BF4-CA228CC0A117}"/>
          </ac:spMkLst>
        </pc:spChg>
        <pc:spChg chg="mod">
          <ac:chgData name="Esther Walker" userId="f1e11e33-ab63-4053-bc81-f884cbad8747" providerId="ADAL" clId="{19BC932A-0D65-4FC5-AAED-2AD352209D35}" dt="2020-10-30T02:12:40.211" v="1088" actId="1035"/>
          <ac:spMkLst>
            <pc:docMk/>
            <pc:sldMk cId="837198665" sldId="261"/>
            <ac:spMk id="73" creationId="{AD215767-45B7-42A2-B9ED-FADD11A2E45C}"/>
          </ac:spMkLst>
        </pc:spChg>
        <pc:spChg chg="mod">
          <ac:chgData name="Esther Walker" userId="f1e11e33-ab63-4053-bc81-f884cbad8747" providerId="ADAL" clId="{19BC932A-0D65-4FC5-AAED-2AD352209D35}" dt="2020-10-30T02:10:09.593" v="798" actId="1035"/>
          <ac:spMkLst>
            <pc:docMk/>
            <pc:sldMk cId="837198665" sldId="261"/>
            <ac:spMk id="76" creationId="{0AB91972-FE8C-4F4A-BB55-6E4DE1C69723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79" creationId="{2A963888-B67A-4CA3-A1EE-110B7F83757C}"/>
          </ac:spMkLst>
        </pc:spChg>
        <pc:spChg chg="mod">
          <ac:chgData name="Esther Walker" userId="f1e11e33-ab63-4053-bc81-f884cbad8747" providerId="ADAL" clId="{19BC932A-0D65-4FC5-AAED-2AD352209D35}" dt="2020-10-30T02:10:16.181" v="818" actId="1035"/>
          <ac:spMkLst>
            <pc:docMk/>
            <pc:sldMk cId="837198665" sldId="261"/>
            <ac:spMk id="81" creationId="{AD895DAF-39B8-4F06-A34D-A22697C86710}"/>
          </ac:spMkLst>
        </pc:spChg>
        <pc:spChg chg="mod">
          <ac:chgData name="Esther Walker" userId="f1e11e33-ab63-4053-bc81-f884cbad8747" providerId="ADAL" clId="{19BC932A-0D65-4FC5-AAED-2AD352209D35}" dt="2020-10-30T02:11:34.759" v="933" actId="1035"/>
          <ac:spMkLst>
            <pc:docMk/>
            <pc:sldMk cId="837198665" sldId="261"/>
            <ac:spMk id="93" creationId="{8FD1B5B0-B901-44FB-8CC8-15CC092C0882}"/>
          </ac:spMkLst>
        </pc:spChg>
        <pc:spChg chg="mod">
          <ac:chgData name="Esther Walker" userId="f1e11e33-ab63-4053-bc81-f884cbad8747" providerId="ADAL" clId="{19BC932A-0D65-4FC5-AAED-2AD352209D35}" dt="2020-10-30T02:09:58.426" v="770" actId="1035"/>
          <ac:spMkLst>
            <pc:docMk/>
            <pc:sldMk cId="837198665" sldId="261"/>
            <ac:spMk id="108" creationId="{5E1BB1AD-13E7-4E2A-A69E-D594AA41E446}"/>
          </ac:spMkLst>
        </pc:spChg>
        <pc:spChg chg="mod">
          <ac:chgData name="Esther Walker" userId="f1e11e33-ab63-4053-bc81-f884cbad8747" providerId="ADAL" clId="{19BC932A-0D65-4FC5-AAED-2AD352209D35}" dt="2020-10-30T02:11:52.566" v="957" actId="1035"/>
          <ac:spMkLst>
            <pc:docMk/>
            <pc:sldMk cId="837198665" sldId="261"/>
            <ac:spMk id="114" creationId="{5807014F-8CC4-40C3-A05B-5E9C24E1954F}"/>
          </ac:spMkLst>
        </pc:spChg>
        <pc:spChg chg="mod">
          <ac:chgData name="Esther Walker" userId="f1e11e33-ab63-4053-bc81-f884cbad8747" providerId="ADAL" clId="{19BC932A-0D65-4FC5-AAED-2AD352209D35}" dt="2020-10-30T02:32:36.623" v="1956"/>
          <ac:spMkLst>
            <pc:docMk/>
            <pc:sldMk cId="837198665" sldId="261"/>
            <ac:spMk id="159" creationId="{7831FD6F-5576-460C-9157-FC9973A1D317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161" creationId="{FE33F56B-2FC7-4E67-8213-4AFA71D877BB}"/>
          </ac:spMkLst>
        </pc:spChg>
        <pc:spChg chg="mod">
          <ac:chgData name="Esther Walker" userId="f1e11e33-ab63-4053-bc81-f884cbad8747" providerId="ADAL" clId="{19BC932A-0D65-4FC5-AAED-2AD352209D35}" dt="2020-10-30T02:10:03.833" v="784" actId="1035"/>
          <ac:spMkLst>
            <pc:docMk/>
            <pc:sldMk cId="837198665" sldId="261"/>
            <ac:spMk id="164" creationId="{D41EFC52-D7E4-418C-9BC2-B55121093F8F}"/>
          </ac:spMkLst>
        </pc:spChg>
        <pc:spChg chg="mod">
          <ac:chgData name="Esther Walker" userId="f1e11e33-ab63-4053-bc81-f884cbad8747" providerId="ADAL" clId="{19BC932A-0D65-4FC5-AAED-2AD352209D35}" dt="2020-10-30T02:10:22.012" v="838" actId="1035"/>
          <ac:spMkLst>
            <pc:docMk/>
            <pc:sldMk cId="837198665" sldId="261"/>
            <ac:spMk id="173" creationId="{10C428E3-5ADC-4AAF-9266-866958778C7F}"/>
          </ac:spMkLst>
        </pc:spChg>
        <pc:spChg chg="add mod or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181" creationId="{0C1F5840-CB16-4947-85A9-F6BA0AAB819B}"/>
          </ac:spMkLst>
        </pc:spChg>
        <pc:spChg chg="mod">
          <ac:chgData name="Esther Walker" userId="f1e11e33-ab63-4053-bc81-f884cbad8747" providerId="ADAL" clId="{19BC932A-0D65-4FC5-AAED-2AD352209D35}" dt="2020-10-30T02:12:45.666" v="1089" actId="1035"/>
          <ac:spMkLst>
            <pc:docMk/>
            <pc:sldMk cId="837198665" sldId="261"/>
            <ac:spMk id="185" creationId="{3C0A267E-80BF-44EB-9318-52DD1BA6C784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187" creationId="{A0E56160-D802-4AB0-B573-1EF6CFF47FE7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189" creationId="{3363EC53-72DB-40DA-80FC-779527B66B4D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191" creationId="{C244DA27-92CB-43E4-9709-D0B892C1C21A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193" creationId="{613F1618-3252-4E2A-BD7D-29FB3750AE3D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195" creationId="{F6D39B6F-0E89-4EE3-BC36-5FC78DDD4C6B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197" creationId="{F8E0D4F2-33B5-4C9D-88F7-B983B4FBB692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199" creationId="{DB84BF18-74E7-4B71-978C-CB2F3D5CA5E5}"/>
          </ac:spMkLst>
        </pc:spChg>
        <pc:spChg chg="mod">
          <ac:chgData name="Esther Walker" userId="f1e11e33-ab63-4053-bc81-f884cbad8747" providerId="ADAL" clId="{19BC932A-0D65-4FC5-AAED-2AD352209D35}" dt="2020-11-24T02:37:27.168" v="2259" actId="1036"/>
          <ac:spMkLst>
            <pc:docMk/>
            <pc:sldMk cId="837198665" sldId="261"/>
            <ac:spMk id="201" creationId="{52CD28CD-EA0C-46CD-BDD0-E3A4F29BF9ED}"/>
          </ac:spMkLst>
        </pc:spChg>
        <pc:spChg chg="add">
          <ac:chgData name="Esther Walker" userId="f1e11e33-ab63-4053-bc81-f884cbad8747" providerId="ADAL" clId="{19BC932A-0D65-4FC5-AAED-2AD352209D35}" dt="2020-11-24T02:36:03.609" v="2192"/>
          <ac:spMkLst>
            <pc:docMk/>
            <pc:sldMk cId="837198665" sldId="261"/>
            <ac:spMk id="203" creationId="{35582DE1-142D-4349-BCA0-5B670347BD7A}"/>
          </ac:spMkLst>
        </pc:s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2" creationId="{01777EF6-89DF-4330-94E9-4F676FB25B4E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5" creationId="{76FB793D-553F-4DEB-AF57-E12D4AFFA4FD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8" creationId="{CCDED3BF-2FD8-48D6-96A3-6F7DECB103D3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22" creationId="{0429D90B-DD0B-45CB-86BD-4FF38B885F1A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33" creationId="{565D8360-DAF7-434E-A2B7-E731BF2AC6B1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53" creationId="{7595C821-546D-40F7-80E8-75ECAFD6E607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60" creationId="{7F9B5B3F-42E6-423A-869D-AC817D067012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63" creationId="{42827AC2-94F3-4E7E-8EB8-431A6BD5FEBB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66" creationId="{BEBCB895-95C2-458D-8A3F-3923801E69CA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69" creationId="{C7DACBF2-7365-4FA8-B598-EA25CCCE286A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72" creationId="{4E6301D4-5ABC-447D-8F98-25CE9D61C573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75" creationId="{AA52855F-EC31-42AA-ADA7-02E54FEA8754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80" creationId="{E247CBC6-ABB7-47B7-B401-431E452088B9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83" creationId="{64F6C468-019B-40D6-8ADA-EC7BC754793A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86" creationId="{C81A86C6-C0A4-46C2-A75C-1E339E36BD35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89" creationId="{838E57FD-1FA3-40FB-9CC3-08F29EC51F3B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92" creationId="{4F515716-FEF7-436D-A964-7CDF28D4C269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95" creationId="{BFBC3DC2-CCF7-453F-A16E-931C8C923FA9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98" creationId="{ECC3DE9D-FAE0-4D13-AF47-83F252AB9ED2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01" creationId="{A011E310-1776-4DF7-905D-004853AF69A1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04" creationId="{D4F9A4C0-AE2A-44EF-A9F5-4D7DD21A2D4B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07" creationId="{248A3223-8DD5-40F6-A427-F1FAC97D3D18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10" creationId="{7B98FA0A-D0F7-49DC-9508-C6F26CC5744A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13" creationId="{7B32C552-4212-4847-BFC4-1BD1B78273FF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16" creationId="{7A86D010-D937-4120-AB2D-63A00A2C3C60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19" creationId="{38DA0E6B-B0B4-4CEE-A148-DC0693E687AE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22" creationId="{F057D517-E165-4444-B372-A6D22604BABD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25" creationId="{ABE1C8AF-509C-4D81-A9C4-6E3E5FCA45C0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28" creationId="{DDE64814-47EA-4FDF-A655-97986519BEB0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55" creationId="{5E9EB851-E23D-4305-8CDD-5A09DC74B935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60" creationId="{68A57E23-2AB7-424A-BBEB-9B177823A22E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66" creationId="{9BD35254-3A54-4469-AC28-448B1C216728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69" creationId="{0EA6071E-DE10-4F2D-A791-E615EE6E28FD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72" creationId="{F384789D-DE62-44CB-80B2-3CD0BB7837CD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75" creationId="{CAF3E426-A772-4A97-BBCA-6236B45AFC76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78" creationId="{C6659C31-4F6A-462A-B772-5E8F096E89F0}"/>
          </ac:grpSpMkLst>
        </pc:grpChg>
        <pc:grpChg chg="mod">
          <ac:chgData name="Esther Walker" userId="f1e11e33-ab63-4053-bc81-f884cbad8747" providerId="ADAL" clId="{19BC932A-0D65-4FC5-AAED-2AD352209D35}" dt="2020-11-24T02:37:27.168" v="2259" actId="1036"/>
          <ac:grpSpMkLst>
            <pc:docMk/>
            <pc:sldMk cId="837198665" sldId="261"/>
            <ac:grpSpMk id="184" creationId="{0A96CDDD-BE77-4674-8949-AC9EE42110D1}"/>
          </ac:grpSpMkLst>
        </pc:grp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49" creationId="{A39766A4-AA92-45A0-9887-9AB7183C91FF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51" creationId="{CFC10EBB-AE62-4D24-A75B-6AADA99987AF}"/>
          </ac:cxnSpMkLst>
        </pc:cxnChg>
        <pc:cxnChg chg="mod">
          <ac:chgData name="Esther Walker" userId="f1e11e33-ab63-4053-bc81-f884cbad8747" providerId="ADAL" clId="{19BC932A-0D65-4FC5-AAED-2AD352209D35}" dt="2020-10-30T02:06:00.096" v="634" actId="1035"/>
          <ac:cxnSpMkLst>
            <pc:docMk/>
            <pc:sldMk cId="837198665" sldId="261"/>
            <ac:cxnSpMk id="55" creationId="{F94B8CC3-8E07-4404-961A-A68F89030817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56" creationId="{51F83E4C-390B-499E-986C-27E66B6418FB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58" creationId="{6AB67100-8BBB-4501-BA35-79772734099B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78" creationId="{4B72F5E2-6690-45BB-B7CF-87ED368ABA04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162" creationId="{C5C5AEE5-60AE-4ED1-BB07-9C8F5A9B49CC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163" creationId="{0C80F604-18C8-45CC-A047-897B8FE5C1F4}"/>
          </ac:cxnSpMkLst>
        </pc:cxnChg>
        <pc:cxnChg chg="add 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182" creationId="{7604BEFE-8ACC-4CDB-93B6-4E72078CA98F}"/>
          </ac:cxnSpMkLst>
        </pc:cxnChg>
        <pc:cxnChg chg="add 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183" creationId="{990E7C3D-FDD1-4A12-BB59-4406A773D3A1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188" creationId="{0EDB6D9F-9A8D-4773-A38F-D1801250E5EB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190" creationId="{5CA3E3B3-6F5B-4BEB-95AE-5F81C2339AC4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192" creationId="{8C59A698-8DA4-4D5D-84A1-5D8C96A6A5CE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194" creationId="{7640DD32-B919-47E4-8ABD-73A08410EB47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196" creationId="{91905CCB-7195-4F8C-9B1E-EBA69D45DDEA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198" creationId="{CB9AF755-32BE-493E-A453-C45816A5C42D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200" creationId="{61F490E6-C6B5-40C4-89B6-770460F3A7D8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202" creationId="{A5167349-F8E3-416A-9BDE-116CBD50F38D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205" creationId="{9A07C46E-6125-4645-B837-7770FDC35A95}"/>
          </ac:cxnSpMkLst>
        </pc:cxnChg>
        <pc:cxnChg chg="mod">
          <ac:chgData name="Esther Walker" userId="f1e11e33-ab63-4053-bc81-f884cbad8747" providerId="ADAL" clId="{19BC932A-0D65-4FC5-AAED-2AD352209D35}" dt="2020-11-24T02:37:27.168" v="2259" actId="1036"/>
          <ac:cxnSpMkLst>
            <pc:docMk/>
            <pc:sldMk cId="837198665" sldId="261"/>
            <ac:cxnSpMk id="206" creationId="{BD7B51DD-4349-4D18-81C3-33B07D95B8CC}"/>
          </ac:cxnSpMkLst>
        </pc:cxnChg>
      </pc:sldChg>
      <pc:sldChg chg="addSp delSp modSp">
        <pc:chgData name="Esther Walker" userId="f1e11e33-ab63-4053-bc81-f884cbad8747" providerId="ADAL" clId="{19BC932A-0D65-4FC5-AAED-2AD352209D35}" dt="2020-11-24T02:36:39.238" v="2217" actId="1035"/>
        <pc:sldMkLst>
          <pc:docMk/>
          <pc:sldMk cId="1823779354" sldId="262"/>
        </pc:sldMkLst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33" creationId="{22B22B7B-6258-4E28-B003-3C90A313F58E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35" creationId="{17BA54C2-D3D4-4B75-8323-369D6F66ED54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37" creationId="{8C1DB723-55C7-43B1-9DC4-BD94DC99E3D3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39" creationId="{E0643725-FDD3-497C-9D6F-1997E16C2473}"/>
          </ac:spMkLst>
        </pc:spChg>
        <pc:spChg chg="mod">
          <ac:chgData name="Esther Walker" userId="f1e11e33-ab63-4053-bc81-f884cbad8747" providerId="ADAL" clId="{19BC932A-0D65-4FC5-AAED-2AD352209D35}" dt="2020-10-30T02:08:58.925" v="711" actId="1036"/>
          <ac:spMkLst>
            <pc:docMk/>
            <pc:sldMk cId="1823779354" sldId="262"/>
            <ac:spMk id="56" creationId="{9FEC3503-2750-4513-8755-BEFFA3CC43BE}"/>
          </ac:spMkLst>
        </pc:spChg>
        <pc:spChg chg="mod">
          <ac:chgData name="Esther Walker" userId="f1e11e33-ab63-4053-bc81-f884cbad8747" providerId="ADAL" clId="{19BC932A-0D65-4FC5-AAED-2AD352209D35}" dt="2020-10-30T01:06:44.137" v="188" actId="1038"/>
          <ac:spMkLst>
            <pc:docMk/>
            <pc:sldMk cId="1823779354" sldId="262"/>
            <ac:spMk id="59" creationId="{98FAFA1F-F210-4E8F-9A2F-FFF199801385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61" creationId="{78917C3B-615A-42A2-BBF5-2C7F43667618}"/>
          </ac:spMkLst>
        </pc:spChg>
        <pc:spChg chg="mod">
          <ac:chgData name="Esther Walker" userId="f1e11e33-ab63-4053-bc81-f884cbad8747" providerId="ADAL" clId="{19BC932A-0D65-4FC5-AAED-2AD352209D35}" dt="2020-11-24T02:36:39.238" v="2217" actId="1035"/>
          <ac:spMkLst>
            <pc:docMk/>
            <pc:sldMk cId="1823779354" sldId="262"/>
            <ac:spMk id="128" creationId="{5A1C6EC2-D7C6-4F74-A5BD-2298385E2D98}"/>
          </ac:spMkLst>
        </pc:spChg>
        <pc:spChg chg="mod">
          <ac:chgData name="Esther Walker" userId="f1e11e33-ab63-4053-bc81-f884cbad8747" providerId="ADAL" clId="{19BC932A-0D65-4FC5-AAED-2AD352209D35}" dt="2020-10-30T02:32:36.623" v="1956"/>
          <ac:spMkLst>
            <pc:docMk/>
            <pc:sldMk cId="1823779354" sldId="262"/>
            <ac:spMk id="131" creationId="{FEBC8242-40E1-44F2-9027-7B1A13B924B2}"/>
          </ac:spMkLst>
        </pc:spChg>
        <pc:spChg chg="mod">
          <ac:chgData name="Esther Walker" userId="f1e11e33-ab63-4053-bc81-f884cbad8747" providerId="ADAL" clId="{19BC932A-0D65-4FC5-AAED-2AD352209D35}" dt="2020-10-30T02:09:04.193" v="721" actId="1035"/>
          <ac:spMkLst>
            <pc:docMk/>
            <pc:sldMk cId="1823779354" sldId="262"/>
            <ac:spMk id="133" creationId="{54F53C63-2F34-4439-B6EF-0D7E095CC28E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50" creationId="{2C7101DC-6127-4225-879C-3F9D3D01DD48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51" creationId="{89529432-F62D-4CC8-8F54-3E35732FBF82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53" creationId="{79A96092-B177-4D69-9695-459BF889DCCF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55" creationId="{7A0F9B50-920E-4CA3-BEDC-D7322953F2EA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65" creationId="{76706B24-5590-4D83-AA57-91E4629CCD67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67" creationId="{B265F390-C8DD-4D5E-99A9-D48D9E3940CD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71" creationId="{7C8EA285-0B38-493F-A2A1-72BFC0BE9047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73" creationId="{3AD6C678-8237-48F9-964B-3D57C886F123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75" creationId="{7D32E132-58FF-4727-BC90-00E26B24E603}"/>
          </ac:spMkLst>
        </pc:spChg>
        <pc:spChg chg="add 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77" creationId="{5979674A-C5E3-40C2-A7D7-CCCF283BA60E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79" creationId="{944FBD8F-9A17-46AB-95F9-7A359EC10C1E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81" creationId="{76CC7302-8DA4-48AA-B50A-9F5FB6279FAD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83" creationId="{62517308-7351-405E-A530-D3A8E82A15E6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88" creationId="{5F05CEF8-E52A-491A-B30A-3E320C5D0FFE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90" creationId="{AB51BB36-F055-4F08-B3EE-F58856871B45}"/>
          </ac:spMkLst>
        </pc:spChg>
        <pc:spChg chg="add 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92" creationId="{F134E7E2-395C-44B6-A14D-015127CFE62F}"/>
          </ac:spMkLst>
        </pc:spChg>
        <pc:spChg chg="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94" creationId="{E134DC15-69BA-4C88-AEAE-CF755D6D22AB}"/>
          </ac:spMkLst>
        </pc:spChg>
        <pc:spChg chg="add">
          <ac:chgData name="Esther Walker" userId="f1e11e33-ab63-4053-bc81-f884cbad8747" providerId="ADAL" clId="{19BC932A-0D65-4FC5-AAED-2AD352209D35}" dt="2020-11-24T02:36:04.929" v="2193"/>
          <ac:spMkLst>
            <pc:docMk/>
            <pc:sldMk cId="1823779354" sldId="262"/>
            <ac:spMk id="196" creationId="{0C02E71F-0EEC-47E3-B351-EED087298CA3}"/>
          </ac:spMkLst>
        </pc:spChg>
        <pc:spChg chg="add del mod">
          <ac:chgData name="Esther Walker" userId="f1e11e33-ab63-4053-bc81-f884cbad8747" providerId="ADAL" clId="{19BC932A-0D65-4FC5-AAED-2AD352209D35}" dt="2020-10-30T01:17:44.237" v="511"/>
          <ac:spMkLst>
            <pc:docMk/>
            <pc:sldMk cId="1823779354" sldId="262"/>
            <ac:spMk id="196" creationId="{E86548D3-9588-4741-8C1C-951E9D0A1718}"/>
          </ac:spMkLst>
        </pc:spChg>
        <pc:spChg chg="add mod">
          <ac:chgData name="Esther Walker" userId="f1e11e33-ab63-4053-bc81-f884cbad8747" providerId="ADAL" clId="{19BC932A-0D65-4FC5-AAED-2AD352209D35}" dt="2020-11-24T02:36:34.319" v="2208" actId="1036"/>
          <ac:spMkLst>
            <pc:docMk/>
            <pc:sldMk cId="1823779354" sldId="262"/>
            <ac:spMk id="198" creationId="{E7A86F05-FE9A-4936-98B5-BF7B79D6C166}"/>
          </ac:spMkLst>
        </pc:s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2" creationId="{5E12AF3C-5727-4DAE-8017-15B56301C27A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23" creationId="{D2F73735-37BB-4750-B121-3DE3A47D73F1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40" creationId="{B9FB9F6A-562D-4632-ACA8-7B37821975EC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43" creationId="{0C5EE1D0-61C5-4815-AF6D-ABC1130C5257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46" creationId="{23688C97-22A0-4966-846F-501D25C53E2D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49" creationId="{754E5A7C-CCAE-4480-87C2-3628DEA17E10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52" creationId="{5332711F-6D53-44AB-9C7C-673A262D3B52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55" creationId="{2E11AB4F-5702-4749-A026-D1BF5AC70A7E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58" creationId="{AA4FFA7E-53E2-4217-B9E4-9A1AFE0A1386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64" creationId="{4441DDCB-C43A-41B2-8696-495B63E0CB89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67" creationId="{4284389E-E22A-402D-8883-D3D1AF26E090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70" creationId="{8EE2E270-D0EA-4F03-9FC2-8070B6887D87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73" creationId="{6B5D2002-5586-45DE-81F7-0D7ED376EB49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76" creationId="{3D4B74D6-F433-4475-BABA-3CD0D44B6942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79" creationId="{1331F6D5-CDA9-47A0-ACB8-34E3CC808093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82" creationId="{701F4592-1595-49A4-9A17-CE4F2AB9D12D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85" creationId="{265CE1FB-7E94-4495-ADB0-621EE58DB960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88" creationId="{DCDDD810-92E7-4824-8154-F0597BA4498B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91" creationId="{B3614E75-F7F0-47AF-B960-B3FD143E453A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94" creationId="{016A6C3A-3923-408C-B2A9-14866E347C37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97" creationId="{701A1B58-C5BF-42DC-8D3D-9AB6A6169EA8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00" creationId="{ABFAF9CA-F6CE-4B48-AAE9-E44A6DA9B0A8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03" creationId="{FDED9064-349C-4243-AD4F-20F3524D1240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06" creationId="{B8BAF566-66DB-4F20-9ED2-3356FE537F7C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09" creationId="{6205A1B7-D4E2-4651-9977-06D7831F76B4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21" creationId="{FF39718D-CED4-4E71-B79E-EEA853AD4926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24" creationId="{758A612C-0447-432C-9665-38DE58D4B6A7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27" creationId="{1C604557-C117-4F34-80CB-ADBB53DA64D7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32" creationId="{51BC617C-55DA-432D-B390-2AD35729615E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35" creationId="{8A8EF19E-E2B6-4987-AAD0-5BA26FC7B334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38" creationId="{01E0C2EF-531B-4762-80A3-C13B03BFE78A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41" creationId="{58278682-7B88-4968-9AEE-B74D8EA90440}"/>
          </ac:grpSpMkLst>
        </pc:grpChg>
        <pc:grpChg chg="mod">
          <ac:chgData name="Esther Walker" userId="f1e11e33-ab63-4053-bc81-f884cbad8747" providerId="ADAL" clId="{19BC932A-0D65-4FC5-AAED-2AD352209D35}" dt="2020-11-24T02:36:34.319" v="2208" actId="1036"/>
          <ac:grpSpMkLst>
            <pc:docMk/>
            <pc:sldMk cId="1823779354" sldId="262"/>
            <ac:grpSpMk id="144" creationId="{B378C9A1-D685-42D8-B368-BCCDDB141192}"/>
          </ac:grpSpMkLst>
        </pc:grp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32" creationId="{EC8FE92E-6D56-4B29-BA1B-ED2F9B3FDFCB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34" creationId="{18A6B861-A042-4CED-9E6D-3866BB8C595A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36" creationId="{DC4B6E04-8564-44E5-B95E-AFF77DD3F0F4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38" creationId="{CEF6FEF2-2C9E-4872-82D4-D6B11D0D64A3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62" creationId="{D567D478-6A65-4E10-B5BC-46AE85563E99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63" creationId="{E7CA681C-F0C4-4D59-946A-C6B8BAA12731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49" creationId="{2CFD1560-6508-4675-8859-96DB7DB9D622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52" creationId="{6090AEE8-E3C5-4B65-8642-791C0EE9E5FA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54" creationId="{3BC20345-5738-4A88-A4DF-2DB1B14E43EE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56" creationId="{6BF6FF85-5236-4F39-B353-D378E66B42D4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66" creationId="{2042E0E9-E0D9-44FF-A941-22D4C0F80DF8}"/>
          </ac:cxnSpMkLst>
        </pc:cxnChg>
        <pc:cxnChg chg="del">
          <ac:chgData name="Esther Walker" userId="f1e11e33-ab63-4053-bc81-f884cbad8747" providerId="ADAL" clId="{19BC932A-0D65-4FC5-AAED-2AD352209D35}" dt="2020-10-30T02:07:13.097" v="642" actId="478"/>
          <ac:cxnSpMkLst>
            <pc:docMk/>
            <pc:sldMk cId="1823779354" sldId="262"/>
            <ac:cxnSpMk id="169" creationId="{751E5D4B-0491-4F70-AFB3-ECF54D5002FB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70" creationId="{E4BB0447-F19A-43AB-B3B8-19D223207352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72" creationId="{5D2F0D9C-C666-4029-BB50-18C0FA85D5ED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74" creationId="{FAACA875-EC5F-417B-AF8C-51FBFE72DAB6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76" creationId="{5BAB4AAB-C2DB-4322-B1ED-F195B3FA0BA4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78" creationId="{29457D84-91B0-4920-93FE-57A62FBFADD9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80" creationId="{E96B1688-D86B-4494-B83D-4EDD3D61B079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82" creationId="{1C19C221-EDEE-4B13-A5E7-E6A195BEC271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84" creationId="{1BD8A201-95A4-4F73-B125-8418D3E48F90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85" creationId="{AB6D83D5-37A4-4309-B4A2-7C9FD17625F3}"/>
          </ac:cxnSpMkLst>
        </pc:cxnChg>
        <pc:cxnChg chg="add 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86" creationId="{9233DD9E-185D-45C4-9F29-DEACCF6F9854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87" creationId="{57A5C354-20C5-4F36-B7B2-19CF4FAF7E0D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89" creationId="{568893EC-2067-470E-B7EC-7CAF272175B8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91" creationId="{926B3662-1152-47FD-85B9-ACDC2D78D7FD}"/>
          </ac:cxnSpMkLst>
        </pc:cxnChg>
        <pc:cxnChg chg="add 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93" creationId="{4CB6580C-BD6C-4EC5-AD8D-B8A797B8E89D}"/>
          </ac:cxnSpMkLst>
        </pc:cxnChg>
        <pc:cxnChg chg="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95" creationId="{470093A5-146C-4EE8-9749-A2AC33E5DBEF}"/>
          </ac:cxnSpMkLst>
        </pc:cxnChg>
        <pc:cxnChg chg="add del mod">
          <ac:chgData name="Esther Walker" userId="f1e11e33-ab63-4053-bc81-f884cbad8747" providerId="ADAL" clId="{19BC932A-0D65-4FC5-AAED-2AD352209D35}" dt="2020-10-30T01:17:44.237" v="511"/>
          <ac:cxnSpMkLst>
            <pc:docMk/>
            <pc:sldMk cId="1823779354" sldId="262"/>
            <ac:cxnSpMk id="197" creationId="{7E4CBD57-6652-47D3-A411-7A79B1B4209A}"/>
          </ac:cxnSpMkLst>
        </pc:cxnChg>
        <pc:cxnChg chg="add mod">
          <ac:chgData name="Esther Walker" userId="f1e11e33-ab63-4053-bc81-f884cbad8747" providerId="ADAL" clId="{19BC932A-0D65-4FC5-AAED-2AD352209D35}" dt="2020-11-24T02:36:34.319" v="2208" actId="1036"/>
          <ac:cxnSpMkLst>
            <pc:docMk/>
            <pc:sldMk cId="1823779354" sldId="262"/>
            <ac:cxnSpMk id="199" creationId="{3A21CDA3-CE3C-4D45-B944-7BB4247C931D}"/>
          </ac:cxnSpMkLst>
        </pc:cxnChg>
      </pc:sldChg>
      <pc:sldChg chg="addSp modSp">
        <pc:chgData name="Esther Walker" userId="f1e11e33-ab63-4053-bc81-f884cbad8747" providerId="ADAL" clId="{19BC932A-0D65-4FC5-AAED-2AD352209D35}" dt="2020-11-24T02:36:48.468" v="2234" actId="1036"/>
        <pc:sldMkLst>
          <pc:docMk/>
          <pc:sldMk cId="2790817727" sldId="263"/>
        </pc:sldMkLst>
        <pc:spChg chg="mod">
          <ac:chgData name="Esther Walker" userId="f1e11e33-ab63-4053-bc81-f884cbad8747" providerId="ADAL" clId="{19BC932A-0D65-4FC5-AAED-2AD352209D35}" dt="2020-11-24T02:36:48.468" v="2234" actId="1036"/>
          <ac:spMkLst>
            <pc:docMk/>
            <pc:sldMk cId="2790817727" sldId="263"/>
            <ac:spMk id="23" creationId="{D3215A74-C4D6-4DFE-9C76-F31B46C57431}"/>
          </ac:spMkLst>
        </pc:spChg>
        <pc:spChg chg="mod">
          <ac:chgData name="Esther Walker" userId="f1e11e33-ab63-4053-bc81-f884cbad8747" providerId="ADAL" clId="{19BC932A-0D65-4FC5-AAED-2AD352209D35}" dt="2020-11-24T02:36:48.468" v="2234" actId="1036"/>
          <ac:spMkLst>
            <pc:docMk/>
            <pc:sldMk cId="2790817727" sldId="263"/>
            <ac:spMk id="25" creationId="{863F9AD1-8236-43B8-A7DB-2757AB51C90C}"/>
          </ac:spMkLst>
        </pc:spChg>
        <pc:spChg chg="mod">
          <ac:chgData name="Esther Walker" userId="f1e11e33-ab63-4053-bc81-f884cbad8747" providerId="ADAL" clId="{19BC932A-0D65-4FC5-AAED-2AD352209D35}" dt="2020-10-30T02:08:19.945" v="704" actId="1035"/>
          <ac:spMkLst>
            <pc:docMk/>
            <pc:sldMk cId="2790817727" sldId="263"/>
            <ac:spMk id="42" creationId="{3CC58765-EDA0-4F25-9D20-07FB2FAB2875}"/>
          </ac:spMkLst>
        </pc:spChg>
        <pc:spChg chg="mod">
          <ac:chgData name="Esther Walker" userId="f1e11e33-ab63-4053-bc81-f884cbad8747" providerId="ADAL" clId="{19BC932A-0D65-4FC5-AAED-2AD352209D35}" dt="2020-10-30T02:32:36.623" v="1956"/>
          <ac:spMkLst>
            <pc:docMk/>
            <pc:sldMk cId="2790817727" sldId="263"/>
            <ac:spMk id="48" creationId="{A2461DB7-6134-44A0-B113-0771FE0033B7}"/>
          </ac:spMkLst>
        </pc:spChg>
        <pc:spChg chg="mod">
          <ac:chgData name="Esther Walker" userId="f1e11e33-ab63-4053-bc81-f884cbad8747" providerId="ADAL" clId="{19BC932A-0D65-4FC5-AAED-2AD352209D35}" dt="2020-11-24T02:36:48.468" v="2234" actId="1036"/>
          <ac:spMkLst>
            <pc:docMk/>
            <pc:sldMk cId="2790817727" sldId="263"/>
            <ac:spMk id="49" creationId="{C797E0EF-BAFC-4FC1-A598-63D2654E07E0}"/>
          </ac:spMkLst>
        </pc:spChg>
        <pc:spChg chg="mod">
          <ac:chgData name="Esther Walker" userId="f1e11e33-ab63-4053-bc81-f884cbad8747" providerId="ADAL" clId="{19BC932A-0D65-4FC5-AAED-2AD352209D35}" dt="2020-11-24T02:36:48.468" v="2234" actId="1036"/>
          <ac:spMkLst>
            <pc:docMk/>
            <pc:sldMk cId="2790817727" sldId="263"/>
            <ac:spMk id="51" creationId="{73DE1E12-F374-43A4-B318-184E5FFE751C}"/>
          </ac:spMkLst>
        </pc:spChg>
        <pc:spChg chg="mod">
          <ac:chgData name="Esther Walker" userId="f1e11e33-ab63-4053-bc81-f884cbad8747" providerId="ADAL" clId="{19BC932A-0D65-4FC5-AAED-2AD352209D35}" dt="2020-11-24T02:36:48.468" v="2234" actId="1036"/>
          <ac:spMkLst>
            <pc:docMk/>
            <pc:sldMk cId="2790817727" sldId="263"/>
            <ac:spMk id="61" creationId="{A2C66A26-88DA-4C24-B545-E34A65F69EBE}"/>
          </ac:spMkLst>
        </pc:spChg>
        <pc:spChg chg="mod">
          <ac:chgData name="Esther Walker" userId="f1e11e33-ab63-4053-bc81-f884cbad8747" providerId="ADAL" clId="{19BC932A-0D65-4FC5-AAED-2AD352209D35}" dt="2020-11-24T02:36:48.468" v="2234" actId="1036"/>
          <ac:spMkLst>
            <pc:docMk/>
            <pc:sldMk cId="2790817727" sldId="263"/>
            <ac:spMk id="63" creationId="{27045252-5240-4967-9D56-FA7478661AB8}"/>
          </ac:spMkLst>
        </pc:spChg>
        <pc:spChg chg="mod">
          <ac:chgData name="Esther Walker" userId="f1e11e33-ab63-4053-bc81-f884cbad8747" providerId="ADAL" clId="{19BC932A-0D65-4FC5-AAED-2AD352209D35}" dt="2020-11-24T02:36:48.468" v="2234" actId="1036"/>
          <ac:spMkLst>
            <pc:docMk/>
            <pc:sldMk cId="2790817727" sldId="263"/>
            <ac:spMk id="65" creationId="{F750BC4E-8F21-426B-9C56-992982F08DE1}"/>
          </ac:spMkLst>
        </pc:spChg>
        <pc:spChg chg="mod">
          <ac:chgData name="Esther Walker" userId="f1e11e33-ab63-4053-bc81-f884cbad8747" providerId="ADAL" clId="{19BC932A-0D65-4FC5-AAED-2AD352209D35}" dt="2020-11-24T02:36:48.468" v="2234" actId="1036"/>
          <ac:spMkLst>
            <pc:docMk/>
            <pc:sldMk cId="2790817727" sldId="263"/>
            <ac:spMk id="67" creationId="{164E1670-292D-4295-B804-D4A065E594A4}"/>
          </ac:spMkLst>
        </pc:spChg>
        <pc:spChg chg="mod">
          <ac:chgData name="Esther Walker" userId="f1e11e33-ab63-4053-bc81-f884cbad8747" providerId="ADAL" clId="{19BC932A-0D65-4FC5-AAED-2AD352209D35}" dt="2020-11-24T02:36:48.468" v="2234" actId="1036"/>
          <ac:spMkLst>
            <pc:docMk/>
            <pc:sldMk cId="2790817727" sldId="263"/>
            <ac:spMk id="69" creationId="{D227E35B-E0D9-48BD-B45F-C5FE6BBD017D}"/>
          </ac:spMkLst>
        </pc:spChg>
        <pc:spChg chg="mod">
          <ac:chgData name="Esther Walker" userId="f1e11e33-ab63-4053-bc81-f884cbad8747" providerId="ADAL" clId="{19BC932A-0D65-4FC5-AAED-2AD352209D35}" dt="2020-11-24T02:36:48.468" v="2234" actId="1036"/>
          <ac:spMkLst>
            <pc:docMk/>
            <pc:sldMk cId="2790817727" sldId="263"/>
            <ac:spMk id="72" creationId="{36FA96AF-7BF6-4007-9C99-56BFB723EC3E}"/>
          </ac:spMkLst>
        </pc:spChg>
        <pc:spChg chg="add">
          <ac:chgData name="Esther Walker" userId="f1e11e33-ab63-4053-bc81-f884cbad8747" providerId="ADAL" clId="{19BC932A-0D65-4FC5-AAED-2AD352209D35}" dt="2020-11-24T02:36:06.840" v="2194"/>
          <ac:spMkLst>
            <pc:docMk/>
            <pc:sldMk cId="2790817727" sldId="263"/>
            <ac:spMk id="74" creationId="{7A158C3E-6764-498D-914D-0348EB31EDAE}"/>
          </ac:spMkLst>
        </pc:spChg>
        <pc:grpChg chg="mod">
          <ac:chgData name="Esther Walker" userId="f1e11e33-ab63-4053-bc81-f884cbad8747" providerId="ADAL" clId="{19BC932A-0D65-4FC5-AAED-2AD352209D35}" dt="2020-11-24T02:36:48.468" v="2234" actId="1036"/>
          <ac:grpSpMkLst>
            <pc:docMk/>
            <pc:sldMk cId="2790817727" sldId="263"/>
            <ac:grpSpMk id="12" creationId="{404EDBDE-056B-42BD-AFBA-EA1667544150}"/>
          </ac:grpSpMkLst>
        </pc:grpChg>
        <pc:grpChg chg="mod">
          <ac:chgData name="Esther Walker" userId="f1e11e33-ab63-4053-bc81-f884cbad8747" providerId="ADAL" clId="{19BC932A-0D65-4FC5-AAED-2AD352209D35}" dt="2020-11-24T02:36:48.468" v="2234" actId="1036"/>
          <ac:grpSpMkLst>
            <pc:docMk/>
            <pc:sldMk cId="2790817727" sldId="263"/>
            <ac:grpSpMk id="26" creationId="{F79AC5D2-F6A5-4D6A-89A4-ADA71877249F}"/>
          </ac:grpSpMkLst>
        </pc:grpChg>
        <pc:grpChg chg="mod">
          <ac:chgData name="Esther Walker" userId="f1e11e33-ab63-4053-bc81-f884cbad8747" providerId="ADAL" clId="{19BC932A-0D65-4FC5-AAED-2AD352209D35}" dt="2020-11-24T02:36:48.468" v="2234" actId="1036"/>
          <ac:grpSpMkLst>
            <pc:docMk/>
            <pc:sldMk cId="2790817727" sldId="263"/>
            <ac:grpSpMk id="29" creationId="{544050EE-8A5E-4158-B8E1-6D9E00B80ACC}"/>
          </ac:grpSpMkLst>
        </pc:grpChg>
        <pc:grpChg chg="mod">
          <ac:chgData name="Esther Walker" userId="f1e11e33-ab63-4053-bc81-f884cbad8747" providerId="ADAL" clId="{19BC932A-0D65-4FC5-AAED-2AD352209D35}" dt="2020-11-24T02:36:48.468" v="2234" actId="1036"/>
          <ac:grpSpMkLst>
            <pc:docMk/>
            <pc:sldMk cId="2790817727" sldId="263"/>
            <ac:grpSpMk id="32" creationId="{F8FC33F5-7340-464C-8FF1-6A66CB68959B}"/>
          </ac:grpSpMkLst>
        </pc:grpChg>
        <pc:grpChg chg="mod">
          <ac:chgData name="Esther Walker" userId="f1e11e33-ab63-4053-bc81-f884cbad8747" providerId="ADAL" clId="{19BC932A-0D65-4FC5-AAED-2AD352209D35}" dt="2020-11-24T02:36:48.468" v="2234" actId="1036"/>
          <ac:grpSpMkLst>
            <pc:docMk/>
            <pc:sldMk cId="2790817727" sldId="263"/>
            <ac:grpSpMk id="35" creationId="{2297C9A1-17BB-4BC1-B9EA-51F6AB11576E}"/>
          </ac:grpSpMkLst>
        </pc:grpChg>
        <pc:grpChg chg="mod">
          <ac:chgData name="Esther Walker" userId="f1e11e33-ab63-4053-bc81-f884cbad8747" providerId="ADAL" clId="{19BC932A-0D65-4FC5-AAED-2AD352209D35}" dt="2020-11-24T02:36:48.468" v="2234" actId="1036"/>
          <ac:grpSpMkLst>
            <pc:docMk/>
            <pc:sldMk cId="2790817727" sldId="263"/>
            <ac:grpSpMk id="38" creationId="{F9F2CB57-8C2E-4996-8017-915E3BD0387B}"/>
          </ac:grpSpMkLst>
        </pc:grpChg>
        <pc:grpChg chg="mod">
          <ac:chgData name="Esther Walker" userId="f1e11e33-ab63-4053-bc81-f884cbad8747" providerId="ADAL" clId="{19BC932A-0D65-4FC5-AAED-2AD352209D35}" dt="2020-11-24T02:36:48.468" v="2234" actId="1036"/>
          <ac:grpSpMkLst>
            <pc:docMk/>
            <pc:sldMk cId="2790817727" sldId="263"/>
            <ac:grpSpMk id="41" creationId="{6DBC1AB7-F4E2-4098-BB11-432E7230DEF8}"/>
          </ac:grpSpMkLst>
        </pc:grpChg>
        <pc:grpChg chg="mod">
          <ac:chgData name="Esther Walker" userId="f1e11e33-ab63-4053-bc81-f884cbad8747" providerId="ADAL" clId="{19BC932A-0D65-4FC5-AAED-2AD352209D35}" dt="2020-11-24T02:36:48.468" v="2234" actId="1036"/>
          <ac:grpSpMkLst>
            <pc:docMk/>
            <pc:sldMk cId="2790817727" sldId="263"/>
            <ac:grpSpMk id="44" creationId="{CC8B39D1-3095-4FC6-BB74-C43E326FAEF1}"/>
          </ac:grpSpMkLst>
        </pc:grpChg>
        <pc:cxnChg chg="mod">
          <ac:chgData name="Esther Walker" userId="f1e11e33-ab63-4053-bc81-f884cbad8747" providerId="ADAL" clId="{19BC932A-0D65-4FC5-AAED-2AD352209D35}" dt="2020-11-24T02:36:48.468" v="2234" actId="1036"/>
          <ac:cxnSpMkLst>
            <pc:docMk/>
            <pc:sldMk cId="2790817727" sldId="263"/>
            <ac:cxnSpMk id="22" creationId="{60D54C26-2BA0-47F9-8F8E-E830B0229FBF}"/>
          </ac:cxnSpMkLst>
        </pc:cxnChg>
        <pc:cxnChg chg="mod">
          <ac:chgData name="Esther Walker" userId="f1e11e33-ab63-4053-bc81-f884cbad8747" providerId="ADAL" clId="{19BC932A-0D65-4FC5-AAED-2AD352209D35}" dt="2020-11-24T02:36:48.468" v="2234" actId="1036"/>
          <ac:cxnSpMkLst>
            <pc:docMk/>
            <pc:sldMk cId="2790817727" sldId="263"/>
            <ac:cxnSpMk id="24" creationId="{45281794-3B48-4E53-B7DE-3EC1B25C18D4}"/>
          </ac:cxnSpMkLst>
        </pc:cxnChg>
        <pc:cxnChg chg="mod">
          <ac:chgData name="Esther Walker" userId="f1e11e33-ab63-4053-bc81-f884cbad8747" providerId="ADAL" clId="{19BC932A-0D65-4FC5-AAED-2AD352209D35}" dt="2020-11-24T02:36:48.468" v="2234" actId="1036"/>
          <ac:cxnSpMkLst>
            <pc:docMk/>
            <pc:sldMk cId="2790817727" sldId="263"/>
            <ac:cxnSpMk id="50" creationId="{381B9229-420B-487A-A073-9F5A951D224F}"/>
          </ac:cxnSpMkLst>
        </pc:cxnChg>
        <pc:cxnChg chg="mod">
          <ac:chgData name="Esther Walker" userId="f1e11e33-ab63-4053-bc81-f884cbad8747" providerId="ADAL" clId="{19BC932A-0D65-4FC5-AAED-2AD352209D35}" dt="2020-11-24T02:36:48.468" v="2234" actId="1036"/>
          <ac:cxnSpMkLst>
            <pc:docMk/>
            <pc:sldMk cId="2790817727" sldId="263"/>
            <ac:cxnSpMk id="52" creationId="{4381228C-11D4-4D5E-9724-6DBDB234D9FC}"/>
          </ac:cxnSpMkLst>
        </pc:cxnChg>
        <pc:cxnChg chg="mod">
          <ac:chgData name="Esther Walker" userId="f1e11e33-ab63-4053-bc81-f884cbad8747" providerId="ADAL" clId="{19BC932A-0D65-4FC5-AAED-2AD352209D35}" dt="2020-11-24T02:36:48.468" v="2234" actId="1036"/>
          <ac:cxnSpMkLst>
            <pc:docMk/>
            <pc:sldMk cId="2790817727" sldId="263"/>
            <ac:cxnSpMk id="62" creationId="{540E6190-8D41-4F9E-A644-437135E321D1}"/>
          </ac:cxnSpMkLst>
        </pc:cxnChg>
        <pc:cxnChg chg="mod">
          <ac:chgData name="Esther Walker" userId="f1e11e33-ab63-4053-bc81-f884cbad8747" providerId="ADAL" clId="{19BC932A-0D65-4FC5-AAED-2AD352209D35}" dt="2020-11-24T02:36:48.468" v="2234" actId="1036"/>
          <ac:cxnSpMkLst>
            <pc:docMk/>
            <pc:sldMk cId="2790817727" sldId="263"/>
            <ac:cxnSpMk id="64" creationId="{5108BA20-35B9-4983-93C1-B860ED3E00F1}"/>
          </ac:cxnSpMkLst>
        </pc:cxnChg>
        <pc:cxnChg chg="mod">
          <ac:chgData name="Esther Walker" userId="f1e11e33-ab63-4053-bc81-f884cbad8747" providerId="ADAL" clId="{19BC932A-0D65-4FC5-AAED-2AD352209D35}" dt="2020-11-24T02:36:48.468" v="2234" actId="1036"/>
          <ac:cxnSpMkLst>
            <pc:docMk/>
            <pc:sldMk cId="2790817727" sldId="263"/>
            <ac:cxnSpMk id="66" creationId="{FB6C06C8-65AD-4158-8670-23869DD8EDB8}"/>
          </ac:cxnSpMkLst>
        </pc:cxnChg>
        <pc:cxnChg chg="mod">
          <ac:chgData name="Esther Walker" userId="f1e11e33-ab63-4053-bc81-f884cbad8747" providerId="ADAL" clId="{19BC932A-0D65-4FC5-AAED-2AD352209D35}" dt="2020-11-24T02:36:48.468" v="2234" actId="1036"/>
          <ac:cxnSpMkLst>
            <pc:docMk/>
            <pc:sldMk cId="2790817727" sldId="263"/>
            <ac:cxnSpMk id="68" creationId="{15588A85-8775-4608-B32B-95035DB57F28}"/>
          </ac:cxnSpMkLst>
        </pc:cxnChg>
        <pc:cxnChg chg="mod">
          <ac:chgData name="Esther Walker" userId="f1e11e33-ab63-4053-bc81-f884cbad8747" providerId="ADAL" clId="{19BC932A-0D65-4FC5-AAED-2AD352209D35}" dt="2020-11-24T02:36:48.468" v="2234" actId="1036"/>
          <ac:cxnSpMkLst>
            <pc:docMk/>
            <pc:sldMk cId="2790817727" sldId="263"/>
            <ac:cxnSpMk id="70" creationId="{FC3DD819-EE98-4E89-8A95-BA17609AE57B}"/>
          </ac:cxnSpMkLst>
        </pc:cxnChg>
        <pc:cxnChg chg="mod">
          <ac:chgData name="Esther Walker" userId="f1e11e33-ab63-4053-bc81-f884cbad8747" providerId="ADAL" clId="{19BC932A-0D65-4FC5-AAED-2AD352209D35}" dt="2020-11-24T02:36:48.468" v="2234" actId="1036"/>
          <ac:cxnSpMkLst>
            <pc:docMk/>
            <pc:sldMk cId="2790817727" sldId="263"/>
            <ac:cxnSpMk id="71" creationId="{29A0FABE-CDBB-4901-8BCF-1D9D43382564}"/>
          </ac:cxnSpMkLst>
        </pc:cxnChg>
        <pc:cxnChg chg="mod">
          <ac:chgData name="Esther Walker" userId="f1e11e33-ab63-4053-bc81-f884cbad8747" providerId="ADAL" clId="{19BC932A-0D65-4FC5-AAED-2AD352209D35}" dt="2020-11-24T02:36:48.468" v="2234" actId="1036"/>
          <ac:cxnSpMkLst>
            <pc:docMk/>
            <pc:sldMk cId="2790817727" sldId="263"/>
            <ac:cxnSpMk id="73" creationId="{0206AF50-CFA7-492A-8772-40E08F0FC34C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F5B7FC-72A9-42B9-A26D-1C08A0B165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73C2D5-5276-45CB-8DA4-A080167929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6C7256-D7F3-4966-9EA5-1D98A814E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94E2A-2C6D-4924-A0E3-001020230874}" type="datetimeFigureOut">
              <a:rPr lang="en-AU" smtClean="0"/>
              <a:t>29/09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5B321A-69BE-4538-B519-9235A2FE03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B2C8A8-CFBB-4DD1-BC39-359644594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3CF7D-134D-429D-92CE-7FA402B0140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97737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E1391C-C46B-4135-B127-9CDC57EA60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100FC8-4050-4508-9991-1036341E44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09DE6A-C853-48AC-82AC-E5BAF39DF2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94E2A-2C6D-4924-A0E3-001020230874}" type="datetimeFigureOut">
              <a:rPr lang="en-AU" smtClean="0"/>
              <a:t>29/09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419807-B07E-424D-A2B2-47882937C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BD43EC-45DB-4810-90B4-0E083C07D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3CF7D-134D-429D-92CE-7FA402B0140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83566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123FE3-288B-4155-ABEC-F017BDD163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BBCAA8-F3FB-40CD-AF61-1358A68CC5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F0DBD6-FA2A-4B86-B278-23EF33209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94E2A-2C6D-4924-A0E3-001020230874}" type="datetimeFigureOut">
              <a:rPr lang="en-AU" smtClean="0"/>
              <a:t>29/09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850CA4-F442-45C7-B1EC-D7698501E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256746-A60C-4830-9969-9305D8764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3CF7D-134D-429D-92CE-7FA402B0140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01622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9272A-46ED-4241-B07F-FBEAB4CD6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DCC8FB-D4A0-4463-9B18-13A601351F5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2D00E-9BDD-4033-A420-B500E26E4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94E2A-2C6D-4924-A0E3-001020230874}" type="datetimeFigureOut">
              <a:rPr lang="en-AU" smtClean="0"/>
              <a:t>29/09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A5F181-8DBE-4C8B-AEF7-0AE5B1C9F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8B320F-B916-4840-97A2-33447E237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3CF7D-134D-429D-92CE-7FA402B0140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95701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1FB572-5051-4F60-A7AD-C814813D4A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1B48BD-959A-4A38-882D-5EBEA553B5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4FDAAE-F429-4C8A-8E03-162C1E3AB6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94E2A-2C6D-4924-A0E3-001020230874}" type="datetimeFigureOut">
              <a:rPr lang="en-AU" smtClean="0"/>
              <a:t>29/09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72B340-7228-44E0-9608-5077B9E21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2CF2B1-16BD-40B3-9EA2-2B9EC7867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3CF7D-134D-429D-92CE-7FA402B0140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29452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3C8BF8-AB9A-4C42-B8F4-12535901A9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7F7546-A050-41E0-A3D0-D2FE330541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80BF16-EA99-462B-ADCF-E4E24AF947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530FEC-9B2A-4BA1-AD1F-31A4C04A4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94E2A-2C6D-4924-A0E3-001020230874}" type="datetimeFigureOut">
              <a:rPr lang="en-AU" smtClean="0"/>
              <a:t>29/09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840316-FBC4-455C-9FEE-044E397E4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1817EE-F6A6-43A9-B726-2ACECAF6A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3CF7D-134D-429D-92CE-7FA402B0140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51837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68BD55-7574-4BF9-8B0C-DD45D749BE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A17030-1B36-4B9D-BC81-91814DB367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EF1295-EC2E-412D-ABBF-1F84E640DF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CAE99C1-A9BA-4998-9006-15B89BDCCE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BC6312-F69B-4B5D-88A0-7FBC6142A6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F956D7B-88A0-44CD-BCEC-056BB148F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94E2A-2C6D-4924-A0E3-001020230874}" type="datetimeFigureOut">
              <a:rPr lang="en-AU" smtClean="0"/>
              <a:t>29/09/2021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B7B5292-71DF-453E-A007-867796577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ECD08AE-7C85-43C5-9940-3A82BD0EB6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3CF7D-134D-429D-92CE-7FA402B0140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9388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CD9B77-9EAF-4DB2-9C10-26BAAA51E4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28A49A-A827-4F53-88BF-C530F86A5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94E2A-2C6D-4924-A0E3-001020230874}" type="datetimeFigureOut">
              <a:rPr lang="en-AU" smtClean="0"/>
              <a:t>29/09/2021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20B31F2-09EF-4C4A-8321-24FBA49159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17E3C9-97A4-45CD-B0AB-678A7313C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3CF7D-134D-429D-92CE-7FA402B0140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837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AA48840-E2E7-4E00-8AB1-4D7F74DAC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94E2A-2C6D-4924-A0E3-001020230874}" type="datetimeFigureOut">
              <a:rPr lang="en-AU" smtClean="0"/>
              <a:t>29/09/2021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E783D3B-5D78-49D7-8B1D-ABA9D7369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B82299-83FF-4B10-8120-12808364B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3CF7D-134D-429D-92CE-7FA402B0140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9354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D85416-1B1C-4320-A4C4-4E238EDAF7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C6F4B9-25FB-4F9F-AB7C-5020A766D5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798EC7-7D62-4811-B2FB-B5AD9E0DE1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D5F557-7067-4DE6-A09F-310725B216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94E2A-2C6D-4924-A0E3-001020230874}" type="datetimeFigureOut">
              <a:rPr lang="en-AU" smtClean="0"/>
              <a:t>29/09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17E53E-9210-4ADF-AFC0-0F3287F01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AD1A3C-4283-40ED-B4A1-159E2C995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3CF7D-134D-429D-92CE-7FA402B0140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96273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917B00-F25C-4F04-88F6-900D44D67D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1FDBF11-C199-41AB-8715-F559F2552F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EB13F7-4DA4-470C-954F-FF5F8D4242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A14425-4F6F-4B11-824E-2FC009153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94E2A-2C6D-4924-A0E3-001020230874}" type="datetimeFigureOut">
              <a:rPr lang="en-AU" smtClean="0"/>
              <a:t>29/09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D62673-F8E0-412C-8E6F-D21BEB727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44B8B8-E4D7-43F9-81F3-B5520D743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33CF7D-134D-429D-92CE-7FA402B0140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86862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51C7A50-E81B-492A-BB82-4476D0E5CA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FFB9C4-B994-4C91-80BB-083524BCB7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7094EA-944F-4E9F-9542-C8995321CA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594E2A-2C6D-4924-A0E3-001020230874}" type="datetimeFigureOut">
              <a:rPr lang="en-AU" smtClean="0"/>
              <a:t>29/09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B374F8-FD8E-4E98-985E-71F9BCA7E5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F6AA31-8B3E-4224-94C5-75EFF4521F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33CF7D-134D-429D-92CE-7FA402B0140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25061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extBox 136">
            <a:extLst>
              <a:ext uri="{FF2B5EF4-FFF2-40B4-BE49-F238E27FC236}">
                <a16:creationId xmlns:a16="http://schemas.microsoft.com/office/drawing/2014/main" id="{7A523E7C-8656-4A7E-BFFD-4C7224686AF9}"/>
              </a:ext>
            </a:extLst>
          </p:cNvPr>
          <p:cNvSpPr txBox="1"/>
          <p:nvPr/>
        </p:nvSpPr>
        <p:spPr>
          <a:xfrm>
            <a:off x="1341072" y="4641683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4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82F3802C-9C88-431C-94A8-F22C3BFF554F}"/>
              </a:ext>
            </a:extLst>
          </p:cNvPr>
          <p:cNvSpPr txBox="1"/>
          <p:nvPr/>
        </p:nvSpPr>
        <p:spPr>
          <a:xfrm>
            <a:off x="5696455" y="3853658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J306762</a:t>
            </a:r>
          </a:p>
        </p:txBody>
      </p:sp>
      <p:grpSp>
        <p:nvGrpSpPr>
          <p:cNvPr id="288" name="Group 287">
            <a:extLst>
              <a:ext uri="{FF2B5EF4-FFF2-40B4-BE49-F238E27FC236}">
                <a16:creationId xmlns:a16="http://schemas.microsoft.com/office/drawing/2014/main" id="{BD631ED1-3DC2-46EC-B47A-DE8ECBBC42BF}"/>
              </a:ext>
            </a:extLst>
          </p:cNvPr>
          <p:cNvGrpSpPr/>
          <p:nvPr/>
        </p:nvGrpSpPr>
        <p:grpSpPr>
          <a:xfrm>
            <a:off x="2083058" y="3424784"/>
            <a:ext cx="270410" cy="1003300"/>
            <a:chOff x="8031292" y="367439"/>
            <a:chExt cx="270410" cy="1003300"/>
          </a:xfrm>
        </p:grpSpPr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EA696686-159A-4F63-A20C-C4F5165470A7}"/>
                </a:ext>
              </a:extLst>
            </p:cNvPr>
            <p:cNvSpPr txBox="1"/>
            <p:nvPr/>
          </p:nvSpPr>
          <p:spPr>
            <a:xfrm rot="5400000">
              <a:off x="7669247" y="738284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T.csiro</a:t>
              </a:r>
            </a:p>
          </p:txBody>
        </p:sp>
        <p:sp>
          <p:nvSpPr>
            <p:cNvPr id="290" name="Rectangle 289">
              <a:extLst>
                <a:ext uri="{FF2B5EF4-FFF2-40B4-BE49-F238E27FC236}">
                  <a16:creationId xmlns:a16="http://schemas.microsoft.com/office/drawing/2014/main" id="{B272A472-8299-4393-B6A0-2D2410E8E9F6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34" name="Group 133">
            <a:extLst>
              <a:ext uri="{FF2B5EF4-FFF2-40B4-BE49-F238E27FC236}">
                <a16:creationId xmlns:a16="http://schemas.microsoft.com/office/drawing/2014/main" id="{CACDBAA6-C6CA-4BAA-9756-FECE2FE2EE2C}"/>
              </a:ext>
            </a:extLst>
          </p:cNvPr>
          <p:cNvGrpSpPr/>
          <p:nvPr/>
        </p:nvGrpSpPr>
        <p:grpSpPr>
          <a:xfrm>
            <a:off x="925065" y="272843"/>
            <a:ext cx="482959" cy="5336828"/>
            <a:chOff x="1760883" y="188953"/>
            <a:chExt cx="482959" cy="5336828"/>
          </a:xfrm>
        </p:grpSpPr>
        <p:grpSp>
          <p:nvGrpSpPr>
            <p:cNvPr id="116" name="Group 115">
              <a:extLst>
                <a:ext uri="{FF2B5EF4-FFF2-40B4-BE49-F238E27FC236}">
                  <a16:creationId xmlns:a16="http://schemas.microsoft.com/office/drawing/2014/main" id="{222D57F6-16DE-4C4A-A75F-A3D2621468C4}"/>
                </a:ext>
              </a:extLst>
            </p:cNvPr>
            <p:cNvGrpSpPr/>
            <p:nvPr/>
          </p:nvGrpSpPr>
          <p:grpSpPr>
            <a:xfrm>
              <a:off x="1912362" y="557781"/>
              <a:ext cx="180000" cy="4968000"/>
              <a:chOff x="1952230" y="557781"/>
              <a:chExt cx="504000" cy="4968000"/>
            </a:xfrm>
          </p:grpSpPr>
          <p:sp>
            <p:nvSpPr>
              <p:cNvPr id="26" name="Rectangle: Rounded Corners 25">
                <a:extLst>
                  <a:ext uri="{FF2B5EF4-FFF2-40B4-BE49-F238E27FC236}">
                    <a16:creationId xmlns:a16="http://schemas.microsoft.com/office/drawing/2014/main" id="{CF500456-77FF-48F7-B643-F176B1077C06}"/>
                  </a:ext>
                </a:extLst>
              </p:cNvPr>
              <p:cNvSpPr/>
              <p:nvPr/>
            </p:nvSpPr>
            <p:spPr>
              <a:xfrm>
                <a:off x="1952230" y="557781"/>
                <a:ext cx="327170" cy="4968000"/>
              </a:xfrm>
              <a:prstGeom prst="round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8A1F277C-4BE9-4602-9897-0D58E297F6C9}"/>
                  </a:ext>
                </a:extLst>
              </p:cNvPr>
              <p:cNvCxnSpPr/>
              <p:nvPr/>
            </p:nvCxnSpPr>
            <p:spPr>
              <a:xfrm>
                <a:off x="1952230" y="12668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8F9A0853-8760-4A22-99B8-D42CA03E6011}"/>
                  </a:ext>
                </a:extLst>
              </p:cNvPr>
              <p:cNvCxnSpPr/>
              <p:nvPr/>
            </p:nvCxnSpPr>
            <p:spPr>
              <a:xfrm>
                <a:off x="1952230" y="19907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CCD8E256-4E60-4D9E-B28A-B6536CC26D4E}"/>
                  </a:ext>
                </a:extLst>
              </p:cNvPr>
              <p:cNvCxnSpPr/>
              <p:nvPr/>
            </p:nvCxnSpPr>
            <p:spPr>
              <a:xfrm>
                <a:off x="1952230" y="27051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CB2B61DC-259E-4D91-A8C1-18068240594B}"/>
                  </a:ext>
                </a:extLst>
              </p:cNvPr>
              <p:cNvCxnSpPr/>
              <p:nvPr/>
            </p:nvCxnSpPr>
            <p:spPr>
              <a:xfrm>
                <a:off x="1952230" y="34290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6E25F2D0-ECCD-47B4-8B8F-95678CDBBF03}"/>
                  </a:ext>
                </a:extLst>
              </p:cNvPr>
              <p:cNvCxnSpPr/>
              <p:nvPr/>
            </p:nvCxnSpPr>
            <p:spPr>
              <a:xfrm>
                <a:off x="1952230" y="41529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6E34C72D-0DC7-4647-98B9-E6170AC2B897}"/>
                  </a:ext>
                </a:extLst>
              </p:cNvPr>
              <p:cNvCxnSpPr/>
              <p:nvPr/>
            </p:nvCxnSpPr>
            <p:spPr>
              <a:xfrm>
                <a:off x="1952230" y="486727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DE6221E9-3335-4B45-9BAC-302A473BF2E1}"/>
                </a:ext>
              </a:extLst>
            </p:cNvPr>
            <p:cNvSpPr txBox="1"/>
            <p:nvPr/>
          </p:nvSpPr>
          <p:spPr>
            <a:xfrm>
              <a:off x="1760883" y="188953"/>
              <a:ext cx="482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1B</a:t>
              </a:r>
            </a:p>
          </p:txBody>
        </p:sp>
      </p:grp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437D25D6-6350-494F-95BF-13062D121CD9}"/>
              </a:ext>
            </a:extLst>
          </p:cNvPr>
          <p:cNvGrpSpPr/>
          <p:nvPr/>
        </p:nvGrpSpPr>
        <p:grpSpPr>
          <a:xfrm>
            <a:off x="5247684" y="272843"/>
            <a:ext cx="482959" cy="3936428"/>
            <a:chOff x="2844685" y="188953"/>
            <a:chExt cx="482959" cy="3936428"/>
          </a:xfrm>
        </p:grpSpPr>
        <p:grpSp>
          <p:nvGrpSpPr>
            <p:cNvPr id="118" name="Group 117">
              <a:extLst>
                <a:ext uri="{FF2B5EF4-FFF2-40B4-BE49-F238E27FC236}">
                  <a16:creationId xmlns:a16="http://schemas.microsoft.com/office/drawing/2014/main" id="{C1086E46-2088-49B8-AA73-37A24312D5C7}"/>
                </a:ext>
              </a:extLst>
            </p:cNvPr>
            <p:cNvGrpSpPr/>
            <p:nvPr/>
          </p:nvGrpSpPr>
          <p:grpSpPr>
            <a:xfrm>
              <a:off x="2996164" y="557781"/>
              <a:ext cx="180000" cy="3567600"/>
              <a:chOff x="2806378" y="557781"/>
              <a:chExt cx="504000" cy="3567600"/>
            </a:xfrm>
          </p:grpSpPr>
          <p:sp>
            <p:nvSpPr>
              <p:cNvPr id="36" name="Rectangle: Rounded Corners 35">
                <a:extLst>
                  <a:ext uri="{FF2B5EF4-FFF2-40B4-BE49-F238E27FC236}">
                    <a16:creationId xmlns:a16="http://schemas.microsoft.com/office/drawing/2014/main" id="{66616C09-09D1-4B45-85EC-02B068C90E00}"/>
                  </a:ext>
                </a:extLst>
              </p:cNvPr>
              <p:cNvSpPr/>
              <p:nvPr/>
            </p:nvSpPr>
            <p:spPr>
              <a:xfrm>
                <a:off x="2806378" y="557781"/>
                <a:ext cx="327170" cy="3567600"/>
              </a:xfrm>
              <a:prstGeom prst="round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dirty="0"/>
              </a:p>
            </p:txBody>
          </p: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696ADCAD-297B-456C-A010-470287917C88}"/>
                  </a:ext>
                </a:extLst>
              </p:cNvPr>
              <p:cNvCxnSpPr/>
              <p:nvPr/>
            </p:nvCxnSpPr>
            <p:spPr>
              <a:xfrm>
                <a:off x="2806378" y="12668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378FCD6B-7BD3-42C8-AEBC-00C59BCA8C88}"/>
                  </a:ext>
                </a:extLst>
              </p:cNvPr>
              <p:cNvCxnSpPr/>
              <p:nvPr/>
            </p:nvCxnSpPr>
            <p:spPr>
              <a:xfrm>
                <a:off x="2806378" y="19907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023A318F-71AC-4BFB-8E46-643BB787F2FE}"/>
                  </a:ext>
                </a:extLst>
              </p:cNvPr>
              <p:cNvCxnSpPr/>
              <p:nvPr/>
            </p:nvCxnSpPr>
            <p:spPr>
              <a:xfrm>
                <a:off x="2806378" y="27051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6D5CB423-3F78-4594-A3B4-7D7B21638307}"/>
                  </a:ext>
                </a:extLst>
              </p:cNvPr>
              <p:cNvCxnSpPr/>
              <p:nvPr/>
            </p:nvCxnSpPr>
            <p:spPr>
              <a:xfrm>
                <a:off x="2806378" y="34290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DC82E60C-027B-4936-8617-5F2D0DEBC519}"/>
                </a:ext>
              </a:extLst>
            </p:cNvPr>
            <p:cNvSpPr txBox="1"/>
            <p:nvPr/>
          </p:nvSpPr>
          <p:spPr>
            <a:xfrm>
              <a:off x="2844685" y="188953"/>
              <a:ext cx="482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1D</a:t>
              </a:r>
            </a:p>
          </p:txBody>
        </p:sp>
      </p:grpSp>
      <p:cxnSp>
        <p:nvCxnSpPr>
          <p:cNvPr id="145" name="Straight Connector 144">
            <a:extLst>
              <a:ext uri="{FF2B5EF4-FFF2-40B4-BE49-F238E27FC236}">
                <a16:creationId xmlns:a16="http://schemas.microsoft.com/office/drawing/2014/main" id="{76E230C2-8F16-49F5-B0EB-58CCE43199A2}"/>
              </a:ext>
            </a:extLst>
          </p:cNvPr>
          <p:cNvCxnSpPr/>
          <p:nvPr/>
        </p:nvCxnSpPr>
        <p:spPr>
          <a:xfrm>
            <a:off x="1072125" y="3195519"/>
            <a:ext cx="340739" cy="0"/>
          </a:xfrm>
          <a:prstGeom prst="line">
            <a:avLst/>
          </a:prstGeom>
          <a:ln>
            <a:solidFill>
              <a:srgbClr val="7047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id="{195E6C8A-6E7F-40C1-ADA3-1F3BECB0D1A0}"/>
              </a:ext>
            </a:extLst>
          </p:cNvPr>
          <p:cNvCxnSpPr/>
          <p:nvPr/>
        </p:nvCxnSpPr>
        <p:spPr>
          <a:xfrm>
            <a:off x="1072125" y="3015120"/>
            <a:ext cx="340739" cy="0"/>
          </a:xfrm>
          <a:prstGeom prst="line">
            <a:avLst/>
          </a:prstGeom>
          <a:ln>
            <a:solidFill>
              <a:srgbClr val="7047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ECA145CE-591F-437D-BEB5-AF3B5F02A7FA}"/>
              </a:ext>
            </a:extLst>
          </p:cNvPr>
          <p:cNvCxnSpPr/>
          <p:nvPr/>
        </p:nvCxnSpPr>
        <p:spPr>
          <a:xfrm>
            <a:off x="1072125" y="3987962"/>
            <a:ext cx="340739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65542558-32CA-42C5-AC7B-5630769ECAF2}"/>
              </a:ext>
            </a:extLst>
          </p:cNvPr>
          <p:cNvCxnSpPr/>
          <p:nvPr/>
        </p:nvCxnSpPr>
        <p:spPr>
          <a:xfrm>
            <a:off x="1072125" y="712164"/>
            <a:ext cx="340739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4C7E173A-7425-4152-A744-0E9AD2BD6FAD}"/>
              </a:ext>
            </a:extLst>
          </p:cNvPr>
          <p:cNvCxnSpPr/>
          <p:nvPr/>
        </p:nvCxnSpPr>
        <p:spPr>
          <a:xfrm>
            <a:off x="1067363" y="1694997"/>
            <a:ext cx="340739" cy="0"/>
          </a:xfrm>
          <a:prstGeom prst="line">
            <a:avLst/>
          </a:prstGeom>
          <a:ln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A4BA70F4-F9FB-4B76-BD02-097FB5FE4267}"/>
              </a:ext>
            </a:extLst>
          </p:cNvPr>
          <p:cNvCxnSpPr/>
          <p:nvPr/>
        </p:nvCxnSpPr>
        <p:spPr>
          <a:xfrm>
            <a:off x="1408024" y="3071671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Oval 162">
            <a:extLst>
              <a:ext uri="{FF2B5EF4-FFF2-40B4-BE49-F238E27FC236}">
                <a16:creationId xmlns:a16="http://schemas.microsoft.com/office/drawing/2014/main" id="{DD562CB2-4659-44E9-A83E-82B9BA74F3A9}"/>
              </a:ext>
            </a:extLst>
          </p:cNvPr>
          <p:cNvSpPr/>
          <p:nvPr/>
        </p:nvSpPr>
        <p:spPr>
          <a:xfrm>
            <a:off x="1437845" y="3160078"/>
            <a:ext cx="90000" cy="90000"/>
          </a:xfrm>
          <a:prstGeom prst="ellipse">
            <a:avLst/>
          </a:prstGeom>
          <a:solidFill>
            <a:srgbClr val="70474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4" name="Diamond 163">
            <a:extLst>
              <a:ext uri="{FF2B5EF4-FFF2-40B4-BE49-F238E27FC236}">
                <a16:creationId xmlns:a16="http://schemas.microsoft.com/office/drawing/2014/main" id="{D838CD79-D1F9-4AE8-B1EF-79022405006B}"/>
              </a:ext>
            </a:extLst>
          </p:cNvPr>
          <p:cNvSpPr/>
          <p:nvPr/>
        </p:nvSpPr>
        <p:spPr>
          <a:xfrm>
            <a:off x="1532936" y="2812600"/>
            <a:ext cx="108000" cy="108000"/>
          </a:xfrm>
          <a:prstGeom prst="diamond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00305680-163B-4AAF-B984-910D3D8D0CDF}"/>
              </a:ext>
            </a:extLst>
          </p:cNvPr>
          <p:cNvGrpSpPr/>
          <p:nvPr/>
        </p:nvGrpSpPr>
        <p:grpSpPr>
          <a:xfrm>
            <a:off x="1072125" y="2892206"/>
            <a:ext cx="455587" cy="88973"/>
            <a:chOff x="359060" y="2793076"/>
            <a:chExt cx="455587" cy="88973"/>
          </a:xfrm>
        </p:grpSpPr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78E10D3D-14CF-454F-A7C3-E0D579878533}"/>
                </a:ext>
              </a:extLst>
            </p:cNvPr>
            <p:cNvCxnSpPr/>
            <p:nvPr/>
          </p:nvCxnSpPr>
          <p:spPr>
            <a:xfrm>
              <a:off x="359060" y="2880072"/>
              <a:ext cx="340739" cy="0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Connector 153">
              <a:extLst>
                <a:ext uri="{FF2B5EF4-FFF2-40B4-BE49-F238E27FC236}">
                  <a16:creationId xmlns:a16="http://schemas.microsoft.com/office/drawing/2014/main" id="{D7230920-8B1E-4BE6-9092-3AEE9C3B657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0803" y="2793076"/>
              <a:ext cx="123844" cy="88973"/>
            </a:xfrm>
            <a:prstGeom prst="line">
              <a:avLst/>
            </a:prstGeom>
            <a:ln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5" name="Oval 164">
            <a:extLst>
              <a:ext uri="{FF2B5EF4-FFF2-40B4-BE49-F238E27FC236}">
                <a16:creationId xmlns:a16="http://schemas.microsoft.com/office/drawing/2014/main" id="{20AC1288-B9E3-43A5-8DAF-2E712E3088F2}"/>
              </a:ext>
            </a:extLst>
          </p:cNvPr>
          <p:cNvSpPr/>
          <p:nvPr/>
        </p:nvSpPr>
        <p:spPr>
          <a:xfrm>
            <a:off x="1437845" y="2973515"/>
            <a:ext cx="90000" cy="90000"/>
          </a:xfrm>
          <a:prstGeom prst="ellipse">
            <a:avLst/>
          </a:prstGeom>
          <a:solidFill>
            <a:srgbClr val="70474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6" name="Diamond 165">
            <a:extLst>
              <a:ext uri="{FF2B5EF4-FFF2-40B4-BE49-F238E27FC236}">
                <a16:creationId xmlns:a16="http://schemas.microsoft.com/office/drawing/2014/main" id="{F35FFC27-1A91-473D-9B7F-373B1EBB2381}"/>
              </a:ext>
            </a:extLst>
          </p:cNvPr>
          <p:cNvSpPr/>
          <p:nvPr/>
        </p:nvSpPr>
        <p:spPr>
          <a:xfrm>
            <a:off x="1437845" y="656387"/>
            <a:ext cx="108000" cy="108000"/>
          </a:xfrm>
          <a:prstGeom prst="diamond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7" name="Diamond 166">
            <a:extLst>
              <a:ext uri="{FF2B5EF4-FFF2-40B4-BE49-F238E27FC236}">
                <a16:creationId xmlns:a16="http://schemas.microsoft.com/office/drawing/2014/main" id="{4EB976A8-F8F2-4D11-94A3-941F6E79E896}"/>
              </a:ext>
            </a:extLst>
          </p:cNvPr>
          <p:cNvSpPr/>
          <p:nvPr/>
        </p:nvSpPr>
        <p:spPr>
          <a:xfrm>
            <a:off x="1437845" y="3935446"/>
            <a:ext cx="108000" cy="108000"/>
          </a:xfrm>
          <a:prstGeom prst="diamond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8" name="Pentagon 167">
            <a:extLst>
              <a:ext uri="{FF2B5EF4-FFF2-40B4-BE49-F238E27FC236}">
                <a16:creationId xmlns:a16="http://schemas.microsoft.com/office/drawing/2014/main" id="{3387566F-23A2-4891-A4BD-19E650C1F23C}"/>
              </a:ext>
            </a:extLst>
          </p:cNvPr>
          <p:cNvSpPr/>
          <p:nvPr/>
        </p:nvSpPr>
        <p:spPr>
          <a:xfrm>
            <a:off x="1437845" y="1637847"/>
            <a:ext cx="108000" cy="108000"/>
          </a:xfrm>
          <a:prstGeom prst="pentagon">
            <a:avLst/>
          </a:prstGeom>
          <a:solidFill>
            <a:schemeClr val="accent3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70" name="Hexagon 169">
            <a:extLst>
              <a:ext uri="{FF2B5EF4-FFF2-40B4-BE49-F238E27FC236}">
                <a16:creationId xmlns:a16="http://schemas.microsoft.com/office/drawing/2014/main" id="{6A9E6460-EB9C-4AC0-B9D1-8260F9DB2C56}"/>
              </a:ext>
            </a:extLst>
          </p:cNvPr>
          <p:cNvSpPr/>
          <p:nvPr/>
        </p:nvSpPr>
        <p:spPr>
          <a:xfrm>
            <a:off x="5771893" y="691570"/>
            <a:ext cx="108000" cy="100800"/>
          </a:xfrm>
          <a:prstGeom prst="hexagon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B93DFEF6-7937-4096-8381-F6551CBA102E}"/>
              </a:ext>
            </a:extLst>
          </p:cNvPr>
          <p:cNvCxnSpPr/>
          <p:nvPr/>
        </p:nvCxnSpPr>
        <p:spPr>
          <a:xfrm>
            <a:off x="5387389" y="740739"/>
            <a:ext cx="340739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6" name="Group 235">
            <a:extLst>
              <a:ext uri="{FF2B5EF4-FFF2-40B4-BE49-F238E27FC236}">
                <a16:creationId xmlns:a16="http://schemas.microsoft.com/office/drawing/2014/main" id="{4318E914-3872-4D13-97B4-01F7EF6AFFAF}"/>
              </a:ext>
            </a:extLst>
          </p:cNvPr>
          <p:cNvGrpSpPr/>
          <p:nvPr/>
        </p:nvGrpSpPr>
        <p:grpSpPr>
          <a:xfrm>
            <a:off x="9592327" y="5251410"/>
            <a:ext cx="1142347" cy="1550617"/>
            <a:chOff x="9592327" y="5251410"/>
            <a:chExt cx="1142347" cy="1550617"/>
          </a:xfrm>
        </p:grpSpPr>
        <p:sp>
          <p:nvSpPr>
            <p:cNvPr id="158" name="Oval 157">
              <a:extLst>
                <a:ext uri="{FF2B5EF4-FFF2-40B4-BE49-F238E27FC236}">
                  <a16:creationId xmlns:a16="http://schemas.microsoft.com/office/drawing/2014/main" id="{D2BB53A5-6324-4133-8A61-AA0A3C73DFC3}"/>
                </a:ext>
              </a:extLst>
            </p:cNvPr>
            <p:cNvSpPr/>
            <p:nvPr/>
          </p:nvSpPr>
          <p:spPr>
            <a:xfrm>
              <a:off x="9601327" y="5359194"/>
              <a:ext cx="90000" cy="90000"/>
            </a:xfrm>
            <a:prstGeom prst="ellipse">
              <a:avLst/>
            </a:prstGeom>
            <a:solidFill>
              <a:srgbClr val="70474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59" name="Isosceles Triangle 158">
              <a:extLst>
                <a:ext uri="{FF2B5EF4-FFF2-40B4-BE49-F238E27FC236}">
                  <a16:creationId xmlns:a16="http://schemas.microsoft.com/office/drawing/2014/main" id="{8CA17061-E954-4A5C-88EB-87768F3B31F4}"/>
                </a:ext>
              </a:extLst>
            </p:cNvPr>
            <p:cNvSpPr/>
            <p:nvPr/>
          </p:nvSpPr>
          <p:spPr>
            <a:xfrm>
              <a:off x="9592327" y="6436293"/>
              <a:ext cx="108000" cy="108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60" name="Diamond 159">
              <a:extLst>
                <a:ext uri="{FF2B5EF4-FFF2-40B4-BE49-F238E27FC236}">
                  <a16:creationId xmlns:a16="http://schemas.microsoft.com/office/drawing/2014/main" id="{5BB9052B-0D1F-4107-9491-FDE8F1D2D6DA}"/>
                </a:ext>
              </a:extLst>
            </p:cNvPr>
            <p:cNvSpPr/>
            <p:nvPr/>
          </p:nvSpPr>
          <p:spPr>
            <a:xfrm>
              <a:off x="9592327" y="5534298"/>
              <a:ext cx="108000" cy="108000"/>
            </a:xfrm>
            <a:prstGeom prst="diamond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61" name="Pentagon 160">
              <a:extLst>
                <a:ext uri="{FF2B5EF4-FFF2-40B4-BE49-F238E27FC236}">
                  <a16:creationId xmlns:a16="http://schemas.microsoft.com/office/drawing/2014/main" id="{A34ADC92-80CD-4A1B-BC0F-7EFA06F37B62}"/>
                </a:ext>
              </a:extLst>
            </p:cNvPr>
            <p:cNvSpPr/>
            <p:nvPr/>
          </p:nvSpPr>
          <p:spPr>
            <a:xfrm>
              <a:off x="9592327" y="6619875"/>
              <a:ext cx="108000" cy="108000"/>
            </a:xfrm>
            <a:prstGeom prst="pentagon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69" name="Hexagon 168">
              <a:extLst>
                <a:ext uri="{FF2B5EF4-FFF2-40B4-BE49-F238E27FC236}">
                  <a16:creationId xmlns:a16="http://schemas.microsoft.com/office/drawing/2014/main" id="{7AA09D79-B99A-41DF-9A86-F4642391A2E3}"/>
                </a:ext>
              </a:extLst>
            </p:cNvPr>
            <p:cNvSpPr/>
            <p:nvPr/>
          </p:nvSpPr>
          <p:spPr>
            <a:xfrm>
              <a:off x="9592327" y="5717877"/>
              <a:ext cx="108000" cy="93600"/>
            </a:xfrm>
            <a:prstGeom prst="hexagon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72" name="Rectangle 171">
              <a:extLst>
                <a:ext uri="{FF2B5EF4-FFF2-40B4-BE49-F238E27FC236}">
                  <a16:creationId xmlns:a16="http://schemas.microsoft.com/office/drawing/2014/main" id="{85D4A91D-0EFA-4234-8ECF-56375337139E}"/>
                </a:ext>
              </a:extLst>
            </p:cNvPr>
            <p:cNvSpPr/>
            <p:nvPr/>
          </p:nvSpPr>
          <p:spPr>
            <a:xfrm>
              <a:off x="9610327" y="6095610"/>
              <a:ext cx="72000" cy="72000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83" name="Trapezoid 182">
              <a:extLst>
                <a:ext uri="{FF2B5EF4-FFF2-40B4-BE49-F238E27FC236}">
                  <a16:creationId xmlns:a16="http://schemas.microsoft.com/office/drawing/2014/main" id="{73CDC6E8-2DF7-40C6-9C06-E233172D4941}"/>
                </a:ext>
              </a:extLst>
            </p:cNvPr>
            <p:cNvSpPr/>
            <p:nvPr/>
          </p:nvSpPr>
          <p:spPr>
            <a:xfrm>
              <a:off x="9592327" y="6252714"/>
              <a:ext cx="108000" cy="108000"/>
            </a:xfrm>
            <a:prstGeom prst="trapezoid">
              <a:avLst/>
            </a:prstGeom>
            <a:solidFill>
              <a:srgbClr val="EF19C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92" name="Oval 191">
              <a:extLst>
                <a:ext uri="{FF2B5EF4-FFF2-40B4-BE49-F238E27FC236}">
                  <a16:creationId xmlns:a16="http://schemas.microsoft.com/office/drawing/2014/main" id="{73C92A69-4D2C-4BD0-B1AC-CB9372FC6430}"/>
                </a:ext>
              </a:extLst>
            </p:cNvPr>
            <p:cNvSpPr/>
            <p:nvPr/>
          </p:nvSpPr>
          <p:spPr>
            <a:xfrm>
              <a:off x="9601327" y="5901456"/>
              <a:ext cx="90000" cy="90000"/>
            </a:xfrm>
            <a:prstGeom prst="ellipse">
              <a:avLst/>
            </a:prstGeom>
            <a:solidFill>
              <a:srgbClr val="FA630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036ABC3C-9FAA-43EA-A6A4-7338B8CE01F6}"/>
                </a:ext>
              </a:extLst>
            </p:cNvPr>
            <p:cNvSpPr txBox="1"/>
            <p:nvPr/>
          </p:nvSpPr>
          <p:spPr>
            <a:xfrm>
              <a:off x="9696449" y="5251410"/>
              <a:ext cx="1038225" cy="1550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AU" sz="800" dirty="0"/>
                <a:t>April 2017 – 9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7 – 12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8 – 16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ne 2018 – 8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ly 2018 – 10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April 2019 – 24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9 – 22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ne 2019 – 11 das</a:t>
              </a:r>
            </a:p>
          </p:txBody>
        </p:sp>
      </p:grp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44DF8E6C-651D-4748-A813-74A4770A7B0C}"/>
              </a:ext>
            </a:extLst>
          </p:cNvPr>
          <p:cNvCxnSpPr/>
          <p:nvPr/>
        </p:nvCxnSpPr>
        <p:spPr>
          <a:xfrm>
            <a:off x="480325" y="5852572"/>
            <a:ext cx="0" cy="72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212DD19F-A09D-48EB-B49D-9C1F3310EAE8}"/>
              </a:ext>
            </a:extLst>
          </p:cNvPr>
          <p:cNvSpPr txBox="1"/>
          <p:nvPr/>
        </p:nvSpPr>
        <p:spPr>
          <a:xfrm>
            <a:off x="489930" y="6062651"/>
            <a:ext cx="1178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/>
              <a:t>100 Mb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A8DA1F68-721D-4B69-A83A-C23E8B71BC3B}"/>
              </a:ext>
            </a:extLst>
          </p:cNvPr>
          <p:cNvSpPr txBox="1"/>
          <p:nvPr/>
        </p:nvSpPr>
        <p:spPr>
          <a:xfrm>
            <a:off x="1422602" y="1755533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GA2ox-B1</a:t>
            </a:r>
          </a:p>
        </p:txBody>
      </p:sp>
      <p:cxnSp>
        <p:nvCxnSpPr>
          <p:cNvPr id="237" name="Straight Connector 236">
            <a:extLst>
              <a:ext uri="{FF2B5EF4-FFF2-40B4-BE49-F238E27FC236}">
                <a16:creationId xmlns:a16="http://schemas.microsoft.com/office/drawing/2014/main" id="{7775041E-7B71-4EF5-AD43-AEA5E23681FC}"/>
              </a:ext>
            </a:extLst>
          </p:cNvPr>
          <p:cNvCxnSpPr/>
          <p:nvPr/>
        </p:nvCxnSpPr>
        <p:spPr>
          <a:xfrm>
            <a:off x="1065414" y="1714531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Straight Connector 251">
            <a:extLst>
              <a:ext uri="{FF2B5EF4-FFF2-40B4-BE49-F238E27FC236}">
                <a16:creationId xmlns:a16="http://schemas.microsoft.com/office/drawing/2014/main" id="{F25CBB24-9ECF-41AC-901D-CE528F7AAAA5}"/>
              </a:ext>
            </a:extLst>
          </p:cNvPr>
          <p:cNvCxnSpPr>
            <a:cxnSpLocks/>
          </p:cNvCxnSpPr>
          <p:nvPr/>
        </p:nvCxnSpPr>
        <p:spPr>
          <a:xfrm rot="15840000" flipV="1">
            <a:off x="1387320" y="1736732"/>
            <a:ext cx="123844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5" name="Group 254">
            <a:extLst>
              <a:ext uri="{FF2B5EF4-FFF2-40B4-BE49-F238E27FC236}">
                <a16:creationId xmlns:a16="http://schemas.microsoft.com/office/drawing/2014/main" id="{626C0087-A174-45AD-A79E-6DB7BDD663E1}"/>
              </a:ext>
            </a:extLst>
          </p:cNvPr>
          <p:cNvGrpSpPr/>
          <p:nvPr/>
        </p:nvGrpSpPr>
        <p:grpSpPr>
          <a:xfrm>
            <a:off x="2196217" y="4023937"/>
            <a:ext cx="263036" cy="1003300"/>
            <a:chOff x="8031292" y="816097"/>
            <a:chExt cx="263036" cy="1003300"/>
          </a:xfrm>
        </p:grpSpPr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CAD8ABFD-A0C4-477D-9BE2-61E87F5569CC}"/>
                </a:ext>
              </a:extLst>
            </p:cNvPr>
            <p:cNvSpPr txBox="1"/>
            <p:nvPr/>
          </p:nvSpPr>
          <p:spPr>
            <a:xfrm rot="5400000">
              <a:off x="7661873" y="118694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257" name="Rectangle 256">
              <a:extLst>
                <a:ext uri="{FF2B5EF4-FFF2-40B4-BE49-F238E27FC236}">
                  <a16:creationId xmlns:a16="http://schemas.microsoft.com/office/drawing/2014/main" id="{46EA995E-9284-4CFC-AEA9-CC7F98A7F872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284" name="TextBox 283">
            <a:extLst>
              <a:ext uri="{FF2B5EF4-FFF2-40B4-BE49-F238E27FC236}">
                <a16:creationId xmlns:a16="http://schemas.microsoft.com/office/drawing/2014/main" id="{1CE5D623-AF9C-4C94-9070-0414924141CB}"/>
              </a:ext>
            </a:extLst>
          </p:cNvPr>
          <p:cNvSpPr txBox="1"/>
          <p:nvPr/>
        </p:nvSpPr>
        <p:spPr>
          <a:xfrm>
            <a:off x="1422602" y="1877453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CD373830</a:t>
            </a:r>
          </a:p>
        </p:txBody>
      </p:sp>
      <p:cxnSp>
        <p:nvCxnSpPr>
          <p:cNvPr id="309" name="Straight Connector 308">
            <a:extLst>
              <a:ext uri="{FF2B5EF4-FFF2-40B4-BE49-F238E27FC236}">
                <a16:creationId xmlns:a16="http://schemas.microsoft.com/office/drawing/2014/main" id="{654150C6-ED78-49B5-A105-F2053CB2E3DC}"/>
              </a:ext>
            </a:extLst>
          </p:cNvPr>
          <p:cNvCxnSpPr/>
          <p:nvPr/>
        </p:nvCxnSpPr>
        <p:spPr>
          <a:xfrm>
            <a:off x="1065414" y="1767871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0" name="Straight Connector 309">
            <a:extLst>
              <a:ext uri="{FF2B5EF4-FFF2-40B4-BE49-F238E27FC236}">
                <a16:creationId xmlns:a16="http://schemas.microsoft.com/office/drawing/2014/main" id="{3A87BD9F-A894-4BCC-96F5-CEF543C57D99}"/>
              </a:ext>
            </a:extLst>
          </p:cNvPr>
          <p:cNvCxnSpPr>
            <a:cxnSpLocks/>
          </p:cNvCxnSpPr>
          <p:nvPr/>
        </p:nvCxnSpPr>
        <p:spPr>
          <a:xfrm rot="-1380000" flipH="1" flipV="1">
            <a:off x="1448530" y="1753843"/>
            <a:ext cx="15634" cy="2208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" name="Group 9">
            <a:extLst>
              <a:ext uri="{FF2B5EF4-FFF2-40B4-BE49-F238E27FC236}">
                <a16:creationId xmlns:a16="http://schemas.microsoft.com/office/drawing/2014/main" id="{0B6A3162-19CB-40B5-BF6A-D80C6800AF98}"/>
              </a:ext>
            </a:extLst>
          </p:cNvPr>
          <p:cNvGrpSpPr/>
          <p:nvPr/>
        </p:nvGrpSpPr>
        <p:grpSpPr>
          <a:xfrm>
            <a:off x="1706133" y="2620947"/>
            <a:ext cx="274744" cy="1003300"/>
            <a:chOff x="993068" y="2546583"/>
            <a:chExt cx="274744" cy="1003300"/>
          </a:xfrm>
        </p:grpSpPr>
        <p:sp>
          <p:nvSpPr>
            <p:cNvPr id="324" name="TextBox 323">
              <a:extLst>
                <a:ext uri="{FF2B5EF4-FFF2-40B4-BE49-F238E27FC236}">
                  <a16:creationId xmlns:a16="http://schemas.microsoft.com/office/drawing/2014/main" id="{E8747A73-80C5-4812-9386-A123BA034C79}"/>
                </a:ext>
              </a:extLst>
            </p:cNvPr>
            <p:cNvSpPr txBox="1"/>
            <p:nvPr/>
          </p:nvSpPr>
          <p:spPr>
            <a:xfrm rot="5400000">
              <a:off x="635357" y="291742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325" name="Rectangle 324">
              <a:extLst>
                <a:ext uri="{FF2B5EF4-FFF2-40B4-BE49-F238E27FC236}">
                  <a16:creationId xmlns:a16="http://schemas.microsoft.com/office/drawing/2014/main" id="{D44C9BE0-30F0-4567-9CC7-89848DFCC74D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39" name="Group 338">
            <a:extLst>
              <a:ext uri="{FF2B5EF4-FFF2-40B4-BE49-F238E27FC236}">
                <a16:creationId xmlns:a16="http://schemas.microsoft.com/office/drawing/2014/main" id="{037AA0B9-CE3A-4412-B130-186C7D8C7A36}"/>
              </a:ext>
            </a:extLst>
          </p:cNvPr>
          <p:cNvGrpSpPr/>
          <p:nvPr/>
        </p:nvGrpSpPr>
        <p:grpSpPr>
          <a:xfrm>
            <a:off x="5912373" y="269498"/>
            <a:ext cx="285221" cy="1240609"/>
            <a:chOff x="8355476" y="467196"/>
            <a:chExt cx="285221" cy="1051392"/>
          </a:xfrm>
        </p:grpSpPr>
        <p:sp>
          <p:nvSpPr>
            <p:cNvPr id="340" name="TextBox 339">
              <a:extLst>
                <a:ext uri="{FF2B5EF4-FFF2-40B4-BE49-F238E27FC236}">
                  <a16:creationId xmlns:a16="http://schemas.microsoft.com/office/drawing/2014/main" id="{DD76BE78-F2AD-44FE-98B0-E5C58BEFAB9E}"/>
                </a:ext>
              </a:extLst>
            </p:cNvPr>
            <p:cNvSpPr txBox="1"/>
            <p:nvPr/>
          </p:nvSpPr>
          <p:spPr>
            <a:xfrm rot="5400000">
              <a:off x="7984196" y="862087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hwwgr-1D</a:t>
              </a:r>
            </a:p>
          </p:txBody>
        </p:sp>
        <p:sp>
          <p:nvSpPr>
            <p:cNvPr id="341" name="Rectangle 340">
              <a:extLst>
                <a:ext uri="{FF2B5EF4-FFF2-40B4-BE49-F238E27FC236}">
                  <a16:creationId xmlns:a16="http://schemas.microsoft.com/office/drawing/2014/main" id="{2B575747-8507-4C78-B918-E51F661C09C2}"/>
                </a:ext>
              </a:extLst>
            </p:cNvPr>
            <p:cNvSpPr/>
            <p:nvPr/>
          </p:nvSpPr>
          <p:spPr>
            <a:xfrm rot="5400000">
              <a:off x="8359594" y="935546"/>
              <a:ext cx="45764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85" name="Group 384">
            <a:extLst>
              <a:ext uri="{FF2B5EF4-FFF2-40B4-BE49-F238E27FC236}">
                <a16:creationId xmlns:a16="http://schemas.microsoft.com/office/drawing/2014/main" id="{FD9896B1-4564-41A1-8C84-B101538C3106}"/>
              </a:ext>
            </a:extLst>
          </p:cNvPr>
          <p:cNvGrpSpPr/>
          <p:nvPr/>
        </p:nvGrpSpPr>
        <p:grpSpPr>
          <a:xfrm>
            <a:off x="3030318" y="4345502"/>
            <a:ext cx="270410" cy="1003300"/>
            <a:chOff x="8031292" y="603407"/>
            <a:chExt cx="270410" cy="1003300"/>
          </a:xfrm>
        </p:grpSpPr>
        <p:sp>
          <p:nvSpPr>
            <p:cNvPr id="386" name="TextBox 385">
              <a:extLst>
                <a:ext uri="{FF2B5EF4-FFF2-40B4-BE49-F238E27FC236}">
                  <a16:creationId xmlns:a16="http://schemas.microsoft.com/office/drawing/2014/main" id="{C2B01BC1-4A46-4DAD-BC85-C22457262697}"/>
                </a:ext>
              </a:extLst>
            </p:cNvPr>
            <p:cNvSpPr txBox="1"/>
            <p:nvPr/>
          </p:nvSpPr>
          <p:spPr>
            <a:xfrm rot="5400000">
              <a:off x="7669247" y="97425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387" name="Rectangle 386">
              <a:extLst>
                <a:ext uri="{FF2B5EF4-FFF2-40B4-BE49-F238E27FC236}">
                  <a16:creationId xmlns:a16="http://schemas.microsoft.com/office/drawing/2014/main" id="{5A31AB98-24E7-4BE3-AF3A-015C73421AEA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88" name="Group 387">
            <a:extLst>
              <a:ext uri="{FF2B5EF4-FFF2-40B4-BE49-F238E27FC236}">
                <a16:creationId xmlns:a16="http://schemas.microsoft.com/office/drawing/2014/main" id="{13E88C7E-B358-4D47-99A1-BB6A20DC0ACE}"/>
              </a:ext>
            </a:extLst>
          </p:cNvPr>
          <p:cNvGrpSpPr/>
          <p:nvPr/>
        </p:nvGrpSpPr>
        <p:grpSpPr>
          <a:xfrm>
            <a:off x="2711521" y="5299846"/>
            <a:ext cx="270410" cy="1003300"/>
            <a:chOff x="8031292" y="719648"/>
            <a:chExt cx="270410" cy="1003300"/>
          </a:xfrm>
        </p:grpSpPr>
        <p:sp>
          <p:nvSpPr>
            <p:cNvPr id="389" name="TextBox 388">
              <a:extLst>
                <a:ext uri="{FF2B5EF4-FFF2-40B4-BE49-F238E27FC236}">
                  <a16:creationId xmlns:a16="http://schemas.microsoft.com/office/drawing/2014/main" id="{3296D58E-CBCD-4C6C-808B-F2AFF27429BF}"/>
                </a:ext>
              </a:extLst>
            </p:cNvPr>
            <p:cNvSpPr txBox="1"/>
            <p:nvPr/>
          </p:nvSpPr>
          <p:spPr>
            <a:xfrm rot="5400000">
              <a:off x="7669247" y="1090493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390" name="Rectangle 389">
              <a:extLst>
                <a:ext uri="{FF2B5EF4-FFF2-40B4-BE49-F238E27FC236}">
                  <a16:creationId xmlns:a16="http://schemas.microsoft.com/office/drawing/2014/main" id="{2D0D8B98-03FA-45FE-B037-DF2D9FAFAB75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400" name="Group 399">
            <a:extLst>
              <a:ext uri="{FF2B5EF4-FFF2-40B4-BE49-F238E27FC236}">
                <a16:creationId xmlns:a16="http://schemas.microsoft.com/office/drawing/2014/main" id="{D21118BE-38AB-451E-90F6-4910254CB9F8}"/>
              </a:ext>
            </a:extLst>
          </p:cNvPr>
          <p:cNvGrpSpPr/>
          <p:nvPr/>
        </p:nvGrpSpPr>
        <p:grpSpPr>
          <a:xfrm>
            <a:off x="6698477" y="3154635"/>
            <a:ext cx="270410" cy="1003300"/>
            <a:chOff x="8031292" y="511395"/>
            <a:chExt cx="270410" cy="1003300"/>
          </a:xfrm>
        </p:grpSpPr>
        <p:sp>
          <p:nvSpPr>
            <p:cNvPr id="401" name="TextBox 400">
              <a:extLst>
                <a:ext uri="{FF2B5EF4-FFF2-40B4-BE49-F238E27FC236}">
                  <a16:creationId xmlns:a16="http://schemas.microsoft.com/office/drawing/2014/main" id="{679974BA-0E25-4299-89FF-4AB55D781DA4}"/>
                </a:ext>
              </a:extLst>
            </p:cNvPr>
            <p:cNvSpPr txBox="1"/>
            <p:nvPr/>
          </p:nvSpPr>
          <p:spPr>
            <a:xfrm rot="5400000">
              <a:off x="7669247" y="882240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402" name="Rectangle 401">
              <a:extLst>
                <a:ext uri="{FF2B5EF4-FFF2-40B4-BE49-F238E27FC236}">
                  <a16:creationId xmlns:a16="http://schemas.microsoft.com/office/drawing/2014/main" id="{735BDC7C-32A5-4718-81C2-142B4CE8966E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457" name="Group 456">
            <a:extLst>
              <a:ext uri="{FF2B5EF4-FFF2-40B4-BE49-F238E27FC236}">
                <a16:creationId xmlns:a16="http://schemas.microsoft.com/office/drawing/2014/main" id="{9C90C557-7F74-40A2-8C06-506E427462A0}"/>
              </a:ext>
            </a:extLst>
          </p:cNvPr>
          <p:cNvGrpSpPr/>
          <p:nvPr/>
        </p:nvGrpSpPr>
        <p:grpSpPr>
          <a:xfrm>
            <a:off x="2463701" y="4092597"/>
            <a:ext cx="280116" cy="1186015"/>
            <a:chOff x="8992024" y="5188616"/>
            <a:chExt cx="280116" cy="1186015"/>
          </a:xfrm>
        </p:grpSpPr>
        <p:sp>
          <p:nvSpPr>
            <p:cNvPr id="458" name="TextBox 457">
              <a:extLst>
                <a:ext uri="{FF2B5EF4-FFF2-40B4-BE49-F238E27FC236}">
                  <a16:creationId xmlns:a16="http://schemas.microsoft.com/office/drawing/2014/main" id="{7515A530-CBC3-4DF5-BE90-F7C42FD35ACE}"/>
                </a:ext>
              </a:extLst>
            </p:cNvPr>
            <p:cNvSpPr txBox="1"/>
            <p:nvPr/>
          </p:nvSpPr>
          <p:spPr>
            <a:xfrm rot="5400000">
              <a:off x="8548327" y="5650819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ahau-1B</a:t>
              </a:r>
            </a:p>
          </p:txBody>
        </p:sp>
        <p:sp>
          <p:nvSpPr>
            <p:cNvPr id="459" name="Rectangle 458">
              <a:extLst>
                <a:ext uri="{FF2B5EF4-FFF2-40B4-BE49-F238E27FC236}">
                  <a16:creationId xmlns:a16="http://schemas.microsoft.com/office/drawing/2014/main" id="{77E7D6B7-806F-40DE-86FB-6D506357F2C3}"/>
                </a:ext>
              </a:extLst>
            </p:cNvPr>
            <p:cNvSpPr/>
            <p:nvPr/>
          </p:nvSpPr>
          <p:spPr>
            <a:xfrm rot="5400000">
              <a:off x="8983024" y="5530812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508" name="Group 507">
            <a:extLst>
              <a:ext uri="{FF2B5EF4-FFF2-40B4-BE49-F238E27FC236}">
                <a16:creationId xmlns:a16="http://schemas.microsoft.com/office/drawing/2014/main" id="{60F3D974-F440-4909-B450-4F896F909D3D}"/>
              </a:ext>
            </a:extLst>
          </p:cNvPr>
          <p:cNvGrpSpPr/>
          <p:nvPr/>
        </p:nvGrpSpPr>
        <p:grpSpPr>
          <a:xfrm>
            <a:off x="2748266" y="4092559"/>
            <a:ext cx="277604" cy="1186015"/>
            <a:chOff x="8994536" y="5637073"/>
            <a:chExt cx="277604" cy="1186015"/>
          </a:xfrm>
        </p:grpSpPr>
        <p:sp>
          <p:nvSpPr>
            <p:cNvPr id="536" name="TextBox 535">
              <a:extLst>
                <a:ext uri="{FF2B5EF4-FFF2-40B4-BE49-F238E27FC236}">
                  <a16:creationId xmlns:a16="http://schemas.microsoft.com/office/drawing/2014/main" id="{985CDD6E-EFA6-4D40-A602-72A49B3D244D}"/>
                </a:ext>
              </a:extLst>
            </p:cNvPr>
            <p:cNvSpPr txBox="1"/>
            <p:nvPr/>
          </p:nvSpPr>
          <p:spPr>
            <a:xfrm rot="5400000">
              <a:off x="8548327" y="6099276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gr.cas-1BL</a:t>
              </a:r>
            </a:p>
          </p:txBody>
        </p:sp>
        <p:sp>
          <p:nvSpPr>
            <p:cNvPr id="537" name="Rectangle 536">
              <a:extLst>
                <a:ext uri="{FF2B5EF4-FFF2-40B4-BE49-F238E27FC236}">
                  <a16:creationId xmlns:a16="http://schemas.microsoft.com/office/drawing/2014/main" id="{26712EDA-B83B-4309-A5BC-6DF1728F374C}"/>
                </a:ext>
              </a:extLst>
            </p:cNvPr>
            <p:cNvSpPr/>
            <p:nvPr/>
          </p:nvSpPr>
          <p:spPr>
            <a:xfrm rot="5400000">
              <a:off x="8994536" y="607122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612" name="Group 611">
            <a:extLst>
              <a:ext uri="{FF2B5EF4-FFF2-40B4-BE49-F238E27FC236}">
                <a16:creationId xmlns:a16="http://schemas.microsoft.com/office/drawing/2014/main" id="{AE07F9BE-1CA9-4EF0-B378-C0B87037B4F1}"/>
              </a:ext>
            </a:extLst>
          </p:cNvPr>
          <p:cNvGrpSpPr/>
          <p:nvPr/>
        </p:nvGrpSpPr>
        <p:grpSpPr>
          <a:xfrm>
            <a:off x="2117304" y="4871373"/>
            <a:ext cx="283132" cy="2025421"/>
            <a:chOff x="993068" y="2571748"/>
            <a:chExt cx="283132" cy="2025421"/>
          </a:xfrm>
        </p:grpSpPr>
        <p:sp>
          <p:nvSpPr>
            <p:cNvPr id="613" name="TextBox 612">
              <a:extLst>
                <a:ext uri="{FF2B5EF4-FFF2-40B4-BE49-F238E27FC236}">
                  <a16:creationId xmlns:a16="http://schemas.microsoft.com/office/drawing/2014/main" id="{59F4A07C-2FBF-488C-AD5C-7D206E03FD7A}"/>
                </a:ext>
              </a:extLst>
            </p:cNvPr>
            <p:cNvSpPr txBox="1"/>
            <p:nvPr/>
          </p:nvSpPr>
          <p:spPr>
            <a:xfrm rot="5400000">
              <a:off x="132684" y="3453654"/>
              <a:ext cx="20254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TL2.PHS .Albrecht et al. 2015</a:t>
              </a:r>
            </a:p>
          </p:txBody>
        </p:sp>
        <p:sp>
          <p:nvSpPr>
            <p:cNvPr id="614" name="Rectangle 613">
              <a:extLst>
                <a:ext uri="{FF2B5EF4-FFF2-40B4-BE49-F238E27FC236}">
                  <a16:creationId xmlns:a16="http://schemas.microsoft.com/office/drawing/2014/main" id="{2CE51486-0603-451F-BE32-F39907A67C54}"/>
                </a:ext>
              </a:extLst>
            </p:cNvPr>
            <p:cNvSpPr/>
            <p:nvPr/>
          </p:nvSpPr>
          <p:spPr>
            <a:xfrm rot="5400000">
              <a:off x="984068" y="2883528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92" name="Group 91">
            <a:extLst>
              <a:ext uri="{FF2B5EF4-FFF2-40B4-BE49-F238E27FC236}">
                <a16:creationId xmlns:a16="http://schemas.microsoft.com/office/drawing/2014/main" id="{D6875899-0527-4B63-82AE-E17DC000786E}"/>
              </a:ext>
            </a:extLst>
          </p:cNvPr>
          <p:cNvGrpSpPr/>
          <p:nvPr/>
        </p:nvGrpSpPr>
        <p:grpSpPr>
          <a:xfrm>
            <a:off x="2436731" y="5296269"/>
            <a:ext cx="280116" cy="1186015"/>
            <a:chOff x="8992024" y="5374438"/>
            <a:chExt cx="280116" cy="1186015"/>
          </a:xfrm>
        </p:grpSpPr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45C81D95-9414-4828-AC68-EC9618568E6E}"/>
                </a:ext>
              </a:extLst>
            </p:cNvPr>
            <p:cNvSpPr txBox="1"/>
            <p:nvPr/>
          </p:nvSpPr>
          <p:spPr>
            <a:xfrm rot="5400000">
              <a:off x="8548327" y="5836641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1B.2</a:t>
              </a: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D8923805-DD09-495B-9873-A92E58FFA742}"/>
                </a:ext>
              </a:extLst>
            </p:cNvPr>
            <p:cNvSpPr/>
            <p:nvPr/>
          </p:nvSpPr>
          <p:spPr>
            <a:xfrm rot="5400000">
              <a:off x="8983024" y="5530812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98BE8EA3-1486-466C-9756-8747F10FA225}"/>
              </a:ext>
            </a:extLst>
          </p:cNvPr>
          <p:cNvGrpSpPr/>
          <p:nvPr/>
        </p:nvGrpSpPr>
        <p:grpSpPr>
          <a:xfrm>
            <a:off x="2052891" y="370337"/>
            <a:ext cx="280116" cy="1186015"/>
            <a:chOff x="8992024" y="5166015"/>
            <a:chExt cx="280116" cy="1186015"/>
          </a:xfrm>
        </p:grpSpPr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B5E569F3-C720-490B-9A98-450D9EF983FA}"/>
                </a:ext>
              </a:extLst>
            </p:cNvPr>
            <p:cNvSpPr txBox="1"/>
            <p:nvPr/>
          </p:nvSpPr>
          <p:spPr>
            <a:xfrm rot="5400000">
              <a:off x="8548327" y="5628218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1B.1</a:t>
              </a:r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C8D9627E-4A59-4466-90E8-41D2E298D059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99" name="Group 98">
            <a:extLst>
              <a:ext uri="{FF2B5EF4-FFF2-40B4-BE49-F238E27FC236}">
                <a16:creationId xmlns:a16="http://schemas.microsoft.com/office/drawing/2014/main" id="{613E0CEE-6D4C-4C52-B528-5C1AF8C7D08C}"/>
              </a:ext>
            </a:extLst>
          </p:cNvPr>
          <p:cNvGrpSpPr/>
          <p:nvPr/>
        </p:nvGrpSpPr>
        <p:grpSpPr>
          <a:xfrm>
            <a:off x="5852866" y="1672825"/>
            <a:ext cx="280116" cy="1186015"/>
            <a:chOff x="8992024" y="5325578"/>
            <a:chExt cx="280116" cy="1186015"/>
          </a:xfrm>
        </p:grpSpPr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F5001376-7549-4912-9994-224BCAE3A463}"/>
                </a:ext>
              </a:extLst>
            </p:cNvPr>
            <p:cNvSpPr txBox="1"/>
            <p:nvPr/>
          </p:nvSpPr>
          <p:spPr>
            <a:xfrm rot="5400000">
              <a:off x="8548327" y="5787781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1D</a:t>
              </a:r>
            </a:p>
          </p:txBody>
        </p:sp>
        <p:sp>
          <p:nvSpPr>
            <p:cNvPr id="101" name="Rectangle 100">
              <a:extLst>
                <a:ext uri="{FF2B5EF4-FFF2-40B4-BE49-F238E27FC236}">
                  <a16:creationId xmlns:a16="http://schemas.microsoft.com/office/drawing/2014/main" id="{897378D9-D16D-4C4C-AED4-198A6433E52B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46467102-C16F-4108-A719-B85EA42FCE05}"/>
              </a:ext>
            </a:extLst>
          </p:cNvPr>
          <p:cNvGrpSpPr/>
          <p:nvPr/>
        </p:nvGrpSpPr>
        <p:grpSpPr>
          <a:xfrm>
            <a:off x="3305177" y="4377858"/>
            <a:ext cx="280116" cy="1186015"/>
            <a:chOff x="8992024" y="5188616"/>
            <a:chExt cx="280116" cy="1186015"/>
          </a:xfrm>
        </p:grpSpPr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B01A18BC-02C2-4C3E-A0E3-993A3633ADDF}"/>
                </a:ext>
              </a:extLst>
            </p:cNvPr>
            <p:cNvSpPr txBox="1"/>
            <p:nvPr/>
          </p:nvSpPr>
          <p:spPr>
            <a:xfrm rot="5400000">
              <a:off x="8548327" y="5650819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gc.hwwgr-1B</a:t>
              </a:r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AC45F5C2-951F-4788-8078-7DC4202F8B21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05" name="Group 104">
            <a:extLst>
              <a:ext uri="{FF2B5EF4-FFF2-40B4-BE49-F238E27FC236}">
                <a16:creationId xmlns:a16="http://schemas.microsoft.com/office/drawing/2014/main" id="{A4710523-2A62-4674-A4F9-F1DACA554591}"/>
              </a:ext>
            </a:extLst>
          </p:cNvPr>
          <p:cNvGrpSpPr/>
          <p:nvPr/>
        </p:nvGrpSpPr>
        <p:grpSpPr>
          <a:xfrm>
            <a:off x="6403712" y="2468383"/>
            <a:ext cx="285190" cy="1240609"/>
            <a:chOff x="8355476" y="713622"/>
            <a:chExt cx="285190" cy="1051392"/>
          </a:xfrm>
        </p:grpSpPr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5B2014E2-320A-4AD6-BFFA-DFC85C0291ED}"/>
                </a:ext>
              </a:extLst>
            </p:cNvPr>
            <p:cNvSpPr txBox="1"/>
            <p:nvPr/>
          </p:nvSpPr>
          <p:spPr>
            <a:xfrm rot="5400000">
              <a:off x="7984165" y="1108513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hwwgr-1D</a:t>
              </a:r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294C0D3E-4025-4B24-9656-F6C2FCEF0444}"/>
                </a:ext>
              </a:extLst>
            </p:cNvPr>
            <p:cNvSpPr/>
            <p:nvPr/>
          </p:nvSpPr>
          <p:spPr>
            <a:xfrm rot="5400000">
              <a:off x="8359594" y="935546"/>
              <a:ext cx="45764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108" name="TextBox 107">
            <a:extLst>
              <a:ext uri="{FF2B5EF4-FFF2-40B4-BE49-F238E27FC236}">
                <a16:creationId xmlns:a16="http://schemas.microsoft.com/office/drawing/2014/main" id="{FA80C75A-7AE0-493E-B845-44ADC315CFF5}"/>
              </a:ext>
            </a:extLst>
          </p:cNvPr>
          <p:cNvSpPr txBox="1"/>
          <p:nvPr/>
        </p:nvSpPr>
        <p:spPr>
          <a:xfrm>
            <a:off x="5737014" y="4085139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DOG1L2</a:t>
            </a:r>
          </a:p>
        </p:txBody>
      </p: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A5FBC704-3266-486C-86C0-46AE5043907C}"/>
              </a:ext>
            </a:extLst>
          </p:cNvPr>
          <p:cNvCxnSpPr/>
          <p:nvPr/>
        </p:nvCxnSpPr>
        <p:spPr>
          <a:xfrm>
            <a:off x="5390222" y="3990055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88C5C78E-DDE4-4E7B-B8ED-4837739562CC}"/>
              </a:ext>
            </a:extLst>
          </p:cNvPr>
          <p:cNvSpPr txBox="1"/>
          <p:nvPr/>
        </p:nvSpPr>
        <p:spPr>
          <a:xfrm>
            <a:off x="1350756" y="5170060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DOG1L2</a:t>
            </a:r>
          </a:p>
        </p:txBody>
      </p: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FD6AC263-03BC-4EA2-ACB6-BCBD16AC13E7}"/>
              </a:ext>
            </a:extLst>
          </p:cNvPr>
          <p:cNvCxnSpPr/>
          <p:nvPr/>
        </p:nvCxnSpPr>
        <p:spPr>
          <a:xfrm>
            <a:off x="1065414" y="5282953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>
            <a:extLst>
              <a:ext uri="{FF2B5EF4-FFF2-40B4-BE49-F238E27FC236}">
                <a16:creationId xmlns:a16="http://schemas.microsoft.com/office/drawing/2014/main" id="{C5A284DE-F20D-49F1-9551-4486A326D084}"/>
              </a:ext>
            </a:extLst>
          </p:cNvPr>
          <p:cNvCxnSpPr/>
          <p:nvPr/>
        </p:nvCxnSpPr>
        <p:spPr>
          <a:xfrm>
            <a:off x="1065414" y="4841553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>
            <a:extLst>
              <a:ext uri="{FF2B5EF4-FFF2-40B4-BE49-F238E27FC236}">
                <a16:creationId xmlns:a16="http://schemas.microsoft.com/office/drawing/2014/main" id="{2D97C4E0-D716-455B-A532-0DCCBECF1B97}"/>
              </a:ext>
            </a:extLst>
          </p:cNvPr>
          <p:cNvSpPr txBox="1"/>
          <p:nvPr/>
        </p:nvSpPr>
        <p:spPr>
          <a:xfrm>
            <a:off x="5648879" y="1406610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IAA1</a:t>
            </a:r>
          </a:p>
        </p:txBody>
      </p: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28A55B4D-582B-48CA-8F75-A481B2CD2D89}"/>
              </a:ext>
            </a:extLst>
          </p:cNvPr>
          <p:cNvCxnSpPr/>
          <p:nvPr/>
        </p:nvCxnSpPr>
        <p:spPr>
          <a:xfrm>
            <a:off x="5397206" y="154321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B4F347EC-AC26-4074-91E8-D66007F215CB}"/>
              </a:ext>
            </a:extLst>
          </p:cNvPr>
          <p:cNvSpPr txBox="1"/>
          <p:nvPr/>
        </p:nvSpPr>
        <p:spPr>
          <a:xfrm>
            <a:off x="5729324" y="3976394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IAA1</a:t>
            </a:r>
          </a:p>
        </p:txBody>
      </p: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2D570ECE-F4A4-4570-AF64-5557E5699D27}"/>
              </a:ext>
            </a:extLst>
          </p:cNvPr>
          <p:cNvCxnSpPr/>
          <p:nvPr/>
        </p:nvCxnSpPr>
        <p:spPr>
          <a:xfrm>
            <a:off x="5397206" y="3978895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7B9B7F74-12CC-488F-98D2-9C33A4E8301C}"/>
              </a:ext>
            </a:extLst>
          </p:cNvPr>
          <p:cNvSpPr txBox="1"/>
          <p:nvPr/>
        </p:nvSpPr>
        <p:spPr>
          <a:xfrm>
            <a:off x="5691438" y="3545216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4</a:t>
            </a:r>
          </a:p>
        </p:txBody>
      </p: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A8C380BD-629E-4551-86AD-B2AAD25DD02A}"/>
              </a:ext>
            </a:extLst>
          </p:cNvPr>
          <p:cNvCxnSpPr/>
          <p:nvPr/>
        </p:nvCxnSpPr>
        <p:spPr>
          <a:xfrm>
            <a:off x="5397206" y="3704851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>
            <a:extLst>
              <a:ext uri="{FF2B5EF4-FFF2-40B4-BE49-F238E27FC236}">
                <a16:creationId xmlns:a16="http://schemas.microsoft.com/office/drawing/2014/main" id="{47AB46E4-6140-4DB5-9980-553FB4F1145E}"/>
              </a:ext>
            </a:extLst>
          </p:cNvPr>
          <p:cNvSpPr txBox="1"/>
          <p:nvPr/>
        </p:nvSpPr>
        <p:spPr>
          <a:xfrm>
            <a:off x="1403591" y="5370148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8</a:t>
            </a:r>
          </a:p>
        </p:txBody>
      </p: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7EB2D6D5-5787-4AC2-851D-18F272D4623E}"/>
              </a:ext>
            </a:extLst>
          </p:cNvPr>
          <p:cNvCxnSpPr/>
          <p:nvPr/>
        </p:nvCxnSpPr>
        <p:spPr>
          <a:xfrm>
            <a:off x="1065414" y="5309907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C78C7EC0-F350-4970-BF86-B4A0CD125507}"/>
              </a:ext>
            </a:extLst>
          </p:cNvPr>
          <p:cNvSpPr txBox="1"/>
          <p:nvPr/>
        </p:nvSpPr>
        <p:spPr>
          <a:xfrm>
            <a:off x="5648438" y="1524502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10</a:t>
            </a:r>
          </a:p>
        </p:txBody>
      </p: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D912E77D-6801-4E48-9EDE-765BC65EC35B}"/>
              </a:ext>
            </a:extLst>
          </p:cNvPr>
          <p:cNvCxnSpPr/>
          <p:nvPr/>
        </p:nvCxnSpPr>
        <p:spPr>
          <a:xfrm>
            <a:off x="5397206" y="1635711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5ACB1FA9-D36F-445A-B837-A74A45DE18BF}"/>
              </a:ext>
            </a:extLst>
          </p:cNvPr>
          <p:cNvSpPr txBox="1"/>
          <p:nvPr/>
        </p:nvSpPr>
        <p:spPr>
          <a:xfrm>
            <a:off x="1441080" y="2053276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10</a:t>
            </a:r>
          </a:p>
        </p:txBody>
      </p: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45EB3121-F6A9-47FC-847C-4FE5276429E5}"/>
              </a:ext>
            </a:extLst>
          </p:cNvPr>
          <p:cNvCxnSpPr/>
          <p:nvPr/>
        </p:nvCxnSpPr>
        <p:spPr>
          <a:xfrm>
            <a:off x="1065414" y="2074420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CF7054E3-87ED-4440-92F1-CBF4A1C9A633}"/>
              </a:ext>
            </a:extLst>
          </p:cNvPr>
          <p:cNvSpPr txBox="1"/>
          <p:nvPr/>
        </p:nvSpPr>
        <p:spPr>
          <a:xfrm>
            <a:off x="5659555" y="1249896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1</a:t>
            </a:r>
          </a:p>
        </p:txBody>
      </p: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3B8C0CAC-28B4-4EC8-83BA-ED872DDBE5CF}"/>
              </a:ext>
            </a:extLst>
          </p:cNvPr>
          <p:cNvCxnSpPr/>
          <p:nvPr/>
        </p:nvCxnSpPr>
        <p:spPr>
          <a:xfrm>
            <a:off x="5397206" y="1361105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Connector 154">
            <a:extLst>
              <a:ext uri="{FF2B5EF4-FFF2-40B4-BE49-F238E27FC236}">
                <a16:creationId xmlns:a16="http://schemas.microsoft.com/office/drawing/2014/main" id="{36FFE469-EA95-47DC-8279-8781D84DA690}"/>
              </a:ext>
            </a:extLst>
          </p:cNvPr>
          <p:cNvCxnSpPr>
            <a:cxnSpLocks/>
          </p:cNvCxnSpPr>
          <p:nvPr/>
        </p:nvCxnSpPr>
        <p:spPr>
          <a:xfrm flipH="1" flipV="1">
            <a:off x="1402501" y="2073045"/>
            <a:ext cx="108000" cy="8213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id="{803FC693-4FBA-4856-A7AE-AB7EF4B254DC}"/>
              </a:ext>
            </a:extLst>
          </p:cNvPr>
          <p:cNvCxnSpPr>
            <a:cxnSpLocks/>
          </p:cNvCxnSpPr>
          <p:nvPr/>
        </p:nvCxnSpPr>
        <p:spPr>
          <a:xfrm flipH="1" flipV="1">
            <a:off x="1404382" y="5310441"/>
            <a:ext cx="71846" cy="1462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>
            <a:extLst>
              <a:ext uri="{FF2B5EF4-FFF2-40B4-BE49-F238E27FC236}">
                <a16:creationId xmlns:a16="http://schemas.microsoft.com/office/drawing/2014/main" id="{5995684C-E1B2-498B-BD8D-0F24D786929F}"/>
              </a:ext>
            </a:extLst>
          </p:cNvPr>
          <p:cNvCxnSpPr/>
          <p:nvPr/>
        </p:nvCxnSpPr>
        <p:spPr>
          <a:xfrm>
            <a:off x="5397206" y="3965320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TextBox 185">
            <a:extLst>
              <a:ext uri="{FF2B5EF4-FFF2-40B4-BE49-F238E27FC236}">
                <a16:creationId xmlns:a16="http://schemas.microsoft.com/office/drawing/2014/main" id="{F9B2A8FB-532E-478A-806A-B71D8E005D18}"/>
              </a:ext>
            </a:extLst>
          </p:cNvPr>
          <p:cNvSpPr txBox="1"/>
          <p:nvPr/>
        </p:nvSpPr>
        <p:spPr>
          <a:xfrm>
            <a:off x="5686798" y="3763079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CD868238</a:t>
            </a:r>
          </a:p>
        </p:txBody>
      </p:sp>
      <p:cxnSp>
        <p:nvCxnSpPr>
          <p:cNvPr id="187" name="Straight Connector 186">
            <a:extLst>
              <a:ext uri="{FF2B5EF4-FFF2-40B4-BE49-F238E27FC236}">
                <a16:creationId xmlns:a16="http://schemas.microsoft.com/office/drawing/2014/main" id="{CDFA193A-176C-4543-9660-5505C0831B53}"/>
              </a:ext>
            </a:extLst>
          </p:cNvPr>
          <p:cNvCxnSpPr/>
          <p:nvPr/>
        </p:nvCxnSpPr>
        <p:spPr>
          <a:xfrm>
            <a:off x="5397206" y="3892061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TextBox 187">
            <a:extLst>
              <a:ext uri="{FF2B5EF4-FFF2-40B4-BE49-F238E27FC236}">
                <a16:creationId xmlns:a16="http://schemas.microsoft.com/office/drawing/2014/main" id="{A443F439-3121-421F-961A-37233E7662D0}"/>
              </a:ext>
            </a:extLst>
          </p:cNvPr>
          <p:cNvSpPr txBox="1"/>
          <p:nvPr/>
        </p:nvSpPr>
        <p:spPr>
          <a:xfrm>
            <a:off x="5685895" y="3646680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CD866884</a:t>
            </a:r>
          </a:p>
        </p:txBody>
      </p: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EEE26F7D-6AA3-4B74-A88C-F00208FE6CF6}"/>
              </a:ext>
            </a:extLst>
          </p:cNvPr>
          <p:cNvCxnSpPr/>
          <p:nvPr/>
        </p:nvCxnSpPr>
        <p:spPr>
          <a:xfrm>
            <a:off x="5397206" y="3753630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xtBox 189">
            <a:extLst>
              <a:ext uri="{FF2B5EF4-FFF2-40B4-BE49-F238E27FC236}">
                <a16:creationId xmlns:a16="http://schemas.microsoft.com/office/drawing/2014/main" id="{9728386F-D3C7-4931-B007-E3D7D10629DE}"/>
              </a:ext>
            </a:extLst>
          </p:cNvPr>
          <p:cNvSpPr txBox="1"/>
          <p:nvPr/>
        </p:nvSpPr>
        <p:spPr>
          <a:xfrm>
            <a:off x="1374867" y="694789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J318011</a:t>
            </a:r>
          </a:p>
        </p:txBody>
      </p: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97141FA1-2187-41AC-A6CD-936B0B9DE14A}"/>
              </a:ext>
            </a:extLst>
          </p:cNvPr>
          <p:cNvCxnSpPr/>
          <p:nvPr/>
        </p:nvCxnSpPr>
        <p:spPr>
          <a:xfrm>
            <a:off x="1065414" y="82009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Box 192">
            <a:extLst>
              <a:ext uri="{FF2B5EF4-FFF2-40B4-BE49-F238E27FC236}">
                <a16:creationId xmlns:a16="http://schemas.microsoft.com/office/drawing/2014/main" id="{08AE9C97-0CDF-4EFE-B32B-22836B0E05FF}"/>
              </a:ext>
            </a:extLst>
          </p:cNvPr>
          <p:cNvSpPr txBox="1"/>
          <p:nvPr/>
        </p:nvSpPr>
        <p:spPr>
          <a:xfrm>
            <a:off x="1355666" y="4863474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J308545</a:t>
            </a:r>
          </a:p>
        </p:txBody>
      </p:sp>
      <p:cxnSp>
        <p:nvCxnSpPr>
          <p:cNvPr id="194" name="Straight Connector 193">
            <a:extLst>
              <a:ext uri="{FF2B5EF4-FFF2-40B4-BE49-F238E27FC236}">
                <a16:creationId xmlns:a16="http://schemas.microsoft.com/office/drawing/2014/main" id="{08C85EFF-B4CF-4753-8AC6-0023306E3D64}"/>
              </a:ext>
            </a:extLst>
          </p:cNvPr>
          <p:cNvCxnSpPr/>
          <p:nvPr/>
        </p:nvCxnSpPr>
        <p:spPr>
          <a:xfrm>
            <a:off x="1065414" y="4988784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AF432005-43AA-4364-906E-643F2044AF9A}"/>
              </a:ext>
            </a:extLst>
          </p:cNvPr>
          <p:cNvCxnSpPr>
            <a:cxnSpLocks/>
          </p:cNvCxnSpPr>
          <p:nvPr/>
        </p:nvCxnSpPr>
        <p:spPr>
          <a:xfrm rot="15840000" flipV="1">
            <a:off x="5718227" y="4003651"/>
            <a:ext cx="123844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id="{FC798F4A-26D6-465D-A957-D90E099F0679}"/>
              </a:ext>
            </a:extLst>
          </p:cNvPr>
          <p:cNvCxnSpPr>
            <a:cxnSpLocks/>
          </p:cNvCxnSpPr>
          <p:nvPr/>
        </p:nvCxnSpPr>
        <p:spPr>
          <a:xfrm flipH="1" flipV="1">
            <a:off x="5729910" y="3987515"/>
            <a:ext cx="93374" cy="1830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TextBox 172">
            <a:extLst>
              <a:ext uri="{FF2B5EF4-FFF2-40B4-BE49-F238E27FC236}">
                <a16:creationId xmlns:a16="http://schemas.microsoft.com/office/drawing/2014/main" id="{14F98618-EFFB-4D5F-9693-183C10A4F260}"/>
              </a:ext>
            </a:extLst>
          </p:cNvPr>
          <p:cNvSpPr txBox="1"/>
          <p:nvPr/>
        </p:nvSpPr>
        <p:spPr>
          <a:xfrm>
            <a:off x="1325579" y="3969467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0ox1</a:t>
            </a:r>
          </a:p>
        </p:txBody>
      </p:sp>
      <p:cxnSp>
        <p:nvCxnSpPr>
          <p:cNvPr id="174" name="Straight Connector 173">
            <a:extLst>
              <a:ext uri="{FF2B5EF4-FFF2-40B4-BE49-F238E27FC236}">
                <a16:creationId xmlns:a16="http://schemas.microsoft.com/office/drawing/2014/main" id="{485C32A7-CBC1-4A6A-AE1C-A4DC77A41732}"/>
              </a:ext>
            </a:extLst>
          </p:cNvPr>
          <p:cNvCxnSpPr/>
          <p:nvPr/>
        </p:nvCxnSpPr>
        <p:spPr>
          <a:xfrm>
            <a:off x="1065414" y="4083270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TextBox 174">
            <a:extLst>
              <a:ext uri="{FF2B5EF4-FFF2-40B4-BE49-F238E27FC236}">
                <a16:creationId xmlns:a16="http://schemas.microsoft.com/office/drawing/2014/main" id="{99814871-C10A-43B8-867A-5C3BF3B64AA2}"/>
              </a:ext>
            </a:extLst>
          </p:cNvPr>
          <p:cNvSpPr txBox="1"/>
          <p:nvPr/>
        </p:nvSpPr>
        <p:spPr>
          <a:xfrm>
            <a:off x="5647341" y="3091456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0ox4</a:t>
            </a:r>
          </a:p>
        </p:txBody>
      </p: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E0D73BBB-1109-4228-B866-77FA586EB0B8}"/>
              </a:ext>
            </a:extLst>
          </p:cNvPr>
          <p:cNvCxnSpPr/>
          <p:nvPr/>
        </p:nvCxnSpPr>
        <p:spPr>
          <a:xfrm>
            <a:off x="5397206" y="322208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D7E92174-631C-4E7A-ACEF-37F8AD189749}"/>
              </a:ext>
            </a:extLst>
          </p:cNvPr>
          <p:cNvSpPr txBox="1"/>
          <p:nvPr/>
        </p:nvSpPr>
        <p:spPr>
          <a:xfrm>
            <a:off x="50917" y="-17021"/>
            <a:ext cx="1165789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100" b="1" dirty="0"/>
              <a:t>Figure S2</a:t>
            </a:r>
            <a:r>
              <a:rPr lang="en-AU" sz="1100" dirty="0"/>
              <a:t>.  Physical position of reported genes and QTL described in Table S2 associated </a:t>
            </a:r>
            <a:r>
              <a:rPr lang="en-AU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eoptile characteristics (length, width, thickness), shoot length, pre-harvest sprouting, total germination percentage and ratio, grain </a:t>
            </a:r>
            <a:r>
              <a:rPr lang="en-AU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or</a:t>
            </a:r>
            <a:r>
              <a:rPr lang="en-AU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seed longevity </a:t>
            </a:r>
            <a:r>
              <a:rPr lang="en-AU" sz="1100" dirty="0"/>
              <a:t>on wheat chromosomes for QTL seedling emergence.</a:t>
            </a:r>
          </a:p>
        </p:txBody>
      </p:sp>
    </p:spTree>
    <p:extLst>
      <p:ext uri="{BB962C8B-B14F-4D97-AF65-F5344CB8AC3E}">
        <p14:creationId xmlns:p14="http://schemas.microsoft.com/office/powerpoint/2010/main" val="3625385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458D47E-4895-435C-852C-3CAC48CC09E6}"/>
              </a:ext>
            </a:extLst>
          </p:cNvPr>
          <p:cNvGrpSpPr/>
          <p:nvPr/>
        </p:nvGrpSpPr>
        <p:grpSpPr>
          <a:xfrm>
            <a:off x="9592327" y="5251410"/>
            <a:ext cx="1142347" cy="1550617"/>
            <a:chOff x="9592327" y="5251410"/>
            <a:chExt cx="1142347" cy="1550617"/>
          </a:xfrm>
        </p:grpSpPr>
        <p:sp>
          <p:nvSpPr>
            <p:cNvPr id="3" name="Oval 2">
              <a:extLst>
                <a:ext uri="{FF2B5EF4-FFF2-40B4-BE49-F238E27FC236}">
                  <a16:creationId xmlns:a16="http://schemas.microsoft.com/office/drawing/2014/main" id="{93200A71-1E0E-4094-825F-8E72B145ACE3}"/>
                </a:ext>
              </a:extLst>
            </p:cNvPr>
            <p:cNvSpPr/>
            <p:nvPr/>
          </p:nvSpPr>
          <p:spPr>
            <a:xfrm>
              <a:off x="9601327" y="5359194"/>
              <a:ext cx="90000" cy="90000"/>
            </a:xfrm>
            <a:prstGeom prst="ellipse">
              <a:avLst/>
            </a:prstGeom>
            <a:solidFill>
              <a:srgbClr val="70474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4" name="Isosceles Triangle 3">
              <a:extLst>
                <a:ext uri="{FF2B5EF4-FFF2-40B4-BE49-F238E27FC236}">
                  <a16:creationId xmlns:a16="http://schemas.microsoft.com/office/drawing/2014/main" id="{32EE6E8B-C357-41E8-A1BA-5A72C63F5E3C}"/>
                </a:ext>
              </a:extLst>
            </p:cNvPr>
            <p:cNvSpPr/>
            <p:nvPr/>
          </p:nvSpPr>
          <p:spPr>
            <a:xfrm>
              <a:off x="9592327" y="6436293"/>
              <a:ext cx="108000" cy="108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5" name="Diamond 4">
              <a:extLst>
                <a:ext uri="{FF2B5EF4-FFF2-40B4-BE49-F238E27FC236}">
                  <a16:creationId xmlns:a16="http://schemas.microsoft.com/office/drawing/2014/main" id="{7260DC0E-90CC-4BA3-B8CA-139ABDF7342A}"/>
                </a:ext>
              </a:extLst>
            </p:cNvPr>
            <p:cNvSpPr/>
            <p:nvPr/>
          </p:nvSpPr>
          <p:spPr>
            <a:xfrm>
              <a:off x="9592327" y="5534298"/>
              <a:ext cx="108000" cy="108000"/>
            </a:xfrm>
            <a:prstGeom prst="diamond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6" name="Pentagon 5">
              <a:extLst>
                <a:ext uri="{FF2B5EF4-FFF2-40B4-BE49-F238E27FC236}">
                  <a16:creationId xmlns:a16="http://schemas.microsoft.com/office/drawing/2014/main" id="{F7DAEFED-BA04-484D-8C91-62B8F32E13A3}"/>
                </a:ext>
              </a:extLst>
            </p:cNvPr>
            <p:cNvSpPr/>
            <p:nvPr/>
          </p:nvSpPr>
          <p:spPr>
            <a:xfrm>
              <a:off x="9592327" y="6619875"/>
              <a:ext cx="108000" cy="108000"/>
            </a:xfrm>
            <a:prstGeom prst="pentagon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7" name="Hexagon 6">
              <a:extLst>
                <a:ext uri="{FF2B5EF4-FFF2-40B4-BE49-F238E27FC236}">
                  <a16:creationId xmlns:a16="http://schemas.microsoft.com/office/drawing/2014/main" id="{81036C07-17C2-40B5-894C-4BB5687652EB}"/>
                </a:ext>
              </a:extLst>
            </p:cNvPr>
            <p:cNvSpPr/>
            <p:nvPr/>
          </p:nvSpPr>
          <p:spPr>
            <a:xfrm>
              <a:off x="9592327" y="5717877"/>
              <a:ext cx="108000" cy="93600"/>
            </a:xfrm>
            <a:prstGeom prst="hexagon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82D02DB1-658C-4016-9C95-61F10082781C}"/>
                </a:ext>
              </a:extLst>
            </p:cNvPr>
            <p:cNvSpPr/>
            <p:nvPr/>
          </p:nvSpPr>
          <p:spPr>
            <a:xfrm>
              <a:off x="9610327" y="6095610"/>
              <a:ext cx="72000" cy="72000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9" name="Trapezoid 8">
              <a:extLst>
                <a:ext uri="{FF2B5EF4-FFF2-40B4-BE49-F238E27FC236}">
                  <a16:creationId xmlns:a16="http://schemas.microsoft.com/office/drawing/2014/main" id="{FF1AF830-9432-47CD-9239-63255A01B6AC}"/>
                </a:ext>
              </a:extLst>
            </p:cNvPr>
            <p:cNvSpPr/>
            <p:nvPr/>
          </p:nvSpPr>
          <p:spPr>
            <a:xfrm>
              <a:off x="9592327" y="6252714"/>
              <a:ext cx="108000" cy="108000"/>
            </a:xfrm>
            <a:prstGeom prst="trapezoid">
              <a:avLst/>
            </a:prstGeom>
            <a:solidFill>
              <a:srgbClr val="EF19C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71897610-294F-48E1-8AB6-A8673D64ABF7}"/>
                </a:ext>
              </a:extLst>
            </p:cNvPr>
            <p:cNvSpPr/>
            <p:nvPr/>
          </p:nvSpPr>
          <p:spPr>
            <a:xfrm>
              <a:off x="9601327" y="5901456"/>
              <a:ext cx="90000" cy="90000"/>
            </a:xfrm>
            <a:prstGeom prst="ellipse">
              <a:avLst/>
            </a:prstGeom>
            <a:solidFill>
              <a:srgbClr val="FA630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6301FC9-EAD6-4CE8-A0EB-BBA0B6417A91}"/>
                </a:ext>
              </a:extLst>
            </p:cNvPr>
            <p:cNvSpPr txBox="1"/>
            <p:nvPr/>
          </p:nvSpPr>
          <p:spPr>
            <a:xfrm>
              <a:off x="9696449" y="5251410"/>
              <a:ext cx="1038225" cy="1550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AU" sz="800" dirty="0"/>
                <a:t>April 2017 – 9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7 – 12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8 – 16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ne 2018 – 8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ly 2018 – 10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April 2019 – 24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9 – 22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ne 2019 – 11 das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7AB99ED0-499D-4FA0-9901-22553F0114CC}"/>
              </a:ext>
            </a:extLst>
          </p:cNvPr>
          <p:cNvGrpSpPr/>
          <p:nvPr/>
        </p:nvGrpSpPr>
        <p:grpSpPr>
          <a:xfrm>
            <a:off x="2587102" y="195697"/>
            <a:ext cx="272742" cy="1186015"/>
            <a:chOff x="8992024" y="4887089"/>
            <a:chExt cx="272742" cy="1186015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9554CDE-BD84-4E66-97C0-5DB89DDF46F1}"/>
                </a:ext>
              </a:extLst>
            </p:cNvPr>
            <p:cNvSpPr txBox="1"/>
            <p:nvPr/>
          </p:nvSpPr>
          <p:spPr>
            <a:xfrm rot="5400000">
              <a:off x="8540953" y="5349292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ahau-2B.1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CF76A85D-CF44-4176-96D8-2B2DFCF05B06}"/>
                </a:ext>
              </a:extLst>
            </p:cNvPr>
            <p:cNvSpPr/>
            <p:nvPr/>
          </p:nvSpPr>
          <p:spPr>
            <a:xfrm rot="5400000">
              <a:off x="8983024" y="5530812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439ECF47-7BE8-4F28-855E-4E1490929DC0}"/>
              </a:ext>
            </a:extLst>
          </p:cNvPr>
          <p:cNvGrpSpPr/>
          <p:nvPr/>
        </p:nvGrpSpPr>
        <p:grpSpPr>
          <a:xfrm>
            <a:off x="1160402" y="323177"/>
            <a:ext cx="482959" cy="6128828"/>
            <a:chOff x="3811970" y="188953"/>
            <a:chExt cx="482959" cy="6128828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280BB82F-6BFC-4ABE-A95B-CB0E8E9EA315}"/>
                </a:ext>
              </a:extLst>
            </p:cNvPr>
            <p:cNvGrpSpPr/>
            <p:nvPr/>
          </p:nvGrpSpPr>
          <p:grpSpPr>
            <a:xfrm>
              <a:off x="3963449" y="557781"/>
              <a:ext cx="180000" cy="5760000"/>
              <a:chOff x="3768403" y="557781"/>
              <a:chExt cx="504000" cy="5760000"/>
            </a:xfrm>
          </p:grpSpPr>
          <p:sp>
            <p:nvSpPr>
              <p:cNvPr id="29" name="Rectangle: Rounded Corners 28">
                <a:extLst>
                  <a:ext uri="{FF2B5EF4-FFF2-40B4-BE49-F238E27FC236}">
                    <a16:creationId xmlns:a16="http://schemas.microsoft.com/office/drawing/2014/main" id="{75C4F4DD-70E3-49BE-BF91-FFBD97DF64B8}"/>
                  </a:ext>
                </a:extLst>
              </p:cNvPr>
              <p:cNvSpPr/>
              <p:nvPr/>
            </p:nvSpPr>
            <p:spPr>
              <a:xfrm>
                <a:off x="3768403" y="557781"/>
                <a:ext cx="327170" cy="5760000"/>
              </a:xfrm>
              <a:prstGeom prst="round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99297C10-F4E5-45D2-A66E-CF9314C02999}"/>
                  </a:ext>
                </a:extLst>
              </p:cNvPr>
              <p:cNvCxnSpPr/>
              <p:nvPr/>
            </p:nvCxnSpPr>
            <p:spPr>
              <a:xfrm>
                <a:off x="3768403" y="12668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D5F1AD07-39C9-4B7E-89C2-E1627EB1C93D}"/>
                  </a:ext>
                </a:extLst>
              </p:cNvPr>
              <p:cNvCxnSpPr/>
              <p:nvPr/>
            </p:nvCxnSpPr>
            <p:spPr>
              <a:xfrm>
                <a:off x="3768403" y="19907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C9AD9A4F-3878-4F02-B558-050CF96BDF0F}"/>
                  </a:ext>
                </a:extLst>
              </p:cNvPr>
              <p:cNvCxnSpPr/>
              <p:nvPr/>
            </p:nvCxnSpPr>
            <p:spPr>
              <a:xfrm>
                <a:off x="3768403" y="27051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FA0C7AE7-A9E1-4FD3-9248-D1E0F2DEA33E}"/>
                  </a:ext>
                </a:extLst>
              </p:cNvPr>
              <p:cNvCxnSpPr/>
              <p:nvPr/>
            </p:nvCxnSpPr>
            <p:spPr>
              <a:xfrm>
                <a:off x="3768403" y="34290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143CEE36-DDDA-41C8-BA5D-37ED702F03B9}"/>
                  </a:ext>
                </a:extLst>
              </p:cNvPr>
              <p:cNvCxnSpPr/>
              <p:nvPr/>
            </p:nvCxnSpPr>
            <p:spPr>
              <a:xfrm>
                <a:off x="3768403" y="41529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F3554B7C-A964-4A26-BDA4-2234B0DF3CCD}"/>
                  </a:ext>
                </a:extLst>
              </p:cNvPr>
              <p:cNvCxnSpPr/>
              <p:nvPr/>
            </p:nvCxnSpPr>
            <p:spPr>
              <a:xfrm>
                <a:off x="3768403" y="486727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C7FFD5AC-9653-4538-B4FC-D676017AA33A}"/>
                  </a:ext>
                </a:extLst>
              </p:cNvPr>
              <p:cNvCxnSpPr/>
              <p:nvPr/>
            </p:nvCxnSpPr>
            <p:spPr>
              <a:xfrm>
                <a:off x="3768403" y="559117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BFA63484-39EF-43A0-84FB-0E3A011FC656}"/>
                  </a:ext>
                </a:extLst>
              </p:cNvPr>
              <p:cNvCxnSpPr/>
              <p:nvPr/>
            </p:nvCxnSpPr>
            <p:spPr>
              <a:xfrm>
                <a:off x="3768403" y="630555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401823E-8460-4AC6-ACFC-05356A686A16}"/>
                </a:ext>
              </a:extLst>
            </p:cNvPr>
            <p:cNvSpPr txBox="1"/>
            <p:nvPr/>
          </p:nvSpPr>
          <p:spPr>
            <a:xfrm>
              <a:off x="3811970" y="188953"/>
              <a:ext cx="482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2B</a:t>
              </a:r>
            </a:p>
          </p:txBody>
        </p:sp>
      </p:grp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754CF5FE-9319-4356-8101-F51C5AC352A3}"/>
              </a:ext>
            </a:extLst>
          </p:cNvPr>
          <p:cNvCxnSpPr/>
          <p:nvPr/>
        </p:nvCxnSpPr>
        <p:spPr>
          <a:xfrm>
            <a:off x="1302277" y="3972423"/>
            <a:ext cx="340739" cy="0"/>
          </a:xfrm>
          <a:prstGeom prst="line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A9D9F2AD-02F6-40FD-A55E-3D3BF49CD8AA}"/>
              </a:ext>
            </a:extLst>
          </p:cNvPr>
          <p:cNvCxnSpPr/>
          <p:nvPr/>
        </p:nvCxnSpPr>
        <p:spPr>
          <a:xfrm>
            <a:off x="1302277" y="3524748"/>
            <a:ext cx="340739" cy="0"/>
          </a:xfrm>
          <a:prstGeom prst="line">
            <a:avLst/>
          </a:prstGeom>
          <a:ln>
            <a:solidFill>
              <a:srgbClr val="EF19C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69EE231E-3048-46C5-A21C-3112BA35AC89}"/>
              </a:ext>
            </a:extLst>
          </p:cNvPr>
          <p:cNvCxnSpPr/>
          <p:nvPr/>
        </p:nvCxnSpPr>
        <p:spPr>
          <a:xfrm>
            <a:off x="1302277" y="3372348"/>
            <a:ext cx="340739" cy="0"/>
          </a:xfrm>
          <a:prstGeom prst="line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643541A1-AB5E-47CA-8ED5-6D7A2C25EB91}"/>
              </a:ext>
            </a:extLst>
          </p:cNvPr>
          <p:cNvCxnSpPr/>
          <p:nvPr/>
        </p:nvCxnSpPr>
        <p:spPr>
          <a:xfrm>
            <a:off x="1302277" y="3971287"/>
            <a:ext cx="340739" cy="0"/>
          </a:xfrm>
          <a:prstGeom prst="line">
            <a:avLst/>
          </a:prstGeom>
          <a:ln>
            <a:solidFill>
              <a:srgbClr val="EF19C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66B666C7-F012-4791-95F2-689BD3377578}"/>
              </a:ext>
            </a:extLst>
          </p:cNvPr>
          <p:cNvCxnSpPr/>
          <p:nvPr/>
        </p:nvCxnSpPr>
        <p:spPr>
          <a:xfrm>
            <a:off x="1302277" y="4982073"/>
            <a:ext cx="340739" cy="0"/>
          </a:xfrm>
          <a:prstGeom prst="line">
            <a:avLst/>
          </a:prstGeom>
          <a:ln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Isosceles Triangle 112">
            <a:extLst>
              <a:ext uri="{FF2B5EF4-FFF2-40B4-BE49-F238E27FC236}">
                <a16:creationId xmlns:a16="http://schemas.microsoft.com/office/drawing/2014/main" id="{B2DF3E5A-D6AF-47C7-A43D-02081E087DC1}"/>
              </a:ext>
            </a:extLst>
          </p:cNvPr>
          <p:cNvSpPr/>
          <p:nvPr/>
        </p:nvSpPr>
        <p:spPr>
          <a:xfrm>
            <a:off x="1665896" y="4915773"/>
            <a:ext cx="108000" cy="108000"/>
          </a:xfrm>
          <a:prstGeom prst="triangle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4" name="Isosceles Triangle 113">
            <a:extLst>
              <a:ext uri="{FF2B5EF4-FFF2-40B4-BE49-F238E27FC236}">
                <a16:creationId xmlns:a16="http://schemas.microsoft.com/office/drawing/2014/main" id="{BFB2EB1B-38AF-4C15-9649-D549A83FB39C}"/>
              </a:ext>
            </a:extLst>
          </p:cNvPr>
          <p:cNvSpPr/>
          <p:nvPr/>
        </p:nvSpPr>
        <p:spPr>
          <a:xfrm>
            <a:off x="1665896" y="3915648"/>
            <a:ext cx="108000" cy="108000"/>
          </a:xfrm>
          <a:prstGeom prst="triangle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5" name="Isosceles Triangle 114">
            <a:extLst>
              <a:ext uri="{FF2B5EF4-FFF2-40B4-BE49-F238E27FC236}">
                <a16:creationId xmlns:a16="http://schemas.microsoft.com/office/drawing/2014/main" id="{8319DBB1-E199-41F9-BC9E-25BFAE4D9B40}"/>
              </a:ext>
            </a:extLst>
          </p:cNvPr>
          <p:cNvSpPr/>
          <p:nvPr/>
        </p:nvSpPr>
        <p:spPr>
          <a:xfrm>
            <a:off x="1665896" y="3306048"/>
            <a:ext cx="108000" cy="108000"/>
          </a:xfrm>
          <a:prstGeom prst="triangle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6" name="Trapezoid 115">
            <a:extLst>
              <a:ext uri="{FF2B5EF4-FFF2-40B4-BE49-F238E27FC236}">
                <a16:creationId xmlns:a16="http://schemas.microsoft.com/office/drawing/2014/main" id="{2F72D106-7398-4A97-8DE0-832DD378FDD0}"/>
              </a:ext>
            </a:extLst>
          </p:cNvPr>
          <p:cNvSpPr/>
          <p:nvPr/>
        </p:nvSpPr>
        <p:spPr>
          <a:xfrm>
            <a:off x="1819517" y="3915648"/>
            <a:ext cx="108000" cy="108000"/>
          </a:xfrm>
          <a:prstGeom prst="trapezoid">
            <a:avLst/>
          </a:prstGeom>
          <a:solidFill>
            <a:srgbClr val="EF19C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7" name="Trapezoid 116">
            <a:extLst>
              <a:ext uri="{FF2B5EF4-FFF2-40B4-BE49-F238E27FC236}">
                <a16:creationId xmlns:a16="http://schemas.microsoft.com/office/drawing/2014/main" id="{208C4C31-FDD2-4B5B-8E90-211FE920B177}"/>
              </a:ext>
            </a:extLst>
          </p:cNvPr>
          <p:cNvSpPr/>
          <p:nvPr/>
        </p:nvSpPr>
        <p:spPr>
          <a:xfrm>
            <a:off x="1665896" y="3477498"/>
            <a:ext cx="108000" cy="108000"/>
          </a:xfrm>
          <a:prstGeom prst="trapezoid">
            <a:avLst/>
          </a:prstGeom>
          <a:solidFill>
            <a:srgbClr val="EF19C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grpSp>
        <p:nvGrpSpPr>
          <p:cNvPr id="156" name="Group 155">
            <a:extLst>
              <a:ext uri="{FF2B5EF4-FFF2-40B4-BE49-F238E27FC236}">
                <a16:creationId xmlns:a16="http://schemas.microsoft.com/office/drawing/2014/main" id="{5EBEA71B-860F-4988-822F-723640453C93}"/>
              </a:ext>
            </a:extLst>
          </p:cNvPr>
          <p:cNvGrpSpPr/>
          <p:nvPr/>
        </p:nvGrpSpPr>
        <p:grpSpPr>
          <a:xfrm>
            <a:off x="2152385" y="2730357"/>
            <a:ext cx="270410" cy="1003300"/>
            <a:chOff x="8031292" y="603407"/>
            <a:chExt cx="270410" cy="1003300"/>
          </a:xfrm>
        </p:grpSpPr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7AD31FA4-4BF4-485D-86F2-34F9635734E1}"/>
                </a:ext>
              </a:extLst>
            </p:cNvPr>
            <p:cNvSpPr txBox="1"/>
            <p:nvPr/>
          </p:nvSpPr>
          <p:spPr>
            <a:xfrm rot="5400000">
              <a:off x="7669247" y="97425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158" name="Rectangle 157">
              <a:extLst>
                <a:ext uri="{FF2B5EF4-FFF2-40B4-BE49-F238E27FC236}">
                  <a16:creationId xmlns:a16="http://schemas.microsoft.com/office/drawing/2014/main" id="{4857854B-2C9E-42EC-9253-62E2B3F838D1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71" name="Group 170">
            <a:extLst>
              <a:ext uri="{FF2B5EF4-FFF2-40B4-BE49-F238E27FC236}">
                <a16:creationId xmlns:a16="http://schemas.microsoft.com/office/drawing/2014/main" id="{A6D45BBE-78D5-4DB7-B4EE-5ADF706A93F2}"/>
              </a:ext>
            </a:extLst>
          </p:cNvPr>
          <p:cNvGrpSpPr/>
          <p:nvPr/>
        </p:nvGrpSpPr>
        <p:grpSpPr>
          <a:xfrm>
            <a:off x="2406379" y="2727373"/>
            <a:ext cx="270410" cy="1003300"/>
            <a:chOff x="8031292" y="603407"/>
            <a:chExt cx="270410" cy="1003300"/>
          </a:xfrm>
        </p:grpSpPr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E70831A-0B98-449D-8213-040ED20B5E77}"/>
                </a:ext>
              </a:extLst>
            </p:cNvPr>
            <p:cNvSpPr txBox="1"/>
            <p:nvPr/>
          </p:nvSpPr>
          <p:spPr>
            <a:xfrm rot="5400000">
              <a:off x="7669247" y="97425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SL.csiro</a:t>
              </a:r>
            </a:p>
          </p:txBody>
        </p:sp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02FF17F2-EAFA-4649-A873-DE77D5161BD5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77" name="Group 176">
            <a:extLst>
              <a:ext uri="{FF2B5EF4-FFF2-40B4-BE49-F238E27FC236}">
                <a16:creationId xmlns:a16="http://schemas.microsoft.com/office/drawing/2014/main" id="{400221B6-2973-435E-A515-558B8FB0D8E3}"/>
              </a:ext>
            </a:extLst>
          </p:cNvPr>
          <p:cNvGrpSpPr/>
          <p:nvPr/>
        </p:nvGrpSpPr>
        <p:grpSpPr>
          <a:xfrm>
            <a:off x="2637162" y="2731728"/>
            <a:ext cx="270410" cy="1003300"/>
            <a:chOff x="8031292" y="603407"/>
            <a:chExt cx="270410" cy="1003300"/>
          </a:xfrm>
        </p:grpSpPr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EE0B7946-E767-41F6-A6E0-2AD65D7A0FFA}"/>
                </a:ext>
              </a:extLst>
            </p:cNvPr>
            <p:cNvSpPr txBox="1"/>
            <p:nvPr/>
          </p:nvSpPr>
          <p:spPr>
            <a:xfrm rot="5400000">
              <a:off x="7669247" y="97425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W.csiro</a:t>
              </a:r>
            </a:p>
          </p:txBody>
        </p:sp>
        <p:sp>
          <p:nvSpPr>
            <p:cNvPr id="179" name="Rectangle 178">
              <a:extLst>
                <a:ext uri="{FF2B5EF4-FFF2-40B4-BE49-F238E27FC236}">
                  <a16:creationId xmlns:a16="http://schemas.microsoft.com/office/drawing/2014/main" id="{F124A0C3-7F0A-4F22-ABE2-F4FE827A6AE0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83" name="Group 182">
            <a:extLst>
              <a:ext uri="{FF2B5EF4-FFF2-40B4-BE49-F238E27FC236}">
                <a16:creationId xmlns:a16="http://schemas.microsoft.com/office/drawing/2014/main" id="{AB1DB979-72C8-4E52-880B-EED5AC63687B}"/>
              </a:ext>
            </a:extLst>
          </p:cNvPr>
          <p:cNvGrpSpPr/>
          <p:nvPr/>
        </p:nvGrpSpPr>
        <p:grpSpPr>
          <a:xfrm>
            <a:off x="2248705" y="3371811"/>
            <a:ext cx="270410" cy="1003300"/>
            <a:chOff x="8031292" y="777584"/>
            <a:chExt cx="270410" cy="1003300"/>
          </a:xfrm>
        </p:grpSpPr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6D662754-CAA4-4DC7-B514-E863F50C145C}"/>
                </a:ext>
              </a:extLst>
            </p:cNvPr>
            <p:cNvSpPr txBox="1"/>
            <p:nvPr/>
          </p:nvSpPr>
          <p:spPr>
            <a:xfrm rot="5400000">
              <a:off x="7669247" y="1148429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W.csiro</a:t>
              </a:r>
            </a:p>
          </p:txBody>
        </p:sp>
        <p:sp>
          <p:nvSpPr>
            <p:cNvPr id="185" name="Rectangle 184">
              <a:extLst>
                <a:ext uri="{FF2B5EF4-FFF2-40B4-BE49-F238E27FC236}">
                  <a16:creationId xmlns:a16="http://schemas.microsoft.com/office/drawing/2014/main" id="{41AD27AC-6603-4EDA-975A-D3853775C0ED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35" name="Group 234">
            <a:extLst>
              <a:ext uri="{FF2B5EF4-FFF2-40B4-BE49-F238E27FC236}">
                <a16:creationId xmlns:a16="http://schemas.microsoft.com/office/drawing/2014/main" id="{26F7637D-BA91-4E4E-BB0B-80AE83B1323B}"/>
              </a:ext>
            </a:extLst>
          </p:cNvPr>
          <p:cNvGrpSpPr/>
          <p:nvPr/>
        </p:nvGrpSpPr>
        <p:grpSpPr>
          <a:xfrm>
            <a:off x="2520744" y="3524748"/>
            <a:ext cx="287188" cy="1003300"/>
            <a:chOff x="8031292" y="777584"/>
            <a:chExt cx="287188" cy="1003300"/>
          </a:xfrm>
        </p:grpSpPr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9FAB6D7-E030-4CB3-82FA-CFF8B3D69A35}"/>
                </a:ext>
              </a:extLst>
            </p:cNvPr>
            <p:cNvSpPr txBox="1"/>
            <p:nvPr/>
          </p:nvSpPr>
          <p:spPr>
            <a:xfrm rot="5400000">
              <a:off x="7686025" y="1148429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.Lng.ipk.2B.1</a:t>
              </a:r>
            </a:p>
          </p:txBody>
        </p:sp>
        <p:sp>
          <p:nvSpPr>
            <p:cNvPr id="237" name="Rectangle 236">
              <a:extLst>
                <a:ext uri="{FF2B5EF4-FFF2-40B4-BE49-F238E27FC236}">
                  <a16:creationId xmlns:a16="http://schemas.microsoft.com/office/drawing/2014/main" id="{E93D1A7D-9E9E-4B8B-9270-DB6BC1698F62}"/>
                </a:ext>
              </a:extLst>
            </p:cNvPr>
            <p:cNvSpPr/>
            <p:nvPr/>
          </p:nvSpPr>
          <p:spPr>
            <a:xfrm rot="5400000">
              <a:off x="7968292" y="1054379"/>
              <a:ext cx="180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43" name="Group 242">
            <a:extLst>
              <a:ext uri="{FF2B5EF4-FFF2-40B4-BE49-F238E27FC236}">
                <a16:creationId xmlns:a16="http://schemas.microsoft.com/office/drawing/2014/main" id="{BFCE9074-CD1D-415A-A63E-4C7E325DBBE9}"/>
              </a:ext>
            </a:extLst>
          </p:cNvPr>
          <p:cNvGrpSpPr/>
          <p:nvPr/>
        </p:nvGrpSpPr>
        <p:grpSpPr>
          <a:xfrm>
            <a:off x="2104696" y="182968"/>
            <a:ext cx="270410" cy="1003300"/>
            <a:chOff x="8031292" y="424976"/>
            <a:chExt cx="270410" cy="1003300"/>
          </a:xfrm>
        </p:grpSpPr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FA2B96A2-E44F-4F6E-BCA3-FF52AF20F9B4}"/>
                </a:ext>
              </a:extLst>
            </p:cNvPr>
            <p:cNvSpPr txBox="1"/>
            <p:nvPr/>
          </p:nvSpPr>
          <p:spPr>
            <a:xfrm rot="5400000">
              <a:off x="7669247" y="795821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dsu-2BS</a:t>
              </a:r>
            </a:p>
          </p:txBody>
        </p:sp>
        <p:sp>
          <p:nvSpPr>
            <p:cNvPr id="245" name="Rectangle 244">
              <a:extLst>
                <a:ext uri="{FF2B5EF4-FFF2-40B4-BE49-F238E27FC236}">
                  <a16:creationId xmlns:a16="http://schemas.microsoft.com/office/drawing/2014/main" id="{1D326FCF-44F7-43B2-9DC9-73ABBD13F634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61" name="Group 260">
            <a:extLst>
              <a:ext uri="{FF2B5EF4-FFF2-40B4-BE49-F238E27FC236}">
                <a16:creationId xmlns:a16="http://schemas.microsoft.com/office/drawing/2014/main" id="{F40B608F-AA1F-41A4-AF8F-A3E75C835E58}"/>
              </a:ext>
            </a:extLst>
          </p:cNvPr>
          <p:cNvGrpSpPr/>
          <p:nvPr/>
        </p:nvGrpSpPr>
        <p:grpSpPr>
          <a:xfrm>
            <a:off x="2989246" y="1393479"/>
            <a:ext cx="270410" cy="1003300"/>
            <a:chOff x="8031292" y="706643"/>
            <a:chExt cx="270410" cy="1003300"/>
          </a:xfrm>
        </p:grpSpPr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D3126BA6-E236-4252-B845-CFFFCC339395}"/>
                </a:ext>
              </a:extLst>
            </p:cNvPr>
            <p:cNvSpPr txBox="1"/>
            <p:nvPr/>
          </p:nvSpPr>
          <p:spPr>
            <a:xfrm rot="5400000">
              <a:off x="7669247" y="107748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263" name="Rectangle 262">
              <a:extLst>
                <a:ext uri="{FF2B5EF4-FFF2-40B4-BE49-F238E27FC236}">
                  <a16:creationId xmlns:a16="http://schemas.microsoft.com/office/drawing/2014/main" id="{34F83B47-A3D7-47CB-95F4-D5F86E4EBBBD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70" name="Group 269">
            <a:extLst>
              <a:ext uri="{FF2B5EF4-FFF2-40B4-BE49-F238E27FC236}">
                <a16:creationId xmlns:a16="http://schemas.microsoft.com/office/drawing/2014/main" id="{74C85084-F0C7-4A5B-B596-2689EDDB9BEA}"/>
              </a:ext>
            </a:extLst>
          </p:cNvPr>
          <p:cNvGrpSpPr/>
          <p:nvPr/>
        </p:nvGrpSpPr>
        <p:grpSpPr>
          <a:xfrm>
            <a:off x="1663284" y="2134995"/>
            <a:ext cx="270410" cy="1003300"/>
            <a:chOff x="8031292" y="603407"/>
            <a:chExt cx="270410" cy="1003300"/>
          </a:xfrm>
        </p:grpSpPr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2554D553-49B3-4785-8249-17D92D310965}"/>
                </a:ext>
              </a:extLst>
            </p:cNvPr>
            <p:cNvSpPr txBox="1"/>
            <p:nvPr/>
          </p:nvSpPr>
          <p:spPr>
            <a:xfrm rot="5400000">
              <a:off x="7669247" y="97425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SL.csiro</a:t>
              </a:r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B84EF069-E7A7-4C0E-BC1B-CDE764F2D6CB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73" name="Group 272">
            <a:extLst>
              <a:ext uri="{FF2B5EF4-FFF2-40B4-BE49-F238E27FC236}">
                <a16:creationId xmlns:a16="http://schemas.microsoft.com/office/drawing/2014/main" id="{01BEDBA4-8B92-4FF2-8ECB-47EF2F3EA7BB}"/>
              </a:ext>
            </a:extLst>
          </p:cNvPr>
          <p:cNvGrpSpPr/>
          <p:nvPr/>
        </p:nvGrpSpPr>
        <p:grpSpPr>
          <a:xfrm>
            <a:off x="3811402" y="1511822"/>
            <a:ext cx="278799" cy="1003300"/>
            <a:chOff x="8031292" y="603407"/>
            <a:chExt cx="278799" cy="1003300"/>
          </a:xfrm>
        </p:grpSpPr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67B3CA42-5FC2-4309-BD1C-8063E32F3B8E}"/>
                </a:ext>
              </a:extLst>
            </p:cNvPr>
            <p:cNvSpPr txBox="1"/>
            <p:nvPr/>
          </p:nvSpPr>
          <p:spPr>
            <a:xfrm rot="5400000">
              <a:off x="7677636" y="97425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SL.csiro</a:t>
              </a:r>
            </a:p>
          </p:txBody>
        </p:sp>
        <p:sp>
          <p:nvSpPr>
            <p:cNvPr id="275" name="Rectangle 274">
              <a:extLst>
                <a:ext uri="{FF2B5EF4-FFF2-40B4-BE49-F238E27FC236}">
                  <a16:creationId xmlns:a16="http://schemas.microsoft.com/office/drawing/2014/main" id="{83D96C58-204C-4591-B0CE-9F97124030FC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82" name="Group 281">
            <a:extLst>
              <a:ext uri="{FF2B5EF4-FFF2-40B4-BE49-F238E27FC236}">
                <a16:creationId xmlns:a16="http://schemas.microsoft.com/office/drawing/2014/main" id="{85BA8555-2E0F-41FF-AA4A-AE9456AAE3DF}"/>
              </a:ext>
            </a:extLst>
          </p:cNvPr>
          <p:cNvGrpSpPr/>
          <p:nvPr/>
        </p:nvGrpSpPr>
        <p:grpSpPr>
          <a:xfrm>
            <a:off x="2442239" y="5365394"/>
            <a:ext cx="270410" cy="1003300"/>
            <a:chOff x="8031292" y="482757"/>
            <a:chExt cx="270410" cy="1003300"/>
          </a:xfrm>
        </p:grpSpPr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26E573FF-8010-4199-97FA-6DFAC4FA5F60}"/>
                </a:ext>
              </a:extLst>
            </p:cNvPr>
            <p:cNvSpPr txBox="1"/>
            <p:nvPr/>
          </p:nvSpPr>
          <p:spPr>
            <a:xfrm rot="5400000">
              <a:off x="7669247" y="85360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SL.csiro</a:t>
              </a:r>
            </a:p>
          </p:txBody>
        </p:sp>
        <p:sp>
          <p:nvSpPr>
            <p:cNvPr id="284" name="Rectangle 283">
              <a:extLst>
                <a:ext uri="{FF2B5EF4-FFF2-40B4-BE49-F238E27FC236}">
                  <a16:creationId xmlns:a16="http://schemas.microsoft.com/office/drawing/2014/main" id="{05CE2F71-65BC-44B8-81DF-A1C2C88015CA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91" name="Group 290">
            <a:extLst>
              <a:ext uri="{FF2B5EF4-FFF2-40B4-BE49-F238E27FC236}">
                <a16:creationId xmlns:a16="http://schemas.microsoft.com/office/drawing/2014/main" id="{F1543C13-03AC-46A2-AEB9-43C255FB5B67}"/>
              </a:ext>
            </a:extLst>
          </p:cNvPr>
          <p:cNvGrpSpPr/>
          <p:nvPr/>
        </p:nvGrpSpPr>
        <p:grpSpPr>
          <a:xfrm>
            <a:off x="1927874" y="2134557"/>
            <a:ext cx="270410" cy="1003300"/>
            <a:chOff x="8031292" y="595018"/>
            <a:chExt cx="270410" cy="1003300"/>
          </a:xfrm>
        </p:grpSpPr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7A8F68FC-8CB8-441C-84A8-52205B309295}"/>
                </a:ext>
              </a:extLst>
            </p:cNvPr>
            <p:cNvSpPr txBox="1"/>
            <p:nvPr/>
          </p:nvSpPr>
          <p:spPr>
            <a:xfrm rot="5400000">
              <a:off x="7669247" y="965863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W.csiro</a:t>
              </a:r>
            </a:p>
          </p:txBody>
        </p:sp>
        <p:sp>
          <p:nvSpPr>
            <p:cNvPr id="293" name="Rectangle 292">
              <a:extLst>
                <a:ext uri="{FF2B5EF4-FFF2-40B4-BE49-F238E27FC236}">
                  <a16:creationId xmlns:a16="http://schemas.microsoft.com/office/drawing/2014/main" id="{E8686360-40F1-46BA-B275-7A386DE9D43E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97" name="Group 296">
            <a:extLst>
              <a:ext uri="{FF2B5EF4-FFF2-40B4-BE49-F238E27FC236}">
                <a16:creationId xmlns:a16="http://schemas.microsoft.com/office/drawing/2014/main" id="{8D7B6729-5861-4D50-B898-CC2276754BCF}"/>
              </a:ext>
            </a:extLst>
          </p:cNvPr>
          <p:cNvGrpSpPr/>
          <p:nvPr/>
        </p:nvGrpSpPr>
        <p:grpSpPr>
          <a:xfrm>
            <a:off x="3605389" y="709819"/>
            <a:ext cx="270410" cy="1003300"/>
            <a:chOff x="8031292" y="494350"/>
            <a:chExt cx="270410" cy="1003300"/>
          </a:xfrm>
        </p:grpSpPr>
        <p:sp>
          <p:nvSpPr>
            <p:cNvPr id="298" name="TextBox 297">
              <a:extLst>
                <a:ext uri="{FF2B5EF4-FFF2-40B4-BE49-F238E27FC236}">
                  <a16:creationId xmlns:a16="http://schemas.microsoft.com/office/drawing/2014/main" id="{94CF0A71-9912-4BBC-8120-ACAC73FF539E}"/>
                </a:ext>
              </a:extLst>
            </p:cNvPr>
            <p:cNvSpPr txBox="1"/>
            <p:nvPr/>
          </p:nvSpPr>
          <p:spPr>
            <a:xfrm rot="5400000">
              <a:off x="7669247" y="865195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W.csiro</a:t>
              </a:r>
            </a:p>
          </p:txBody>
        </p:sp>
        <p:sp>
          <p:nvSpPr>
            <p:cNvPr id="299" name="Rectangle 298">
              <a:extLst>
                <a:ext uri="{FF2B5EF4-FFF2-40B4-BE49-F238E27FC236}">
                  <a16:creationId xmlns:a16="http://schemas.microsoft.com/office/drawing/2014/main" id="{9C7F6EDE-7427-415D-9C71-6CC20369A498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06" name="Group 305">
            <a:extLst>
              <a:ext uri="{FF2B5EF4-FFF2-40B4-BE49-F238E27FC236}">
                <a16:creationId xmlns:a16="http://schemas.microsoft.com/office/drawing/2014/main" id="{B183E376-9CA2-4D73-A362-7EF9FC7699E2}"/>
              </a:ext>
            </a:extLst>
          </p:cNvPr>
          <p:cNvGrpSpPr/>
          <p:nvPr/>
        </p:nvGrpSpPr>
        <p:grpSpPr>
          <a:xfrm>
            <a:off x="3263299" y="1414479"/>
            <a:ext cx="270410" cy="1003300"/>
            <a:chOff x="8031292" y="610781"/>
            <a:chExt cx="270410" cy="1003300"/>
          </a:xfrm>
        </p:grpSpPr>
        <p:sp>
          <p:nvSpPr>
            <p:cNvPr id="307" name="TextBox 306">
              <a:extLst>
                <a:ext uri="{FF2B5EF4-FFF2-40B4-BE49-F238E27FC236}">
                  <a16:creationId xmlns:a16="http://schemas.microsoft.com/office/drawing/2014/main" id="{A2219830-53DD-461C-9F4A-098C036A6B20}"/>
                </a:ext>
              </a:extLst>
            </p:cNvPr>
            <p:cNvSpPr txBox="1"/>
            <p:nvPr/>
          </p:nvSpPr>
          <p:spPr>
            <a:xfrm rot="5400000">
              <a:off x="7669247" y="981626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T.csiro</a:t>
              </a:r>
            </a:p>
          </p:txBody>
        </p:sp>
        <p:sp>
          <p:nvSpPr>
            <p:cNvPr id="308" name="Rectangle 307">
              <a:extLst>
                <a:ext uri="{FF2B5EF4-FFF2-40B4-BE49-F238E27FC236}">
                  <a16:creationId xmlns:a16="http://schemas.microsoft.com/office/drawing/2014/main" id="{9ECD163A-85C4-4EDC-BA07-96267365280D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09" name="Group 308">
            <a:extLst>
              <a:ext uri="{FF2B5EF4-FFF2-40B4-BE49-F238E27FC236}">
                <a16:creationId xmlns:a16="http://schemas.microsoft.com/office/drawing/2014/main" id="{A17649C9-3458-4672-BB46-10735B2B0E24}"/>
              </a:ext>
            </a:extLst>
          </p:cNvPr>
          <p:cNvGrpSpPr/>
          <p:nvPr/>
        </p:nvGrpSpPr>
        <p:grpSpPr>
          <a:xfrm>
            <a:off x="3537352" y="1478391"/>
            <a:ext cx="270410" cy="1003300"/>
            <a:chOff x="8031292" y="610781"/>
            <a:chExt cx="270410" cy="1003300"/>
          </a:xfrm>
        </p:grpSpPr>
        <p:sp>
          <p:nvSpPr>
            <p:cNvPr id="310" name="TextBox 309">
              <a:extLst>
                <a:ext uri="{FF2B5EF4-FFF2-40B4-BE49-F238E27FC236}">
                  <a16:creationId xmlns:a16="http://schemas.microsoft.com/office/drawing/2014/main" id="{1AA46FE9-9182-4DED-8BCF-37BB5C4668E9}"/>
                </a:ext>
              </a:extLst>
            </p:cNvPr>
            <p:cNvSpPr txBox="1"/>
            <p:nvPr/>
          </p:nvSpPr>
          <p:spPr>
            <a:xfrm rot="5400000">
              <a:off x="7669247" y="981626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err="1">
                  <a:solidFill>
                    <a:schemeClr val="bg1">
                      <a:lumMod val="50000"/>
                    </a:schemeClr>
                  </a:solidFill>
                </a:rPr>
                <a:t>QCWS.csiro</a:t>
              </a:r>
              <a:endParaRPr lang="en-AU" sz="11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311" name="Rectangle 310">
              <a:extLst>
                <a:ext uri="{FF2B5EF4-FFF2-40B4-BE49-F238E27FC236}">
                  <a16:creationId xmlns:a16="http://schemas.microsoft.com/office/drawing/2014/main" id="{29CC9861-311B-4F03-8EAC-1A47B68596B7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12" name="Group 311">
            <a:extLst>
              <a:ext uri="{FF2B5EF4-FFF2-40B4-BE49-F238E27FC236}">
                <a16:creationId xmlns:a16="http://schemas.microsoft.com/office/drawing/2014/main" id="{1FF4A272-5317-4186-9125-B75A8314D1EC}"/>
              </a:ext>
            </a:extLst>
          </p:cNvPr>
          <p:cNvGrpSpPr/>
          <p:nvPr/>
        </p:nvGrpSpPr>
        <p:grpSpPr>
          <a:xfrm>
            <a:off x="3868706" y="494448"/>
            <a:ext cx="280116" cy="1186015"/>
            <a:chOff x="8992024" y="4709306"/>
            <a:chExt cx="280116" cy="1186015"/>
          </a:xfrm>
        </p:grpSpPr>
        <p:sp>
          <p:nvSpPr>
            <p:cNvPr id="313" name="TextBox 312">
              <a:extLst>
                <a:ext uri="{FF2B5EF4-FFF2-40B4-BE49-F238E27FC236}">
                  <a16:creationId xmlns:a16="http://schemas.microsoft.com/office/drawing/2014/main" id="{B975C8A3-1C81-4260-A247-8CE25EA292D8}"/>
                </a:ext>
              </a:extLst>
            </p:cNvPr>
            <p:cNvSpPr txBox="1"/>
            <p:nvPr/>
          </p:nvSpPr>
          <p:spPr>
            <a:xfrm rot="5400000">
              <a:off x="8548327" y="5171509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ahau-2B.2</a:t>
              </a:r>
            </a:p>
          </p:txBody>
        </p:sp>
        <p:sp>
          <p:nvSpPr>
            <p:cNvPr id="314" name="Rectangle 313">
              <a:extLst>
                <a:ext uri="{FF2B5EF4-FFF2-40B4-BE49-F238E27FC236}">
                  <a16:creationId xmlns:a16="http://schemas.microsoft.com/office/drawing/2014/main" id="{778C6664-37CC-470A-A1BB-AFDEAB4721DF}"/>
                </a:ext>
              </a:extLst>
            </p:cNvPr>
            <p:cNvSpPr/>
            <p:nvPr/>
          </p:nvSpPr>
          <p:spPr>
            <a:xfrm rot="5400000">
              <a:off x="8983024" y="5530812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15" name="Group 314">
            <a:extLst>
              <a:ext uri="{FF2B5EF4-FFF2-40B4-BE49-F238E27FC236}">
                <a16:creationId xmlns:a16="http://schemas.microsoft.com/office/drawing/2014/main" id="{8BFEDC81-FD6F-4652-B255-6CC3505E5554}"/>
              </a:ext>
            </a:extLst>
          </p:cNvPr>
          <p:cNvGrpSpPr/>
          <p:nvPr/>
        </p:nvGrpSpPr>
        <p:grpSpPr>
          <a:xfrm>
            <a:off x="3845838" y="5848494"/>
            <a:ext cx="280116" cy="1186015"/>
            <a:chOff x="8992024" y="4978891"/>
            <a:chExt cx="280116" cy="1186015"/>
          </a:xfrm>
        </p:grpSpPr>
        <p:sp>
          <p:nvSpPr>
            <p:cNvPr id="316" name="TextBox 315">
              <a:extLst>
                <a:ext uri="{FF2B5EF4-FFF2-40B4-BE49-F238E27FC236}">
                  <a16:creationId xmlns:a16="http://schemas.microsoft.com/office/drawing/2014/main" id="{13AE772B-85DC-45F0-BB75-8EE4398B4C34}"/>
                </a:ext>
              </a:extLst>
            </p:cNvPr>
            <p:cNvSpPr txBox="1"/>
            <p:nvPr/>
          </p:nvSpPr>
          <p:spPr>
            <a:xfrm rot="5400000">
              <a:off x="8548327" y="5441094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ahau-2B.3</a:t>
              </a:r>
            </a:p>
          </p:txBody>
        </p:sp>
        <p:sp>
          <p:nvSpPr>
            <p:cNvPr id="317" name="Rectangle 316">
              <a:extLst>
                <a:ext uri="{FF2B5EF4-FFF2-40B4-BE49-F238E27FC236}">
                  <a16:creationId xmlns:a16="http://schemas.microsoft.com/office/drawing/2014/main" id="{C78D719D-D21E-44E2-93F5-9F97E2B55B7F}"/>
                </a:ext>
              </a:extLst>
            </p:cNvPr>
            <p:cNvSpPr/>
            <p:nvPr/>
          </p:nvSpPr>
          <p:spPr>
            <a:xfrm rot="5400000">
              <a:off x="8983024" y="5530812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24" name="Group 323">
            <a:extLst>
              <a:ext uri="{FF2B5EF4-FFF2-40B4-BE49-F238E27FC236}">
                <a16:creationId xmlns:a16="http://schemas.microsoft.com/office/drawing/2014/main" id="{48ED22A8-AFFC-49DF-93E9-C2588EEDC706}"/>
              </a:ext>
            </a:extLst>
          </p:cNvPr>
          <p:cNvGrpSpPr/>
          <p:nvPr/>
        </p:nvGrpSpPr>
        <p:grpSpPr>
          <a:xfrm>
            <a:off x="3352486" y="764328"/>
            <a:ext cx="274744" cy="1003300"/>
            <a:chOff x="993068" y="2546583"/>
            <a:chExt cx="274744" cy="1003300"/>
          </a:xfrm>
        </p:grpSpPr>
        <p:sp>
          <p:nvSpPr>
            <p:cNvPr id="325" name="TextBox 324">
              <a:extLst>
                <a:ext uri="{FF2B5EF4-FFF2-40B4-BE49-F238E27FC236}">
                  <a16:creationId xmlns:a16="http://schemas.microsoft.com/office/drawing/2014/main" id="{48B3046E-694A-410F-9781-C2094D15111E}"/>
                </a:ext>
              </a:extLst>
            </p:cNvPr>
            <p:cNvSpPr txBox="1"/>
            <p:nvPr/>
          </p:nvSpPr>
          <p:spPr>
            <a:xfrm rot="5400000">
              <a:off x="635357" y="291742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326" name="Rectangle 325">
              <a:extLst>
                <a:ext uri="{FF2B5EF4-FFF2-40B4-BE49-F238E27FC236}">
                  <a16:creationId xmlns:a16="http://schemas.microsoft.com/office/drawing/2014/main" id="{E89B7783-3D4C-4D1E-B210-ADBE9388AE9C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27" name="Group 326">
            <a:extLst>
              <a:ext uri="{FF2B5EF4-FFF2-40B4-BE49-F238E27FC236}">
                <a16:creationId xmlns:a16="http://schemas.microsoft.com/office/drawing/2014/main" id="{A21CD8BF-2F0C-4076-8031-674B3EABAC3E}"/>
              </a:ext>
            </a:extLst>
          </p:cNvPr>
          <p:cNvGrpSpPr/>
          <p:nvPr/>
        </p:nvGrpSpPr>
        <p:grpSpPr>
          <a:xfrm>
            <a:off x="2710859" y="1318960"/>
            <a:ext cx="274744" cy="1003300"/>
            <a:chOff x="993068" y="2723559"/>
            <a:chExt cx="274744" cy="1003300"/>
          </a:xfrm>
        </p:grpSpPr>
        <p:sp>
          <p:nvSpPr>
            <p:cNvPr id="328" name="TextBox 327">
              <a:extLst>
                <a:ext uri="{FF2B5EF4-FFF2-40B4-BE49-F238E27FC236}">
                  <a16:creationId xmlns:a16="http://schemas.microsoft.com/office/drawing/2014/main" id="{AC670CB5-7976-44AD-82FE-A73109D99FAB}"/>
                </a:ext>
              </a:extLst>
            </p:cNvPr>
            <p:cNvSpPr txBox="1"/>
            <p:nvPr/>
          </p:nvSpPr>
          <p:spPr>
            <a:xfrm rot="5400000">
              <a:off x="635357" y="3094404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329" name="Rectangle 328">
              <a:extLst>
                <a:ext uri="{FF2B5EF4-FFF2-40B4-BE49-F238E27FC236}">
                  <a16:creationId xmlns:a16="http://schemas.microsoft.com/office/drawing/2014/main" id="{1263DC25-59CB-43A9-A9B2-90C4EA526767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30" name="Group 329">
            <a:extLst>
              <a:ext uri="{FF2B5EF4-FFF2-40B4-BE49-F238E27FC236}">
                <a16:creationId xmlns:a16="http://schemas.microsoft.com/office/drawing/2014/main" id="{390B3F26-8968-4781-9071-4BE840C26094}"/>
              </a:ext>
            </a:extLst>
          </p:cNvPr>
          <p:cNvGrpSpPr/>
          <p:nvPr/>
        </p:nvGrpSpPr>
        <p:grpSpPr>
          <a:xfrm>
            <a:off x="3350771" y="5964362"/>
            <a:ext cx="274744" cy="1003300"/>
            <a:chOff x="993068" y="2546583"/>
            <a:chExt cx="274744" cy="1003300"/>
          </a:xfrm>
        </p:grpSpPr>
        <p:sp>
          <p:nvSpPr>
            <p:cNvPr id="331" name="TextBox 330">
              <a:extLst>
                <a:ext uri="{FF2B5EF4-FFF2-40B4-BE49-F238E27FC236}">
                  <a16:creationId xmlns:a16="http://schemas.microsoft.com/office/drawing/2014/main" id="{E0C41292-1EA7-4F9F-85D8-E9508FB84BE1}"/>
                </a:ext>
              </a:extLst>
            </p:cNvPr>
            <p:cNvSpPr txBox="1"/>
            <p:nvPr/>
          </p:nvSpPr>
          <p:spPr>
            <a:xfrm rot="5400000">
              <a:off x="635357" y="291742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332" name="Rectangle 331">
              <a:extLst>
                <a:ext uri="{FF2B5EF4-FFF2-40B4-BE49-F238E27FC236}">
                  <a16:creationId xmlns:a16="http://schemas.microsoft.com/office/drawing/2014/main" id="{5334D2CD-63C1-421C-AE84-D8B1593ADCC3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51" name="Group 350">
            <a:extLst>
              <a:ext uri="{FF2B5EF4-FFF2-40B4-BE49-F238E27FC236}">
                <a16:creationId xmlns:a16="http://schemas.microsoft.com/office/drawing/2014/main" id="{2FE94297-4ED4-416C-B8DD-160C3245A43B}"/>
              </a:ext>
            </a:extLst>
          </p:cNvPr>
          <p:cNvGrpSpPr/>
          <p:nvPr/>
        </p:nvGrpSpPr>
        <p:grpSpPr>
          <a:xfrm>
            <a:off x="3098210" y="5960468"/>
            <a:ext cx="277604" cy="1186015"/>
            <a:chOff x="8994536" y="5887305"/>
            <a:chExt cx="277604" cy="1186015"/>
          </a:xfrm>
        </p:grpSpPr>
        <p:sp>
          <p:nvSpPr>
            <p:cNvPr id="352" name="TextBox 351">
              <a:extLst>
                <a:ext uri="{FF2B5EF4-FFF2-40B4-BE49-F238E27FC236}">
                  <a16:creationId xmlns:a16="http://schemas.microsoft.com/office/drawing/2014/main" id="{CA474208-F5D1-4266-9026-902ED24AB007}"/>
                </a:ext>
              </a:extLst>
            </p:cNvPr>
            <p:cNvSpPr txBox="1"/>
            <p:nvPr/>
          </p:nvSpPr>
          <p:spPr>
            <a:xfrm rot="5400000">
              <a:off x="8548327" y="6349508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fcgr.cas-2B</a:t>
              </a:r>
            </a:p>
          </p:txBody>
        </p:sp>
        <p:sp>
          <p:nvSpPr>
            <p:cNvPr id="353" name="Rectangle 352">
              <a:extLst>
                <a:ext uri="{FF2B5EF4-FFF2-40B4-BE49-F238E27FC236}">
                  <a16:creationId xmlns:a16="http://schemas.microsoft.com/office/drawing/2014/main" id="{05604FFA-43B2-4C43-B88A-15C0EEAE54A2}"/>
                </a:ext>
              </a:extLst>
            </p:cNvPr>
            <p:cNvSpPr/>
            <p:nvPr/>
          </p:nvSpPr>
          <p:spPr>
            <a:xfrm rot="5400000">
              <a:off x="8994536" y="6213835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81" name="Group 380">
            <a:extLst>
              <a:ext uri="{FF2B5EF4-FFF2-40B4-BE49-F238E27FC236}">
                <a16:creationId xmlns:a16="http://schemas.microsoft.com/office/drawing/2014/main" id="{FA8E57A6-082B-4831-A583-600747CBBAD6}"/>
              </a:ext>
            </a:extLst>
          </p:cNvPr>
          <p:cNvGrpSpPr/>
          <p:nvPr/>
        </p:nvGrpSpPr>
        <p:grpSpPr>
          <a:xfrm>
            <a:off x="2162683" y="1222387"/>
            <a:ext cx="277604" cy="1186015"/>
            <a:chOff x="8994536" y="5874331"/>
            <a:chExt cx="277604" cy="1186015"/>
          </a:xfrm>
        </p:grpSpPr>
        <p:sp>
          <p:nvSpPr>
            <p:cNvPr id="382" name="TextBox 381">
              <a:extLst>
                <a:ext uri="{FF2B5EF4-FFF2-40B4-BE49-F238E27FC236}">
                  <a16:creationId xmlns:a16="http://schemas.microsoft.com/office/drawing/2014/main" id="{F83F8D23-7988-4328-A73F-CF51E49315F4}"/>
                </a:ext>
              </a:extLst>
            </p:cNvPr>
            <p:cNvSpPr txBox="1"/>
            <p:nvPr/>
          </p:nvSpPr>
          <p:spPr>
            <a:xfrm rot="5400000">
              <a:off x="8548327" y="6336534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gr.cas-2BS</a:t>
              </a:r>
            </a:p>
          </p:txBody>
        </p:sp>
        <p:sp>
          <p:nvSpPr>
            <p:cNvPr id="383" name="Rectangle 382">
              <a:extLst>
                <a:ext uri="{FF2B5EF4-FFF2-40B4-BE49-F238E27FC236}">
                  <a16:creationId xmlns:a16="http://schemas.microsoft.com/office/drawing/2014/main" id="{E94BFCAA-6362-46FA-8F4B-745BAF0FB9BF}"/>
                </a:ext>
              </a:extLst>
            </p:cNvPr>
            <p:cNvSpPr/>
            <p:nvPr/>
          </p:nvSpPr>
          <p:spPr>
            <a:xfrm rot="5400000">
              <a:off x="8994536" y="607122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93" name="Group 392">
            <a:extLst>
              <a:ext uri="{FF2B5EF4-FFF2-40B4-BE49-F238E27FC236}">
                <a16:creationId xmlns:a16="http://schemas.microsoft.com/office/drawing/2014/main" id="{C0EBFE80-3129-4FBD-9D65-4A86851F7A76}"/>
              </a:ext>
            </a:extLst>
          </p:cNvPr>
          <p:cNvGrpSpPr/>
          <p:nvPr/>
        </p:nvGrpSpPr>
        <p:grpSpPr>
          <a:xfrm>
            <a:off x="2837999" y="360485"/>
            <a:ext cx="287771" cy="1208456"/>
            <a:chOff x="8018622" y="351738"/>
            <a:chExt cx="287771" cy="1208456"/>
          </a:xfrm>
        </p:grpSpPr>
        <p:sp>
          <p:nvSpPr>
            <p:cNvPr id="394" name="TextBox 393">
              <a:extLst>
                <a:ext uri="{FF2B5EF4-FFF2-40B4-BE49-F238E27FC236}">
                  <a16:creationId xmlns:a16="http://schemas.microsoft.com/office/drawing/2014/main" id="{C1596E60-CB4D-4029-908E-54E244AECBFE}"/>
                </a:ext>
              </a:extLst>
            </p:cNvPr>
            <p:cNvSpPr txBox="1"/>
            <p:nvPr/>
          </p:nvSpPr>
          <p:spPr>
            <a:xfrm rot="5400000">
              <a:off x="7558280" y="812080"/>
              <a:ext cx="1208456" cy="2877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icau-2B.1</a:t>
              </a:r>
            </a:p>
          </p:txBody>
        </p:sp>
        <p:sp>
          <p:nvSpPr>
            <p:cNvPr id="395" name="Rectangle 394">
              <a:extLst>
                <a:ext uri="{FF2B5EF4-FFF2-40B4-BE49-F238E27FC236}">
                  <a16:creationId xmlns:a16="http://schemas.microsoft.com/office/drawing/2014/main" id="{5BF447B9-B23A-49CB-8580-A80F835C4CC2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96" name="Group 395">
            <a:extLst>
              <a:ext uri="{FF2B5EF4-FFF2-40B4-BE49-F238E27FC236}">
                <a16:creationId xmlns:a16="http://schemas.microsoft.com/office/drawing/2014/main" id="{ECC63E71-9B44-4699-960E-672AD1D92837}"/>
              </a:ext>
            </a:extLst>
          </p:cNvPr>
          <p:cNvGrpSpPr/>
          <p:nvPr/>
        </p:nvGrpSpPr>
        <p:grpSpPr>
          <a:xfrm>
            <a:off x="3103925" y="365543"/>
            <a:ext cx="270410" cy="1208456"/>
            <a:chOff x="8031292" y="276236"/>
            <a:chExt cx="270410" cy="1208456"/>
          </a:xfrm>
        </p:grpSpPr>
        <p:sp>
          <p:nvSpPr>
            <p:cNvPr id="397" name="TextBox 396">
              <a:extLst>
                <a:ext uri="{FF2B5EF4-FFF2-40B4-BE49-F238E27FC236}">
                  <a16:creationId xmlns:a16="http://schemas.microsoft.com/office/drawing/2014/main" id="{4525CE16-3143-4526-9565-4A80302CBAB9}"/>
                </a:ext>
              </a:extLst>
            </p:cNvPr>
            <p:cNvSpPr txBox="1"/>
            <p:nvPr/>
          </p:nvSpPr>
          <p:spPr>
            <a:xfrm rot="5400000">
              <a:off x="7566669" y="749659"/>
              <a:ext cx="12084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icau-2B.2</a:t>
              </a:r>
            </a:p>
          </p:txBody>
        </p:sp>
        <p:sp>
          <p:nvSpPr>
            <p:cNvPr id="398" name="Rectangle 397">
              <a:extLst>
                <a:ext uri="{FF2B5EF4-FFF2-40B4-BE49-F238E27FC236}">
                  <a16:creationId xmlns:a16="http://schemas.microsoft.com/office/drawing/2014/main" id="{DF205A0E-F241-4566-99BE-2A2D49F7C063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411" name="Group 410">
            <a:extLst>
              <a:ext uri="{FF2B5EF4-FFF2-40B4-BE49-F238E27FC236}">
                <a16:creationId xmlns:a16="http://schemas.microsoft.com/office/drawing/2014/main" id="{A6408926-7C94-4800-AC68-9945C8273ECC}"/>
              </a:ext>
            </a:extLst>
          </p:cNvPr>
          <p:cNvGrpSpPr/>
          <p:nvPr/>
        </p:nvGrpSpPr>
        <p:grpSpPr>
          <a:xfrm>
            <a:off x="3600472" y="5906230"/>
            <a:ext cx="295577" cy="1003300"/>
            <a:chOff x="8031292" y="626582"/>
            <a:chExt cx="295577" cy="1003300"/>
          </a:xfrm>
        </p:grpSpPr>
        <p:sp>
          <p:nvSpPr>
            <p:cNvPr id="412" name="TextBox 411">
              <a:extLst>
                <a:ext uri="{FF2B5EF4-FFF2-40B4-BE49-F238E27FC236}">
                  <a16:creationId xmlns:a16="http://schemas.microsoft.com/office/drawing/2014/main" id="{6319764F-5566-43E7-9A03-A82EC9E66916}"/>
                </a:ext>
              </a:extLst>
            </p:cNvPr>
            <p:cNvSpPr txBox="1"/>
            <p:nvPr/>
          </p:nvSpPr>
          <p:spPr>
            <a:xfrm rot="5400000">
              <a:off x="7694414" y="997427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.Lng.ipk.2B.2</a:t>
              </a:r>
            </a:p>
          </p:txBody>
        </p:sp>
        <p:sp>
          <p:nvSpPr>
            <p:cNvPr id="413" name="Rectangle 412">
              <a:extLst>
                <a:ext uri="{FF2B5EF4-FFF2-40B4-BE49-F238E27FC236}">
                  <a16:creationId xmlns:a16="http://schemas.microsoft.com/office/drawing/2014/main" id="{C30F9086-070B-4784-A08F-0C88901EE2AE}"/>
                </a:ext>
              </a:extLst>
            </p:cNvPr>
            <p:cNvSpPr/>
            <p:nvPr/>
          </p:nvSpPr>
          <p:spPr>
            <a:xfrm rot="5400000">
              <a:off x="8031292" y="991379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447" name="Group 446">
            <a:extLst>
              <a:ext uri="{FF2B5EF4-FFF2-40B4-BE49-F238E27FC236}">
                <a16:creationId xmlns:a16="http://schemas.microsoft.com/office/drawing/2014/main" id="{9A34B016-8E2A-40CD-AC91-F57D7AA5C5E3}"/>
              </a:ext>
            </a:extLst>
          </p:cNvPr>
          <p:cNvGrpSpPr/>
          <p:nvPr/>
        </p:nvGrpSpPr>
        <p:grpSpPr>
          <a:xfrm>
            <a:off x="4109545" y="675499"/>
            <a:ext cx="274743" cy="2025421"/>
            <a:chOff x="993068" y="2546581"/>
            <a:chExt cx="274743" cy="2025421"/>
          </a:xfrm>
        </p:grpSpPr>
        <p:sp>
          <p:nvSpPr>
            <p:cNvPr id="448" name="TextBox 447">
              <a:extLst>
                <a:ext uri="{FF2B5EF4-FFF2-40B4-BE49-F238E27FC236}">
                  <a16:creationId xmlns:a16="http://schemas.microsoft.com/office/drawing/2014/main" id="{8A375890-601A-4861-9732-6B1334416F78}"/>
                </a:ext>
              </a:extLst>
            </p:cNvPr>
            <p:cNvSpPr txBox="1"/>
            <p:nvPr/>
          </p:nvSpPr>
          <p:spPr>
            <a:xfrm rot="5400000">
              <a:off x="124295" y="3428487"/>
              <a:ext cx="20254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TL5.PHS. Albrecht et al. 2015</a:t>
              </a:r>
            </a:p>
          </p:txBody>
        </p:sp>
        <p:sp>
          <p:nvSpPr>
            <p:cNvPr id="449" name="Rectangle 448">
              <a:extLst>
                <a:ext uri="{FF2B5EF4-FFF2-40B4-BE49-F238E27FC236}">
                  <a16:creationId xmlns:a16="http://schemas.microsoft.com/office/drawing/2014/main" id="{71B2D657-0AE5-4D89-99D8-BBF3BD69796A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2E7A31FF-3D26-41BC-AFAE-FEDB70F209AA}"/>
              </a:ext>
            </a:extLst>
          </p:cNvPr>
          <p:cNvCxnSpPr/>
          <p:nvPr/>
        </p:nvCxnSpPr>
        <p:spPr>
          <a:xfrm>
            <a:off x="480325" y="5852572"/>
            <a:ext cx="0" cy="72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>
            <a:extLst>
              <a:ext uri="{FF2B5EF4-FFF2-40B4-BE49-F238E27FC236}">
                <a16:creationId xmlns:a16="http://schemas.microsoft.com/office/drawing/2014/main" id="{146250BF-0D9B-4C6F-9591-74830FE30C6F}"/>
              </a:ext>
            </a:extLst>
          </p:cNvPr>
          <p:cNvSpPr txBox="1"/>
          <p:nvPr/>
        </p:nvSpPr>
        <p:spPr>
          <a:xfrm>
            <a:off x="489930" y="6062651"/>
            <a:ext cx="1178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/>
              <a:t>100 Mb</a:t>
            </a:r>
          </a:p>
        </p:txBody>
      </p:sp>
      <p:grpSp>
        <p:nvGrpSpPr>
          <p:cNvPr id="120" name="Group 119">
            <a:extLst>
              <a:ext uri="{FF2B5EF4-FFF2-40B4-BE49-F238E27FC236}">
                <a16:creationId xmlns:a16="http://schemas.microsoft.com/office/drawing/2014/main" id="{C9C4948C-7EC8-4BCF-9FC2-8706B6BA7436}"/>
              </a:ext>
            </a:extLst>
          </p:cNvPr>
          <p:cNvGrpSpPr/>
          <p:nvPr/>
        </p:nvGrpSpPr>
        <p:grpSpPr>
          <a:xfrm>
            <a:off x="2443930" y="1219600"/>
            <a:ext cx="280116" cy="1186015"/>
            <a:chOff x="8992024" y="5325359"/>
            <a:chExt cx="280116" cy="1186015"/>
          </a:xfrm>
        </p:grpSpPr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67FABE95-DA30-42D2-8A41-274A8AB0C0A0}"/>
                </a:ext>
              </a:extLst>
            </p:cNvPr>
            <p:cNvSpPr txBox="1"/>
            <p:nvPr/>
          </p:nvSpPr>
          <p:spPr>
            <a:xfrm rot="5400000">
              <a:off x="8548327" y="5787562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2B</a:t>
              </a:r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5055C1FE-9D28-43CE-AAA0-A5FBD7EEEE4B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9ED12080-3881-42C2-BC83-2F8385A1D187}"/>
              </a:ext>
            </a:extLst>
          </p:cNvPr>
          <p:cNvGrpSpPr/>
          <p:nvPr/>
        </p:nvGrpSpPr>
        <p:grpSpPr>
          <a:xfrm>
            <a:off x="2323757" y="187676"/>
            <a:ext cx="285226" cy="1240609"/>
            <a:chOff x="8355476" y="455758"/>
            <a:chExt cx="285226" cy="1051392"/>
          </a:xfrm>
        </p:grpSpPr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07568E09-C04D-425B-A484-974EBCA01940}"/>
                </a:ext>
              </a:extLst>
            </p:cNvPr>
            <p:cNvSpPr txBox="1"/>
            <p:nvPr/>
          </p:nvSpPr>
          <p:spPr>
            <a:xfrm rot="5400000">
              <a:off x="7984201" y="850649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hwwgr-2B.1</a:t>
              </a:r>
            </a:p>
          </p:txBody>
        </p:sp>
        <p:sp>
          <p:nvSpPr>
            <p:cNvPr id="125" name="Rectangle 124">
              <a:extLst>
                <a:ext uri="{FF2B5EF4-FFF2-40B4-BE49-F238E27FC236}">
                  <a16:creationId xmlns:a16="http://schemas.microsoft.com/office/drawing/2014/main" id="{919B2F35-55A5-4949-A27C-FBEF31BF06C1}"/>
                </a:ext>
              </a:extLst>
            </p:cNvPr>
            <p:cNvSpPr/>
            <p:nvPr/>
          </p:nvSpPr>
          <p:spPr>
            <a:xfrm rot="5400000">
              <a:off x="8359594" y="935546"/>
              <a:ext cx="45764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26" name="Group 125">
            <a:extLst>
              <a:ext uri="{FF2B5EF4-FFF2-40B4-BE49-F238E27FC236}">
                <a16:creationId xmlns:a16="http://schemas.microsoft.com/office/drawing/2014/main" id="{15E1BC05-95BE-43F1-BF84-EA128BF8AB4E}"/>
              </a:ext>
            </a:extLst>
          </p:cNvPr>
          <p:cNvGrpSpPr/>
          <p:nvPr/>
        </p:nvGrpSpPr>
        <p:grpSpPr>
          <a:xfrm>
            <a:off x="2845650" y="5693696"/>
            <a:ext cx="285236" cy="1240609"/>
            <a:chOff x="8355476" y="664527"/>
            <a:chExt cx="285236" cy="1051392"/>
          </a:xfrm>
        </p:grpSpPr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499C627E-0C6D-4E48-AF12-C811F768CB0B}"/>
                </a:ext>
              </a:extLst>
            </p:cNvPr>
            <p:cNvSpPr txBox="1"/>
            <p:nvPr/>
          </p:nvSpPr>
          <p:spPr>
            <a:xfrm rot="5400000">
              <a:off x="7984211" y="1059418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hwwgr-2B.2</a:t>
              </a:r>
            </a:p>
          </p:txBody>
        </p:sp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id="{6D42884C-A548-4BE7-B810-11FD718CD6BA}"/>
                </a:ext>
              </a:extLst>
            </p:cNvPr>
            <p:cNvSpPr/>
            <p:nvPr/>
          </p:nvSpPr>
          <p:spPr>
            <a:xfrm rot="5400000">
              <a:off x="8359594" y="935546"/>
              <a:ext cx="45764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CB506827-A4D7-4964-909F-E0F9B5855532}"/>
              </a:ext>
            </a:extLst>
          </p:cNvPr>
          <p:cNvCxnSpPr/>
          <p:nvPr/>
        </p:nvCxnSpPr>
        <p:spPr>
          <a:xfrm>
            <a:off x="1308733" y="2136734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>
            <a:extLst>
              <a:ext uri="{FF2B5EF4-FFF2-40B4-BE49-F238E27FC236}">
                <a16:creationId xmlns:a16="http://schemas.microsoft.com/office/drawing/2014/main" id="{C246643E-FF9F-4A1E-BDFD-B2F4D8B7F0EE}"/>
              </a:ext>
            </a:extLst>
          </p:cNvPr>
          <p:cNvSpPr txBox="1"/>
          <p:nvPr/>
        </p:nvSpPr>
        <p:spPr>
          <a:xfrm>
            <a:off x="1589079" y="2008574"/>
            <a:ext cx="668566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Sdr-B1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56F01360-4C65-4CFE-A80F-5C3FC442AEE3}"/>
              </a:ext>
            </a:extLst>
          </p:cNvPr>
          <p:cNvSpPr txBox="1"/>
          <p:nvPr/>
        </p:nvSpPr>
        <p:spPr>
          <a:xfrm>
            <a:off x="1582492" y="5638323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DOG1L-N2</a:t>
            </a:r>
          </a:p>
        </p:txBody>
      </p: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B004AD38-EB26-40D8-B3C3-78E5DB9FA62F}"/>
              </a:ext>
            </a:extLst>
          </p:cNvPr>
          <p:cNvCxnSpPr/>
          <p:nvPr/>
        </p:nvCxnSpPr>
        <p:spPr>
          <a:xfrm>
            <a:off x="1308733" y="5793128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E970A328-242E-4064-87B3-6CD063DF6F81}"/>
              </a:ext>
            </a:extLst>
          </p:cNvPr>
          <p:cNvSpPr txBox="1"/>
          <p:nvPr/>
        </p:nvSpPr>
        <p:spPr>
          <a:xfrm>
            <a:off x="1568215" y="1105969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DOG1L5-1</a:t>
            </a: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436432AC-C2D3-421B-BA72-1383DEA00C07}"/>
              </a:ext>
            </a:extLst>
          </p:cNvPr>
          <p:cNvCxnSpPr/>
          <p:nvPr/>
        </p:nvCxnSpPr>
        <p:spPr>
          <a:xfrm>
            <a:off x="1308733" y="1242578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F13E2728-2A39-45FB-AAE7-EA24934BF5FC}"/>
              </a:ext>
            </a:extLst>
          </p:cNvPr>
          <p:cNvSpPr txBox="1"/>
          <p:nvPr/>
        </p:nvSpPr>
        <p:spPr>
          <a:xfrm>
            <a:off x="1580206" y="660927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CHS</a:t>
            </a:r>
          </a:p>
        </p:txBody>
      </p: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FB41C832-153C-4864-BFAE-ADEAA85098F2}"/>
              </a:ext>
            </a:extLst>
          </p:cNvPr>
          <p:cNvCxnSpPr/>
          <p:nvPr/>
        </p:nvCxnSpPr>
        <p:spPr>
          <a:xfrm>
            <a:off x="1308733" y="797536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>
            <a:extLst>
              <a:ext uri="{FF2B5EF4-FFF2-40B4-BE49-F238E27FC236}">
                <a16:creationId xmlns:a16="http://schemas.microsoft.com/office/drawing/2014/main" id="{794F2EB9-7609-4767-8BF9-42E9583F5AA7}"/>
              </a:ext>
            </a:extLst>
          </p:cNvPr>
          <p:cNvSpPr txBox="1"/>
          <p:nvPr/>
        </p:nvSpPr>
        <p:spPr>
          <a:xfrm>
            <a:off x="1588255" y="5747950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F3H-B1</a:t>
            </a:r>
          </a:p>
        </p:txBody>
      </p: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5D22C475-E38A-4946-B267-CA30FC6D6ECB}"/>
              </a:ext>
            </a:extLst>
          </p:cNvPr>
          <p:cNvCxnSpPr/>
          <p:nvPr/>
        </p:nvCxnSpPr>
        <p:spPr>
          <a:xfrm>
            <a:off x="1308733" y="5848167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4CDCE845-1AF4-47AD-931B-27A514A5DE68}"/>
              </a:ext>
            </a:extLst>
          </p:cNvPr>
          <p:cNvSpPr txBox="1"/>
          <p:nvPr/>
        </p:nvSpPr>
        <p:spPr>
          <a:xfrm>
            <a:off x="1590783" y="4579927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6</a:t>
            </a:r>
          </a:p>
        </p:txBody>
      </p: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F32B5D34-08FB-4696-8389-08250B3C2E2E}"/>
              </a:ext>
            </a:extLst>
          </p:cNvPr>
          <p:cNvCxnSpPr/>
          <p:nvPr/>
        </p:nvCxnSpPr>
        <p:spPr>
          <a:xfrm>
            <a:off x="1308733" y="4727016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>
            <a:extLst>
              <a:ext uri="{FF2B5EF4-FFF2-40B4-BE49-F238E27FC236}">
                <a16:creationId xmlns:a16="http://schemas.microsoft.com/office/drawing/2014/main" id="{9D5B2F97-C4C2-46E7-B2B7-68BE8B4F4EDB}"/>
              </a:ext>
            </a:extLst>
          </p:cNvPr>
          <p:cNvSpPr txBox="1"/>
          <p:nvPr/>
        </p:nvSpPr>
        <p:spPr>
          <a:xfrm>
            <a:off x="1590783" y="6026369"/>
            <a:ext cx="13871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3ox3/TaGA1ox1</a:t>
            </a:r>
          </a:p>
        </p:txBody>
      </p:sp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id="{EFE2BD5D-9153-4392-84A0-4B636CADF458}"/>
              </a:ext>
            </a:extLst>
          </p:cNvPr>
          <p:cNvCxnSpPr/>
          <p:nvPr/>
        </p:nvCxnSpPr>
        <p:spPr>
          <a:xfrm>
            <a:off x="1308733" y="6156628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2E53D6C6-88D0-4E67-BC4C-AA1BBE241943}"/>
              </a:ext>
            </a:extLst>
          </p:cNvPr>
          <p:cNvSpPr txBox="1"/>
          <p:nvPr/>
        </p:nvSpPr>
        <p:spPr>
          <a:xfrm>
            <a:off x="1605490" y="3595310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CD919701</a:t>
            </a:r>
          </a:p>
        </p:txBody>
      </p: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33399657-97EB-45C1-A8C9-93DDB5A35328}"/>
              </a:ext>
            </a:extLst>
          </p:cNvPr>
          <p:cNvCxnSpPr/>
          <p:nvPr/>
        </p:nvCxnSpPr>
        <p:spPr>
          <a:xfrm>
            <a:off x="1308733" y="3724292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Box 146">
            <a:extLst>
              <a:ext uri="{FF2B5EF4-FFF2-40B4-BE49-F238E27FC236}">
                <a16:creationId xmlns:a16="http://schemas.microsoft.com/office/drawing/2014/main" id="{57BD0209-B15B-4A6D-B182-0C8E2E7D9494}"/>
              </a:ext>
            </a:extLst>
          </p:cNvPr>
          <p:cNvSpPr txBox="1"/>
          <p:nvPr/>
        </p:nvSpPr>
        <p:spPr>
          <a:xfrm>
            <a:off x="1598246" y="6212268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J224721</a:t>
            </a:r>
          </a:p>
        </p:txBody>
      </p: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1862A7C9-7747-4FD4-96EF-11DE0E542325}"/>
              </a:ext>
            </a:extLst>
          </p:cNvPr>
          <p:cNvCxnSpPr/>
          <p:nvPr/>
        </p:nvCxnSpPr>
        <p:spPr>
          <a:xfrm>
            <a:off x="1308733" y="6341250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id="{E3C12CA3-166A-46BA-BDF0-9EF02B4B169E}"/>
              </a:ext>
            </a:extLst>
          </p:cNvPr>
          <p:cNvSpPr txBox="1"/>
          <p:nvPr/>
        </p:nvSpPr>
        <p:spPr>
          <a:xfrm>
            <a:off x="1594240" y="4683879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E429383</a:t>
            </a:r>
          </a:p>
        </p:txBody>
      </p: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CE01C65B-AE7F-40F1-9C2B-3DB9BD178C09}"/>
              </a:ext>
            </a:extLst>
          </p:cNvPr>
          <p:cNvCxnSpPr/>
          <p:nvPr/>
        </p:nvCxnSpPr>
        <p:spPr>
          <a:xfrm>
            <a:off x="1308733" y="479073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4FFF589D-14AD-4E96-9A6D-C4DB0E5D9382}"/>
              </a:ext>
            </a:extLst>
          </p:cNvPr>
          <p:cNvSpPr txBox="1"/>
          <p:nvPr/>
        </p:nvSpPr>
        <p:spPr>
          <a:xfrm>
            <a:off x="1594240" y="1789569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M26672</a:t>
            </a:r>
          </a:p>
        </p:txBody>
      </p: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14B853F8-24C8-474E-8729-904AEC85E647}"/>
              </a:ext>
            </a:extLst>
          </p:cNvPr>
          <p:cNvCxnSpPr/>
          <p:nvPr/>
        </p:nvCxnSpPr>
        <p:spPr>
          <a:xfrm>
            <a:off x="1308733" y="1918551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>
            <a:extLst>
              <a:ext uri="{FF2B5EF4-FFF2-40B4-BE49-F238E27FC236}">
                <a16:creationId xmlns:a16="http://schemas.microsoft.com/office/drawing/2014/main" id="{AC79A9C7-BB73-42B2-B9E3-C0C7D3B48E03}"/>
              </a:ext>
            </a:extLst>
          </p:cNvPr>
          <p:cNvSpPr txBox="1"/>
          <p:nvPr/>
        </p:nvSpPr>
        <p:spPr>
          <a:xfrm>
            <a:off x="1605490" y="5155718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J282439</a:t>
            </a:r>
          </a:p>
        </p:txBody>
      </p: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id="{EB912048-435E-4EC4-B479-F25901FEEA5A}"/>
              </a:ext>
            </a:extLst>
          </p:cNvPr>
          <p:cNvCxnSpPr/>
          <p:nvPr/>
        </p:nvCxnSpPr>
        <p:spPr>
          <a:xfrm>
            <a:off x="1308733" y="5284700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8B137C98-22E3-41A0-8BE1-6BEB627764C3}"/>
              </a:ext>
            </a:extLst>
          </p:cNvPr>
          <p:cNvSpPr txBox="1"/>
          <p:nvPr/>
        </p:nvSpPr>
        <p:spPr>
          <a:xfrm>
            <a:off x="1585801" y="3132272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CK202188</a:t>
            </a:r>
          </a:p>
        </p:txBody>
      </p: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3848ABCE-FFA9-4F5D-A6C6-A9D27D99958E}"/>
              </a:ext>
            </a:extLst>
          </p:cNvPr>
          <p:cNvCxnSpPr/>
          <p:nvPr/>
        </p:nvCxnSpPr>
        <p:spPr>
          <a:xfrm>
            <a:off x="1308733" y="3275543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238155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TextBox 307">
            <a:extLst>
              <a:ext uri="{FF2B5EF4-FFF2-40B4-BE49-F238E27FC236}">
                <a16:creationId xmlns:a16="http://schemas.microsoft.com/office/drawing/2014/main" id="{06F29FEA-CFD7-4A80-A5C6-174E9D718E07}"/>
              </a:ext>
            </a:extLst>
          </p:cNvPr>
          <p:cNvSpPr txBox="1"/>
          <p:nvPr/>
        </p:nvSpPr>
        <p:spPr>
          <a:xfrm>
            <a:off x="1348799" y="5142497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AJ612538</a:t>
            </a:r>
          </a:p>
        </p:txBody>
      </p:sp>
      <p:sp>
        <p:nvSpPr>
          <p:cNvPr id="292" name="TextBox 291">
            <a:extLst>
              <a:ext uri="{FF2B5EF4-FFF2-40B4-BE49-F238E27FC236}">
                <a16:creationId xmlns:a16="http://schemas.microsoft.com/office/drawing/2014/main" id="{0D2DF875-A402-4A12-8E5B-B393970F61AA}"/>
              </a:ext>
            </a:extLst>
          </p:cNvPr>
          <p:cNvSpPr txBox="1"/>
          <p:nvPr/>
        </p:nvSpPr>
        <p:spPr>
          <a:xfrm>
            <a:off x="1460620" y="4101124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3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44023138-5B7C-4539-8A54-F69801E82B1B}"/>
              </a:ext>
            </a:extLst>
          </p:cNvPr>
          <p:cNvSpPr txBox="1"/>
          <p:nvPr/>
        </p:nvSpPr>
        <p:spPr>
          <a:xfrm>
            <a:off x="1453847" y="4223799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DOG1L4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2F71F6E-19C5-40CB-8DA1-1F8586A8A63B}"/>
              </a:ext>
            </a:extLst>
          </p:cNvPr>
          <p:cNvGrpSpPr/>
          <p:nvPr/>
        </p:nvGrpSpPr>
        <p:grpSpPr>
          <a:xfrm>
            <a:off x="9592327" y="5251410"/>
            <a:ext cx="1142347" cy="1550617"/>
            <a:chOff x="9592327" y="5251410"/>
            <a:chExt cx="1142347" cy="1550617"/>
          </a:xfrm>
        </p:grpSpPr>
        <p:sp>
          <p:nvSpPr>
            <p:cNvPr id="3" name="Oval 2">
              <a:extLst>
                <a:ext uri="{FF2B5EF4-FFF2-40B4-BE49-F238E27FC236}">
                  <a16:creationId xmlns:a16="http://schemas.microsoft.com/office/drawing/2014/main" id="{1E52DC64-304D-48E4-8610-5136C665FE61}"/>
                </a:ext>
              </a:extLst>
            </p:cNvPr>
            <p:cNvSpPr/>
            <p:nvPr/>
          </p:nvSpPr>
          <p:spPr>
            <a:xfrm>
              <a:off x="9601327" y="5359194"/>
              <a:ext cx="90000" cy="90000"/>
            </a:xfrm>
            <a:prstGeom prst="ellipse">
              <a:avLst/>
            </a:prstGeom>
            <a:solidFill>
              <a:srgbClr val="70474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4" name="Isosceles Triangle 3">
              <a:extLst>
                <a:ext uri="{FF2B5EF4-FFF2-40B4-BE49-F238E27FC236}">
                  <a16:creationId xmlns:a16="http://schemas.microsoft.com/office/drawing/2014/main" id="{28EAC49E-3C2D-4FD9-8417-3D823EB4F827}"/>
                </a:ext>
              </a:extLst>
            </p:cNvPr>
            <p:cNvSpPr/>
            <p:nvPr/>
          </p:nvSpPr>
          <p:spPr>
            <a:xfrm>
              <a:off x="9592327" y="6436293"/>
              <a:ext cx="108000" cy="108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5" name="Diamond 4">
              <a:extLst>
                <a:ext uri="{FF2B5EF4-FFF2-40B4-BE49-F238E27FC236}">
                  <a16:creationId xmlns:a16="http://schemas.microsoft.com/office/drawing/2014/main" id="{67E3F196-C6A4-4214-8E66-4AA4FFC8F2EE}"/>
                </a:ext>
              </a:extLst>
            </p:cNvPr>
            <p:cNvSpPr/>
            <p:nvPr/>
          </p:nvSpPr>
          <p:spPr>
            <a:xfrm>
              <a:off x="9592327" y="5534298"/>
              <a:ext cx="108000" cy="108000"/>
            </a:xfrm>
            <a:prstGeom prst="diamond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6" name="Pentagon 5">
              <a:extLst>
                <a:ext uri="{FF2B5EF4-FFF2-40B4-BE49-F238E27FC236}">
                  <a16:creationId xmlns:a16="http://schemas.microsoft.com/office/drawing/2014/main" id="{E1F3A475-461E-4924-BB30-1A809CAF9571}"/>
                </a:ext>
              </a:extLst>
            </p:cNvPr>
            <p:cNvSpPr/>
            <p:nvPr/>
          </p:nvSpPr>
          <p:spPr>
            <a:xfrm>
              <a:off x="9592327" y="6619875"/>
              <a:ext cx="108000" cy="108000"/>
            </a:xfrm>
            <a:prstGeom prst="pentagon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7" name="Hexagon 6">
              <a:extLst>
                <a:ext uri="{FF2B5EF4-FFF2-40B4-BE49-F238E27FC236}">
                  <a16:creationId xmlns:a16="http://schemas.microsoft.com/office/drawing/2014/main" id="{80CA3F85-E3DC-4B0D-A404-15DBC49AFF11}"/>
                </a:ext>
              </a:extLst>
            </p:cNvPr>
            <p:cNvSpPr/>
            <p:nvPr/>
          </p:nvSpPr>
          <p:spPr>
            <a:xfrm>
              <a:off x="9592327" y="5717877"/>
              <a:ext cx="108000" cy="93600"/>
            </a:xfrm>
            <a:prstGeom prst="hexagon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867CA427-306B-4F9E-B0C2-FEDEA72A903D}"/>
                </a:ext>
              </a:extLst>
            </p:cNvPr>
            <p:cNvSpPr/>
            <p:nvPr/>
          </p:nvSpPr>
          <p:spPr>
            <a:xfrm>
              <a:off x="9610327" y="6095610"/>
              <a:ext cx="72000" cy="72000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9" name="Trapezoid 8">
              <a:extLst>
                <a:ext uri="{FF2B5EF4-FFF2-40B4-BE49-F238E27FC236}">
                  <a16:creationId xmlns:a16="http://schemas.microsoft.com/office/drawing/2014/main" id="{9A89FC98-9B4E-46A9-9567-8D5733A1439B}"/>
                </a:ext>
              </a:extLst>
            </p:cNvPr>
            <p:cNvSpPr/>
            <p:nvPr/>
          </p:nvSpPr>
          <p:spPr>
            <a:xfrm>
              <a:off x="9592327" y="6252714"/>
              <a:ext cx="108000" cy="108000"/>
            </a:xfrm>
            <a:prstGeom prst="trapezoid">
              <a:avLst/>
            </a:prstGeom>
            <a:solidFill>
              <a:srgbClr val="EF19C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AD2F9FDC-CDA6-40FA-9963-29B499B68823}"/>
                </a:ext>
              </a:extLst>
            </p:cNvPr>
            <p:cNvSpPr/>
            <p:nvPr/>
          </p:nvSpPr>
          <p:spPr>
            <a:xfrm>
              <a:off x="9601327" y="5901456"/>
              <a:ext cx="90000" cy="90000"/>
            </a:xfrm>
            <a:prstGeom prst="ellipse">
              <a:avLst/>
            </a:prstGeom>
            <a:solidFill>
              <a:srgbClr val="FA630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5CA2C82-AECE-423C-9475-4DFDC95970BD}"/>
                </a:ext>
              </a:extLst>
            </p:cNvPr>
            <p:cNvSpPr txBox="1"/>
            <p:nvPr/>
          </p:nvSpPr>
          <p:spPr>
            <a:xfrm>
              <a:off x="9696449" y="5251410"/>
              <a:ext cx="1038225" cy="1550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AU" sz="800" dirty="0"/>
                <a:t>April 2017 – 9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7 – 12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8 – 16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ne 2018 – 8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ly 2018 – 10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April 2019 – 24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9 – 22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ne 2019 – 11 das</a:t>
              </a:r>
            </a:p>
          </p:txBody>
        </p:sp>
      </p:grpSp>
      <p:sp>
        <p:nvSpPr>
          <p:cNvPr id="120" name="TextBox 119">
            <a:extLst>
              <a:ext uri="{FF2B5EF4-FFF2-40B4-BE49-F238E27FC236}">
                <a16:creationId xmlns:a16="http://schemas.microsoft.com/office/drawing/2014/main" id="{51F367E6-EAAA-4DA2-B9A3-885AD4DF21A0}"/>
              </a:ext>
            </a:extLst>
          </p:cNvPr>
          <p:cNvSpPr txBox="1"/>
          <p:nvPr/>
        </p:nvSpPr>
        <p:spPr>
          <a:xfrm>
            <a:off x="5786156" y="5552174"/>
            <a:ext cx="11468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ABI3/TaVp-1</a:t>
            </a:r>
          </a:p>
        </p:txBody>
      </p:sp>
      <p:grpSp>
        <p:nvGrpSpPr>
          <p:cNvPr id="121" name="Group 120">
            <a:extLst>
              <a:ext uri="{FF2B5EF4-FFF2-40B4-BE49-F238E27FC236}">
                <a16:creationId xmlns:a16="http://schemas.microsoft.com/office/drawing/2014/main" id="{22877434-DD1B-4068-B08C-FB35109CC0B9}"/>
              </a:ext>
            </a:extLst>
          </p:cNvPr>
          <p:cNvGrpSpPr/>
          <p:nvPr/>
        </p:nvGrpSpPr>
        <p:grpSpPr>
          <a:xfrm>
            <a:off x="5263542" y="188953"/>
            <a:ext cx="482959" cy="6344828"/>
            <a:chOff x="6021770" y="188953"/>
            <a:chExt cx="482959" cy="6344828"/>
          </a:xfrm>
        </p:grpSpPr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BA9A699D-B448-45D5-B384-D1E5F27F9218}"/>
                </a:ext>
              </a:extLst>
            </p:cNvPr>
            <p:cNvGrpSpPr/>
            <p:nvPr/>
          </p:nvGrpSpPr>
          <p:grpSpPr>
            <a:xfrm>
              <a:off x="6173249" y="557781"/>
              <a:ext cx="180000" cy="5976000"/>
              <a:chOff x="244153" y="557781"/>
              <a:chExt cx="504000" cy="5976000"/>
            </a:xfrm>
          </p:grpSpPr>
          <p:sp>
            <p:nvSpPr>
              <p:cNvPr id="124" name="Rectangle: Rounded Corners 123">
                <a:extLst>
                  <a:ext uri="{FF2B5EF4-FFF2-40B4-BE49-F238E27FC236}">
                    <a16:creationId xmlns:a16="http://schemas.microsoft.com/office/drawing/2014/main" id="{0CFB6CC2-FEDB-4D8C-85CF-9ADE616A3DD2}"/>
                  </a:ext>
                </a:extLst>
              </p:cNvPr>
              <p:cNvSpPr/>
              <p:nvPr/>
            </p:nvSpPr>
            <p:spPr>
              <a:xfrm>
                <a:off x="244153" y="557781"/>
                <a:ext cx="327170" cy="5976000"/>
              </a:xfrm>
              <a:prstGeom prst="round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125" name="Straight Connector 124">
                <a:extLst>
                  <a:ext uri="{FF2B5EF4-FFF2-40B4-BE49-F238E27FC236}">
                    <a16:creationId xmlns:a16="http://schemas.microsoft.com/office/drawing/2014/main" id="{5DD91CA7-2180-49B8-996A-FD387607386A}"/>
                  </a:ext>
                </a:extLst>
              </p:cNvPr>
              <p:cNvCxnSpPr/>
              <p:nvPr/>
            </p:nvCxnSpPr>
            <p:spPr>
              <a:xfrm>
                <a:off x="244153" y="12668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Straight Connector 125">
                <a:extLst>
                  <a:ext uri="{FF2B5EF4-FFF2-40B4-BE49-F238E27FC236}">
                    <a16:creationId xmlns:a16="http://schemas.microsoft.com/office/drawing/2014/main" id="{31A47AB3-3E06-4517-98A1-2C04B36AA90A}"/>
                  </a:ext>
                </a:extLst>
              </p:cNvPr>
              <p:cNvCxnSpPr/>
              <p:nvPr/>
            </p:nvCxnSpPr>
            <p:spPr>
              <a:xfrm>
                <a:off x="244153" y="19907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Straight Connector 126">
                <a:extLst>
                  <a:ext uri="{FF2B5EF4-FFF2-40B4-BE49-F238E27FC236}">
                    <a16:creationId xmlns:a16="http://schemas.microsoft.com/office/drawing/2014/main" id="{42847123-0480-4312-B9E5-52AD72955B00}"/>
                  </a:ext>
                </a:extLst>
              </p:cNvPr>
              <p:cNvCxnSpPr/>
              <p:nvPr/>
            </p:nvCxnSpPr>
            <p:spPr>
              <a:xfrm>
                <a:off x="244153" y="27051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>
                <a:extLst>
                  <a:ext uri="{FF2B5EF4-FFF2-40B4-BE49-F238E27FC236}">
                    <a16:creationId xmlns:a16="http://schemas.microsoft.com/office/drawing/2014/main" id="{ACC6B6F3-0C2A-4EEF-A254-3E075951DA88}"/>
                  </a:ext>
                </a:extLst>
              </p:cNvPr>
              <p:cNvCxnSpPr/>
              <p:nvPr/>
            </p:nvCxnSpPr>
            <p:spPr>
              <a:xfrm>
                <a:off x="244153" y="34290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Straight Connector 128">
                <a:extLst>
                  <a:ext uri="{FF2B5EF4-FFF2-40B4-BE49-F238E27FC236}">
                    <a16:creationId xmlns:a16="http://schemas.microsoft.com/office/drawing/2014/main" id="{2C57B676-3D33-40E8-AA91-3DD042FA48B7}"/>
                  </a:ext>
                </a:extLst>
              </p:cNvPr>
              <p:cNvCxnSpPr/>
              <p:nvPr/>
            </p:nvCxnSpPr>
            <p:spPr>
              <a:xfrm>
                <a:off x="244153" y="41529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>
                <a:extLst>
                  <a:ext uri="{FF2B5EF4-FFF2-40B4-BE49-F238E27FC236}">
                    <a16:creationId xmlns:a16="http://schemas.microsoft.com/office/drawing/2014/main" id="{7C114F16-60D6-4133-850E-0A026670616D}"/>
                  </a:ext>
                </a:extLst>
              </p:cNvPr>
              <p:cNvCxnSpPr/>
              <p:nvPr/>
            </p:nvCxnSpPr>
            <p:spPr>
              <a:xfrm>
                <a:off x="244153" y="486727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>
                <a:extLst>
                  <a:ext uri="{FF2B5EF4-FFF2-40B4-BE49-F238E27FC236}">
                    <a16:creationId xmlns:a16="http://schemas.microsoft.com/office/drawing/2014/main" id="{A406E1EB-100A-4D70-A979-5DEDAA739EC4}"/>
                  </a:ext>
                </a:extLst>
              </p:cNvPr>
              <p:cNvCxnSpPr/>
              <p:nvPr/>
            </p:nvCxnSpPr>
            <p:spPr>
              <a:xfrm>
                <a:off x="244153" y="559117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Straight Connector 131">
                <a:extLst>
                  <a:ext uri="{FF2B5EF4-FFF2-40B4-BE49-F238E27FC236}">
                    <a16:creationId xmlns:a16="http://schemas.microsoft.com/office/drawing/2014/main" id="{339ECCC3-C126-46BB-9832-52B96D35BEBD}"/>
                  </a:ext>
                </a:extLst>
              </p:cNvPr>
              <p:cNvCxnSpPr/>
              <p:nvPr/>
            </p:nvCxnSpPr>
            <p:spPr>
              <a:xfrm>
                <a:off x="244153" y="630555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7831CA70-41EE-4725-840E-7E99F434571F}"/>
                </a:ext>
              </a:extLst>
            </p:cNvPr>
            <p:cNvSpPr txBox="1"/>
            <p:nvPr/>
          </p:nvSpPr>
          <p:spPr>
            <a:xfrm>
              <a:off x="6021770" y="188953"/>
              <a:ext cx="482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3B</a:t>
              </a:r>
            </a:p>
          </p:txBody>
        </p:sp>
      </p:grpSp>
      <p:grpSp>
        <p:nvGrpSpPr>
          <p:cNvPr id="133" name="Group 132">
            <a:extLst>
              <a:ext uri="{FF2B5EF4-FFF2-40B4-BE49-F238E27FC236}">
                <a16:creationId xmlns:a16="http://schemas.microsoft.com/office/drawing/2014/main" id="{2C8A1FAD-B7E1-4422-9440-5EB9AB29917A}"/>
              </a:ext>
            </a:extLst>
          </p:cNvPr>
          <p:cNvGrpSpPr/>
          <p:nvPr/>
        </p:nvGrpSpPr>
        <p:grpSpPr>
          <a:xfrm>
            <a:off x="913570" y="188953"/>
            <a:ext cx="482959" cy="5768828"/>
            <a:chOff x="4726370" y="188953"/>
            <a:chExt cx="482959" cy="5768828"/>
          </a:xfrm>
        </p:grpSpPr>
        <p:grpSp>
          <p:nvGrpSpPr>
            <p:cNvPr id="134" name="Group 133">
              <a:extLst>
                <a:ext uri="{FF2B5EF4-FFF2-40B4-BE49-F238E27FC236}">
                  <a16:creationId xmlns:a16="http://schemas.microsoft.com/office/drawing/2014/main" id="{B436EF3E-FC27-4C4A-AC9E-8EF58CAB4B2A}"/>
                </a:ext>
              </a:extLst>
            </p:cNvPr>
            <p:cNvGrpSpPr/>
            <p:nvPr/>
          </p:nvGrpSpPr>
          <p:grpSpPr>
            <a:xfrm>
              <a:off x="4877849" y="557781"/>
              <a:ext cx="180000" cy="5400000"/>
              <a:chOff x="4682803" y="557781"/>
              <a:chExt cx="504000" cy="5400000"/>
            </a:xfrm>
          </p:grpSpPr>
          <p:sp>
            <p:nvSpPr>
              <p:cNvPr id="136" name="Rectangle: Rounded Corners 135">
                <a:extLst>
                  <a:ext uri="{FF2B5EF4-FFF2-40B4-BE49-F238E27FC236}">
                    <a16:creationId xmlns:a16="http://schemas.microsoft.com/office/drawing/2014/main" id="{9CBD5A29-4FFC-4E4D-B537-E4D88154CA14}"/>
                  </a:ext>
                </a:extLst>
              </p:cNvPr>
              <p:cNvSpPr/>
              <p:nvPr/>
            </p:nvSpPr>
            <p:spPr>
              <a:xfrm>
                <a:off x="4682803" y="557781"/>
                <a:ext cx="327170" cy="5400000"/>
              </a:xfrm>
              <a:prstGeom prst="round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137" name="Straight Connector 136">
                <a:extLst>
                  <a:ext uri="{FF2B5EF4-FFF2-40B4-BE49-F238E27FC236}">
                    <a16:creationId xmlns:a16="http://schemas.microsoft.com/office/drawing/2014/main" id="{E798B3E4-7794-4826-B6C8-0E92B2ECF8D0}"/>
                  </a:ext>
                </a:extLst>
              </p:cNvPr>
              <p:cNvCxnSpPr/>
              <p:nvPr/>
            </p:nvCxnSpPr>
            <p:spPr>
              <a:xfrm>
                <a:off x="4682803" y="12668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Straight Connector 137">
                <a:extLst>
                  <a:ext uri="{FF2B5EF4-FFF2-40B4-BE49-F238E27FC236}">
                    <a16:creationId xmlns:a16="http://schemas.microsoft.com/office/drawing/2014/main" id="{6CDDD02A-06CD-42D5-84AA-54DBB91A8C99}"/>
                  </a:ext>
                </a:extLst>
              </p:cNvPr>
              <p:cNvCxnSpPr/>
              <p:nvPr/>
            </p:nvCxnSpPr>
            <p:spPr>
              <a:xfrm>
                <a:off x="4682803" y="19907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Straight Connector 138">
                <a:extLst>
                  <a:ext uri="{FF2B5EF4-FFF2-40B4-BE49-F238E27FC236}">
                    <a16:creationId xmlns:a16="http://schemas.microsoft.com/office/drawing/2014/main" id="{D6198201-0E83-4FCE-8E14-3C05601C5A3F}"/>
                  </a:ext>
                </a:extLst>
              </p:cNvPr>
              <p:cNvCxnSpPr/>
              <p:nvPr/>
            </p:nvCxnSpPr>
            <p:spPr>
              <a:xfrm>
                <a:off x="4682803" y="27051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Straight Connector 139">
                <a:extLst>
                  <a:ext uri="{FF2B5EF4-FFF2-40B4-BE49-F238E27FC236}">
                    <a16:creationId xmlns:a16="http://schemas.microsoft.com/office/drawing/2014/main" id="{532D72E2-072C-49AB-A703-CE1C879FF460}"/>
                  </a:ext>
                </a:extLst>
              </p:cNvPr>
              <p:cNvCxnSpPr/>
              <p:nvPr/>
            </p:nvCxnSpPr>
            <p:spPr>
              <a:xfrm>
                <a:off x="4682803" y="34290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Straight Connector 140">
                <a:extLst>
                  <a:ext uri="{FF2B5EF4-FFF2-40B4-BE49-F238E27FC236}">
                    <a16:creationId xmlns:a16="http://schemas.microsoft.com/office/drawing/2014/main" id="{2CD0BDFE-55AD-4E11-B450-86B8F7F7574F}"/>
                  </a:ext>
                </a:extLst>
              </p:cNvPr>
              <p:cNvCxnSpPr/>
              <p:nvPr/>
            </p:nvCxnSpPr>
            <p:spPr>
              <a:xfrm>
                <a:off x="4682803" y="41529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Straight Connector 141">
                <a:extLst>
                  <a:ext uri="{FF2B5EF4-FFF2-40B4-BE49-F238E27FC236}">
                    <a16:creationId xmlns:a16="http://schemas.microsoft.com/office/drawing/2014/main" id="{796E25B1-2639-4095-880D-521B666BCFA6}"/>
                  </a:ext>
                </a:extLst>
              </p:cNvPr>
              <p:cNvCxnSpPr/>
              <p:nvPr/>
            </p:nvCxnSpPr>
            <p:spPr>
              <a:xfrm>
                <a:off x="4682803" y="486727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Straight Connector 142">
                <a:extLst>
                  <a:ext uri="{FF2B5EF4-FFF2-40B4-BE49-F238E27FC236}">
                    <a16:creationId xmlns:a16="http://schemas.microsoft.com/office/drawing/2014/main" id="{9D21BCE4-546D-4694-B48B-54FB8CED5490}"/>
                  </a:ext>
                </a:extLst>
              </p:cNvPr>
              <p:cNvCxnSpPr/>
              <p:nvPr/>
            </p:nvCxnSpPr>
            <p:spPr>
              <a:xfrm>
                <a:off x="4682803" y="559117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14888646-52BB-4729-919A-53F93502288D}"/>
                </a:ext>
              </a:extLst>
            </p:cNvPr>
            <p:cNvSpPr txBox="1"/>
            <p:nvPr/>
          </p:nvSpPr>
          <p:spPr>
            <a:xfrm>
              <a:off x="4726370" y="188953"/>
              <a:ext cx="482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3A</a:t>
              </a:r>
            </a:p>
          </p:txBody>
        </p:sp>
      </p:grp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F1FE030F-0D18-44D1-95FB-9EBF7A48ACFC}"/>
              </a:ext>
            </a:extLst>
          </p:cNvPr>
          <p:cNvCxnSpPr/>
          <p:nvPr/>
        </p:nvCxnSpPr>
        <p:spPr>
          <a:xfrm>
            <a:off x="5403311" y="5800349"/>
            <a:ext cx="340739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Diamond 144">
            <a:extLst>
              <a:ext uri="{FF2B5EF4-FFF2-40B4-BE49-F238E27FC236}">
                <a16:creationId xmlns:a16="http://schemas.microsoft.com/office/drawing/2014/main" id="{0E9F4D5D-4D1C-4D8D-86DB-9CA781680417}"/>
              </a:ext>
            </a:extLst>
          </p:cNvPr>
          <p:cNvSpPr/>
          <p:nvPr/>
        </p:nvSpPr>
        <p:spPr>
          <a:xfrm>
            <a:off x="5769031" y="5744572"/>
            <a:ext cx="108000" cy="108000"/>
          </a:xfrm>
          <a:prstGeom prst="diamond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id="{BFD28E1E-C095-46EF-852A-4A0F45571D16}"/>
              </a:ext>
            </a:extLst>
          </p:cNvPr>
          <p:cNvCxnSpPr/>
          <p:nvPr/>
        </p:nvCxnSpPr>
        <p:spPr>
          <a:xfrm>
            <a:off x="5400232" y="4238249"/>
            <a:ext cx="340739" cy="0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Diamond 146">
            <a:extLst>
              <a:ext uri="{FF2B5EF4-FFF2-40B4-BE49-F238E27FC236}">
                <a16:creationId xmlns:a16="http://schemas.microsoft.com/office/drawing/2014/main" id="{660D9CEB-0530-4406-85C1-4E58FD80D091}"/>
              </a:ext>
            </a:extLst>
          </p:cNvPr>
          <p:cNvSpPr/>
          <p:nvPr/>
        </p:nvSpPr>
        <p:spPr>
          <a:xfrm>
            <a:off x="5765952" y="4182472"/>
            <a:ext cx="108000" cy="108000"/>
          </a:xfrm>
          <a:prstGeom prst="diamond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33B9A70C-1470-45C9-BBE2-016AB0540DF0}"/>
              </a:ext>
            </a:extLst>
          </p:cNvPr>
          <p:cNvCxnSpPr/>
          <p:nvPr/>
        </p:nvCxnSpPr>
        <p:spPr>
          <a:xfrm>
            <a:off x="5403311" y="5530979"/>
            <a:ext cx="340739" cy="0"/>
          </a:xfrm>
          <a:prstGeom prst="line">
            <a:avLst/>
          </a:prstGeom>
          <a:ln>
            <a:solidFill>
              <a:srgbClr val="FA630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Oval 148">
            <a:extLst>
              <a:ext uri="{FF2B5EF4-FFF2-40B4-BE49-F238E27FC236}">
                <a16:creationId xmlns:a16="http://schemas.microsoft.com/office/drawing/2014/main" id="{4C867C3A-3669-4A15-BB81-A8CD03E729C8}"/>
              </a:ext>
            </a:extLst>
          </p:cNvPr>
          <p:cNvSpPr/>
          <p:nvPr/>
        </p:nvSpPr>
        <p:spPr>
          <a:xfrm>
            <a:off x="5769031" y="5495538"/>
            <a:ext cx="90000" cy="90000"/>
          </a:xfrm>
          <a:prstGeom prst="ellipse">
            <a:avLst/>
          </a:prstGeom>
          <a:solidFill>
            <a:srgbClr val="FA630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3E281513-3FD2-4E87-A81B-2B994B23EFAD}"/>
              </a:ext>
            </a:extLst>
          </p:cNvPr>
          <p:cNvCxnSpPr/>
          <p:nvPr/>
        </p:nvCxnSpPr>
        <p:spPr>
          <a:xfrm>
            <a:off x="1057615" y="4464179"/>
            <a:ext cx="340739" cy="0"/>
          </a:xfrm>
          <a:prstGeom prst="line">
            <a:avLst/>
          </a:prstGeom>
          <a:ln>
            <a:solidFill>
              <a:srgbClr val="FA630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Oval 150">
            <a:extLst>
              <a:ext uri="{FF2B5EF4-FFF2-40B4-BE49-F238E27FC236}">
                <a16:creationId xmlns:a16="http://schemas.microsoft.com/office/drawing/2014/main" id="{AF767347-891B-488D-92BF-C83AAE674191}"/>
              </a:ext>
            </a:extLst>
          </p:cNvPr>
          <p:cNvSpPr/>
          <p:nvPr/>
        </p:nvSpPr>
        <p:spPr>
          <a:xfrm>
            <a:off x="1434555" y="4428738"/>
            <a:ext cx="90000" cy="90000"/>
          </a:xfrm>
          <a:prstGeom prst="ellipse">
            <a:avLst/>
          </a:prstGeom>
          <a:solidFill>
            <a:srgbClr val="FA630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27507037-0C97-4671-9541-D4CDBFC79FDB}"/>
              </a:ext>
            </a:extLst>
          </p:cNvPr>
          <p:cNvCxnSpPr/>
          <p:nvPr/>
        </p:nvCxnSpPr>
        <p:spPr>
          <a:xfrm>
            <a:off x="5408339" y="555162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6896A6BF-1323-4E3E-B27E-250DC41F28F5}"/>
              </a:ext>
            </a:extLst>
          </p:cNvPr>
          <p:cNvCxnSpPr>
            <a:cxnSpLocks/>
          </p:cNvCxnSpPr>
          <p:nvPr/>
        </p:nvCxnSpPr>
        <p:spPr>
          <a:xfrm rot="15420000" flipV="1">
            <a:off x="5733056" y="5574949"/>
            <a:ext cx="13320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0084EB7C-EC0C-44D1-A1DC-DFE9269F540A}"/>
              </a:ext>
            </a:extLst>
          </p:cNvPr>
          <p:cNvGrpSpPr/>
          <p:nvPr/>
        </p:nvGrpSpPr>
        <p:grpSpPr>
          <a:xfrm>
            <a:off x="6517020" y="4725410"/>
            <a:ext cx="285158" cy="1003300"/>
            <a:chOff x="8031292" y="378962"/>
            <a:chExt cx="285158" cy="1003300"/>
          </a:xfrm>
        </p:grpSpPr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C8D1BAB9-7B8D-435F-AAF5-2FBBC472F6BB}"/>
                </a:ext>
              </a:extLst>
            </p:cNvPr>
            <p:cNvSpPr txBox="1"/>
            <p:nvPr/>
          </p:nvSpPr>
          <p:spPr>
            <a:xfrm rot="5400000">
              <a:off x="7683995" y="749807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156" name="Rectangle 155">
              <a:extLst>
                <a:ext uri="{FF2B5EF4-FFF2-40B4-BE49-F238E27FC236}">
                  <a16:creationId xmlns:a16="http://schemas.microsoft.com/office/drawing/2014/main" id="{C162A585-2879-4FF0-8B01-5B458A99A30B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9E27DBB6-6E43-48DE-9190-A02FC37896BA}"/>
              </a:ext>
            </a:extLst>
          </p:cNvPr>
          <p:cNvCxnSpPr/>
          <p:nvPr/>
        </p:nvCxnSpPr>
        <p:spPr>
          <a:xfrm>
            <a:off x="5408339" y="5490215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055CB6E7-DFC8-4742-9B51-D94549C7032E}"/>
              </a:ext>
            </a:extLst>
          </p:cNvPr>
          <p:cNvCxnSpPr>
            <a:cxnSpLocks/>
          </p:cNvCxnSpPr>
          <p:nvPr/>
        </p:nvCxnSpPr>
        <p:spPr>
          <a:xfrm rot="10440000" flipV="1">
            <a:off x="5741695" y="5412905"/>
            <a:ext cx="123844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TextBox 158">
            <a:extLst>
              <a:ext uri="{FF2B5EF4-FFF2-40B4-BE49-F238E27FC236}">
                <a16:creationId xmlns:a16="http://schemas.microsoft.com/office/drawing/2014/main" id="{EA7F121C-67FA-46AA-B684-FF97493DBDF4}"/>
              </a:ext>
            </a:extLst>
          </p:cNvPr>
          <p:cNvSpPr txBox="1"/>
          <p:nvPr/>
        </p:nvSpPr>
        <p:spPr>
          <a:xfrm>
            <a:off x="5790132" y="5287762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Q169109</a:t>
            </a:r>
          </a:p>
        </p:txBody>
      </p:sp>
      <p:grpSp>
        <p:nvGrpSpPr>
          <p:cNvPr id="160" name="Group 159">
            <a:extLst>
              <a:ext uri="{FF2B5EF4-FFF2-40B4-BE49-F238E27FC236}">
                <a16:creationId xmlns:a16="http://schemas.microsoft.com/office/drawing/2014/main" id="{54F61A18-C8B2-4A62-8CC9-04ED75E3D684}"/>
              </a:ext>
            </a:extLst>
          </p:cNvPr>
          <p:cNvGrpSpPr/>
          <p:nvPr/>
        </p:nvGrpSpPr>
        <p:grpSpPr>
          <a:xfrm>
            <a:off x="5905394" y="3543384"/>
            <a:ext cx="274744" cy="1003300"/>
            <a:chOff x="993068" y="2355624"/>
            <a:chExt cx="274744" cy="1003300"/>
          </a:xfrm>
        </p:grpSpPr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6FB9F276-D352-408A-AE18-93090583CD51}"/>
                </a:ext>
              </a:extLst>
            </p:cNvPr>
            <p:cNvSpPr txBox="1"/>
            <p:nvPr/>
          </p:nvSpPr>
          <p:spPr>
            <a:xfrm rot="5400000">
              <a:off x="635357" y="2726469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56CC16FE-9541-484B-A4B9-F1A96DD0C8BF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63" name="Group 162">
            <a:extLst>
              <a:ext uri="{FF2B5EF4-FFF2-40B4-BE49-F238E27FC236}">
                <a16:creationId xmlns:a16="http://schemas.microsoft.com/office/drawing/2014/main" id="{ECA54C36-BEBF-4BB0-B596-05129EA1ED7E}"/>
              </a:ext>
            </a:extLst>
          </p:cNvPr>
          <p:cNvGrpSpPr/>
          <p:nvPr/>
        </p:nvGrpSpPr>
        <p:grpSpPr>
          <a:xfrm>
            <a:off x="6490552" y="5750636"/>
            <a:ext cx="285158" cy="1051392"/>
            <a:chOff x="8355476" y="798751"/>
            <a:chExt cx="285158" cy="1051392"/>
          </a:xfrm>
        </p:grpSpPr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572EC7C6-C740-431F-9159-752887C19AF3}"/>
                </a:ext>
              </a:extLst>
            </p:cNvPr>
            <p:cNvSpPr txBox="1"/>
            <p:nvPr/>
          </p:nvSpPr>
          <p:spPr>
            <a:xfrm rot="5400000">
              <a:off x="7984133" y="1193642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gc.hwwgr-3B</a:t>
              </a:r>
            </a:p>
          </p:txBody>
        </p:sp>
        <p:sp>
          <p:nvSpPr>
            <p:cNvPr id="165" name="Rectangle 164">
              <a:extLst>
                <a:ext uri="{FF2B5EF4-FFF2-40B4-BE49-F238E27FC236}">
                  <a16:creationId xmlns:a16="http://schemas.microsoft.com/office/drawing/2014/main" id="{A8E5CAAB-78F9-4C5B-9B1C-C9A1C6B63790}"/>
                </a:ext>
              </a:extLst>
            </p:cNvPr>
            <p:cNvSpPr/>
            <p:nvPr/>
          </p:nvSpPr>
          <p:spPr>
            <a:xfrm rot="5400000">
              <a:off x="8332076" y="963064"/>
              <a:ext cx="1008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166" name="TextBox 165">
            <a:extLst>
              <a:ext uri="{FF2B5EF4-FFF2-40B4-BE49-F238E27FC236}">
                <a16:creationId xmlns:a16="http://schemas.microsoft.com/office/drawing/2014/main" id="{7D31BC74-D6D4-4AF3-9C02-9D0FE891003B}"/>
              </a:ext>
            </a:extLst>
          </p:cNvPr>
          <p:cNvSpPr txBox="1"/>
          <p:nvPr/>
        </p:nvSpPr>
        <p:spPr>
          <a:xfrm>
            <a:off x="5662685" y="5874978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myb10-B1</a:t>
            </a:r>
          </a:p>
        </p:txBody>
      </p: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F8DBCE98-FF3A-4C04-B97E-D64B5C646A24}"/>
              </a:ext>
            </a:extLst>
          </p:cNvPr>
          <p:cNvCxnSpPr/>
          <p:nvPr/>
        </p:nvCxnSpPr>
        <p:spPr>
          <a:xfrm>
            <a:off x="5408339" y="6011587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8" name="Group 167">
            <a:extLst>
              <a:ext uri="{FF2B5EF4-FFF2-40B4-BE49-F238E27FC236}">
                <a16:creationId xmlns:a16="http://schemas.microsoft.com/office/drawing/2014/main" id="{1CA0D4C4-E6EB-4320-AE23-DDF5F34A7B04}"/>
              </a:ext>
            </a:extLst>
          </p:cNvPr>
          <p:cNvGrpSpPr/>
          <p:nvPr/>
        </p:nvGrpSpPr>
        <p:grpSpPr>
          <a:xfrm>
            <a:off x="6768632" y="5725352"/>
            <a:ext cx="293881" cy="1250371"/>
            <a:chOff x="8355476" y="798751"/>
            <a:chExt cx="293881" cy="1051392"/>
          </a:xfrm>
        </p:grpSpPr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52648884-4C1A-41CB-A5B3-75BF1C895E09}"/>
                </a:ext>
              </a:extLst>
            </p:cNvPr>
            <p:cNvSpPr txBox="1"/>
            <p:nvPr/>
          </p:nvSpPr>
          <p:spPr>
            <a:xfrm rot="5400000">
              <a:off x="7992856" y="1193642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hwwgr-3BL</a:t>
              </a:r>
            </a:p>
          </p:txBody>
        </p:sp>
        <p:sp>
          <p:nvSpPr>
            <p:cNvPr id="170" name="Rectangle 169">
              <a:extLst>
                <a:ext uri="{FF2B5EF4-FFF2-40B4-BE49-F238E27FC236}">
                  <a16:creationId xmlns:a16="http://schemas.microsoft.com/office/drawing/2014/main" id="{ADBDB652-21B6-41C2-ADC9-B66773113BD8}"/>
                </a:ext>
              </a:extLst>
            </p:cNvPr>
            <p:cNvSpPr/>
            <p:nvPr/>
          </p:nvSpPr>
          <p:spPr>
            <a:xfrm rot="5400000">
              <a:off x="8058476" y="1236664"/>
              <a:ext cx="648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71" name="Group 170">
            <a:extLst>
              <a:ext uri="{FF2B5EF4-FFF2-40B4-BE49-F238E27FC236}">
                <a16:creationId xmlns:a16="http://schemas.microsoft.com/office/drawing/2014/main" id="{71250EF6-74ED-4D90-A2BC-71A49994C248}"/>
              </a:ext>
            </a:extLst>
          </p:cNvPr>
          <p:cNvGrpSpPr/>
          <p:nvPr/>
        </p:nvGrpSpPr>
        <p:grpSpPr>
          <a:xfrm>
            <a:off x="7040105" y="5796785"/>
            <a:ext cx="285316" cy="1250371"/>
            <a:chOff x="8355475" y="798751"/>
            <a:chExt cx="285316" cy="1051392"/>
          </a:xfrm>
        </p:grpSpPr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23A7770A-C6EA-4578-908D-09A1B84F7BBB}"/>
                </a:ext>
              </a:extLst>
            </p:cNvPr>
            <p:cNvSpPr txBox="1"/>
            <p:nvPr/>
          </p:nvSpPr>
          <p:spPr>
            <a:xfrm rot="5400000">
              <a:off x="7984290" y="1193642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icau-3B.1</a:t>
              </a:r>
            </a:p>
          </p:txBody>
        </p:sp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3F9A0E02-D3D5-49AC-B840-0CE6D5EE6CAB}"/>
                </a:ext>
              </a:extLst>
            </p:cNvPr>
            <p:cNvSpPr/>
            <p:nvPr/>
          </p:nvSpPr>
          <p:spPr>
            <a:xfrm rot="5400000">
              <a:off x="8359771" y="935368"/>
              <a:ext cx="45407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174" name="TextBox 173">
            <a:extLst>
              <a:ext uri="{FF2B5EF4-FFF2-40B4-BE49-F238E27FC236}">
                <a16:creationId xmlns:a16="http://schemas.microsoft.com/office/drawing/2014/main" id="{C9575847-AB72-435C-90EA-CD1E8030DDDA}"/>
              </a:ext>
            </a:extLst>
          </p:cNvPr>
          <p:cNvSpPr txBox="1"/>
          <p:nvPr/>
        </p:nvSpPr>
        <p:spPr>
          <a:xfrm>
            <a:off x="1313155" y="4764631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myb10-A1</a:t>
            </a:r>
          </a:p>
        </p:txBody>
      </p: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id="{D29CE0EF-51B2-46C6-A45F-27B54128704E}"/>
              </a:ext>
            </a:extLst>
          </p:cNvPr>
          <p:cNvCxnSpPr/>
          <p:nvPr/>
        </p:nvCxnSpPr>
        <p:spPr>
          <a:xfrm>
            <a:off x="1061096" y="4901240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76" name="Group 175">
            <a:extLst>
              <a:ext uri="{FF2B5EF4-FFF2-40B4-BE49-F238E27FC236}">
                <a16:creationId xmlns:a16="http://schemas.microsoft.com/office/drawing/2014/main" id="{3114A960-FE16-4DEF-8B66-CCB19334C05D}"/>
              </a:ext>
            </a:extLst>
          </p:cNvPr>
          <p:cNvGrpSpPr/>
          <p:nvPr/>
        </p:nvGrpSpPr>
        <p:grpSpPr>
          <a:xfrm>
            <a:off x="6889480" y="275134"/>
            <a:ext cx="270410" cy="1003300"/>
            <a:chOff x="8031292" y="516297"/>
            <a:chExt cx="270410" cy="1003300"/>
          </a:xfrm>
        </p:grpSpPr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DDE0310C-82FA-4DEB-B52E-BB0565B6DEA3}"/>
                </a:ext>
              </a:extLst>
            </p:cNvPr>
            <p:cNvSpPr txBox="1"/>
            <p:nvPr/>
          </p:nvSpPr>
          <p:spPr>
            <a:xfrm rot="5400000">
              <a:off x="7669247" y="88714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dsu-3BS</a:t>
              </a:r>
            </a:p>
          </p:txBody>
        </p:sp>
        <p:sp>
          <p:nvSpPr>
            <p:cNvPr id="178" name="Rectangle 177">
              <a:extLst>
                <a:ext uri="{FF2B5EF4-FFF2-40B4-BE49-F238E27FC236}">
                  <a16:creationId xmlns:a16="http://schemas.microsoft.com/office/drawing/2014/main" id="{B2AF3354-FD82-4811-9A31-498D5F9C2277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79" name="Group 178">
            <a:extLst>
              <a:ext uri="{FF2B5EF4-FFF2-40B4-BE49-F238E27FC236}">
                <a16:creationId xmlns:a16="http://schemas.microsoft.com/office/drawing/2014/main" id="{39A1D9E8-EEAD-46EF-9028-318DDF1F46AF}"/>
              </a:ext>
            </a:extLst>
          </p:cNvPr>
          <p:cNvGrpSpPr/>
          <p:nvPr/>
        </p:nvGrpSpPr>
        <p:grpSpPr>
          <a:xfrm>
            <a:off x="2104816" y="4980578"/>
            <a:ext cx="270410" cy="1003300"/>
            <a:chOff x="8031292" y="818576"/>
            <a:chExt cx="270410" cy="1003300"/>
          </a:xfrm>
        </p:grpSpPr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4E6C271C-BB8D-4BDD-9CBB-FFE04DDD196B}"/>
                </a:ext>
              </a:extLst>
            </p:cNvPr>
            <p:cNvSpPr txBox="1"/>
            <p:nvPr/>
          </p:nvSpPr>
          <p:spPr>
            <a:xfrm rot="5400000">
              <a:off x="7669247" y="1189421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181" name="Rectangle 180">
              <a:extLst>
                <a:ext uri="{FF2B5EF4-FFF2-40B4-BE49-F238E27FC236}">
                  <a16:creationId xmlns:a16="http://schemas.microsoft.com/office/drawing/2014/main" id="{BFB7F154-FA9A-485E-815A-9BEA0173ABF2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82" name="Group 181">
            <a:extLst>
              <a:ext uri="{FF2B5EF4-FFF2-40B4-BE49-F238E27FC236}">
                <a16:creationId xmlns:a16="http://schemas.microsoft.com/office/drawing/2014/main" id="{E095877A-E811-48CE-B81A-D7BF35B29941}"/>
              </a:ext>
            </a:extLst>
          </p:cNvPr>
          <p:cNvGrpSpPr/>
          <p:nvPr/>
        </p:nvGrpSpPr>
        <p:grpSpPr>
          <a:xfrm>
            <a:off x="3713575" y="765175"/>
            <a:ext cx="270410" cy="1003300"/>
            <a:chOff x="8031292" y="706643"/>
            <a:chExt cx="270410" cy="1003300"/>
          </a:xfrm>
        </p:grpSpPr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3493CCE8-C1F3-46C3-8992-1166487DB102}"/>
                </a:ext>
              </a:extLst>
            </p:cNvPr>
            <p:cNvSpPr txBox="1"/>
            <p:nvPr/>
          </p:nvSpPr>
          <p:spPr>
            <a:xfrm rot="5400000">
              <a:off x="7669247" y="107748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184" name="Rectangle 183">
              <a:extLst>
                <a:ext uri="{FF2B5EF4-FFF2-40B4-BE49-F238E27FC236}">
                  <a16:creationId xmlns:a16="http://schemas.microsoft.com/office/drawing/2014/main" id="{1D27F393-0745-4877-B5FD-475C815D2548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85" name="Group 184">
            <a:extLst>
              <a:ext uri="{FF2B5EF4-FFF2-40B4-BE49-F238E27FC236}">
                <a16:creationId xmlns:a16="http://schemas.microsoft.com/office/drawing/2014/main" id="{DD1DDA4F-4F53-47E5-98D5-8B69DBAB592A}"/>
              </a:ext>
            </a:extLst>
          </p:cNvPr>
          <p:cNvGrpSpPr/>
          <p:nvPr/>
        </p:nvGrpSpPr>
        <p:grpSpPr>
          <a:xfrm>
            <a:off x="6620000" y="274360"/>
            <a:ext cx="270410" cy="1003300"/>
            <a:chOff x="8031292" y="529667"/>
            <a:chExt cx="270410" cy="1003300"/>
          </a:xfrm>
        </p:grpSpPr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E1355E56-5BCB-48D5-9C5E-1A97CCEA926F}"/>
                </a:ext>
              </a:extLst>
            </p:cNvPr>
            <p:cNvSpPr txBox="1"/>
            <p:nvPr/>
          </p:nvSpPr>
          <p:spPr>
            <a:xfrm rot="5400000">
              <a:off x="7669247" y="90051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W.csiro</a:t>
              </a:r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022E9514-7570-4762-ACF6-89D91E8ED09C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88" name="Group 187">
            <a:extLst>
              <a:ext uri="{FF2B5EF4-FFF2-40B4-BE49-F238E27FC236}">
                <a16:creationId xmlns:a16="http://schemas.microsoft.com/office/drawing/2014/main" id="{F16A150F-3F13-48B8-BE8F-BE8A2AACF471}"/>
              </a:ext>
            </a:extLst>
          </p:cNvPr>
          <p:cNvGrpSpPr/>
          <p:nvPr/>
        </p:nvGrpSpPr>
        <p:grpSpPr>
          <a:xfrm>
            <a:off x="7734653" y="664446"/>
            <a:ext cx="280116" cy="1186015"/>
            <a:chOff x="8992024" y="5188616"/>
            <a:chExt cx="280116" cy="1186015"/>
          </a:xfrm>
        </p:grpSpPr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D1A17B01-9469-499A-AB12-9B2E53EA7DE9}"/>
                </a:ext>
              </a:extLst>
            </p:cNvPr>
            <p:cNvSpPr txBox="1"/>
            <p:nvPr/>
          </p:nvSpPr>
          <p:spPr>
            <a:xfrm rot="5400000">
              <a:off x="8548327" y="5650819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ahau-3B</a:t>
              </a:r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27FB6A30-7D35-44F6-AF22-C8E0851FCF16}"/>
                </a:ext>
              </a:extLst>
            </p:cNvPr>
            <p:cNvSpPr/>
            <p:nvPr/>
          </p:nvSpPr>
          <p:spPr>
            <a:xfrm rot="5400000">
              <a:off x="8983024" y="5530812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91" name="Group 190">
            <a:extLst>
              <a:ext uri="{FF2B5EF4-FFF2-40B4-BE49-F238E27FC236}">
                <a16:creationId xmlns:a16="http://schemas.microsoft.com/office/drawing/2014/main" id="{0578323E-C405-44B2-897C-E4469F46A889}"/>
              </a:ext>
            </a:extLst>
          </p:cNvPr>
          <p:cNvGrpSpPr/>
          <p:nvPr/>
        </p:nvGrpSpPr>
        <p:grpSpPr>
          <a:xfrm>
            <a:off x="7191358" y="565302"/>
            <a:ext cx="274744" cy="1003300"/>
            <a:chOff x="993068" y="2546583"/>
            <a:chExt cx="274744" cy="1003300"/>
          </a:xfrm>
        </p:grpSpPr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816DA833-D4F5-4263-9126-369036859042}"/>
                </a:ext>
              </a:extLst>
            </p:cNvPr>
            <p:cNvSpPr txBox="1"/>
            <p:nvPr/>
          </p:nvSpPr>
          <p:spPr>
            <a:xfrm rot="5400000">
              <a:off x="635357" y="291742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193" name="Rectangle 192">
              <a:extLst>
                <a:ext uri="{FF2B5EF4-FFF2-40B4-BE49-F238E27FC236}">
                  <a16:creationId xmlns:a16="http://schemas.microsoft.com/office/drawing/2014/main" id="{58147368-3E53-4088-A287-AFA8CD630048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94" name="Group 193">
            <a:extLst>
              <a:ext uri="{FF2B5EF4-FFF2-40B4-BE49-F238E27FC236}">
                <a16:creationId xmlns:a16="http://schemas.microsoft.com/office/drawing/2014/main" id="{26DF513D-9E50-44C2-926B-AB096831DC17}"/>
              </a:ext>
            </a:extLst>
          </p:cNvPr>
          <p:cNvGrpSpPr/>
          <p:nvPr/>
        </p:nvGrpSpPr>
        <p:grpSpPr>
          <a:xfrm>
            <a:off x="2878287" y="376010"/>
            <a:ext cx="277604" cy="1186015"/>
            <a:chOff x="8994536" y="5511238"/>
            <a:chExt cx="277604" cy="1186015"/>
          </a:xfrm>
        </p:grpSpPr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67FC8070-D6C2-42D0-922B-AE15278C9897}"/>
                </a:ext>
              </a:extLst>
            </p:cNvPr>
            <p:cNvSpPr txBox="1"/>
            <p:nvPr/>
          </p:nvSpPr>
          <p:spPr>
            <a:xfrm rot="5400000">
              <a:off x="8548327" y="5973441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fcgr.cas-3AS</a:t>
              </a:r>
            </a:p>
          </p:txBody>
        </p:sp>
        <p:sp>
          <p:nvSpPr>
            <p:cNvPr id="196" name="Rectangle 195">
              <a:extLst>
                <a:ext uri="{FF2B5EF4-FFF2-40B4-BE49-F238E27FC236}">
                  <a16:creationId xmlns:a16="http://schemas.microsoft.com/office/drawing/2014/main" id="{4AB4C994-F91D-432E-B069-2DCB059EFF66}"/>
                </a:ext>
              </a:extLst>
            </p:cNvPr>
            <p:cNvSpPr/>
            <p:nvPr/>
          </p:nvSpPr>
          <p:spPr>
            <a:xfrm rot="5400000">
              <a:off x="8971136" y="5794795"/>
              <a:ext cx="1008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97" name="Group 196">
            <a:extLst>
              <a:ext uri="{FF2B5EF4-FFF2-40B4-BE49-F238E27FC236}">
                <a16:creationId xmlns:a16="http://schemas.microsoft.com/office/drawing/2014/main" id="{A6FA5B0C-D068-42FB-9227-BB3F867C9E4B}"/>
              </a:ext>
            </a:extLst>
          </p:cNvPr>
          <p:cNvGrpSpPr/>
          <p:nvPr/>
        </p:nvGrpSpPr>
        <p:grpSpPr>
          <a:xfrm>
            <a:off x="2286809" y="367214"/>
            <a:ext cx="277604" cy="1186015"/>
            <a:chOff x="8994536" y="5569961"/>
            <a:chExt cx="277604" cy="1186015"/>
          </a:xfrm>
        </p:grpSpPr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0538BEC3-9EAC-4EAF-AC7A-CB94812ECAA7}"/>
                </a:ext>
              </a:extLst>
            </p:cNvPr>
            <p:cNvSpPr txBox="1"/>
            <p:nvPr/>
          </p:nvSpPr>
          <p:spPr>
            <a:xfrm rot="5400000">
              <a:off x="8548327" y="6032164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bifcgr.cas-3AS</a:t>
              </a:r>
            </a:p>
          </p:txBody>
        </p:sp>
        <p:sp>
          <p:nvSpPr>
            <p:cNvPr id="199" name="Rectangle 198">
              <a:extLst>
                <a:ext uri="{FF2B5EF4-FFF2-40B4-BE49-F238E27FC236}">
                  <a16:creationId xmlns:a16="http://schemas.microsoft.com/office/drawing/2014/main" id="{803F1D2F-2321-4646-9AA5-6198D1A6FB8E}"/>
                </a:ext>
              </a:extLst>
            </p:cNvPr>
            <p:cNvSpPr/>
            <p:nvPr/>
          </p:nvSpPr>
          <p:spPr>
            <a:xfrm rot="5400000">
              <a:off x="8994536" y="5771395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00" name="Group 199">
            <a:extLst>
              <a:ext uri="{FF2B5EF4-FFF2-40B4-BE49-F238E27FC236}">
                <a16:creationId xmlns:a16="http://schemas.microsoft.com/office/drawing/2014/main" id="{DAD0A1A7-DEA8-428A-BF34-3C42AAEF9D37}"/>
              </a:ext>
            </a:extLst>
          </p:cNvPr>
          <p:cNvGrpSpPr/>
          <p:nvPr/>
        </p:nvGrpSpPr>
        <p:grpSpPr>
          <a:xfrm>
            <a:off x="2352591" y="5144555"/>
            <a:ext cx="277604" cy="1186015"/>
            <a:chOff x="8994536" y="5536405"/>
            <a:chExt cx="277604" cy="1186015"/>
          </a:xfrm>
        </p:grpSpPr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996687C0-FA06-4808-B345-5E2B614A08D5}"/>
                </a:ext>
              </a:extLst>
            </p:cNvPr>
            <p:cNvSpPr txBox="1"/>
            <p:nvPr/>
          </p:nvSpPr>
          <p:spPr>
            <a:xfrm rot="5400000">
              <a:off x="8548327" y="5998608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fcgr.cas-3AL.2</a:t>
              </a:r>
            </a:p>
          </p:txBody>
        </p:sp>
        <p:sp>
          <p:nvSpPr>
            <p:cNvPr id="202" name="Rectangle 201">
              <a:extLst>
                <a:ext uri="{FF2B5EF4-FFF2-40B4-BE49-F238E27FC236}">
                  <a16:creationId xmlns:a16="http://schemas.microsoft.com/office/drawing/2014/main" id="{8124728A-76F9-4721-A526-01FCE8A52DC2}"/>
                </a:ext>
              </a:extLst>
            </p:cNvPr>
            <p:cNvSpPr/>
            <p:nvPr/>
          </p:nvSpPr>
          <p:spPr>
            <a:xfrm rot="5400000">
              <a:off x="8994536" y="5771395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06" name="Group 205">
            <a:extLst>
              <a:ext uri="{FF2B5EF4-FFF2-40B4-BE49-F238E27FC236}">
                <a16:creationId xmlns:a16="http://schemas.microsoft.com/office/drawing/2014/main" id="{00303DFB-41BE-410B-BF8D-F1CD550ACFA3}"/>
              </a:ext>
            </a:extLst>
          </p:cNvPr>
          <p:cNvGrpSpPr/>
          <p:nvPr/>
        </p:nvGrpSpPr>
        <p:grpSpPr>
          <a:xfrm>
            <a:off x="2582548" y="370574"/>
            <a:ext cx="277604" cy="1186015"/>
            <a:chOff x="8994536" y="5536405"/>
            <a:chExt cx="277604" cy="1186015"/>
          </a:xfrm>
        </p:grpSpPr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48F3915A-0871-4C42-8D82-CE9ECE5EE114}"/>
                </a:ext>
              </a:extLst>
            </p:cNvPr>
            <p:cNvSpPr txBox="1"/>
            <p:nvPr/>
          </p:nvSpPr>
          <p:spPr>
            <a:xfrm rot="5400000">
              <a:off x="8548327" y="5998608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bigr.cas-3AS</a:t>
              </a:r>
            </a:p>
          </p:txBody>
        </p:sp>
        <p:sp>
          <p:nvSpPr>
            <p:cNvPr id="208" name="Rectangle 207">
              <a:extLst>
                <a:ext uri="{FF2B5EF4-FFF2-40B4-BE49-F238E27FC236}">
                  <a16:creationId xmlns:a16="http://schemas.microsoft.com/office/drawing/2014/main" id="{2243C826-26D1-48CC-ABFD-89B4BD1723FB}"/>
                </a:ext>
              </a:extLst>
            </p:cNvPr>
            <p:cNvSpPr/>
            <p:nvPr/>
          </p:nvSpPr>
          <p:spPr>
            <a:xfrm rot="5400000">
              <a:off x="8994536" y="5771395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09" name="Group 208">
            <a:extLst>
              <a:ext uri="{FF2B5EF4-FFF2-40B4-BE49-F238E27FC236}">
                <a16:creationId xmlns:a16="http://schemas.microsoft.com/office/drawing/2014/main" id="{16675313-86D9-479E-90CF-59B56604C921}"/>
              </a:ext>
            </a:extLst>
          </p:cNvPr>
          <p:cNvGrpSpPr/>
          <p:nvPr/>
        </p:nvGrpSpPr>
        <p:grpSpPr>
          <a:xfrm>
            <a:off x="6343326" y="274932"/>
            <a:ext cx="285993" cy="1186015"/>
            <a:chOff x="8994536" y="5779417"/>
            <a:chExt cx="285993" cy="1186015"/>
          </a:xfrm>
        </p:grpSpPr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C61681DF-80C6-47C7-AC83-607870B94BB2}"/>
                </a:ext>
              </a:extLst>
            </p:cNvPr>
            <p:cNvSpPr txBox="1"/>
            <p:nvPr/>
          </p:nvSpPr>
          <p:spPr>
            <a:xfrm rot="5400000">
              <a:off x="8556716" y="6241620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gr.cas-3BS</a:t>
              </a:r>
            </a:p>
          </p:txBody>
        </p:sp>
        <p:sp>
          <p:nvSpPr>
            <p:cNvPr id="211" name="Rectangle 210">
              <a:extLst>
                <a:ext uri="{FF2B5EF4-FFF2-40B4-BE49-F238E27FC236}">
                  <a16:creationId xmlns:a16="http://schemas.microsoft.com/office/drawing/2014/main" id="{19E0EB00-F90E-4780-9BE0-6A1C44355769}"/>
                </a:ext>
              </a:extLst>
            </p:cNvPr>
            <p:cNvSpPr/>
            <p:nvPr/>
          </p:nvSpPr>
          <p:spPr>
            <a:xfrm rot="5400000">
              <a:off x="8994536" y="607122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12" name="Group 211">
            <a:extLst>
              <a:ext uri="{FF2B5EF4-FFF2-40B4-BE49-F238E27FC236}">
                <a16:creationId xmlns:a16="http://schemas.microsoft.com/office/drawing/2014/main" id="{19E6E5DD-810F-4C94-BA3C-BBD5616020F4}"/>
              </a:ext>
            </a:extLst>
          </p:cNvPr>
          <p:cNvGrpSpPr/>
          <p:nvPr/>
        </p:nvGrpSpPr>
        <p:grpSpPr>
          <a:xfrm>
            <a:off x="2614884" y="5238038"/>
            <a:ext cx="270410" cy="1208456"/>
            <a:chOff x="8031292" y="603407"/>
            <a:chExt cx="270410" cy="1208456"/>
          </a:xfrm>
        </p:grpSpPr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D8FA6343-66D5-4533-BDCA-4C7BE50E81ED}"/>
                </a:ext>
              </a:extLst>
            </p:cNvPr>
            <p:cNvSpPr txBox="1"/>
            <p:nvPr/>
          </p:nvSpPr>
          <p:spPr>
            <a:xfrm rot="5400000">
              <a:off x="7566669" y="1076830"/>
              <a:ext cx="12084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icau-3A.2</a:t>
              </a:r>
            </a:p>
          </p:txBody>
        </p:sp>
        <p:sp>
          <p:nvSpPr>
            <p:cNvPr id="214" name="Rectangle 213">
              <a:extLst>
                <a:ext uri="{FF2B5EF4-FFF2-40B4-BE49-F238E27FC236}">
                  <a16:creationId xmlns:a16="http://schemas.microsoft.com/office/drawing/2014/main" id="{DB669E43-B354-4C16-BE88-103CA01C96DF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15" name="Group 214">
            <a:extLst>
              <a:ext uri="{FF2B5EF4-FFF2-40B4-BE49-F238E27FC236}">
                <a16:creationId xmlns:a16="http://schemas.microsoft.com/office/drawing/2014/main" id="{DCA86147-1442-4BA7-BD9F-EEE329655F6C}"/>
              </a:ext>
            </a:extLst>
          </p:cNvPr>
          <p:cNvGrpSpPr/>
          <p:nvPr/>
        </p:nvGrpSpPr>
        <p:grpSpPr>
          <a:xfrm>
            <a:off x="1861856" y="3001510"/>
            <a:ext cx="270410" cy="1208456"/>
            <a:chOff x="8031292" y="489940"/>
            <a:chExt cx="270410" cy="1208456"/>
          </a:xfrm>
        </p:grpSpPr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ABECDF81-04A1-4144-B48C-CC87A4495223}"/>
                </a:ext>
              </a:extLst>
            </p:cNvPr>
            <p:cNvSpPr txBox="1"/>
            <p:nvPr/>
          </p:nvSpPr>
          <p:spPr>
            <a:xfrm rot="5400000">
              <a:off x="7566669" y="963363"/>
              <a:ext cx="12084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icau-3A.1</a:t>
              </a:r>
            </a:p>
          </p:txBody>
        </p:sp>
        <p:sp>
          <p:nvSpPr>
            <p:cNvPr id="217" name="Rectangle 216">
              <a:extLst>
                <a:ext uri="{FF2B5EF4-FFF2-40B4-BE49-F238E27FC236}">
                  <a16:creationId xmlns:a16="http://schemas.microsoft.com/office/drawing/2014/main" id="{12FC4880-5083-44E0-93AA-FE236B403093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18" name="Group 217">
            <a:extLst>
              <a:ext uri="{FF2B5EF4-FFF2-40B4-BE49-F238E27FC236}">
                <a16:creationId xmlns:a16="http://schemas.microsoft.com/office/drawing/2014/main" id="{C87F7BAC-987E-4693-A7F0-229003FD8219}"/>
              </a:ext>
            </a:extLst>
          </p:cNvPr>
          <p:cNvGrpSpPr/>
          <p:nvPr/>
        </p:nvGrpSpPr>
        <p:grpSpPr>
          <a:xfrm>
            <a:off x="7304820" y="5805562"/>
            <a:ext cx="285344" cy="1250371"/>
            <a:chOff x="8355475" y="689714"/>
            <a:chExt cx="285344" cy="1051392"/>
          </a:xfrm>
        </p:grpSpPr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A543E7D2-B372-4FCD-8908-5BFFDC67497F}"/>
                </a:ext>
              </a:extLst>
            </p:cNvPr>
            <p:cNvSpPr txBox="1"/>
            <p:nvPr/>
          </p:nvSpPr>
          <p:spPr>
            <a:xfrm rot="5400000">
              <a:off x="7984318" y="1084605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icau-3B.2</a:t>
              </a:r>
            </a:p>
          </p:txBody>
        </p:sp>
        <p:sp>
          <p:nvSpPr>
            <p:cNvPr id="220" name="Rectangle 219">
              <a:extLst>
                <a:ext uri="{FF2B5EF4-FFF2-40B4-BE49-F238E27FC236}">
                  <a16:creationId xmlns:a16="http://schemas.microsoft.com/office/drawing/2014/main" id="{38ABFC70-4B5E-43D0-901D-8E35D9478089}"/>
                </a:ext>
              </a:extLst>
            </p:cNvPr>
            <p:cNvSpPr/>
            <p:nvPr/>
          </p:nvSpPr>
          <p:spPr>
            <a:xfrm rot="5400000">
              <a:off x="8359771" y="935368"/>
              <a:ext cx="45407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21" name="Group 220">
            <a:extLst>
              <a:ext uri="{FF2B5EF4-FFF2-40B4-BE49-F238E27FC236}">
                <a16:creationId xmlns:a16="http://schemas.microsoft.com/office/drawing/2014/main" id="{8C522E8B-3F60-4690-8D64-2EC654D377B4}"/>
              </a:ext>
            </a:extLst>
          </p:cNvPr>
          <p:cNvGrpSpPr/>
          <p:nvPr/>
        </p:nvGrpSpPr>
        <p:grpSpPr>
          <a:xfrm>
            <a:off x="7545462" y="5805799"/>
            <a:ext cx="285362" cy="1250371"/>
            <a:chOff x="8355475" y="450728"/>
            <a:chExt cx="285362" cy="1051392"/>
          </a:xfrm>
        </p:grpSpPr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97DFE4A9-6CA2-4322-AD69-3DE91E33CFBC}"/>
                </a:ext>
              </a:extLst>
            </p:cNvPr>
            <p:cNvSpPr txBox="1"/>
            <p:nvPr/>
          </p:nvSpPr>
          <p:spPr>
            <a:xfrm rot="5400000">
              <a:off x="7984336" y="845619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icau-3B.3</a:t>
              </a:r>
            </a:p>
          </p:txBody>
        </p:sp>
        <p:sp>
          <p:nvSpPr>
            <p:cNvPr id="223" name="Rectangle 222">
              <a:extLst>
                <a:ext uri="{FF2B5EF4-FFF2-40B4-BE49-F238E27FC236}">
                  <a16:creationId xmlns:a16="http://schemas.microsoft.com/office/drawing/2014/main" id="{015C5EE8-9F45-46EC-B686-245F079E5125}"/>
                </a:ext>
              </a:extLst>
            </p:cNvPr>
            <p:cNvSpPr/>
            <p:nvPr/>
          </p:nvSpPr>
          <p:spPr>
            <a:xfrm rot="5400000">
              <a:off x="8359771" y="935368"/>
              <a:ext cx="45407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24" name="Group 223">
            <a:extLst>
              <a:ext uri="{FF2B5EF4-FFF2-40B4-BE49-F238E27FC236}">
                <a16:creationId xmlns:a16="http://schemas.microsoft.com/office/drawing/2014/main" id="{4A5B0090-9A14-4073-8AEB-4FB3429124B6}"/>
              </a:ext>
            </a:extLst>
          </p:cNvPr>
          <p:cNvGrpSpPr/>
          <p:nvPr/>
        </p:nvGrpSpPr>
        <p:grpSpPr>
          <a:xfrm>
            <a:off x="2668838" y="3310627"/>
            <a:ext cx="266405" cy="1003300"/>
            <a:chOff x="8031292" y="313217"/>
            <a:chExt cx="266405" cy="1003300"/>
          </a:xfrm>
        </p:grpSpPr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A87B5416-7856-4894-818B-A1FA3DDF7D92}"/>
                </a:ext>
              </a:extLst>
            </p:cNvPr>
            <p:cNvSpPr txBox="1"/>
            <p:nvPr/>
          </p:nvSpPr>
          <p:spPr>
            <a:xfrm rot="5400000">
              <a:off x="7665242" y="68406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.Lng.ipk.3A</a:t>
              </a:r>
            </a:p>
          </p:txBody>
        </p:sp>
        <p:sp>
          <p:nvSpPr>
            <p:cNvPr id="226" name="Rectangle 225">
              <a:extLst>
                <a:ext uri="{FF2B5EF4-FFF2-40B4-BE49-F238E27FC236}">
                  <a16:creationId xmlns:a16="http://schemas.microsoft.com/office/drawing/2014/main" id="{E9619BFE-61CB-49A2-83AE-EE3C95E245DF}"/>
                </a:ext>
              </a:extLst>
            </p:cNvPr>
            <p:cNvSpPr/>
            <p:nvPr/>
          </p:nvSpPr>
          <p:spPr>
            <a:xfrm rot="5400000">
              <a:off x="8031292" y="991379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27" name="Group 226">
            <a:extLst>
              <a:ext uri="{FF2B5EF4-FFF2-40B4-BE49-F238E27FC236}">
                <a16:creationId xmlns:a16="http://schemas.microsoft.com/office/drawing/2014/main" id="{F0E5C4E1-B2E8-4BF3-AD88-91DB83C5A537}"/>
              </a:ext>
            </a:extLst>
          </p:cNvPr>
          <p:cNvGrpSpPr/>
          <p:nvPr/>
        </p:nvGrpSpPr>
        <p:grpSpPr>
          <a:xfrm>
            <a:off x="7465172" y="636057"/>
            <a:ext cx="270410" cy="1003300"/>
            <a:chOff x="8031292" y="777584"/>
            <a:chExt cx="270410" cy="1003300"/>
          </a:xfrm>
        </p:grpSpPr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41FB2BE6-0008-45F7-809D-39C6F94C2475}"/>
                </a:ext>
              </a:extLst>
            </p:cNvPr>
            <p:cNvSpPr txBox="1"/>
            <p:nvPr/>
          </p:nvSpPr>
          <p:spPr>
            <a:xfrm rot="5400000">
              <a:off x="7669247" y="1148429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.Lng.ipk.3B</a:t>
              </a:r>
            </a:p>
          </p:txBody>
        </p:sp>
        <p:sp>
          <p:nvSpPr>
            <p:cNvPr id="229" name="Rectangle 228">
              <a:extLst>
                <a:ext uri="{FF2B5EF4-FFF2-40B4-BE49-F238E27FC236}">
                  <a16:creationId xmlns:a16="http://schemas.microsoft.com/office/drawing/2014/main" id="{4D96C4E8-6672-4848-8E09-C5B9A41ABBE0}"/>
                </a:ext>
              </a:extLst>
            </p:cNvPr>
            <p:cNvSpPr/>
            <p:nvPr/>
          </p:nvSpPr>
          <p:spPr>
            <a:xfrm rot="5400000">
              <a:off x="8031292" y="1065119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cxnSp>
        <p:nvCxnSpPr>
          <p:cNvPr id="233" name="Straight Connector 232">
            <a:extLst>
              <a:ext uri="{FF2B5EF4-FFF2-40B4-BE49-F238E27FC236}">
                <a16:creationId xmlns:a16="http://schemas.microsoft.com/office/drawing/2014/main" id="{A2F70C2D-301D-4D6F-8EF7-B58B45B1DDA8}"/>
              </a:ext>
            </a:extLst>
          </p:cNvPr>
          <p:cNvCxnSpPr/>
          <p:nvPr/>
        </p:nvCxnSpPr>
        <p:spPr>
          <a:xfrm>
            <a:off x="480325" y="5852572"/>
            <a:ext cx="0" cy="72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TextBox 233">
            <a:extLst>
              <a:ext uri="{FF2B5EF4-FFF2-40B4-BE49-F238E27FC236}">
                <a16:creationId xmlns:a16="http://schemas.microsoft.com/office/drawing/2014/main" id="{78B88447-E994-42F2-9805-2DDE8354CCBB}"/>
              </a:ext>
            </a:extLst>
          </p:cNvPr>
          <p:cNvSpPr txBox="1"/>
          <p:nvPr/>
        </p:nvSpPr>
        <p:spPr>
          <a:xfrm>
            <a:off x="489930" y="6062651"/>
            <a:ext cx="1178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/>
              <a:t>100 Mb</a:t>
            </a:r>
          </a:p>
        </p:txBody>
      </p:sp>
      <p:grpSp>
        <p:nvGrpSpPr>
          <p:cNvPr id="235" name="Group 234">
            <a:extLst>
              <a:ext uri="{FF2B5EF4-FFF2-40B4-BE49-F238E27FC236}">
                <a16:creationId xmlns:a16="http://schemas.microsoft.com/office/drawing/2014/main" id="{86DFE07A-F7A0-4B52-9B7D-B4A048D244E3}"/>
              </a:ext>
            </a:extLst>
          </p:cNvPr>
          <p:cNvGrpSpPr/>
          <p:nvPr/>
        </p:nvGrpSpPr>
        <p:grpSpPr>
          <a:xfrm>
            <a:off x="3421676" y="499111"/>
            <a:ext cx="280116" cy="1186015"/>
            <a:chOff x="8992024" y="5188616"/>
            <a:chExt cx="280116" cy="1186015"/>
          </a:xfrm>
        </p:grpSpPr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C633485C-2187-4E9A-811A-6BC5DC5A3CD5}"/>
                </a:ext>
              </a:extLst>
            </p:cNvPr>
            <p:cNvSpPr txBox="1"/>
            <p:nvPr/>
          </p:nvSpPr>
          <p:spPr>
            <a:xfrm rot="5400000">
              <a:off x="8548327" y="5650819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3A.2</a:t>
              </a:r>
            </a:p>
          </p:txBody>
        </p:sp>
        <p:sp>
          <p:nvSpPr>
            <p:cNvPr id="240" name="Rectangle 239">
              <a:extLst>
                <a:ext uri="{FF2B5EF4-FFF2-40B4-BE49-F238E27FC236}">
                  <a16:creationId xmlns:a16="http://schemas.microsoft.com/office/drawing/2014/main" id="{2BF5E378-C2C9-45F8-B293-79C9F0609EA8}"/>
                </a:ext>
              </a:extLst>
            </p:cNvPr>
            <p:cNvSpPr/>
            <p:nvPr/>
          </p:nvSpPr>
          <p:spPr>
            <a:xfrm rot="5400000">
              <a:off x="8983024" y="5530812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41" name="Group 240">
            <a:extLst>
              <a:ext uri="{FF2B5EF4-FFF2-40B4-BE49-F238E27FC236}">
                <a16:creationId xmlns:a16="http://schemas.microsoft.com/office/drawing/2014/main" id="{12F97629-767E-49AF-9A89-93CEE3FE20F8}"/>
              </a:ext>
            </a:extLst>
          </p:cNvPr>
          <p:cNvGrpSpPr/>
          <p:nvPr/>
        </p:nvGrpSpPr>
        <p:grpSpPr>
          <a:xfrm>
            <a:off x="6266958" y="1204073"/>
            <a:ext cx="280116" cy="1186015"/>
            <a:chOff x="8992024" y="5280149"/>
            <a:chExt cx="280116" cy="1186015"/>
          </a:xfrm>
        </p:grpSpPr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43C99220-34BE-4BA5-8761-F17D659174AD}"/>
                </a:ext>
              </a:extLst>
            </p:cNvPr>
            <p:cNvSpPr txBox="1"/>
            <p:nvPr/>
          </p:nvSpPr>
          <p:spPr>
            <a:xfrm rot="5400000">
              <a:off x="8548327" y="5742352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3B.2</a:t>
              </a:r>
            </a:p>
          </p:txBody>
        </p:sp>
        <p:sp>
          <p:nvSpPr>
            <p:cNvPr id="249" name="Rectangle 248">
              <a:extLst>
                <a:ext uri="{FF2B5EF4-FFF2-40B4-BE49-F238E27FC236}">
                  <a16:creationId xmlns:a16="http://schemas.microsoft.com/office/drawing/2014/main" id="{9E8BBE01-5B63-43D7-862C-8DC90E494B22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53" name="Group 252">
            <a:extLst>
              <a:ext uri="{FF2B5EF4-FFF2-40B4-BE49-F238E27FC236}">
                <a16:creationId xmlns:a16="http://schemas.microsoft.com/office/drawing/2014/main" id="{2C1A6F13-E197-4E7A-9E16-9B9413539CF7}"/>
              </a:ext>
            </a:extLst>
          </p:cNvPr>
          <p:cNvGrpSpPr/>
          <p:nvPr/>
        </p:nvGrpSpPr>
        <p:grpSpPr>
          <a:xfrm>
            <a:off x="1988558" y="375562"/>
            <a:ext cx="280116" cy="1186015"/>
            <a:chOff x="8992024" y="5341657"/>
            <a:chExt cx="280116" cy="1186015"/>
          </a:xfrm>
        </p:grpSpPr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73A80B89-0E42-4DA4-9B88-25B5E277C6B6}"/>
                </a:ext>
              </a:extLst>
            </p:cNvPr>
            <p:cNvSpPr txBox="1"/>
            <p:nvPr/>
          </p:nvSpPr>
          <p:spPr>
            <a:xfrm rot="5400000">
              <a:off x="8548327" y="5803860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3A.1</a:t>
              </a:r>
            </a:p>
          </p:txBody>
        </p:sp>
        <p:sp>
          <p:nvSpPr>
            <p:cNvPr id="255" name="Rectangle 254">
              <a:extLst>
                <a:ext uri="{FF2B5EF4-FFF2-40B4-BE49-F238E27FC236}">
                  <a16:creationId xmlns:a16="http://schemas.microsoft.com/office/drawing/2014/main" id="{A1C8F926-8B71-4DEC-BEF6-EA7584E215EF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56" name="Group 255">
            <a:extLst>
              <a:ext uri="{FF2B5EF4-FFF2-40B4-BE49-F238E27FC236}">
                <a16:creationId xmlns:a16="http://schemas.microsoft.com/office/drawing/2014/main" id="{9926D4FB-805E-48D3-BD29-3D63E19B4A27}"/>
              </a:ext>
            </a:extLst>
          </p:cNvPr>
          <p:cNvGrpSpPr/>
          <p:nvPr/>
        </p:nvGrpSpPr>
        <p:grpSpPr>
          <a:xfrm>
            <a:off x="3163990" y="382226"/>
            <a:ext cx="285201" cy="1240609"/>
            <a:chOff x="8355475" y="606982"/>
            <a:chExt cx="285201" cy="1051392"/>
          </a:xfrm>
        </p:grpSpPr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863ADA61-A449-4219-A7EE-1E99AA2D82C2}"/>
                </a:ext>
              </a:extLst>
            </p:cNvPr>
            <p:cNvSpPr txBox="1"/>
            <p:nvPr/>
          </p:nvSpPr>
          <p:spPr>
            <a:xfrm rot="5400000">
              <a:off x="7984175" y="1001873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hwwgr-3AS</a:t>
              </a:r>
            </a:p>
          </p:txBody>
        </p:sp>
        <p:sp>
          <p:nvSpPr>
            <p:cNvPr id="258" name="Rectangle 257">
              <a:extLst>
                <a:ext uri="{FF2B5EF4-FFF2-40B4-BE49-F238E27FC236}">
                  <a16:creationId xmlns:a16="http://schemas.microsoft.com/office/drawing/2014/main" id="{6E646BE2-B42E-4E82-9EA0-A03C84EA7A9F}"/>
                </a:ext>
              </a:extLst>
            </p:cNvPr>
            <p:cNvSpPr/>
            <p:nvPr/>
          </p:nvSpPr>
          <p:spPr>
            <a:xfrm rot="5400000">
              <a:off x="8359593" y="921326"/>
              <a:ext cx="45764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59" name="Group 258">
            <a:extLst>
              <a:ext uri="{FF2B5EF4-FFF2-40B4-BE49-F238E27FC236}">
                <a16:creationId xmlns:a16="http://schemas.microsoft.com/office/drawing/2014/main" id="{073A0A9F-549C-4235-A370-4CD3D28C2909}"/>
              </a:ext>
            </a:extLst>
          </p:cNvPr>
          <p:cNvGrpSpPr/>
          <p:nvPr/>
        </p:nvGrpSpPr>
        <p:grpSpPr>
          <a:xfrm>
            <a:off x="2389330" y="3009923"/>
            <a:ext cx="285262" cy="1240609"/>
            <a:chOff x="8355475" y="617390"/>
            <a:chExt cx="285262" cy="1051392"/>
          </a:xfrm>
        </p:grpSpPr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8EC96764-8677-4350-8997-6F69229A5771}"/>
                </a:ext>
              </a:extLst>
            </p:cNvPr>
            <p:cNvSpPr txBox="1"/>
            <p:nvPr/>
          </p:nvSpPr>
          <p:spPr>
            <a:xfrm rot="5400000">
              <a:off x="7984236" y="1012281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hwwgr-3AL</a:t>
              </a:r>
            </a:p>
          </p:txBody>
        </p:sp>
        <p:sp>
          <p:nvSpPr>
            <p:cNvPr id="261" name="Rectangle 260">
              <a:extLst>
                <a:ext uri="{FF2B5EF4-FFF2-40B4-BE49-F238E27FC236}">
                  <a16:creationId xmlns:a16="http://schemas.microsoft.com/office/drawing/2014/main" id="{590E8334-4B9A-42D2-9A1F-817C81E51E2A}"/>
                </a:ext>
              </a:extLst>
            </p:cNvPr>
            <p:cNvSpPr/>
            <p:nvPr/>
          </p:nvSpPr>
          <p:spPr>
            <a:xfrm rot="5400000">
              <a:off x="8347389" y="947748"/>
              <a:ext cx="70171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62" name="Group 261">
            <a:extLst>
              <a:ext uri="{FF2B5EF4-FFF2-40B4-BE49-F238E27FC236}">
                <a16:creationId xmlns:a16="http://schemas.microsoft.com/office/drawing/2014/main" id="{3A187D6A-B7B2-4A4A-8B29-483947D6C31E}"/>
              </a:ext>
            </a:extLst>
          </p:cNvPr>
          <p:cNvGrpSpPr/>
          <p:nvPr/>
        </p:nvGrpSpPr>
        <p:grpSpPr>
          <a:xfrm>
            <a:off x="2136559" y="2999961"/>
            <a:ext cx="285260" cy="1240609"/>
            <a:chOff x="8355475" y="608952"/>
            <a:chExt cx="285260" cy="1051392"/>
          </a:xfrm>
        </p:grpSpPr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6A95F4BE-B780-44C7-B3A2-FA637425477D}"/>
                </a:ext>
              </a:extLst>
            </p:cNvPr>
            <p:cNvSpPr txBox="1"/>
            <p:nvPr/>
          </p:nvSpPr>
          <p:spPr>
            <a:xfrm rot="5400000">
              <a:off x="7984234" y="1003843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gc.hwwgr-3A</a:t>
              </a:r>
            </a:p>
          </p:txBody>
        </p:sp>
        <p:sp>
          <p:nvSpPr>
            <p:cNvPr id="264" name="Rectangle 263">
              <a:extLst>
                <a:ext uri="{FF2B5EF4-FFF2-40B4-BE49-F238E27FC236}">
                  <a16:creationId xmlns:a16="http://schemas.microsoft.com/office/drawing/2014/main" id="{C5020B21-86C5-40F1-BDF5-896200FF5828}"/>
                </a:ext>
              </a:extLst>
            </p:cNvPr>
            <p:cNvSpPr/>
            <p:nvPr/>
          </p:nvSpPr>
          <p:spPr>
            <a:xfrm rot="5400000">
              <a:off x="8347389" y="947748"/>
              <a:ext cx="70171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230" name="TextBox 229">
            <a:extLst>
              <a:ext uri="{FF2B5EF4-FFF2-40B4-BE49-F238E27FC236}">
                <a16:creationId xmlns:a16="http://schemas.microsoft.com/office/drawing/2014/main" id="{A5CCE129-0EBB-42BF-971B-EF79D47DE26E}"/>
              </a:ext>
            </a:extLst>
          </p:cNvPr>
          <p:cNvSpPr txBox="1"/>
          <p:nvPr/>
        </p:nvSpPr>
        <p:spPr>
          <a:xfrm>
            <a:off x="1322811" y="479055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MFT-A1</a:t>
            </a:r>
          </a:p>
        </p:txBody>
      </p:sp>
      <p:cxnSp>
        <p:nvCxnSpPr>
          <p:cNvPr id="231" name="Straight Connector 230">
            <a:extLst>
              <a:ext uri="{FF2B5EF4-FFF2-40B4-BE49-F238E27FC236}">
                <a16:creationId xmlns:a16="http://schemas.microsoft.com/office/drawing/2014/main" id="{C1207E42-82B3-44CD-9925-BA80CB30011A}"/>
              </a:ext>
            </a:extLst>
          </p:cNvPr>
          <p:cNvCxnSpPr/>
          <p:nvPr/>
        </p:nvCxnSpPr>
        <p:spPr>
          <a:xfrm>
            <a:off x="1061096" y="615664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2" name="TextBox 231">
            <a:extLst>
              <a:ext uri="{FF2B5EF4-FFF2-40B4-BE49-F238E27FC236}">
                <a16:creationId xmlns:a16="http://schemas.microsoft.com/office/drawing/2014/main" id="{489A8009-DC30-460E-BADF-C16073510DCB}"/>
              </a:ext>
            </a:extLst>
          </p:cNvPr>
          <p:cNvSpPr txBox="1"/>
          <p:nvPr/>
        </p:nvSpPr>
        <p:spPr>
          <a:xfrm>
            <a:off x="1312334" y="3142749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ABI1</a:t>
            </a:r>
          </a:p>
        </p:txBody>
      </p:sp>
      <p:cxnSp>
        <p:nvCxnSpPr>
          <p:cNvPr id="236" name="Straight Connector 235">
            <a:extLst>
              <a:ext uri="{FF2B5EF4-FFF2-40B4-BE49-F238E27FC236}">
                <a16:creationId xmlns:a16="http://schemas.microsoft.com/office/drawing/2014/main" id="{834BEAC1-B896-4549-BD82-C5CB557FFFA6}"/>
              </a:ext>
            </a:extLst>
          </p:cNvPr>
          <p:cNvCxnSpPr/>
          <p:nvPr/>
        </p:nvCxnSpPr>
        <p:spPr>
          <a:xfrm>
            <a:off x="1061096" y="3235822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7" name="TextBox 236">
            <a:extLst>
              <a:ext uri="{FF2B5EF4-FFF2-40B4-BE49-F238E27FC236}">
                <a16:creationId xmlns:a16="http://schemas.microsoft.com/office/drawing/2014/main" id="{5A2160EF-911E-42A4-8F8D-F0B04EF9FD66}"/>
              </a:ext>
            </a:extLst>
          </p:cNvPr>
          <p:cNvSpPr txBox="1"/>
          <p:nvPr/>
        </p:nvSpPr>
        <p:spPr>
          <a:xfrm>
            <a:off x="1401382" y="4994185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err="1"/>
              <a:t>TaABF</a:t>
            </a:r>
            <a:endParaRPr lang="en-AU" sz="1000" dirty="0"/>
          </a:p>
        </p:txBody>
      </p:sp>
      <p:cxnSp>
        <p:nvCxnSpPr>
          <p:cNvPr id="238" name="Straight Connector 237">
            <a:extLst>
              <a:ext uri="{FF2B5EF4-FFF2-40B4-BE49-F238E27FC236}">
                <a16:creationId xmlns:a16="http://schemas.microsoft.com/office/drawing/2014/main" id="{544D178D-711C-4837-B267-9CAFCB7001A3}"/>
              </a:ext>
            </a:extLst>
          </p:cNvPr>
          <p:cNvCxnSpPr/>
          <p:nvPr/>
        </p:nvCxnSpPr>
        <p:spPr>
          <a:xfrm>
            <a:off x="1061096" y="5017065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2" name="TextBox 241">
            <a:extLst>
              <a:ext uri="{FF2B5EF4-FFF2-40B4-BE49-F238E27FC236}">
                <a16:creationId xmlns:a16="http://schemas.microsoft.com/office/drawing/2014/main" id="{0F327D5D-BCB6-465B-A21D-043FD55F107E}"/>
              </a:ext>
            </a:extLst>
          </p:cNvPr>
          <p:cNvSpPr txBox="1"/>
          <p:nvPr/>
        </p:nvSpPr>
        <p:spPr>
          <a:xfrm>
            <a:off x="1338764" y="1503445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ABI8</a:t>
            </a:r>
          </a:p>
        </p:txBody>
      </p:sp>
      <p:cxnSp>
        <p:nvCxnSpPr>
          <p:cNvPr id="243" name="Straight Connector 242">
            <a:extLst>
              <a:ext uri="{FF2B5EF4-FFF2-40B4-BE49-F238E27FC236}">
                <a16:creationId xmlns:a16="http://schemas.microsoft.com/office/drawing/2014/main" id="{2CFF3026-5464-41E0-A558-56275A0051C2}"/>
              </a:ext>
            </a:extLst>
          </p:cNvPr>
          <p:cNvCxnSpPr/>
          <p:nvPr/>
        </p:nvCxnSpPr>
        <p:spPr>
          <a:xfrm>
            <a:off x="1061096" y="1636530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TextBox 243">
            <a:extLst>
              <a:ext uri="{FF2B5EF4-FFF2-40B4-BE49-F238E27FC236}">
                <a16:creationId xmlns:a16="http://schemas.microsoft.com/office/drawing/2014/main" id="{205CCFC3-22A0-4522-8B68-AC085740E4CF}"/>
              </a:ext>
            </a:extLst>
          </p:cNvPr>
          <p:cNvSpPr txBox="1"/>
          <p:nvPr/>
        </p:nvSpPr>
        <p:spPr>
          <a:xfrm>
            <a:off x="1457940" y="3979729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mERA1</a:t>
            </a:r>
          </a:p>
        </p:txBody>
      </p:sp>
      <p:cxnSp>
        <p:nvCxnSpPr>
          <p:cNvPr id="245" name="Straight Connector 244">
            <a:extLst>
              <a:ext uri="{FF2B5EF4-FFF2-40B4-BE49-F238E27FC236}">
                <a16:creationId xmlns:a16="http://schemas.microsoft.com/office/drawing/2014/main" id="{464CAA5D-A224-47C8-BB67-17F6927E38AF}"/>
              </a:ext>
            </a:extLst>
          </p:cNvPr>
          <p:cNvCxnSpPr/>
          <p:nvPr/>
        </p:nvCxnSpPr>
        <p:spPr>
          <a:xfrm>
            <a:off x="1061096" y="4217792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TextBox 245">
            <a:extLst>
              <a:ext uri="{FF2B5EF4-FFF2-40B4-BE49-F238E27FC236}">
                <a16:creationId xmlns:a16="http://schemas.microsoft.com/office/drawing/2014/main" id="{3BC0CE34-18FD-427C-952D-D46D52EC99CF}"/>
              </a:ext>
            </a:extLst>
          </p:cNvPr>
          <p:cNvSpPr txBox="1"/>
          <p:nvPr/>
        </p:nvSpPr>
        <p:spPr>
          <a:xfrm>
            <a:off x="1326213" y="899795"/>
            <a:ext cx="10027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DOG1L1</a:t>
            </a:r>
          </a:p>
        </p:txBody>
      </p:sp>
      <p:cxnSp>
        <p:nvCxnSpPr>
          <p:cNvPr id="247" name="Straight Connector 246">
            <a:extLst>
              <a:ext uri="{FF2B5EF4-FFF2-40B4-BE49-F238E27FC236}">
                <a16:creationId xmlns:a16="http://schemas.microsoft.com/office/drawing/2014/main" id="{234D789D-CBFA-47C2-A0CE-76F9F55ADDA0}"/>
              </a:ext>
            </a:extLst>
          </p:cNvPr>
          <p:cNvCxnSpPr/>
          <p:nvPr/>
        </p:nvCxnSpPr>
        <p:spPr>
          <a:xfrm>
            <a:off x="1061096" y="1050052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Straight Connector 250">
            <a:extLst>
              <a:ext uri="{FF2B5EF4-FFF2-40B4-BE49-F238E27FC236}">
                <a16:creationId xmlns:a16="http://schemas.microsoft.com/office/drawing/2014/main" id="{221CA852-721A-446A-A54B-FE370BE13A6F}"/>
              </a:ext>
            </a:extLst>
          </p:cNvPr>
          <p:cNvCxnSpPr/>
          <p:nvPr/>
        </p:nvCxnSpPr>
        <p:spPr>
          <a:xfrm>
            <a:off x="1061096" y="4455778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Straight Connector 251">
            <a:extLst>
              <a:ext uri="{FF2B5EF4-FFF2-40B4-BE49-F238E27FC236}">
                <a16:creationId xmlns:a16="http://schemas.microsoft.com/office/drawing/2014/main" id="{8EE9B327-F4E6-4A0F-84CC-6C5AE92B60E7}"/>
              </a:ext>
            </a:extLst>
          </p:cNvPr>
          <p:cNvCxnSpPr>
            <a:cxnSpLocks/>
          </p:cNvCxnSpPr>
          <p:nvPr/>
        </p:nvCxnSpPr>
        <p:spPr>
          <a:xfrm rot="10320000" flipV="1">
            <a:off x="1397167" y="4372808"/>
            <a:ext cx="123844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5" name="TextBox 264">
            <a:extLst>
              <a:ext uri="{FF2B5EF4-FFF2-40B4-BE49-F238E27FC236}">
                <a16:creationId xmlns:a16="http://schemas.microsoft.com/office/drawing/2014/main" id="{EBFE74F1-641C-4317-B7D5-39E93F34585D}"/>
              </a:ext>
            </a:extLst>
          </p:cNvPr>
          <p:cNvSpPr txBox="1"/>
          <p:nvPr/>
        </p:nvSpPr>
        <p:spPr>
          <a:xfrm>
            <a:off x="5679617" y="1064830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DOG1L1</a:t>
            </a:r>
          </a:p>
        </p:txBody>
      </p:sp>
      <p:cxnSp>
        <p:nvCxnSpPr>
          <p:cNvPr id="266" name="Straight Connector 265">
            <a:extLst>
              <a:ext uri="{FF2B5EF4-FFF2-40B4-BE49-F238E27FC236}">
                <a16:creationId xmlns:a16="http://schemas.microsoft.com/office/drawing/2014/main" id="{DCF99884-8E59-4998-9845-0F673A23E7B5}"/>
              </a:ext>
            </a:extLst>
          </p:cNvPr>
          <p:cNvCxnSpPr/>
          <p:nvPr/>
        </p:nvCxnSpPr>
        <p:spPr>
          <a:xfrm>
            <a:off x="5408339" y="120143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7" name="TextBox 266">
            <a:extLst>
              <a:ext uri="{FF2B5EF4-FFF2-40B4-BE49-F238E27FC236}">
                <a16:creationId xmlns:a16="http://schemas.microsoft.com/office/drawing/2014/main" id="{DAC8DA0B-185F-416D-A6EE-F7758376CB12}"/>
              </a:ext>
            </a:extLst>
          </p:cNvPr>
          <p:cNvSpPr txBox="1"/>
          <p:nvPr/>
        </p:nvSpPr>
        <p:spPr>
          <a:xfrm>
            <a:off x="5682540" y="4310674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DOG1L4</a:t>
            </a:r>
          </a:p>
        </p:txBody>
      </p:sp>
      <p:cxnSp>
        <p:nvCxnSpPr>
          <p:cNvPr id="268" name="Straight Connector 267">
            <a:extLst>
              <a:ext uri="{FF2B5EF4-FFF2-40B4-BE49-F238E27FC236}">
                <a16:creationId xmlns:a16="http://schemas.microsoft.com/office/drawing/2014/main" id="{B90395FF-EE9F-4BED-BB41-88190AC156D2}"/>
              </a:ext>
            </a:extLst>
          </p:cNvPr>
          <p:cNvCxnSpPr/>
          <p:nvPr/>
        </p:nvCxnSpPr>
        <p:spPr>
          <a:xfrm>
            <a:off x="5408339" y="439502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9" name="TextBox 268">
            <a:extLst>
              <a:ext uri="{FF2B5EF4-FFF2-40B4-BE49-F238E27FC236}">
                <a16:creationId xmlns:a16="http://schemas.microsoft.com/office/drawing/2014/main" id="{FCF903C6-7D7E-447D-A2EC-EA2A8BD85E88}"/>
              </a:ext>
            </a:extLst>
          </p:cNvPr>
          <p:cNvSpPr txBox="1"/>
          <p:nvPr/>
        </p:nvSpPr>
        <p:spPr>
          <a:xfrm>
            <a:off x="1319312" y="3465125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DFR</a:t>
            </a:r>
          </a:p>
        </p:txBody>
      </p:sp>
      <p:cxnSp>
        <p:nvCxnSpPr>
          <p:cNvPr id="270" name="Straight Connector 269">
            <a:extLst>
              <a:ext uri="{FF2B5EF4-FFF2-40B4-BE49-F238E27FC236}">
                <a16:creationId xmlns:a16="http://schemas.microsoft.com/office/drawing/2014/main" id="{9897E914-DD89-4A61-9186-9E13BC89C595}"/>
              </a:ext>
            </a:extLst>
          </p:cNvPr>
          <p:cNvCxnSpPr/>
          <p:nvPr/>
        </p:nvCxnSpPr>
        <p:spPr>
          <a:xfrm>
            <a:off x="1061096" y="3601734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1" name="TextBox 270">
            <a:extLst>
              <a:ext uri="{FF2B5EF4-FFF2-40B4-BE49-F238E27FC236}">
                <a16:creationId xmlns:a16="http://schemas.microsoft.com/office/drawing/2014/main" id="{9EDA8842-4678-4E9D-AABE-474776016875}"/>
              </a:ext>
            </a:extLst>
          </p:cNvPr>
          <p:cNvSpPr txBox="1"/>
          <p:nvPr/>
        </p:nvSpPr>
        <p:spPr>
          <a:xfrm>
            <a:off x="5673259" y="4837060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Myc3</a:t>
            </a:r>
          </a:p>
        </p:txBody>
      </p:sp>
      <p:cxnSp>
        <p:nvCxnSpPr>
          <p:cNvPr id="272" name="Straight Connector 271">
            <a:extLst>
              <a:ext uri="{FF2B5EF4-FFF2-40B4-BE49-F238E27FC236}">
                <a16:creationId xmlns:a16="http://schemas.microsoft.com/office/drawing/2014/main" id="{BB38A1FB-2220-4BB0-9E33-C4A2A3FE31BD}"/>
              </a:ext>
            </a:extLst>
          </p:cNvPr>
          <p:cNvCxnSpPr/>
          <p:nvPr/>
        </p:nvCxnSpPr>
        <p:spPr>
          <a:xfrm>
            <a:off x="5408339" y="497366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7" name="TextBox 276">
            <a:extLst>
              <a:ext uri="{FF2B5EF4-FFF2-40B4-BE49-F238E27FC236}">
                <a16:creationId xmlns:a16="http://schemas.microsoft.com/office/drawing/2014/main" id="{A1FEA16C-44CA-438D-8725-0B41B6732F44}"/>
              </a:ext>
            </a:extLst>
          </p:cNvPr>
          <p:cNvSpPr txBox="1"/>
          <p:nvPr/>
        </p:nvSpPr>
        <p:spPr>
          <a:xfrm>
            <a:off x="1325319" y="1111358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IAA1</a:t>
            </a:r>
          </a:p>
        </p:txBody>
      </p:sp>
      <p:cxnSp>
        <p:nvCxnSpPr>
          <p:cNvPr id="278" name="Straight Connector 277">
            <a:extLst>
              <a:ext uri="{FF2B5EF4-FFF2-40B4-BE49-F238E27FC236}">
                <a16:creationId xmlns:a16="http://schemas.microsoft.com/office/drawing/2014/main" id="{D4AD7242-8621-4942-A6AD-7073A581253E}"/>
              </a:ext>
            </a:extLst>
          </p:cNvPr>
          <p:cNvCxnSpPr/>
          <p:nvPr/>
        </p:nvCxnSpPr>
        <p:spPr>
          <a:xfrm>
            <a:off x="1061096" y="1227495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5" name="TextBox 284">
            <a:extLst>
              <a:ext uri="{FF2B5EF4-FFF2-40B4-BE49-F238E27FC236}">
                <a16:creationId xmlns:a16="http://schemas.microsoft.com/office/drawing/2014/main" id="{C28D3141-3952-4F8D-B014-2DAC62CFB166}"/>
              </a:ext>
            </a:extLst>
          </p:cNvPr>
          <p:cNvSpPr txBox="1"/>
          <p:nvPr/>
        </p:nvSpPr>
        <p:spPr>
          <a:xfrm>
            <a:off x="5687298" y="1804520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IAA1</a:t>
            </a:r>
          </a:p>
        </p:txBody>
      </p:sp>
      <p:cxnSp>
        <p:nvCxnSpPr>
          <p:cNvPr id="286" name="Straight Connector 285">
            <a:extLst>
              <a:ext uri="{FF2B5EF4-FFF2-40B4-BE49-F238E27FC236}">
                <a16:creationId xmlns:a16="http://schemas.microsoft.com/office/drawing/2014/main" id="{3FABCBB3-335C-4E0C-8BC9-4C28F1D90495}"/>
              </a:ext>
            </a:extLst>
          </p:cNvPr>
          <p:cNvCxnSpPr/>
          <p:nvPr/>
        </p:nvCxnSpPr>
        <p:spPr>
          <a:xfrm>
            <a:off x="5408339" y="1920657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7" name="TextBox 286">
            <a:extLst>
              <a:ext uri="{FF2B5EF4-FFF2-40B4-BE49-F238E27FC236}">
                <a16:creationId xmlns:a16="http://schemas.microsoft.com/office/drawing/2014/main" id="{4B890E38-F32A-4CFD-AF33-9CB85FA8DE94}"/>
              </a:ext>
            </a:extLst>
          </p:cNvPr>
          <p:cNvSpPr txBox="1"/>
          <p:nvPr/>
        </p:nvSpPr>
        <p:spPr>
          <a:xfrm>
            <a:off x="5661038" y="625434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3ox2</a:t>
            </a:r>
          </a:p>
        </p:txBody>
      </p:sp>
      <p:cxnSp>
        <p:nvCxnSpPr>
          <p:cNvPr id="288" name="Straight Connector 287">
            <a:extLst>
              <a:ext uri="{FF2B5EF4-FFF2-40B4-BE49-F238E27FC236}">
                <a16:creationId xmlns:a16="http://schemas.microsoft.com/office/drawing/2014/main" id="{B43837D2-8D32-44BB-8453-64721B0DD1CB}"/>
              </a:ext>
            </a:extLst>
          </p:cNvPr>
          <p:cNvCxnSpPr/>
          <p:nvPr/>
        </p:nvCxnSpPr>
        <p:spPr>
          <a:xfrm>
            <a:off x="5408339" y="762043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9" name="TextBox 288">
            <a:extLst>
              <a:ext uri="{FF2B5EF4-FFF2-40B4-BE49-F238E27FC236}">
                <a16:creationId xmlns:a16="http://schemas.microsoft.com/office/drawing/2014/main" id="{FE6DB039-A3AD-4608-B15B-26176ACA1990}"/>
              </a:ext>
            </a:extLst>
          </p:cNvPr>
          <p:cNvSpPr txBox="1"/>
          <p:nvPr/>
        </p:nvSpPr>
        <p:spPr>
          <a:xfrm>
            <a:off x="1378284" y="1230585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3ox2</a:t>
            </a:r>
          </a:p>
        </p:txBody>
      </p:sp>
      <p:cxnSp>
        <p:nvCxnSpPr>
          <p:cNvPr id="290" name="Straight Connector 289">
            <a:extLst>
              <a:ext uri="{FF2B5EF4-FFF2-40B4-BE49-F238E27FC236}">
                <a16:creationId xmlns:a16="http://schemas.microsoft.com/office/drawing/2014/main" id="{B769663A-EE40-4780-8BD9-03FE7BA7D6EC}"/>
              </a:ext>
            </a:extLst>
          </p:cNvPr>
          <p:cNvCxnSpPr/>
          <p:nvPr/>
        </p:nvCxnSpPr>
        <p:spPr>
          <a:xfrm>
            <a:off x="1061096" y="1249040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1" name="Straight Connector 290">
            <a:extLst>
              <a:ext uri="{FF2B5EF4-FFF2-40B4-BE49-F238E27FC236}">
                <a16:creationId xmlns:a16="http://schemas.microsoft.com/office/drawing/2014/main" id="{CC1DC92E-DE7C-48F5-AC70-90BE77E97B1C}"/>
              </a:ext>
            </a:extLst>
          </p:cNvPr>
          <p:cNvCxnSpPr>
            <a:cxnSpLocks/>
          </p:cNvCxnSpPr>
          <p:nvPr/>
        </p:nvCxnSpPr>
        <p:spPr>
          <a:xfrm flipH="1" flipV="1">
            <a:off x="1400850" y="1246748"/>
            <a:ext cx="62649" cy="818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3" name="Straight Connector 292">
            <a:extLst>
              <a:ext uri="{FF2B5EF4-FFF2-40B4-BE49-F238E27FC236}">
                <a16:creationId xmlns:a16="http://schemas.microsoft.com/office/drawing/2014/main" id="{BFCB59C1-ABB4-4708-BD5C-C9E0169EF657}"/>
              </a:ext>
            </a:extLst>
          </p:cNvPr>
          <p:cNvCxnSpPr/>
          <p:nvPr/>
        </p:nvCxnSpPr>
        <p:spPr>
          <a:xfrm>
            <a:off x="1061096" y="4333453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4" name="TextBox 293">
            <a:extLst>
              <a:ext uri="{FF2B5EF4-FFF2-40B4-BE49-F238E27FC236}">
                <a16:creationId xmlns:a16="http://schemas.microsoft.com/office/drawing/2014/main" id="{1DDEBEF8-F10A-4511-8464-9127F480BAC6}"/>
              </a:ext>
            </a:extLst>
          </p:cNvPr>
          <p:cNvSpPr txBox="1"/>
          <p:nvPr/>
        </p:nvSpPr>
        <p:spPr>
          <a:xfrm>
            <a:off x="5688326" y="4208444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3</a:t>
            </a:r>
          </a:p>
        </p:txBody>
      </p:sp>
      <p:cxnSp>
        <p:nvCxnSpPr>
          <p:cNvPr id="295" name="Straight Connector 294">
            <a:extLst>
              <a:ext uri="{FF2B5EF4-FFF2-40B4-BE49-F238E27FC236}">
                <a16:creationId xmlns:a16="http://schemas.microsoft.com/office/drawing/2014/main" id="{575B20C0-11F7-4D1B-BF0C-5C0A460A3E14}"/>
              </a:ext>
            </a:extLst>
          </p:cNvPr>
          <p:cNvCxnSpPr/>
          <p:nvPr/>
        </p:nvCxnSpPr>
        <p:spPr>
          <a:xfrm>
            <a:off x="5408339" y="4353762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Straight Connector 295">
            <a:extLst>
              <a:ext uri="{FF2B5EF4-FFF2-40B4-BE49-F238E27FC236}">
                <a16:creationId xmlns:a16="http://schemas.microsoft.com/office/drawing/2014/main" id="{6CC42B9F-AFC0-4623-B299-96990FB02A9D}"/>
              </a:ext>
            </a:extLst>
          </p:cNvPr>
          <p:cNvCxnSpPr>
            <a:cxnSpLocks/>
          </p:cNvCxnSpPr>
          <p:nvPr/>
        </p:nvCxnSpPr>
        <p:spPr>
          <a:xfrm flipH="1">
            <a:off x="1397881" y="4240681"/>
            <a:ext cx="144000" cy="92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Straight Connector 296">
            <a:extLst>
              <a:ext uri="{FF2B5EF4-FFF2-40B4-BE49-F238E27FC236}">
                <a16:creationId xmlns:a16="http://schemas.microsoft.com/office/drawing/2014/main" id="{42BCBDD8-2F1B-4769-9DA5-C34655DD96C4}"/>
              </a:ext>
            </a:extLst>
          </p:cNvPr>
          <p:cNvCxnSpPr>
            <a:cxnSpLocks/>
          </p:cNvCxnSpPr>
          <p:nvPr/>
        </p:nvCxnSpPr>
        <p:spPr>
          <a:xfrm flipH="1">
            <a:off x="1398872" y="4125386"/>
            <a:ext cx="144000" cy="92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8" name="TextBox 297">
            <a:extLst>
              <a:ext uri="{FF2B5EF4-FFF2-40B4-BE49-F238E27FC236}">
                <a16:creationId xmlns:a16="http://schemas.microsoft.com/office/drawing/2014/main" id="{39811099-BB0B-4D88-B369-B1345EB7D739}"/>
              </a:ext>
            </a:extLst>
          </p:cNvPr>
          <p:cNvSpPr txBox="1"/>
          <p:nvPr/>
        </p:nvSpPr>
        <p:spPr>
          <a:xfrm>
            <a:off x="1357968" y="4467290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7</a:t>
            </a:r>
          </a:p>
        </p:txBody>
      </p:sp>
      <p:cxnSp>
        <p:nvCxnSpPr>
          <p:cNvPr id="299" name="Straight Connector 298">
            <a:extLst>
              <a:ext uri="{FF2B5EF4-FFF2-40B4-BE49-F238E27FC236}">
                <a16:creationId xmlns:a16="http://schemas.microsoft.com/office/drawing/2014/main" id="{AF291778-4D4B-4CC6-BA32-5123EE2EDC04}"/>
              </a:ext>
            </a:extLst>
          </p:cNvPr>
          <p:cNvCxnSpPr/>
          <p:nvPr/>
        </p:nvCxnSpPr>
        <p:spPr>
          <a:xfrm>
            <a:off x="1061096" y="459754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6" name="TextBox 305">
            <a:extLst>
              <a:ext uri="{FF2B5EF4-FFF2-40B4-BE49-F238E27FC236}">
                <a16:creationId xmlns:a16="http://schemas.microsoft.com/office/drawing/2014/main" id="{597DB099-ED42-4DF7-8B3B-98D48D91128C}"/>
              </a:ext>
            </a:extLst>
          </p:cNvPr>
          <p:cNvSpPr txBox="1"/>
          <p:nvPr/>
        </p:nvSpPr>
        <p:spPr>
          <a:xfrm>
            <a:off x="1356496" y="5780846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F200045</a:t>
            </a:r>
          </a:p>
        </p:txBody>
      </p:sp>
      <p:cxnSp>
        <p:nvCxnSpPr>
          <p:cNvPr id="307" name="Straight Connector 306">
            <a:extLst>
              <a:ext uri="{FF2B5EF4-FFF2-40B4-BE49-F238E27FC236}">
                <a16:creationId xmlns:a16="http://schemas.microsoft.com/office/drawing/2014/main" id="{DAA8CEBF-E258-4678-833E-BCF15A50B461}"/>
              </a:ext>
            </a:extLst>
          </p:cNvPr>
          <p:cNvCxnSpPr/>
          <p:nvPr/>
        </p:nvCxnSpPr>
        <p:spPr>
          <a:xfrm>
            <a:off x="1061096" y="5909828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9" name="Straight Connector 308">
            <a:extLst>
              <a:ext uri="{FF2B5EF4-FFF2-40B4-BE49-F238E27FC236}">
                <a16:creationId xmlns:a16="http://schemas.microsoft.com/office/drawing/2014/main" id="{3F0ABCAF-0D94-46BC-A9CB-117C4D9ECD5F}"/>
              </a:ext>
            </a:extLst>
          </p:cNvPr>
          <p:cNvCxnSpPr/>
          <p:nvPr/>
        </p:nvCxnSpPr>
        <p:spPr>
          <a:xfrm>
            <a:off x="1061096" y="527147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0" name="TextBox 309">
            <a:extLst>
              <a:ext uri="{FF2B5EF4-FFF2-40B4-BE49-F238E27FC236}">
                <a16:creationId xmlns:a16="http://schemas.microsoft.com/office/drawing/2014/main" id="{97B689D4-C2CA-493C-A0E0-3C671925B503}"/>
              </a:ext>
            </a:extLst>
          </p:cNvPr>
          <p:cNvSpPr txBox="1"/>
          <p:nvPr/>
        </p:nvSpPr>
        <p:spPr>
          <a:xfrm>
            <a:off x="1352860" y="762115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J229643</a:t>
            </a:r>
          </a:p>
        </p:txBody>
      </p:sp>
      <p:cxnSp>
        <p:nvCxnSpPr>
          <p:cNvPr id="311" name="Straight Connector 310">
            <a:extLst>
              <a:ext uri="{FF2B5EF4-FFF2-40B4-BE49-F238E27FC236}">
                <a16:creationId xmlns:a16="http://schemas.microsoft.com/office/drawing/2014/main" id="{72C96852-EC38-4758-909D-3FDCAB0BAEFC}"/>
              </a:ext>
            </a:extLst>
          </p:cNvPr>
          <p:cNvCxnSpPr/>
          <p:nvPr/>
        </p:nvCxnSpPr>
        <p:spPr>
          <a:xfrm>
            <a:off x="1061096" y="891097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2" name="TextBox 311">
            <a:extLst>
              <a:ext uri="{FF2B5EF4-FFF2-40B4-BE49-F238E27FC236}">
                <a16:creationId xmlns:a16="http://schemas.microsoft.com/office/drawing/2014/main" id="{FDC23014-1FC6-4F21-B150-CE535130E1F0}"/>
              </a:ext>
            </a:extLst>
          </p:cNvPr>
          <p:cNvSpPr txBox="1"/>
          <p:nvPr/>
        </p:nvSpPr>
        <p:spPr>
          <a:xfrm>
            <a:off x="1392482" y="4882774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CA741454</a:t>
            </a:r>
          </a:p>
        </p:txBody>
      </p:sp>
      <p:cxnSp>
        <p:nvCxnSpPr>
          <p:cNvPr id="313" name="Straight Connector 312">
            <a:extLst>
              <a:ext uri="{FF2B5EF4-FFF2-40B4-BE49-F238E27FC236}">
                <a16:creationId xmlns:a16="http://schemas.microsoft.com/office/drawing/2014/main" id="{A189B527-A0DB-4530-8CD0-C983AB313100}"/>
              </a:ext>
            </a:extLst>
          </p:cNvPr>
          <p:cNvCxnSpPr/>
          <p:nvPr/>
        </p:nvCxnSpPr>
        <p:spPr>
          <a:xfrm>
            <a:off x="1061096" y="4948066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4" name="TextBox 313">
            <a:extLst>
              <a:ext uri="{FF2B5EF4-FFF2-40B4-BE49-F238E27FC236}">
                <a16:creationId xmlns:a16="http://schemas.microsoft.com/office/drawing/2014/main" id="{505AADD8-40F0-46E0-8B12-F8248EC7EB60}"/>
              </a:ext>
            </a:extLst>
          </p:cNvPr>
          <p:cNvSpPr txBox="1"/>
          <p:nvPr/>
        </p:nvSpPr>
        <p:spPr>
          <a:xfrm>
            <a:off x="1383007" y="1323234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CD490513</a:t>
            </a:r>
          </a:p>
        </p:txBody>
      </p:sp>
      <p:cxnSp>
        <p:nvCxnSpPr>
          <p:cNvPr id="315" name="Straight Connector 314">
            <a:extLst>
              <a:ext uri="{FF2B5EF4-FFF2-40B4-BE49-F238E27FC236}">
                <a16:creationId xmlns:a16="http://schemas.microsoft.com/office/drawing/2014/main" id="{26EA24F5-4A0D-48D1-BEF5-45877E1A2645}"/>
              </a:ext>
            </a:extLst>
          </p:cNvPr>
          <p:cNvCxnSpPr/>
          <p:nvPr/>
        </p:nvCxnSpPr>
        <p:spPr>
          <a:xfrm>
            <a:off x="1061096" y="130750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6" name="Straight Connector 315">
            <a:extLst>
              <a:ext uri="{FF2B5EF4-FFF2-40B4-BE49-F238E27FC236}">
                <a16:creationId xmlns:a16="http://schemas.microsoft.com/office/drawing/2014/main" id="{500CEB80-E746-411F-A3BA-A3D4549898E6}"/>
              </a:ext>
            </a:extLst>
          </p:cNvPr>
          <p:cNvCxnSpPr>
            <a:cxnSpLocks/>
          </p:cNvCxnSpPr>
          <p:nvPr/>
        </p:nvCxnSpPr>
        <p:spPr>
          <a:xfrm rot="360000" flipH="1" flipV="1">
            <a:off x="1393154" y="1309863"/>
            <a:ext cx="79268" cy="880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7" name="Straight Connector 316">
            <a:extLst>
              <a:ext uri="{FF2B5EF4-FFF2-40B4-BE49-F238E27FC236}">
                <a16:creationId xmlns:a16="http://schemas.microsoft.com/office/drawing/2014/main" id="{E5DC5581-3643-4801-B9BA-4726C66AEDCB}"/>
              </a:ext>
            </a:extLst>
          </p:cNvPr>
          <p:cNvCxnSpPr>
            <a:cxnSpLocks/>
          </p:cNvCxnSpPr>
          <p:nvPr/>
        </p:nvCxnSpPr>
        <p:spPr>
          <a:xfrm flipH="1" flipV="1">
            <a:off x="1400548" y="4948517"/>
            <a:ext cx="72000" cy="4002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8" name="Straight Connector 317">
            <a:extLst>
              <a:ext uri="{FF2B5EF4-FFF2-40B4-BE49-F238E27FC236}">
                <a16:creationId xmlns:a16="http://schemas.microsoft.com/office/drawing/2014/main" id="{27EEBF1F-BED7-4FC1-AF81-6AB37D491395}"/>
              </a:ext>
            </a:extLst>
          </p:cNvPr>
          <p:cNvCxnSpPr>
            <a:cxnSpLocks/>
          </p:cNvCxnSpPr>
          <p:nvPr/>
        </p:nvCxnSpPr>
        <p:spPr>
          <a:xfrm rot="15420000" flipV="1">
            <a:off x="1391106" y="5024199"/>
            <a:ext cx="10800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0" name="TextBox 299">
            <a:extLst>
              <a:ext uri="{FF2B5EF4-FFF2-40B4-BE49-F238E27FC236}">
                <a16:creationId xmlns:a16="http://schemas.microsoft.com/office/drawing/2014/main" id="{BB693654-CA4B-48B1-A184-1E0E49AAE88D}"/>
              </a:ext>
            </a:extLst>
          </p:cNvPr>
          <p:cNvSpPr txBox="1"/>
          <p:nvPr/>
        </p:nvSpPr>
        <p:spPr>
          <a:xfrm>
            <a:off x="1310816" y="3054349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PP2C</a:t>
            </a:r>
          </a:p>
        </p:txBody>
      </p:sp>
      <p:cxnSp>
        <p:nvCxnSpPr>
          <p:cNvPr id="301" name="Straight Connector 300">
            <a:extLst>
              <a:ext uri="{FF2B5EF4-FFF2-40B4-BE49-F238E27FC236}">
                <a16:creationId xmlns:a16="http://schemas.microsoft.com/office/drawing/2014/main" id="{90E02712-2EBE-4E02-B69C-CDC8A9EB56AF}"/>
              </a:ext>
            </a:extLst>
          </p:cNvPr>
          <p:cNvCxnSpPr/>
          <p:nvPr/>
        </p:nvCxnSpPr>
        <p:spPr>
          <a:xfrm>
            <a:off x="1061096" y="3215447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3" name="TextBox 202">
            <a:extLst>
              <a:ext uri="{FF2B5EF4-FFF2-40B4-BE49-F238E27FC236}">
                <a16:creationId xmlns:a16="http://schemas.microsoft.com/office/drawing/2014/main" id="{D0C2479E-8C78-4203-B7F1-331502CA8F37}"/>
              </a:ext>
            </a:extLst>
          </p:cNvPr>
          <p:cNvSpPr txBox="1"/>
          <p:nvPr/>
        </p:nvSpPr>
        <p:spPr>
          <a:xfrm>
            <a:off x="5687821" y="4701959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EXPA2</a:t>
            </a:r>
          </a:p>
        </p:txBody>
      </p:sp>
      <p:cxnSp>
        <p:nvCxnSpPr>
          <p:cNvPr id="204" name="Straight Connector 203">
            <a:extLst>
              <a:ext uri="{FF2B5EF4-FFF2-40B4-BE49-F238E27FC236}">
                <a16:creationId xmlns:a16="http://schemas.microsoft.com/office/drawing/2014/main" id="{81D7B0A8-68F7-4D15-ADF8-5877DD2A2552}"/>
              </a:ext>
            </a:extLst>
          </p:cNvPr>
          <p:cNvCxnSpPr/>
          <p:nvPr/>
        </p:nvCxnSpPr>
        <p:spPr>
          <a:xfrm>
            <a:off x="5408339" y="4818096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036001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TextBox 180">
            <a:extLst>
              <a:ext uri="{FF2B5EF4-FFF2-40B4-BE49-F238E27FC236}">
                <a16:creationId xmlns:a16="http://schemas.microsoft.com/office/drawing/2014/main" id="{0C1F5840-CB16-4947-85A9-F6BA0AAB819B}"/>
              </a:ext>
            </a:extLst>
          </p:cNvPr>
          <p:cNvSpPr txBox="1"/>
          <p:nvPr/>
        </p:nvSpPr>
        <p:spPr>
          <a:xfrm>
            <a:off x="1431561" y="4990651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0ox1A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270DC70-F0A4-4E0D-9297-2CAEA6D2F76E}"/>
              </a:ext>
            </a:extLst>
          </p:cNvPr>
          <p:cNvGrpSpPr/>
          <p:nvPr/>
        </p:nvGrpSpPr>
        <p:grpSpPr>
          <a:xfrm>
            <a:off x="9592327" y="5251410"/>
            <a:ext cx="1142347" cy="1550617"/>
            <a:chOff x="9592327" y="5251410"/>
            <a:chExt cx="1142347" cy="1550617"/>
          </a:xfrm>
        </p:grpSpPr>
        <p:sp>
          <p:nvSpPr>
            <p:cNvPr id="3" name="Oval 2">
              <a:extLst>
                <a:ext uri="{FF2B5EF4-FFF2-40B4-BE49-F238E27FC236}">
                  <a16:creationId xmlns:a16="http://schemas.microsoft.com/office/drawing/2014/main" id="{251BC8D5-5DEB-49D9-BF58-F81E8D2944AB}"/>
                </a:ext>
              </a:extLst>
            </p:cNvPr>
            <p:cNvSpPr/>
            <p:nvPr/>
          </p:nvSpPr>
          <p:spPr>
            <a:xfrm>
              <a:off x="9601327" y="5359194"/>
              <a:ext cx="90000" cy="90000"/>
            </a:xfrm>
            <a:prstGeom prst="ellipse">
              <a:avLst/>
            </a:prstGeom>
            <a:solidFill>
              <a:srgbClr val="70474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4" name="Isosceles Triangle 3">
              <a:extLst>
                <a:ext uri="{FF2B5EF4-FFF2-40B4-BE49-F238E27FC236}">
                  <a16:creationId xmlns:a16="http://schemas.microsoft.com/office/drawing/2014/main" id="{C97D1B21-3456-46F2-803E-E306213A5448}"/>
                </a:ext>
              </a:extLst>
            </p:cNvPr>
            <p:cNvSpPr/>
            <p:nvPr/>
          </p:nvSpPr>
          <p:spPr>
            <a:xfrm>
              <a:off x="9592327" y="6436293"/>
              <a:ext cx="108000" cy="108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5" name="Diamond 4">
              <a:extLst>
                <a:ext uri="{FF2B5EF4-FFF2-40B4-BE49-F238E27FC236}">
                  <a16:creationId xmlns:a16="http://schemas.microsoft.com/office/drawing/2014/main" id="{AB8E1643-2152-4EA4-9B9E-014DD7AC2AC3}"/>
                </a:ext>
              </a:extLst>
            </p:cNvPr>
            <p:cNvSpPr/>
            <p:nvPr/>
          </p:nvSpPr>
          <p:spPr>
            <a:xfrm>
              <a:off x="9592327" y="5534298"/>
              <a:ext cx="108000" cy="108000"/>
            </a:xfrm>
            <a:prstGeom prst="diamond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6" name="Pentagon 5">
              <a:extLst>
                <a:ext uri="{FF2B5EF4-FFF2-40B4-BE49-F238E27FC236}">
                  <a16:creationId xmlns:a16="http://schemas.microsoft.com/office/drawing/2014/main" id="{714A9BD8-9032-48A2-9B71-5EB8377C5635}"/>
                </a:ext>
              </a:extLst>
            </p:cNvPr>
            <p:cNvSpPr/>
            <p:nvPr/>
          </p:nvSpPr>
          <p:spPr>
            <a:xfrm>
              <a:off x="9592327" y="6619875"/>
              <a:ext cx="108000" cy="108000"/>
            </a:xfrm>
            <a:prstGeom prst="pentagon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7" name="Hexagon 6">
              <a:extLst>
                <a:ext uri="{FF2B5EF4-FFF2-40B4-BE49-F238E27FC236}">
                  <a16:creationId xmlns:a16="http://schemas.microsoft.com/office/drawing/2014/main" id="{0D0E9D75-8F17-4A25-8C76-63F2C21923E3}"/>
                </a:ext>
              </a:extLst>
            </p:cNvPr>
            <p:cNvSpPr/>
            <p:nvPr/>
          </p:nvSpPr>
          <p:spPr>
            <a:xfrm>
              <a:off x="9592327" y="5717877"/>
              <a:ext cx="108000" cy="93600"/>
            </a:xfrm>
            <a:prstGeom prst="hexagon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51E4D73C-E786-4CEC-9E43-1CC06F427B44}"/>
                </a:ext>
              </a:extLst>
            </p:cNvPr>
            <p:cNvSpPr/>
            <p:nvPr/>
          </p:nvSpPr>
          <p:spPr>
            <a:xfrm>
              <a:off x="9610327" y="6095610"/>
              <a:ext cx="72000" cy="72000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9" name="Trapezoid 8">
              <a:extLst>
                <a:ext uri="{FF2B5EF4-FFF2-40B4-BE49-F238E27FC236}">
                  <a16:creationId xmlns:a16="http://schemas.microsoft.com/office/drawing/2014/main" id="{8F62C6FF-601C-420E-8ADB-6FE5DA4B21D1}"/>
                </a:ext>
              </a:extLst>
            </p:cNvPr>
            <p:cNvSpPr/>
            <p:nvPr/>
          </p:nvSpPr>
          <p:spPr>
            <a:xfrm>
              <a:off x="9592327" y="6252714"/>
              <a:ext cx="108000" cy="108000"/>
            </a:xfrm>
            <a:prstGeom prst="trapezoid">
              <a:avLst/>
            </a:prstGeom>
            <a:solidFill>
              <a:srgbClr val="EF19C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65561650-111E-4EA0-A6AC-821266460E24}"/>
                </a:ext>
              </a:extLst>
            </p:cNvPr>
            <p:cNvSpPr/>
            <p:nvPr/>
          </p:nvSpPr>
          <p:spPr>
            <a:xfrm>
              <a:off x="9601327" y="5901456"/>
              <a:ext cx="90000" cy="90000"/>
            </a:xfrm>
            <a:prstGeom prst="ellipse">
              <a:avLst/>
            </a:prstGeom>
            <a:solidFill>
              <a:srgbClr val="FA630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4089FF4-1767-4D25-958A-1FEE2ED3BE5C}"/>
                </a:ext>
              </a:extLst>
            </p:cNvPr>
            <p:cNvSpPr txBox="1"/>
            <p:nvPr/>
          </p:nvSpPr>
          <p:spPr>
            <a:xfrm>
              <a:off x="9696449" y="5251410"/>
              <a:ext cx="1038225" cy="1550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AU" sz="800" dirty="0"/>
                <a:t>April 2017 – 9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7 – 12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8 – 16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ne 2018 – 8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ly 2018 – 10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April 2019 – 24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9 – 22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ne 2019 – 11 das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01777EF6-89DF-4330-94E9-4F676FB25B4E}"/>
              </a:ext>
            </a:extLst>
          </p:cNvPr>
          <p:cNvGrpSpPr/>
          <p:nvPr/>
        </p:nvGrpSpPr>
        <p:grpSpPr>
          <a:xfrm>
            <a:off x="6327072" y="84166"/>
            <a:ext cx="270410" cy="1003300"/>
            <a:chOff x="8031292" y="307311"/>
            <a:chExt cx="270410" cy="1003300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6127B65-AD51-4509-9C8E-86A5F461E97F}"/>
                </a:ext>
              </a:extLst>
            </p:cNvPr>
            <p:cNvSpPr txBox="1"/>
            <p:nvPr/>
          </p:nvSpPr>
          <p:spPr>
            <a:xfrm rot="5400000">
              <a:off x="7669247" y="678156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err="1">
                  <a:solidFill>
                    <a:schemeClr val="bg1">
                      <a:lumMod val="50000"/>
                    </a:schemeClr>
                  </a:solidFill>
                </a:rPr>
                <a:t>QCW.csiro</a:t>
              </a:r>
              <a:endParaRPr lang="en-AU" sz="11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6EBBD3EE-C4AD-455E-A133-6A4F6DFCB612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76FB793D-553F-4DEB-AF57-E12D4AFFA4FD}"/>
              </a:ext>
            </a:extLst>
          </p:cNvPr>
          <p:cNvGrpSpPr/>
          <p:nvPr/>
        </p:nvGrpSpPr>
        <p:grpSpPr>
          <a:xfrm>
            <a:off x="2194671" y="4128616"/>
            <a:ext cx="270410" cy="1003300"/>
            <a:chOff x="8031292" y="394391"/>
            <a:chExt cx="270410" cy="1003300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EDD4583-95C5-4B1D-950F-A4AEEC7AE2F3}"/>
                </a:ext>
              </a:extLst>
            </p:cNvPr>
            <p:cNvSpPr txBox="1"/>
            <p:nvPr/>
          </p:nvSpPr>
          <p:spPr>
            <a:xfrm rot="5400000">
              <a:off x="7669247" y="765236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W.csiro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0FE8596F-7519-4D9B-9013-1063E41C8F64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CCDED3BF-2FD8-48D6-96A3-6F7DECB103D3}"/>
              </a:ext>
            </a:extLst>
          </p:cNvPr>
          <p:cNvGrpSpPr/>
          <p:nvPr/>
        </p:nvGrpSpPr>
        <p:grpSpPr>
          <a:xfrm>
            <a:off x="1964204" y="3983760"/>
            <a:ext cx="285158" cy="1003300"/>
            <a:chOff x="8031292" y="466508"/>
            <a:chExt cx="285158" cy="1003300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EAA2EE1-9193-41AC-9E8B-6D4613CC3741}"/>
                </a:ext>
              </a:extLst>
            </p:cNvPr>
            <p:cNvSpPr txBox="1"/>
            <p:nvPr/>
          </p:nvSpPr>
          <p:spPr>
            <a:xfrm rot="5400000">
              <a:off x="7683995" y="837353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74080AD5-4C23-4861-8EEF-E644B2B4D58A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DDE8A63D-DC18-493D-B119-543A6B977863}"/>
              </a:ext>
            </a:extLst>
          </p:cNvPr>
          <p:cNvSpPr txBox="1"/>
          <p:nvPr/>
        </p:nvSpPr>
        <p:spPr>
          <a:xfrm>
            <a:off x="5817441" y="624937"/>
            <a:ext cx="572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Rht-B1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0429D90B-DD0B-45CB-86BD-4FF38B885F1A}"/>
              </a:ext>
            </a:extLst>
          </p:cNvPr>
          <p:cNvGrpSpPr/>
          <p:nvPr/>
        </p:nvGrpSpPr>
        <p:grpSpPr>
          <a:xfrm>
            <a:off x="949280" y="298010"/>
            <a:ext cx="482959" cy="5732828"/>
            <a:chOff x="7174295" y="188953"/>
            <a:chExt cx="482959" cy="5732828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F5C0F634-6723-4F29-88E2-AA970487EBC4}"/>
                </a:ext>
              </a:extLst>
            </p:cNvPr>
            <p:cNvGrpSpPr/>
            <p:nvPr/>
          </p:nvGrpSpPr>
          <p:grpSpPr>
            <a:xfrm>
              <a:off x="7325774" y="557781"/>
              <a:ext cx="180000" cy="5364000"/>
              <a:chOff x="5549578" y="557781"/>
              <a:chExt cx="504000" cy="5364000"/>
            </a:xfrm>
          </p:grpSpPr>
          <p:sp>
            <p:nvSpPr>
              <p:cNvPr id="25" name="Rectangle: Rounded Corners 24">
                <a:extLst>
                  <a:ext uri="{FF2B5EF4-FFF2-40B4-BE49-F238E27FC236}">
                    <a16:creationId xmlns:a16="http://schemas.microsoft.com/office/drawing/2014/main" id="{660D31F3-8FA9-4816-8553-B964119CA0F1}"/>
                  </a:ext>
                </a:extLst>
              </p:cNvPr>
              <p:cNvSpPr/>
              <p:nvPr/>
            </p:nvSpPr>
            <p:spPr>
              <a:xfrm>
                <a:off x="5549578" y="557781"/>
                <a:ext cx="327170" cy="5364000"/>
              </a:xfrm>
              <a:prstGeom prst="round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116DC112-1E64-4802-A355-46A96937453C}"/>
                  </a:ext>
                </a:extLst>
              </p:cNvPr>
              <p:cNvCxnSpPr/>
              <p:nvPr/>
            </p:nvCxnSpPr>
            <p:spPr>
              <a:xfrm>
                <a:off x="5549578" y="12668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0CB18568-CAB1-41B8-A855-F83AC9B0DDCC}"/>
                  </a:ext>
                </a:extLst>
              </p:cNvPr>
              <p:cNvCxnSpPr/>
              <p:nvPr/>
            </p:nvCxnSpPr>
            <p:spPr>
              <a:xfrm>
                <a:off x="5549578" y="19907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88EBA157-88B0-45EA-B14E-2D356FB61958}"/>
                  </a:ext>
                </a:extLst>
              </p:cNvPr>
              <p:cNvCxnSpPr/>
              <p:nvPr/>
            </p:nvCxnSpPr>
            <p:spPr>
              <a:xfrm>
                <a:off x="5549578" y="27051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F1CF6F06-5781-4D8C-891C-6B82FBBC2D1E}"/>
                  </a:ext>
                </a:extLst>
              </p:cNvPr>
              <p:cNvCxnSpPr/>
              <p:nvPr/>
            </p:nvCxnSpPr>
            <p:spPr>
              <a:xfrm>
                <a:off x="5549578" y="34290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DB98B299-76C8-4E01-AD7C-0C403DB5FD1C}"/>
                  </a:ext>
                </a:extLst>
              </p:cNvPr>
              <p:cNvCxnSpPr/>
              <p:nvPr/>
            </p:nvCxnSpPr>
            <p:spPr>
              <a:xfrm>
                <a:off x="5549578" y="41529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1FDF44AE-FFF5-43F1-A1B3-EA783D07AAED}"/>
                  </a:ext>
                </a:extLst>
              </p:cNvPr>
              <p:cNvCxnSpPr/>
              <p:nvPr/>
            </p:nvCxnSpPr>
            <p:spPr>
              <a:xfrm>
                <a:off x="5549578" y="486727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ABE134E2-4270-4098-8D62-61F50AA009FE}"/>
                  </a:ext>
                </a:extLst>
              </p:cNvPr>
              <p:cNvCxnSpPr/>
              <p:nvPr/>
            </p:nvCxnSpPr>
            <p:spPr>
              <a:xfrm>
                <a:off x="5549578" y="559117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05EE51F-6176-4B75-804E-238D29C7A833}"/>
                </a:ext>
              </a:extLst>
            </p:cNvPr>
            <p:cNvSpPr txBox="1"/>
            <p:nvPr/>
          </p:nvSpPr>
          <p:spPr>
            <a:xfrm>
              <a:off x="7174295" y="188953"/>
              <a:ext cx="482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4A</a:t>
              </a:r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565D8360-DAF7-434E-A2B7-E731BF2AC6B1}"/>
              </a:ext>
            </a:extLst>
          </p:cNvPr>
          <p:cNvGrpSpPr/>
          <p:nvPr/>
        </p:nvGrpSpPr>
        <p:grpSpPr>
          <a:xfrm>
            <a:off x="5277841" y="298010"/>
            <a:ext cx="482959" cy="5228828"/>
            <a:chOff x="8041070" y="188953"/>
            <a:chExt cx="482959" cy="5228828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6CCF5B94-ED40-4ECB-910C-89858A9C2347}"/>
                </a:ext>
              </a:extLst>
            </p:cNvPr>
            <p:cNvGrpSpPr/>
            <p:nvPr/>
          </p:nvGrpSpPr>
          <p:grpSpPr>
            <a:xfrm>
              <a:off x="8192548" y="557781"/>
              <a:ext cx="206846" cy="4860000"/>
              <a:chOff x="6416353" y="557781"/>
              <a:chExt cx="579169" cy="4860000"/>
            </a:xfrm>
          </p:grpSpPr>
          <p:sp>
            <p:nvSpPr>
              <p:cNvPr id="36" name="Rectangle: Rounded Corners 35">
                <a:extLst>
                  <a:ext uri="{FF2B5EF4-FFF2-40B4-BE49-F238E27FC236}">
                    <a16:creationId xmlns:a16="http://schemas.microsoft.com/office/drawing/2014/main" id="{196DF4C4-40B7-4D89-A302-B24E060F05E3}"/>
                  </a:ext>
                </a:extLst>
              </p:cNvPr>
              <p:cNvSpPr/>
              <p:nvPr/>
            </p:nvSpPr>
            <p:spPr>
              <a:xfrm>
                <a:off x="6416353" y="557781"/>
                <a:ext cx="327170" cy="4860000"/>
              </a:xfrm>
              <a:prstGeom prst="round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76C0243D-7D52-4BCB-9F41-2F86E6A78D48}"/>
                  </a:ext>
                </a:extLst>
              </p:cNvPr>
              <p:cNvCxnSpPr/>
              <p:nvPr/>
            </p:nvCxnSpPr>
            <p:spPr>
              <a:xfrm>
                <a:off x="6416353" y="1266825"/>
                <a:ext cx="504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016E8138-860B-4B1D-9B83-D45500720ADE}"/>
                  </a:ext>
                </a:extLst>
              </p:cNvPr>
              <p:cNvCxnSpPr/>
              <p:nvPr/>
            </p:nvCxnSpPr>
            <p:spPr>
              <a:xfrm>
                <a:off x="6416353" y="1990725"/>
                <a:ext cx="504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A9440793-E83F-4515-ADB0-E40ADBF6CF99}"/>
                  </a:ext>
                </a:extLst>
              </p:cNvPr>
              <p:cNvCxnSpPr/>
              <p:nvPr/>
            </p:nvCxnSpPr>
            <p:spPr>
              <a:xfrm>
                <a:off x="6416353" y="2705100"/>
                <a:ext cx="504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BD5522D2-4AE9-42BD-8A74-8A449E84CECD}"/>
                  </a:ext>
                </a:extLst>
              </p:cNvPr>
              <p:cNvCxnSpPr/>
              <p:nvPr/>
            </p:nvCxnSpPr>
            <p:spPr>
              <a:xfrm>
                <a:off x="6416353" y="3429000"/>
                <a:ext cx="504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id="{A875686D-6D74-4584-9028-3BED17959879}"/>
                  </a:ext>
                </a:extLst>
              </p:cNvPr>
              <p:cNvCxnSpPr/>
              <p:nvPr/>
            </p:nvCxnSpPr>
            <p:spPr>
              <a:xfrm>
                <a:off x="6416353" y="4152900"/>
                <a:ext cx="504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ABB2F38C-D2B0-48B8-9DA2-5E8CF5F383FC}"/>
                  </a:ext>
                </a:extLst>
              </p:cNvPr>
              <p:cNvCxnSpPr/>
              <p:nvPr/>
            </p:nvCxnSpPr>
            <p:spPr>
              <a:xfrm>
                <a:off x="6416353" y="4867275"/>
                <a:ext cx="50400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id="{DB46B932-121F-4E52-A981-83C3F96E9151}"/>
                  </a:ext>
                </a:extLst>
              </p:cNvPr>
              <p:cNvCxnSpPr/>
              <p:nvPr/>
            </p:nvCxnSpPr>
            <p:spPr>
              <a:xfrm>
                <a:off x="6491522" y="1266449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25A7A1B0-0A33-42B0-A867-D24F52D6AB2A}"/>
                  </a:ext>
                </a:extLst>
              </p:cNvPr>
              <p:cNvCxnSpPr/>
              <p:nvPr/>
            </p:nvCxnSpPr>
            <p:spPr>
              <a:xfrm>
                <a:off x="6491522" y="1990349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4296560C-1881-4B08-8680-F5B6D643DA9E}"/>
                  </a:ext>
                </a:extLst>
              </p:cNvPr>
              <p:cNvCxnSpPr/>
              <p:nvPr/>
            </p:nvCxnSpPr>
            <p:spPr>
              <a:xfrm>
                <a:off x="6491522" y="2704724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1FA86334-7E01-4DB6-AB40-A53E06B7916D}"/>
                  </a:ext>
                </a:extLst>
              </p:cNvPr>
              <p:cNvCxnSpPr/>
              <p:nvPr/>
            </p:nvCxnSpPr>
            <p:spPr>
              <a:xfrm>
                <a:off x="6491522" y="3428624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DE01A791-6600-4ACD-BDA1-4C63FD38ABC1}"/>
                  </a:ext>
                </a:extLst>
              </p:cNvPr>
              <p:cNvCxnSpPr/>
              <p:nvPr/>
            </p:nvCxnSpPr>
            <p:spPr>
              <a:xfrm>
                <a:off x="6491522" y="4152524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66290501-0915-48ED-B77A-4FBB27B839A9}"/>
                  </a:ext>
                </a:extLst>
              </p:cNvPr>
              <p:cNvCxnSpPr/>
              <p:nvPr/>
            </p:nvCxnSpPr>
            <p:spPr>
              <a:xfrm>
                <a:off x="6491522" y="4866899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D40B2AE-0438-4F3C-8C30-48545B5282D1}"/>
                </a:ext>
              </a:extLst>
            </p:cNvPr>
            <p:cNvSpPr txBox="1"/>
            <p:nvPr/>
          </p:nvSpPr>
          <p:spPr>
            <a:xfrm>
              <a:off x="8041070" y="188953"/>
              <a:ext cx="482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4B</a:t>
              </a:r>
            </a:p>
          </p:txBody>
        </p:sp>
      </p:grp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A39766A4-AA92-45A0-9887-9AB7183C91FF}"/>
              </a:ext>
            </a:extLst>
          </p:cNvPr>
          <p:cNvCxnSpPr/>
          <p:nvPr/>
        </p:nvCxnSpPr>
        <p:spPr>
          <a:xfrm>
            <a:off x="1094586" y="4592286"/>
            <a:ext cx="340739" cy="0"/>
          </a:xfrm>
          <a:prstGeom prst="line">
            <a:avLst/>
          </a:prstGeom>
          <a:ln>
            <a:solidFill>
              <a:srgbClr val="FA630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Oval 49">
            <a:extLst>
              <a:ext uri="{FF2B5EF4-FFF2-40B4-BE49-F238E27FC236}">
                <a16:creationId xmlns:a16="http://schemas.microsoft.com/office/drawing/2014/main" id="{96D4DF8F-0CA8-47B6-BC57-1171DC47B06F}"/>
              </a:ext>
            </a:extLst>
          </p:cNvPr>
          <p:cNvSpPr/>
          <p:nvPr/>
        </p:nvSpPr>
        <p:spPr>
          <a:xfrm>
            <a:off x="1460306" y="4556845"/>
            <a:ext cx="90000" cy="90000"/>
          </a:xfrm>
          <a:prstGeom prst="ellipse">
            <a:avLst/>
          </a:prstGeom>
          <a:solidFill>
            <a:srgbClr val="FA630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CFC10EBB-AE62-4D24-A75B-6AADA99987AF}"/>
              </a:ext>
            </a:extLst>
          </p:cNvPr>
          <p:cNvCxnSpPr/>
          <p:nvPr/>
        </p:nvCxnSpPr>
        <p:spPr>
          <a:xfrm>
            <a:off x="5428396" y="896586"/>
            <a:ext cx="340739" cy="0"/>
          </a:xfrm>
          <a:prstGeom prst="line">
            <a:avLst/>
          </a:prstGeom>
          <a:ln>
            <a:solidFill>
              <a:srgbClr val="FA630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Oval 51">
            <a:extLst>
              <a:ext uri="{FF2B5EF4-FFF2-40B4-BE49-F238E27FC236}">
                <a16:creationId xmlns:a16="http://schemas.microsoft.com/office/drawing/2014/main" id="{18889C8C-15B7-4E8B-94E1-CE404876C58A}"/>
              </a:ext>
            </a:extLst>
          </p:cNvPr>
          <p:cNvSpPr/>
          <p:nvPr/>
        </p:nvSpPr>
        <p:spPr>
          <a:xfrm>
            <a:off x="5794116" y="861145"/>
            <a:ext cx="90000" cy="90000"/>
          </a:xfrm>
          <a:prstGeom prst="ellipse">
            <a:avLst/>
          </a:prstGeom>
          <a:solidFill>
            <a:srgbClr val="FA630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7595C821-546D-40F7-80E8-75ECAFD6E607}"/>
              </a:ext>
            </a:extLst>
          </p:cNvPr>
          <p:cNvGrpSpPr/>
          <p:nvPr/>
        </p:nvGrpSpPr>
        <p:grpSpPr>
          <a:xfrm>
            <a:off x="5426563" y="780761"/>
            <a:ext cx="462861" cy="91191"/>
            <a:chOff x="359060" y="2788881"/>
            <a:chExt cx="462861" cy="91191"/>
          </a:xfrm>
        </p:grpSpPr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C6FCC527-C83D-476C-8EF2-8050160A1863}"/>
                </a:ext>
              </a:extLst>
            </p:cNvPr>
            <p:cNvCxnSpPr/>
            <p:nvPr/>
          </p:nvCxnSpPr>
          <p:spPr>
            <a:xfrm>
              <a:off x="359060" y="2880072"/>
              <a:ext cx="34073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F94B8CC3-8E07-4404-961A-A68F8903081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8077" y="2788881"/>
              <a:ext cx="123844" cy="889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51F83E4C-390B-499E-986C-27E66B6418FB}"/>
              </a:ext>
            </a:extLst>
          </p:cNvPr>
          <p:cNvCxnSpPr/>
          <p:nvPr/>
        </p:nvCxnSpPr>
        <p:spPr>
          <a:xfrm>
            <a:off x="1091219" y="4878036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66772BD4-0C60-4CAC-86B6-D94B8F454271}"/>
              </a:ext>
            </a:extLst>
          </p:cNvPr>
          <p:cNvSpPr txBox="1"/>
          <p:nvPr/>
        </p:nvSpPr>
        <p:spPr>
          <a:xfrm>
            <a:off x="1425225" y="4762187"/>
            <a:ext cx="572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Rht-A1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6AB67100-8BBB-4501-BA35-79772734099B}"/>
              </a:ext>
            </a:extLst>
          </p:cNvPr>
          <p:cNvCxnSpPr/>
          <p:nvPr/>
        </p:nvCxnSpPr>
        <p:spPr>
          <a:xfrm>
            <a:off x="5426563" y="5382848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137DF6D3-49D2-4F99-83C3-557FB99FC91C}"/>
              </a:ext>
            </a:extLst>
          </p:cNvPr>
          <p:cNvSpPr txBox="1"/>
          <p:nvPr/>
        </p:nvSpPr>
        <p:spPr>
          <a:xfrm>
            <a:off x="5775354" y="5152394"/>
            <a:ext cx="572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Vrn-B2</a:t>
            </a: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7F9B5B3F-42E6-423A-869D-AC817D067012}"/>
              </a:ext>
            </a:extLst>
          </p:cNvPr>
          <p:cNvGrpSpPr/>
          <p:nvPr/>
        </p:nvGrpSpPr>
        <p:grpSpPr>
          <a:xfrm>
            <a:off x="7015831" y="745974"/>
            <a:ext cx="270410" cy="1003300"/>
            <a:chOff x="8031292" y="750888"/>
            <a:chExt cx="270410" cy="1003300"/>
          </a:xfrm>
        </p:grpSpPr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29B819A9-CE59-4A93-AF52-BAB58408C13B}"/>
                </a:ext>
              </a:extLst>
            </p:cNvPr>
            <p:cNvSpPr txBox="1"/>
            <p:nvPr/>
          </p:nvSpPr>
          <p:spPr>
            <a:xfrm rot="5400000">
              <a:off x="7669247" y="1121733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dsu-4BS</a:t>
              </a:r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EA48C472-8C36-4EB0-8410-3A03D4FF86F0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42827AC2-94F3-4E7E-8EB8-431A6BD5FEBB}"/>
              </a:ext>
            </a:extLst>
          </p:cNvPr>
          <p:cNvGrpSpPr/>
          <p:nvPr/>
        </p:nvGrpSpPr>
        <p:grpSpPr>
          <a:xfrm>
            <a:off x="7271037" y="802213"/>
            <a:ext cx="275971" cy="1186015"/>
            <a:chOff x="9474158" y="4519384"/>
            <a:chExt cx="275971" cy="1186015"/>
          </a:xfrm>
        </p:grpSpPr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61DE05CB-CF5A-45B0-AAC2-1F6665204B3B}"/>
                </a:ext>
              </a:extLst>
            </p:cNvPr>
            <p:cNvSpPr txBox="1"/>
            <p:nvPr/>
          </p:nvSpPr>
          <p:spPr>
            <a:xfrm rot="5400000">
              <a:off x="9026316" y="4981587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tars-4BS2</a:t>
              </a: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57B93412-3432-4A3E-A997-DE3B0B2395A9}"/>
                </a:ext>
              </a:extLst>
            </p:cNvPr>
            <p:cNvSpPr/>
            <p:nvPr/>
          </p:nvSpPr>
          <p:spPr>
            <a:xfrm rot="5400000">
              <a:off x="9474158" y="4706940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BEBCB895-95C2-458D-8A3F-3923801E69CA}"/>
              </a:ext>
            </a:extLst>
          </p:cNvPr>
          <p:cNvGrpSpPr/>
          <p:nvPr/>
        </p:nvGrpSpPr>
        <p:grpSpPr>
          <a:xfrm>
            <a:off x="2461977" y="4209228"/>
            <a:ext cx="285158" cy="1003300"/>
            <a:chOff x="8031292" y="399094"/>
            <a:chExt cx="285158" cy="1003300"/>
          </a:xfrm>
        </p:grpSpPr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FA40F4C6-1EB2-498F-A597-39B720C3DB6F}"/>
                </a:ext>
              </a:extLst>
            </p:cNvPr>
            <p:cNvSpPr txBox="1"/>
            <p:nvPr/>
          </p:nvSpPr>
          <p:spPr>
            <a:xfrm rot="5400000">
              <a:off x="7683995" y="769939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DC5F9226-294D-4DC7-87C8-A3057979693F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C7DACBF2-7365-4FA8-B598-EA25CCCE286A}"/>
              </a:ext>
            </a:extLst>
          </p:cNvPr>
          <p:cNvGrpSpPr/>
          <p:nvPr/>
        </p:nvGrpSpPr>
        <p:grpSpPr>
          <a:xfrm>
            <a:off x="6251629" y="747332"/>
            <a:ext cx="269702" cy="1003300"/>
            <a:chOff x="8031292" y="763481"/>
            <a:chExt cx="269702" cy="1003300"/>
          </a:xfrm>
        </p:grpSpPr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14E1C63-2210-41C1-9BF4-CA228CC0A117}"/>
                </a:ext>
              </a:extLst>
            </p:cNvPr>
            <p:cNvSpPr txBox="1"/>
            <p:nvPr/>
          </p:nvSpPr>
          <p:spPr>
            <a:xfrm rot="5400000">
              <a:off x="7668539" y="1134326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2CC36329-A5A7-4C90-813D-CE2B8DFB25A9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4E6301D4-5ABC-447D-8F98-25CE9D61C573}"/>
              </a:ext>
            </a:extLst>
          </p:cNvPr>
          <p:cNvGrpSpPr/>
          <p:nvPr/>
        </p:nvGrpSpPr>
        <p:grpSpPr>
          <a:xfrm>
            <a:off x="6506127" y="745334"/>
            <a:ext cx="269702" cy="1003300"/>
            <a:chOff x="8031292" y="757131"/>
            <a:chExt cx="269702" cy="1003300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AD215767-45B7-42A2-B9ED-FADD11A2E45C}"/>
                </a:ext>
              </a:extLst>
            </p:cNvPr>
            <p:cNvSpPr txBox="1"/>
            <p:nvPr/>
          </p:nvSpPr>
          <p:spPr>
            <a:xfrm rot="5400000">
              <a:off x="7668539" y="1127976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SL.csiro</a:t>
              </a:r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747C367D-34EA-4EBA-961A-DFA95C145B4B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AA52855F-EC31-42AA-ADA7-02E54FEA8754}"/>
              </a:ext>
            </a:extLst>
          </p:cNvPr>
          <p:cNvGrpSpPr/>
          <p:nvPr/>
        </p:nvGrpSpPr>
        <p:grpSpPr>
          <a:xfrm>
            <a:off x="2714066" y="4608037"/>
            <a:ext cx="277604" cy="1186015"/>
            <a:chOff x="8994536" y="5287119"/>
            <a:chExt cx="277604" cy="1186015"/>
          </a:xfrm>
        </p:grpSpPr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0AB91972-FE8C-4F4A-BB55-6E4DE1C69723}"/>
                </a:ext>
              </a:extLst>
            </p:cNvPr>
            <p:cNvSpPr txBox="1"/>
            <p:nvPr/>
          </p:nvSpPr>
          <p:spPr>
            <a:xfrm rot="5400000">
              <a:off x="8548327" y="5749322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ahau-4A</a:t>
              </a:r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94876638-A78C-491E-9843-8C8C6574D054}"/>
                </a:ext>
              </a:extLst>
            </p:cNvPr>
            <p:cNvSpPr/>
            <p:nvPr/>
          </p:nvSpPr>
          <p:spPr>
            <a:xfrm rot="5400000">
              <a:off x="8989619" y="5526729"/>
              <a:ext cx="63834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4B72F5E2-6690-45BB-B7CF-87ED368ABA04}"/>
              </a:ext>
            </a:extLst>
          </p:cNvPr>
          <p:cNvCxnSpPr/>
          <p:nvPr/>
        </p:nvCxnSpPr>
        <p:spPr>
          <a:xfrm>
            <a:off x="1095571" y="5025832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2A963888-B67A-4CA3-A1EE-110B7F83757C}"/>
              </a:ext>
            </a:extLst>
          </p:cNvPr>
          <p:cNvSpPr txBox="1"/>
          <p:nvPr/>
        </p:nvSpPr>
        <p:spPr>
          <a:xfrm>
            <a:off x="1369372" y="4891433"/>
            <a:ext cx="751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ZXQ6118</a:t>
            </a:r>
          </a:p>
        </p:txBody>
      </p:sp>
      <p:grpSp>
        <p:nvGrpSpPr>
          <p:cNvPr id="80" name="Group 79">
            <a:extLst>
              <a:ext uri="{FF2B5EF4-FFF2-40B4-BE49-F238E27FC236}">
                <a16:creationId xmlns:a16="http://schemas.microsoft.com/office/drawing/2014/main" id="{E247CBC6-ABB7-47B7-B401-431E452088B9}"/>
              </a:ext>
            </a:extLst>
          </p:cNvPr>
          <p:cNvGrpSpPr/>
          <p:nvPr/>
        </p:nvGrpSpPr>
        <p:grpSpPr>
          <a:xfrm>
            <a:off x="4059393" y="4622227"/>
            <a:ext cx="277604" cy="1186015"/>
            <a:chOff x="8994536" y="5131573"/>
            <a:chExt cx="277604" cy="1186015"/>
          </a:xfrm>
        </p:grpSpPr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AD895DAF-39B8-4F06-A34D-A22697C86710}"/>
                </a:ext>
              </a:extLst>
            </p:cNvPr>
            <p:cNvSpPr txBox="1"/>
            <p:nvPr/>
          </p:nvSpPr>
          <p:spPr>
            <a:xfrm rot="5400000">
              <a:off x="8548327" y="5593776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hwwgr-4A</a:t>
              </a:r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C83B6E56-0F01-432E-A1D9-BC708A3138CF}"/>
                </a:ext>
              </a:extLst>
            </p:cNvPr>
            <p:cNvSpPr/>
            <p:nvPr/>
          </p:nvSpPr>
          <p:spPr>
            <a:xfrm rot="5400000">
              <a:off x="8989619" y="5526729"/>
              <a:ext cx="63834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83" name="Group 82">
            <a:extLst>
              <a:ext uri="{FF2B5EF4-FFF2-40B4-BE49-F238E27FC236}">
                <a16:creationId xmlns:a16="http://schemas.microsoft.com/office/drawing/2014/main" id="{64F6C468-019B-40D6-8ADA-EC7BC754793A}"/>
              </a:ext>
            </a:extLst>
          </p:cNvPr>
          <p:cNvGrpSpPr/>
          <p:nvPr/>
        </p:nvGrpSpPr>
        <p:grpSpPr>
          <a:xfrm>
            <a:off x="1680370" y="3664652"/>
            <a:ext cx="277604" cy="1186015"/>
            <a:chOff x="8994536" y="5433169"/>
            <a:chExt cx="277604" cy="1186015"/>
          </a:xfrm>
        </p:grpSpPr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0638312B-FD22-4CE7-84FF-5FE9F7FBF655}"/>
                </a:ext>
              </a:extLst>
            </p:cNvPr>
            <p:cNvSpPr txBox="1"/>
            <p:nvPr/>
          </p:nvSpPr>
          <p:spPr>
            <a:xfrm rot="5400000">
              <a:off x="8548327" y="5895372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fcgr.cas-4AS</a:t>
              </a:r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8EAFBCBB-275C-4839-80CA-D31C60F32F4A}"/>
                </a:ext>
              </a:extLst>
            </p:cNvPr>
            <p:cNvSpPr/>
            <p:nvPr/>
          </p:nvSpPr>
          <p:spPr>
            <a:xfrm rot="5400000">
              <a:off x="8994536" y="6213835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86" name="Group 85">
            <a:extLst>
              <a:ext uri="{FF2B5EF4-FFF2-40B4-BE49-F238E27FC236}">
                <a16:creationId xmlns:a16="http://schemas.microsoft.com/office/drawing/2014/main" id="{C81A86C6-C0A4-46C2-A75C-1E339E36BD35}"/>
              </a:ext>
            </a:extLst>
          </p:cNvPr>
          <p:cNvGrpSpPr/>
          <p:nvPr/>
        </p:nvGrpSpPr>
        <p:grpSpPr>
          <a:xfrm>
            <a:off x="1367540" y="3753980"/>
            <a:ext cx="277604" cy="1186015"/>
            <a:chOff x="8994536" y="5525448"/>
            <a:chExt cx="277604" cy="1186015"/>
          </a:xfrm>
        </p:grpSpPr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65F2209A-37EC-4C68-8651-E54F16369ED9}"/>
                </a:ext>
              </a:extLst>
            </p:cNvPr>
            <p:cNvSpPr txBox="1"/>
            <p:nvPr/>
          </p:nvSpPr>
          <p:spPr>
            <a:xfrm rot="5400000">
              <a:off x="8548327" y="5987651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gr.cas-4AS</a:t>
              </a: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D8A707F0-3EB6-436C-8726-4EC78F7BA130}"/>
                </a:ext>
              </a:extLst>
            </p:cNvPr>
            <p:cNvSpPr/>
            <p:nvPr/>
          </p:nvSpPr>
          <p:spPr>
            <a:xfrm rot="5400000">
              <a:off x="8994536" y="6220897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89" name="Group 88">
            <a:extLst>
              <a:ext uri="{FF2B5EF4-FFF2-40B4-BE49-F238E27FC236}">
                <a16:creationId xmlns:a16="http://schemas.microsoft.com/office/drawing/2014/main" id="{838E57FD-1FA3-40FB-9CC3-08F29EC51F3B}"/>
              </a:ext>
            </a:extLst>
          </p:cNvPr>
          <p:cNvGrpSpPr/>
          <p:nvPr/>
        </p:nvGrpSpPr>
        <p:grpSpPr>
          <a:xfrm>
            <a:off x="6562175" y="88132"/>
            <a:ext cx="277604" cy="1186015"/>
            <a:chOff x="8994536" y="5600949"/>
            <a:chExt cx="277604" cy="1186015"/>
          </a:xfrm>
        </p:grpSpPr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8282766-BBB9-48D6-803D-B2CDA207A0A5}"/>
                </a:ext>
              </a:extLst>
            </p:cNvPr>
            <p:cNvSpPr txBox="1"/>
            <p:nvPr/>
          </p:nvSpPr>
          <p:spPr>
            <a:xfrm rot="5400000">
              <a:off x="8548327" y="6063152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gr.cas-4B</a:t>
              </a:r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C38FD456-1C84-453F-B2E3-6851CB11EC18}"/>
                </a:ext>
              </a:extLst>
            </p:cNvPr>
            <p:cNvSpPr/>
            <p:nvPr/>
          </p:nvSpPr>
          <p:spPr>
            <a:xfrm rot="5400000">
              <a:off x="8994536" y="6220897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92" name="Group 91">
            <a:extLst>
              <a:ext uri="{FF2B5EF4-FFF2-40B4-BE49-F238E27FC236}">
                <a16:creationId xmlns:a16="http://schemas.microsoft.com/office/drawing/2014/main" id="{4F515716-FEF7-436D-A964-7CDF28D4C269}"/>
              </a:ext>
            </a:extLst>
          </p:cNvPr>
          <p:cNvGrpSpPr/>
          <p:nvPr/>
        </p:nvGrpSpPr>
        <p:grpSpPr>
          <a:xfrm>
            <a:off x="5990073" y="745359"/>
            <a:ext cx="276760" cy="1003300"/>
            <a:chOff x="8031292" y="842657"/>
            <a:chExt cx="276760" cy="1003300"/>
          </a:xfrm>
        </p:grpSpPr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8FD1B5B0-B901-44FB-8CC8-15CC092C0882}"/>
                </a:ext>
              </a:extLst>
            </p:cNvPr>
            <p:cNvSpPr txBox="1"/>
            <p:nvPr/>
          </p:nvSpPr>
          <p:spPr>
            <a:xfrm rot="5400000">
              <a:off x="7675597" y="121350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.Lng.ipk.4B.1</a:t>
              </a: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019A5A44-D0CE-4282-98FC-A2D7EC2E77BD}"/>
                </a:ext>
              </a:extLst>
            </p:cNvPr>
            <p:cNvSpPr/>
            <p:nvPr/>
          </p:nvSpPr>
          <p:spPr>
            <a:xfrm rot="5400000">
              <a:off x="8025892" y="984311"/>
              <a:ext cx="648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95" name="Group 94">
            <a:extLst>
              <a:ext uri="{FF2B5EF4-FFF2-40B4-BE49-F238E27FC236}">
                <a16:creationId xmlns:a16="http://schemas.microsoft.com/office/drawing/2014/main" id="{BFBC3DC2-CCF7-453F-A16E-931C8C923FA9}"/>
              </a:ext>
            </a:extLst>
          </p:cNvPr>
          <p:cNvGrpSpPr/>
          <p:nvPr/>
        </p:nvGrpSpPr>
        <p:grpSpPr>
          <a:xfrm>
            <a:off x="7848548" y="5065257"/>
            <a:ext cx="270410" cy="1003300"/>
            <a:chOff x="8031292" y="580645"/>
            <a:chExt cx="270410" cy="1003300"/>
          </a:xfrm>
        </p:grpSpPr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719DA53E-8D31-400D-B767-E62E67CF17B4}"/>
                </a:ext>
              </a:extLst>
            </p:cNvPr>
            <p:cNvSpPr txBox="1"/>
            <p:nvPr/>
          </p:nvSpPr>
          <p:spPr>
            <a:xfrm rot="5400000">
              <a:off x="7669247" y="951490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dsu-4BL</a:t>
              </a:r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68EB55C2-0F34-4993-81B0-EC106B2FDF61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98" name="Group 97">
            <a:extLst>
              <a:ext uri="{FF2B5EF4-FFF2-40B4-BE49-F238E27FC236}">
                <a16:creationId xmlns:a16="http://schemas.microsoft.com/office/drawing/2014/main" id="{ECC3DE9D-FAE0-4D13-AF47-83F252AB9ED2}"/>
              </a:ext>
            </a:extLst>
          </p:cNvPr>
          <p:cNvGrpSpPr/>
          <p:nvPr/>
        </p:nvGrpSpPr>
        <p:grpSpPr>
          <a:xfrm>
            <a:off x="2188950" y="5564072"/>
            <a:ext cx="274744" cy="1003300"/>
            <a:chOff x="993068" y="2546583"/>
            <a:chExt cx="274744" cy="1003300"/>
          </a:xfrm>
        </p:grpSpPr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15ABBBD1-1D5C-4CAE-86D3-6FCD73B7D38F}"/>
                </a:ext>
              </a:extLst>
            </p:cNvPr>
            <p:cNvSpPr txBox="1"/>
            <p:nvPr/>
          </p:nvSpPr>
          <p:spPr>
            <a:xfrm rot="5400000">
              <a:off x="635357" y="291742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CC08ED28-973B-467C-BBA4-5C86F03ED90D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01" name="Group 100">
            <a:extLst>
              <a:ext uri="{FF2B5EF4-FFF2-40B4-BE49-F238E27FC236}">
                <a16:creationId xmlns:a16="http://schemas.microsoft.com/office/drawing/2014/main" id="{A011E310-1776-4DF7-905D-004853AF69A1}"/>
              </a:ext>
            </a:extLst>
          </p:cNvPr>
          <p:cNvGrpSpPr/>
          <p:nvPr/>
        </p:nvGrpSpPr>
        <p:grpSpPr>
          <a:xfrm>
            <a:off x="5733854" y="3106150"/>
            <a:ext cx="274744" cy="1003300"/>
            <a:chOff x="993068" y="2546583"/>
            <a:chExt cx="274744" cy="1003300"/>
          </a:xfrm>
        </p:grpSpPr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8E0045D9-7544-4725-8FEB-990B7C594492}"/>
                </a:ext>
              </a:extLst>
            </p:cNvPr>
            <p:cNvSpPr txBox="1"/>
            <p:nvPr/>
          </p:nvSpPr>
          <p:spPr>
            <a:xfrm rot="5400000">
              <a:off x="635357" y="291742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CAC9A4CE-68CE-4E5C-8CDC-3453A7307125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D4F9A4C0-AE2A-44EF-A9F5-4D7DD21A2D4B}"/>
              </a:ext>
            </a:extLst>
          </p:cNvPr>
          <p:cNvGrpSpPr/>
          <p:nvPr/>
        </p:nvGrpSpPr>
        <p:grpSpPr>
          <a:xfrm>
            <a:off x="6488710" y="4262936"/>
            <a:ext cx="274744" cy="1003300"/>
            <a:chOff x="993068" y="2546583"/>
            <a:chExt cx="274744" cy="1003300"/>
          </a:xfrm>
        </p:grpSpPr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DD9305EC-9A70-4B5E-A0CD-58BCB30AF441}"/>
                </a:ext>
              </a:extLst>
            </p:cNvPr>
            <p:cNvSpPr txBox="1"/>
            <p:nvPr/>
          </p:nvSpPr>
          <p:spPr>
            <a:xfrm rot="5400000">
              <a:off x="635357" y="291742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DF6E1EAA-02C3-4FAD-AD26-FA85E1F70555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07" name="Group 106">
            <a:extLst>
              <a:ext uri="{FF2B5EF4-FFF2-40B4-BE49-F238E27FC236}">
                <a16:creationId xmlns:a16="http://schemas.microsoft.com/office/drawing/2014/main" id="{248A3223-8DD5-40F6-A427-F1FAC97D3D18}"/>
              </a:ext>
            </a:extLst>
          </p:cNvPr>
          <p:cNvGrpSpPr/>
          <p:nvPr/>
        </p:nvGrpSpPr>
        <p:grpSpPr>
          <a:xfrm>
            <a:off x="3389416" y="4623344"/>
            <a:ext cx="277604" cy="1186015"/>
            <a:chOff x="8994536" y="5255369"/>
            <a:chExt cx="277604" cy="1186015"/>
          </a:xfrm>
        </p:grpSpPr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5E1BB1AD-13E7-4E2A-A69E-D594AA41E446}"/>
                </a:ext>
              </a:extLst>
            </p:cNvPr>
            <p:cNvSpPr txBox="1"/>
            <p:nvPr/>
          </p:nvSpPr>
          <p:spPr>
            <a:xfrm rot="5400000">
              <a:off x="8548327" y="5717572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fcgr.cas-4AL.1</a:t>
              </a:r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37063B6D-5E49-4336-8B29-14290C1EAC29}"/>
                </a:ext>
              </a:extLst>
            </p:cNvPr>
            <p:cNvSpPr/>
            <p:nvPr/>
          </p:nvSpPr>
          <p:spPr>
            <a:xfrm rot="5400000">
              <a:off x="8994536" y="5604206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10" name="Group 109">
            <a:extLst>
              <a:ext uri="{FF2B5EF4-FFF2-40B4-BE49-F238E27FC236}">
                <a16:creationId xmlns:a16="http://schemas.microsoft.com/office/drawing/2014/main" id="{7B98FA0A-D0F7-49DC-9508-C6F26CC5744A}"/>
              </a:ext>
            </a:extLst>
          </p:cNvPr>
          <p:cNvGrpSpPr/>
          <p:nvPr/>
        </p:nvGrpSpPr>
        <p:grpSpPr>
          <a:xfrm>
            <a:off x="1664315" y="5302525"/>
            <a:ext cx="277604" cy="1186015"/>
            <a:chOff x="8994536" y="5433169"/>
            <a:chExt cx="277604" cy="1186015"/>
          </a:xfrm>
        </p:grpSpPr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DED24739-61FD-48A8-A875-7E0B4F2DFA43}"/>
                </a:ext>
              </a:extLst>
            </p:cNvPr>
            <p:cNvSpPr txBox="1"/>
            <p:nvPr/>
          </p:nvSpPr>
          <p:spPr>
            <a:xfrm rot="5400000">
              <a:off x="8548327" y="5895372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fcgr.cas-4AL.2</a:t>
              </a:r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5FC05DDF-A69D-41B6-BDA6-C8607709389B}"/>
                </a:ext>
              </a:extLst>
            </p:cNvPr>
            <p:cNvSpPr/>
            <p:nvPr/>
          </p:nvSpPr>
          <p:spPr>
            <a:xfrm rot="5400000">
              <a:off x="8994536" y="5604206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13" name="Group 112">
            <a:extLst>
              <a:ext uri="{FF2B5EF4-FFF2-40B4-BE49-F238E27FC236}">
                <a16:creationId xmlns:a16="http://schemas.microsoft.com/office/drawing/2014/main" id="{7B32C552-4212-4847-BFC4-1BD1B78273FF}"/>
              </a:ext>
            </a:extLst>
          </p:cNvPr>
          <p:cNvGrpSpPr/>
          <p:nvPr/>
        </p:nvGrpSpPr>
        <p:grpSpPr>
          <a:xfrm>
            <a:off x="8027201" y="1041642"/>
            <a:ext cx="277604" cy="1186015"/>
            <a:chOff x="8994536" y="5287119"/>
            <a:chExt cx="277604" cy="1186015"/>
          </a:xfrm>
        </p:grpSpPr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5807014F-8CC4-40C3-A05B-5E9C24E1954F}"/>
                </a:ext>
              </a:extLst>
            </p:cNvPr>
            <p:cNvSpPr txBox="1"/>
            <p:nvPr/>
          </p:nvSpPr>
          <p:spPr>
            <a:xfrm rot="5400000">
              <a:off x="8548327" y="5749322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fcgr.cas-4B</a:t>
              </a:r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C8012088-E47A-458F-99EA-EAB14A0DEA09}"/>
                </a:ext>
              </a:extLst>
            </p:cNvPr>
            <p:cNvSpPr/>
            <p:nvPr/>
          </p:nvSpPr>
          <p:spPr>
            <a:xfrm rot="5400000">
              <a:off x="8994536" y="5604206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7A86D010-D937-4120-AB2D-63A00A2C3C60}"/>
              </a:ext>
            </a:extLst>
          </p:cNvPr>
          <p:cNvGrpSpPr/>
          <p:nvPr/>
        </p:nvGrpSpPr>
        <p:grpSpPr>
          <a:xfrm>
            <a:off x="1357794" y="5300071"/>
            <a:ext cx="277604" cy="1186015"/>
            <a:chOff x="8994536" y="5433169"/>
            <a:chExt cx="277604" cy="1186015"/>
          </a:xfrm>
        </p:grpSpPr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225E8B88-7A52-4E07-ADA4-AC673E2FD644}"/>
                </a:ext>
              </a:extLst>
            </p:cNvPr>
            <p:cNvSpPr txBox="1"/>
            <p:nvPr/>
          </p:nvSpPr>
          <p:spPr>
            <a:xfrm rot="5400000">
              <a:off x="8548327" y="5895372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gr.cas-4A</a:t>
              </a:r>
            </a:p>
          </p:txBody>
        </p: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7B978673-00AB-4E8C-8CFE-75B5CB352B3A}"/>
                </a:ext>
              </a:extLst>
            </p:cNvPr>
            <p:cNvSpPr/>
            <p:nvPr/>
          </p:nvSpPr>
          <p:spPr>
            <a:xfrm rot="5400000">
              <a:off x="8994536" y="5604206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19" name="Group 118">
            <a:extLst>
              <a:ext uri="{FF2B5EF4-FFF2-40B4-BE49-F238E27FC236}">
                <a16:creationId xmlns:a16="http://schemas.microsoft.com/office/drawing/2014/main" id="{38DA0E6B-B0B4-4CEE-A148-DC0693E687AE}"/>
              </a:ext>
            </a:extLst>
          </p:cNvPr>
          <p:cNvGrpSpPr/>
          <p:nvPr/>
        </p:nvGrpSpPr>
        <p:grpSpPr>
          <a:xfrm>
            <a:off x="7796716" y="817012"/>
            <a:ext cx="277604" cy="1186015"/>
            <a:chOff x="8994536" y="5559004"/>
            <a:chExt cx="277604" cy="1186015"/>
          </a:xfrm>
        </p:grpSpPr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1BFF2126-81B8-465A-9F20-6E9750A1EEC2}"/>
                </a:ext>
              </a:extLst>
            </p:cNvPr>
            <p:cNvSpPr txBox="1"/>
            <p:nvPr/>
          </p:nvSpPr>
          <p:spPr>
            <a:xfrm rot="5400000">
              <a:off x="8548327" y="6021207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gr.cas-4BS</a:t>
              </a:r>
            </a:p>
          </p:txBody>
        </p: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14EE3A10-6D8F-4BC0-8611-2594FB7443BF}"/>
                </a:ext>
              </a:extLst>
            </p:cNvPr>
            <p:cNvSpPr/>
            <p:nvPr/>
          </p:nvSpPr>
          <p:spPr>
            <a:xfrm rot="5400000">
              <a:off x="8796536" y="5920190"/>
              <a:ext cx="450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22" name="Group 121">
            <a:extLst>
              <a:ext uri="{FF2B5EF4-FFF2-40B4-BE49-F238E27FC236}">
                <a16:creationId xmlns:a16="http://schemas.microsoft.com/office/drawing/2014/main" id="{F057D517-E165-4444-B372-A6D22604BABD}"/>
              </a:ext>
            </a:extLst>
          </p:cNvPr>
          <p:cNvGrpSpPr/>
          <p:nvPr/>
        </p:nvGrpSpPr>
        <p:grpSpPr>
          <a:xfrm>
            <a:off x="2121754" y="516367"/>
            <a:ext cx="278985" cy="1250371"/>
            <a:chOff x="8355475" y="598447"/>
            <a:chExt cx="278985" cy="1051392"/>
          </a:xfrm>
        </p:grpSpPr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0FA31767-25E4-4EE6-9266-76E996A3FCDD}"/>
                </a:ext>
              </a:extLst>
            </p:cNvPr>
            <p:cNvSpPr txBox="1"/>
            <p:nvPr/>
          </p:nvSpPr>
          <p:spPr>
            <a:xfrm rot="5400000">
              <a:off x="7977959" y="993338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.Lng.ipk.4A.1</a:t>
              </a:r>
            </a:p>
          </p:txBody>
        </p:sp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12AB80D2-8DD4-43AE-82E5-CE19BB9767B5}"/>
                </a:ext>
              </a:extLst>
            </p:cNvPr>
            <p:cNvSpPr/>
            <p:nvPr/>
          </p:nvSpPr>
          <p:spPr>
            <a:xfrm rot="5400000">
              <a:off x="8359771" y="935368"/>
              <a:ext cx="45407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25" name="Group 124">
            <a:extLst>
              <a:ext uri="{FF2B5EF4-FFF2-40B4-BE49-F238E27FC236}">
                <a16:creationId xmlns:a16="http://schemas.microsoft.com/office/drawing/2014/main" id="{ABE1C8AF-509C-4D81-A9C4-6E3E5FCA45C0}"/>
              </a:ext>
            </a:extLst>
          </p:cNvPr>
          <p:cNvGrpSpPr/>
          <p:nvPr/>
        </p:nvGrpSpPr>
        <p:grpSpPr>
          <a:xfrm>
            <a:off x="1915486" y="5551656"/>
            <a:ext cx="285369" cy="1250371"/>
            <a:chOff x="8355475" y="707049"/>
            <a:chExt cx="285369" cy="1051392"/>
          </a:xfrm>
        </p:grpSpPr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2F53EC37-6E52-4BD7-BE11-5C1A8BCB0B90}"/>
                </a:ext>
              </a:extLst>
            </p:cNvPr>
            <p:cNvSpPr txBox="1"/>
            <p:nvPr/>
          </p:nvSpPr>
          <p:spPr>
            <a:xfrm rot="5400000">
              <a:off x="7984343" y="1101940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.Lng.ipk.4A.2</a:t>
              </a:r>
            </a:p>
          </p:txBody>
        </p:sp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523F38A5-6DD9-43F0-893D-FDC660CC9139}"/>
                </a:ext>
              </a:extLst>
            </p:cNvPr>
            <p:cNvSpPr/>
            <p:nvPr/>
          </p:nvSpPr>
          <p:spPr>
            <a:xfrm rot="5400000">
              <a:off x="8359771" y="935368"/>
              <a:ext cx="45407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28" name="Group 127">
            <a:extLst>
              <a:ext uri="{FF2B5EF4-FFF2-40B4-BE49-F238E27FC236}">
                <a16:creationId xmlns:a16="http://schemas.microsoft.com/office/drawing/2014/main" id="{DDE64814-47EA-4FDF-A655-97986519BEB0}"/>
              </a:ext>
            </a:extLst>
          </p:cNvPr>
          <p:cNvGrpSpPr/>
          <p:nvPr/>
        </p:nvGrpSpPr>
        <p:grpSpPr>
          <a:xfrm>
            <a:off x="6816996" y="4344350"/>
            <a:ext cx="270410" cy="1003300"/>
            <a:chOff x="8031292" y="299411"/>
            <a:chExt cx="270410" cy="1003300"/>
          </a:xfrm>
        </p:grpSpPr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ECC4A601-D1DB-465B-804A-F00A82265C14}"/>
                </a:ext>
              </a:extLst>
            </p:cNvPr>
            <p:cNvSpPr txBox="1"/>
            <p:nvPr/>
          </p:nvSpPr>
          <p:spPr>
            <a:xfrm rot="5400000">
              <a:off x="7669247" y="670256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.Lng.ipk.4B.2</a:t>
              </a:r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16A4F58F-EEF7-4AD6-91D2-C669507A4C1E}"/>
                </a:ext>
              </a:extLst>
            </p:cNvPr>
            <p:cNvSpPr/>
            <p:nvPr/>
          </p:nvSpPr>
          <p:spPr>
            <a:xfrm rot="5400000">
              <a:off x="8013292" y="996911"/>
              <a:ext cx="90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55" name="Group 154">
            <a:extLst>
              <a:ext uri="{FF2B5EF4-FFF2-40B4-BE49-F238E27FC236}">
                <a16:creationId xmlns:a16="http://schemas.microsoft.com/office/drawing/2014/main" id="{5E9EB851-E23D-4305-8CDD-5A09DC74B935}"/>
              </a:ext>
            </a:extLst>
          </p:cNvPr>
          <p:cNvGrpSpPr/>
          <p:nvPr/>
        </p:nvGrpSpPr>
        <p:grpSpPr>
          <a:xfrm>
            <a:off x="3725835" y="4626469"/>
            <a:ext cx="274743" cy="2025421"/>
            <a:chOff x="993068" y="2554970"/>
            <a:chExt cx="274743" cy="2025421"/>
          </a:xfrm>
        </p:grpSpPr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2D8DD048-6C5B-4C0C-84F2-A64512E5D8F6}"/>
                </a:ext>
              </a:extLst>
            </p:cNvPr>
            <p:cNvSpPr txBox="1"/>
            <p:nvPr/>
          </p:nvSpPr>
          <p:spPr>
            <a:xfrm rot="5400000">
              <a:off x="124295" y="3436876"/>
              <a:ext cx="20254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TL10.PHS. Albrecht et al. 2015</a:t>
              </a:r>
            </a:p>
          </p:txBody>
        </p:sp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FE41072F-6AD3-4A49-AABE-23EBE854EE31}"/>
                </a:ext>
              </a:extLst>
            </p:cNvPr>
            <p:cNvSpPr/>
            <p:nvPr/>
          </p:nvSpPr>
          <p:spPr>
            <a:xfrm rot="5400000">
              <a:off x="984068" y="2883528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FEB5B4AB-33F3-4277-A8FC-0EFA970F00F4}"/>
              </a:ext>
            </a:extLst>
          </p:cNvPr>
          <p:cNvCxnSpPr/>
          <p:nvPr/>
        </p:nvCxnSpPr>
        <p:spPr>
          <a:xfrm>
            <a:off x="480325" y="5852572"/>
            <a:ext cx="0" cy="72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TextBox 158">
            <a:extLst>
              <a:ext uri="{FF2B5EF4-FFF2-40B4-BE49-F238E27FC236}">
                <a16:creationId xmlns:a16="http://schemas.microsoft.com/office/drawing/2014/main" id="{7831FD6F-5576-460C-9157-FC9973A1D317}"/>
              </a:ext>
            </a:extLst>
          </p:cNvPr>
          <p:cNvSpPr txBox="1"/>
          <p:nvPr/>
        </p:nvSpPr>
        <p:spPr>
          <a:xfrm>
            <a:off x="489930" y="6062651"/>
            <a:ext cx="1178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/>
              <a:t>100 Mb</a:t>
            </a:r>
          </a:p>
        </p:txBody>
      </p:sp>
      <p:grpSp>
        <p:nvGrpSpPr>
          <p:cNvPr id="160" name="Group 159">
            <a:extLst>
              <a:ext uri="{FF2B5EF4-FFF2-40B4-BE49-F238E27FC236}">
                <a16:creationId xmlns:a16="http://schemas.microsoft.com/office/drawing/2014/main" id="{68A57E23-2AB7-424A-BBEB-9B177823A22E}"/>
              </a:ext>
            </a:extLst>
          </p:cNvPr>
          <p:cNvGrpSpPr/>
          <p:nvPr/>
        </p:nvGrpSpPr>
        <p:grpSpPr>
          <a:xfrm>
            <a:off x="3050485" y="4614363"/>
            <a:ext cx="280116" cy="1186015"/>
            <a:chOff x="8992024" y="5226716"/>
            <a:chExt cx="280116" cy="1186015"/>
          </a:xfrm>
        </p:grpSpPr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D41EFC52-D7E4-418C-9BC2-B55121093F8F}"/>
                </a:ext>
              </a:extLst>
            </p:cNvPr>
            <p:cNvSpPr txBox="1"/>
            <p:nvPr/>
          </p:nvSpPr>
          <p:spPr>
            <a:xfrm rot="5400000">
              <a:off x="8548327" y="5688919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4A.1</a:t>
              </a:r>
            </a:p>
          </p:txBody>
        </p:sp>
        <p:sp>
          <p:nvSpPr>
            <p:cNvPr id="165" name="Rectangle 164">
              <a:extLst>
                <a:ext uri="{FF2B5EF4-FFF2-40B4-BE49-F238E27FC236}">
                  <a16:creationId xmlns:a16="http://schemas.microsoft.com/office/drawing/2014/main" id="{35CF91DC-BDB2-497A-ABA7-CEC64A247B50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66" name="Group 165">
            <a:extLst>
              <a:ext uri="{FF2B5EF4-FFF2-40B4-BE49-F238E27FC236}">
                <a16:creationId xmlns:a16="http://schemas.microsoft.com/office/drawing/2014/main" id="{9BD35254-3A54-4469-AC28-448B1C216728}"/>
              </a:ext>
            </a:extLst>
          </p:cNvPr>
          <p:cNvGrpSpPr/>
          <p:nvPr/>
        </p:nvGrpSpPr>
        <p:grpSpPr>
          <a:xfrm>
            <a:off x="7146474" y="4342060"/>
            <a:ext cx="280116" cy="1186015"/>
            <a:chOff x="8992024" y="4824674"/>
            <a:chExt cx="280116" cy="1186015"/>
          </a:xfrm>
        </p:grpSpPr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670DB605-0B2C-4794-BBD0-6929633DFC2A}"/>
                </a:ext>
              </a:extLst>
            </p:cNvPr>
            <p:cNvSpPr txBox="1"/>
            <p:nvPr/>
          </p:nvSpPr>
          <p:spPr>
            <a:xfrm rot="5400000">
              <a:off x="8548327" y="5286877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4B.1</a:t>
              </a:r>
            </a:p>
          </p:txBody>
        </p:sp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F03A9313-DF67-4DC4-8884-1D52A51F6A22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69" name="Group 168">
            <a:extLst>
              <a:ext uri="{FF2B5EF4-FFF2-40B4-BE49-F238E27FC236}">
                <a16:creationId xmlns:a16="http://schemas.microsoft.com/office/drawing/2014/main" id="{0EA6071E-DE10-4F2D-A791-E615EE6E28FD}"/>
              </a:ext>
            </a:extLst>
          </p:cNvPr>
          <p:cNvGrpSpPr/>
          <p:nvPr/>
        </p:nvGrpSpPr>
        <p:grpSpPr>
          <a:xfrm>
            <a:off x="7472318" y="5018027"/>
            <a:ext cx="280116" cy="1186015"/>
            <a:chOff x="8992024" y="5188616"/>
            <a:chExt cx="280116" cy="1186015"/>
          </a:xfrm>
        </p:grpSpPr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1434048E-5275-4343-8A65-C57158048797}"/>
                </a:ext>
              </a:extLst>
            </p:cNvPr>
            <p:cNvSpPr txBox="1"/>
            <p:nvPr/>
          </p:nvSpPr>
          <p:spPr>
            <a:xfrm rot="5400000">
              <a:off x="8548327" y="5650819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4B.2</a:t>
              </a:r>
            </a:p>
          </p:txBody>
        </p:sp>
        <p:sp>
          <p:nvSpPr>
            <p:cNvPr id="171" name="Rectangle 170">
              <a:extLst>
                <a:ext uri="{FF2B5EF4-FFF2-40B4-BE49-F238E27FC236}">
                  <a16:creationId xmlns:a16="http://schemas.microsoft.com/office/drawing/2014/main" id="{F4FD7772-1587-4FD7-814C-7DAB7A0951DE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72" name="Group 171">
            <a:extLst>
              <a:ext uri="{FF2B5EF4-FFF2-40B4-BE49-F238E27FC236}">
                <a16:creationId xmlns:a16="http://schemas.microsoft.com/office/drawing/2014/main" id="{F384789D-DE62-44CB-80B2-3CD0BB7837CD}"/>
              </a:ext>
            </a:extLst>
          </p:cNvPr>
          <p:cNvGrpSpPr/>
          <p:nvPr/>
        </p:nvGrpSpPr>
        <p:grpSpPr>
          <a:xfrm>
            <a:off x="4395812" y="4619982"/>
            <a:ext cx="280116" cy="1186015"/>
            <a:chOff x="8992024" y="5071578"/>
            <a:chExt cx="280116" cy="1186015"/>
          </a:xfrm>
        </p:grpSpPr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10C428E3-5ADC-4AAF-9266-866958778C7F}"/>
                </a:ext>
              </a:extLst>
            </p:cNvPr>
            <p:cNvSpPr txBox="1"/>
            <p:nvPr/>
          </p:nvSpPr>
          <p:spPr>
            <a:xfrm rot="5400000">
              <a:off x="8548327" y="5533781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4A.2</a:t>
              </a:r>
            </a:p>
          </p:txBody>
        </p:sp>
        <p:sp>
          <p:nvSpPr>
            <p:cNvPr id="174" name="Rectangle 173">
              <a:extLst>
                <a:ext uri="{FF2B5EF4-FFF2-40B4-BE49-F238E27FC236}">
                  <a16:creationId xmlns:a16="http://schemas.microsoft.com/office/drawing/2014/main" id="{EC20468A-1A06-43BD-BDBA-C3949937F4AA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75" name="Group 174">
            <a:extLst>
              <a:ext uri="{FF2B5EF4-FFF2-40B4-BE49-F238E27FC236}">
                <a16:creationId xmlns:a16="http://schemas.microsoft.com/office/drawing/2014/main" id="{CAF3E426-A772-4A97-BBCA-6236B45AFC76}"/>
              </a:ext>
            </a:extLst>
          </p:cNvPr>
          <p:cNvGrpSpPr/>
          <p:nvPr/>
        </p:nvGrpSpPr>
        <p:grpSpPr>
          <a:xfrm>
            <a:off x="2484222" y="5560701"/>
            <a:ext cx="280116" cy="1186015"/>
            <a:chOff x="8992024" y="5121504"/>
            <a:chExt cx="280116" cy="1186015"/>
          </a:xfrm>
        </p:grpSpPr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ABEE02B6-F0B3-4CC2-B855-EC32D326A558}"/>
                </a:ext>
              </a:extLst>
            </p:cNvPr>
            <p:cNvSpPr txBox="1"/>
            <p:nvPr/>
          </p:nvSpPr>
          <p:spPr>
            <a:xfrm rot="5400000">
              <a:off x="8548327" y="5583707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4A.3</a:t>
              </a:r>
            </a:p>
          </p:txBody>
        </p:sp>
        <p:sp>
          <p:nvSpPr>
            <p:cNvPr id="177" name="Rectangle 176">
              <a:extLst>
                <a:ext uri="{FF2B5EF4-FFF2-40B4-BE49-F238E27FC236}">
                  <a16:creationId xmlns:a16="http://schemas.microsoft.com/office/drawing/2014/main" id="{20140CA0-4A2E-4FA8-8256-A09499766641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78" name="Group 177">
            <a:extLst>
              <a:ext uri="{FF2B5EF4-FFF2-40B4-BE49-F238E27FC236}">
                <a16:creationId xmlns:a16="http://schemas.microsoft.com/office/drawing/2014/main" id="{C6659C31-4F6A-462A-B772-5E8F096E89F0}"/>
              </a:ext>
            </a:extLst>
          </p:cNvPr>
          <p:cNvGrpSpPr/>
          <p:nvPr/>
        </p:nvGrpSpPr>
        <p:grpSpPr>
          <a:xfrm>
            <a:off x="7531804" y="820412"/>
            <a:ext cx="280116" cy="1186015"/>
            <a:chOff x="8992024" y="5348007"/>
            <a:chExt cx="280116" cy="1186015"/>
          </a:xfrm>
        </p:grpSpPr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73F8996D-134D-4B3E-8A85-57A888C96BE2}"/>
                </a:ext>
              </a:extLst>
            </p:cNvPr>
            <p:cNvSpPr txBox="1"/>
            <p:nvPr/>
          </p:nvSpPr>
          <p:spPr>
            <a:xfrm rot="5400000">
              <a:off x="8548327" y="5810210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4B.1</a:t>
              </a:r>
            </a:p>
          </p:txBody>
        </p:sp>
        <p:sp>
          <p:nvSpPr>
            <p:cNvPr id="180" name="Rectangle 179">
              <a:extLst>
                <a:ext uri="{FF2B5EF4-FFF2-40B4-BE49-F238E27FC236}">
                  <a16:creationId xmlns:a16="http://schemas.microsoft.com/office/drawing/2014/main" id="{15F2ED0B-E939-474F-B1BF-5D511C004B21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84" name="Group 183">
            <a:extLst>
              <a:ext uri="{FF2B5EF4-FFF2-40B4-BE49-F238E27FC236}">
                <a16:creationId xmlns:a16="http://schemas.microsoft.com/office/drawing/2014/main" id="{0A96CDDD-BE77-4674-8949-AC9EE42110D1}"/>
              </a:ext>
            </a:extLst>
          </p:cNvPr>
          <p:cNvGrpSpPr/>
          <p:nvPr/>
        </p:nvGrpSpPr>
        <p:grpSpPr>
          <a:xfrm>
            <a:off x="6760625" y="750777"/>
            <a:ext cx="270410" cy="1003300"/>
            <a:chOff x="8031292" y="763463"/>
            <a:chExt cx="270410" cy="1003300"/>
          </a:xfrm>
        </p:grpSpPr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3C0A267E-80BF-44EB-9318-52DD1BA6C784}"/>
                </a:ext>
              </a:extLst>
            </p:cNvPr>
            <p:cNvSpPr txBox="1"/>
            <p:nvPr/>
          </p:nvSpPr>
          <p:spPr>
            <a:xfrm rot="5400000">
              <a:off x="7669247" y="113430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err="1">
                  <a:solidFill>
                    <a:schemeClr val="bg1">
                      <a:lumMod val="50000"/>
                    </a:schemeClr>
                  </a:solidFill>
                </a:rPr>
                <a:t>QCW.csiro</a:t>
              </a:r>
              <a:endParaRPr lang="en-AU" sz="11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86" name="Rectangle 185">
              <a:extLst>
                <a:ext uri="{FF2B5EF4-FFF2-40B4-BE49-F238E27FC236}">
                  <a16:creationId xmlns:a16="http://schemas.microsoft.com/office/drawing/2014/main" id="{2373F3ED-3D5B-426D-9B26-CA5AB05FBBC3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161" name="TextBox 160">
            <a:extLst>
              <a:ext uri="{FF2B5EF4-FFF2-40B4-BE49-F238E27FC236}">
                <a16:creationId xmlns:a16="http://schemas.microsoft.com/office/drawing/2014/main" id="{FE33F56B-2FC7-4E67-8213-4AFA71D877BB}"/>
              </a:ext>
            </a:extLst>
          </p:cNvPr>
          <p:cNvSpPr txBox="1"/>
          <p:nvPr/>
        </p:nvSpPr>
        <p:spPr>
          <a:xfrm>
            <a:off x="1438343" y="5093502"/>
            <a:ext cx="12147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MKK3-A</a:t>
            </a:r>
          </a:p>
        </p:txBody>
      </p: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C5C5AEE5-60AE-4ED1-BB07-9C8F5A9B49CC}"/>
              </a:ext>
            </a:extLst>
          </p:cNvPr>
          <p:cNvCxnSpPr/>
          <p:nvPr/>
        </p:nvCxnSpPr>
        <p:spPr>
          <a:xfrm>
            <a:off x="1095571" y="5043482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0C80F604-18C8-45CC-A047-897B8FE5C1F4}"/>
              </a:ext>
            </a:extLst>
          </p:cNvPr>
          <p:cNvCxnSpPr>
            <a:cxnSpLocks/>
          </p:cNvCxnSpPr>
          <p:nvPr/>
        </p:nvCxnSpPr>
        <p:spPr>
          <a:xfrm rot="540000">
            <a:off x="1430474" y="5043454"/>
            <a:ext cx="100699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TextBox 186">
            <a:extLst>
              <a:ext uri="{FF2B5EF4-FFF2-40B4-BE49-F238E27FC236}">
                <a16:creationId xmlns:a16="http://schemas.microsoft.com/office/drawing/2014/main" id="{A0E56160-D802-4AB0-B573-1EF6CFF47FE7}"/>
              </a:ext>
            </a:extLst>
          </p:cNvPr>
          <p:cNvSpPr txBox="1"/>
          <p:nvPr/>
        </p:nvSpPr>
        <p:spPr>
          <a:xfrm>
            <a:off x="5710839" y="4476550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11</a:t>
            </a:r>
          </a:p>
        </p:txBody>
      </p:sp>
      <p:cxnSp>
        <p:nvCxnSpPr>
          <p:cNvPr id="188" name="Straight Connector 187">
            <a:extLst>
              <a:ext uri="{FF2B5EF4-FFF2-40B4-BE49-F238E27FC236}">
                <a16:creationId xmlns:a16="http://schemas.microsoft.com/office/drawing/2014/main" id="{0EDB6D9F-9A8D-4773-A38F-D1801250E5EB}"/>
              </a:ext>
            </a:extLst>
          </p:cNvPr>
          <p:cNvCxnSpPr/>
          <p:nvPr/>
        </p:nvCxnSpPr>
        <p:spPr>
          <a:xfrm>
            <a:off x="5426563" y="460680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TextBox 188">
            <a:extLst>
              <a:ext uri="{FF2B5EF4-FFF2-40B4-BE49-F238E27FC236}">
                <a16:creationId xmlns:a16="http://schemas.microsoft.com/office/drawing/2014/main" id="{3363EC53-72DB-40DA-80FC-779527B66B4D}"/>
              </a:ext>
            </a:extLst>
          </p:cNvPr>
          <p:cNvSpPr txBox="1"/>
          <p:nvPr/>
        </p:nvSpPr>
        <p:spPr>
          <a:xfrm>
            <a:off x="1385394" y="718004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11</a:t>
            </a:r>
          </a:p>
        </p:txBody>
      </p: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5CA3E3B3-6F5B-4BEB-95AE-5F81C2339AC4}"/>
              </a:ext>
            </a:extLst>
          </p:cNvPr>
          <p:cNvCxnSpPr/>
          <p:nvPr/>
        </p:nvCxnSpPr>
        <p:spPr>
          <a:xfrm>
            <a:off x="1101337" y="835563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TextBox 190">
            <a:extLst>
              <a:ext uri="{FF2B5EF4-FFF2-40B4-BE49-F238E27FC236}">
                <a16:creationId xmlns:a16="http://schemas.microsoft.com/office/drawing/2014/main" id="{C244DA27-92CB-43E4-9709-D0B892C1C21A}"/>
              </a:ext>
            </a:extLst>
          </p:cNvPr>
          <p:cNvSpPr txBox="1"/>
          <p:nvPr/>
        </p:nvSpPr>
        <p:spPr>
          <a:xfrm>
            <a:off x="5716883" y="5297413"/>
            <a:ext cx="1513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12/TaGA2ox13</a:t>
            </a:r>
          </a:p>
        </p:txBody>
      </p:sp>
      <p:cxnSp>
        <p:nvCxnSpPr>
          <p:cNvPr id="192" name="Straight Connector 191">
            <a:extLst>
              <a:ext uri="{FF2B5EF4-FFF2-40B4-BE49-F238E27FC236}">
                <a16:creationId xmlns:a16="http://schemas.microsoft.com/office/drawing/2014/main" id="{8C59A698-8DA4-4D5D-84A1-5D8C96A6A5CE}"/>
              </a:ext>
            </a:extLst>
          </p:cNvPr>
          <p:cNvCxnSpPr/>
          <p:nvPr/>
        </p:nvCxnSpPr>
        <p:spPr>
          <a:xfrm>
            <a:off x="5426563" y="5409668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Box 192">
            <a:extLst>
              <a:ext uri="{FF2B5EF4-FFF2-40B4-BE49-F238E27FC236}">
                <a16:creationId xmlns:a16="http://schemas.microsoft.com/office/drawing/2014/main" id="{613F1618-3252-4E2A-BD7D-29FB3750AE3D}"/>
              </a:ext>
            </a:extLst>
          </p:cNvPr>
          <p:cNvSpPr txBox="1"/>
          <p:nvPr/>
        </p:nvSpPr>
        <p:spPr>
          <a:xfrm>
            <a:off x="5764393" y="5439415"/>
            <a:ext cx="12838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CK154440</a:t>
            </a:r>
          </a:p>
        </p:txBody>
      </p:sp>
      <p:cxnSp>
        <p:nvCxnSpPr>
          <p:cNvPr id="194" name="Straight Connector 193">
            <a:extLst>
              <a:ext uri="{FF2B5EF4-FFF2-40B4-BE49-F238E27FC236}">
                <a16:creationId xmlns:a16="http://schemas.microsoft.com/office/drawing/2014/main" id="{7640DD32-B919-47E4-8ABD-73A08410EB47}"/>
              </a:ext>
            </a:extLst>
          </p:cNvPr>
          <p:cNvCxnSpPr/>
          <p:nvPr/>
        </p:nvCxnSpPr>
        <p:spPr>
          <a:xfrm>
            <a:off x="5426563" y="5429053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TextBox 194">
            <a:extLst>
              <a:ext uri="{FF2B5EF4-FFF2-40B4-BE49-F238E27FC236}">
                <a16:creationId xmlns:a16="http://schemas.microsoft.com/office/drawing/2014/main" id="{F6D39B6F-0E89-4EE3-BC36-5FC78DDD4C6B}"/>
              </a:ext>
            </a:extLst>
          </p:cNvPr>
          <p:cNvSpPr txBox="1"/>
          <p:nvPr/>
        </p:nvSpPr>
        <p:spPr>
          <a:xfrm>
            <a:off x="5711373" y="4116251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AY491968</a:t>
            </a:r>
          </a:p>
        </p:txBody>
      </p: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id="{91905CCB-7195-4F8C-9B1E-EBA69D45DDEA}"/>
              </a:ext>
            </a:extLst>
          </p:cNvPr>
          <p:cNvCxnSpPr/>
          <p:nvPr/>
        </p:nvCxnSpPr>
        <p:spPr>
          <a:xfrm>
            <a:off x="5426563" y="4245233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TextBox 196">
            <a:extLst>
              <a:ext uri="{FF2B5EF4-FFF2-40B4-BE49-F238E27FC236}">
                <a16:creationId xmlns:a16="http://schemas.microsoft.com/office/drawing/2014/main" id="{F8E0D4F2-33B5-4C9D-88F7-B983B4FBB692}"/>
              </a:ext>
            </a:extLst>
          </p:cNvPr>
          <p:cNvSpPr txBox="1"/>
          <p:nvPr/>
        </p:nvSpPr>
        <p:spPr>
          <a:xfrm>
            <a:off x="1400920" y="1499170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CD934753</a:t>
            </a:r>
          </a:p>
        </p:txBody>
      </p: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CB9AF755-32BE-493E-A453-C45816A5C42D}"/>
              </a:ext>
            </a:extLst>
          </p:cNvPr>
          <p:cNvCxnSpPr/>
          <p:nvPr/>
        </p:nvCxnSpPr>
        <p:spPr>
          <a:xfrm>
            <a:off x="1110152" y="1628152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Straight Connector 204">
            <a:extLst>
              <a:ext uri="{FF2B5EF4-FFF2-40B4-BE49-F238E27FC236}">
                <a16:creationId xmlns:a16="http://schemas.microsoft.com/office/drawing/2014/main" id="{9A07C46E-6125-4645-B837-7770FDC35A95}"/>
              </a:ext>
            </a:extLst>
          </p:cNvPr>
          <p:cNvCxnSpPr>
            <a:cxnSpLocks/>
          </p:cNvCxnSpPr>
          <p:nvPr/>
        </p:nvCxnSpPr>
        <p:spPr>
          <a:xfrm>
            <a:off x="5766091" y="5429904"/>
            <a:ext cx="98038" cy="973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Straight Connector 205">
            <a:extLst>
              <a:ext uri="{FF2B5EF4-FFF2-40B4-BE49-F238E27FC236}">
                <a16:creationId xmlns:a16="http://schemas.microsoft.com/office/drawing/2014/main" id="{BD7B51DD-4349-4D18-81C3-33B07D95B8CC}"/>
              </a:ext>
            </a:extLst>
          </p:cNvPr>
          <p:cNvCxnSpPr>
            <a:cxnSpLocks/>
          </p:cNvCxnSpPr>
          <p:nvPr/>
        </p:nvCxnSpPr>
        <p:spPr>
          <a:xfrm rot="-5220000">
            <a:off x="5768351" y="5289357"/>
            <a:ext cx="98038" cy="973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9" name="TextBox 198">
            <a:extLst>
              <a:ext uri="{FF2B5EF4-FFF2-40B4-BE49-F238E27FC236}">
                <a16:creationId xmlns:a16="http://schemas.microsoft.com/office/drawing/2014/main" id="{DB84BF18-74E7-4B71-978C-CB2F3D5CA5E5}"/>
              </a:ext>
            </a:extLst>
          </p:cNvPr>
          <p:cNvSpPr txBox="1"/>
          <p:nvPr/>
        </p:nvSpPr>
        <p:spPr>
          <a:xfrm>
            <a:off x="1382641" y="615454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SUT1A</a:t>
            </a:r>
          </a:p>
        </p:txBody>
      </p:sp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61F490E6-C6B5-40C4-89B6-770460F3A7D8}"/>
              </a:ext>
            </a:extLst>
          </p:cNvPr>
          <p:cNvCxnSpPr/>
          <p:nvPr/>
        </p:nvCxnSpPr>
        <p:spPr>
          <a:xfrm>
            <a:off x="1098584" y="745713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1" name="TextBox 200">
            <a:extLst>
              <a:ext uri="{FF2B5EF4-FFF2-40B4-BE49-F238E27FC236}">
                <a16:creationId xmlns:a16="http://schemas.microsoft.com/office/drawing/2014/main" id="{52CD28CD-EA0C-46CD-BDD0-E3A4F29BF9ED}"/>
              </a:ext>
            </a:extLst>
          </p:cNvPr>
          <p:cNvSpPr txBox="1"/>
          <p:nvPr/>
        </p:nvSpPr>
        <p:spPr>
          <a:xfrm>
            <a:off x="5710839" y="4639076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SUT1B</a:t>
            </a:r>
          </a:p>
        </p:txBody>
      </p:sp>
      <p:cxnSp>
        <p:nvCxnSpPr>
          <p:cNvPr id="202" name="Straight Connector 201">
            <a:extLst>
              <a:ext uri="{FF2B5EF4-FFF2-40B4-BE49-F238E27FC236}">
                <a16:creationId xmlns:a16="http://schemas.microsoft.com/office/drawing/2014/main" id="{A5167349-F8E3-416A-9BDE-116CBD50F38D}"/>
              </a:ext>
            </a:extLst>
          </p:cNvPr>
          <p:cNvCxnSpPr/>
          <p:nvPr/>
        </p:nvCxnSpPr>
        <p:spPr>
          <a:xfrm>
            <a:off x="5426563" y="4769335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id="{7604BEFE-8ACC-4CDB-93B6-4E72078CA98F}"/>
              </a:ext>
            </a:extLst>
          </p:cNvPr>
          <p:cNvCxnSpPr/>
          <p:nvPr/>
        </p:nvCxnSpPr>
        <p:spPr>
          <a:xfrm>
            <a:off x="1095571" y="5037522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Connector 182">
            <a:extLst>
              <a:ext uri="{FF2B5EF4-FFF2-40B4-BE49-F238E27FC236}">
                <a16:creationId xmlns:a16="http://schemas.microsoft.com/office/drawing/2014/main" id="{990E7C3D-FDD1-4A12-BB59-4406A773D3A1}"/>
              </a:ext>
            </a:extLst>
          </p:cNvPr>
          <p:cNvCxnSpPr>
            <a:cxnSpLocks/>
          </p:cNvCxnSpPr>
          <p:nvPr/>
        </p:nvCxnSpPr>
        <p:spPr>
          <a:xfrm rot="60000">
            <a:off x="1432749" y="5045297"/>
            <a:ext cx="108000" cy="122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371986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TextBox 172">
            <a:extLst>
              <a:ext uri="{FF2B5EF4-FFF2-40B4-BE49-F238E27FC236}">
                <a16:creationId xmlns:a16="http://schemas.microsoft.com/office/drawing/2014/main" id="{3AD6C678-8237-48F9-964B-3D57C886F123}"/>
              </a:ext>
            </a:extLst>
          </p:cNvPr>
          <p:cNvSpPr txBox="1"/>
          <p:nvPr/>
        </p:nvSpPr>
        <p:spPr>
          <a:xfrm>
            <a:off x="1342166" y="4576446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E604829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84812694-6A7B-4A16-879C-717E5A6AA453}"/>
              </a:ext>
            </a:extLst>
          </p:cNvPr>
          <p:cNvGrpSpPr/>
          <p:nvPr/>
        </p:nvGrpSpPr>
        <p:grpSpPr>
          <a:xfrm>
            <a:off x="9592327" y="5251410"/>
            <a:ext cx="1142347" cy="1550617"/>
            <a:chOff x="9592327" y="5251410"/>
            <a:chExt cx="1142347" cy="1550617"/>
          </a:xfrm>
        </p:grpSpPr>
        <p:sp>
          <p:nvSpPr>
            <p:cNvPr id="3" name="Oval 2">
              <a:extLst>
                <a:ext uri="{FF2B5EF4-FFF2-40B4-BE49-F238E27FC236}">
                  <a16:creationId xmlns:a16="http://schemas.microsoft.com/office/drawing/2014/main" id="{5A9E18EA-4381-4619-8B54-672BBAFB834B}"/>
                </a:ext>
              </a:extLst>
            </p:cNvPr>
            <p:cNvSpPr/>
            <p:nvPr/>
          </p:nvSpPr>
          <p:spPr>
            <a:xfrm>
              <a:off x="9601327" y="5359194"/>
              <a:ext cx="90000" cy="90000"/>
            </a:xfrm>
            <a:prstGeom prst="ellipse">
              <a:avLst/>
            </a:prstGeom>
            <a:solidFill>
              <a:srgbClr val="70474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4" name="Isosceles Triangle 3">
              <a:extLst>
                <a:ext uri="{FF2B5EF4-FFF2-40B4-BE49-F238E27FC236}">
                  <a16:creationId xmlns:a16="http://schemas.microsoft.com/office/drawing/2014/main" id="{D7589DEF-5B88-45E4-892E-6B512C797E9F}"/>
                </a:ext>
              </a:extLst>
            </p:cNvPr>
            <p:cNvSpPr/>
            <p:nvPr/>
          </p:nvSpPr>
          <p:spPr>
            <a:xfrm>
              <a:off x="9592327" y="6436293"/>
              <a:ext cx="108000" cy="108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5" name="Diamond 4">
              <a:extLst>
                <a:ext uri="{FF2B5EF4-FFF2-40B4-BE49-F238E27FC236}">
                  <a16:creationId xmlns:a16="http://schemas.microsoft.com/office/drawing/2014/main" id="{27559D62-1666-47A7-98CE-17695BB8C8BE}"/>
                </a:ext>
              </a:extLst>
            </p:cNvPr>
            <p:cNvSpPr/>
            <p:nvPr/>
          </p:nvSpPr>
          <p:spPr>
            <a:xfrm>
              <a:off x="9592327" y="5534298"/>
              <a:ext cx="108000" cy="108000"/>
            </a:xfrm>
            <a:prstGeom prst="diamond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6" name="Pentagon 5">
              <a:extLst>
                <a:ext uri="{FF2B5EF4-FFF2-40B4-BE49-F238E27FC236}">
                  <a16:creationId xmlns:a16="http://schemas.microsoft.com/office/drawing/2014/main" id="{1A52471C-D9D4-43A1-89DD-38FD86B9DA71}"/>
                </a:ext>
              </a:extLst>
            </p:cNvPr>
            <p:cNvSpPr/>
            <p:nvPr/>
          </p:nvSpPr>
          <p:spPr>
            <a:xfrm>
              <a:off x="9592327" y="6619875"/>
              <a:ext cx="108000" cy="108000"/>
            </a:xfrm>
            <a:prstGeom prst="pentagon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7" name="Hexagon 6">
              <a:extLst>
                <a:ext uri="{FF2B5EF4-FFF2-40B4-BE49-F238E27FC236}">
                  <a16:creationId xmlns:a16="http://schemas.microsoft.com/office/drawing/2014/main" id="{E090EBD7-72A7-42FD-A826-20CC596B13DF}"/>
                </a:ext>
              </a:extLst>
            </p:cNvPr>
            <p:cNvSpPr/>
            <p:nvPr/>
          </p:nvSpPr>
          <p:spPr>
            <a:xfrm>
              <a:off x="9592327" y="5717877"/>
              <a:ext cx="108000" cy="93600"/>
            </a:xfrm>
            <a:prstGeom prst="hexagon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E7DC7DCE-0101-4692-B9FE-CB9932AE5E87}"/>
                </a:ext>
              </a:extLst>
            </p:cNvPr>
            <p:cNvSpPr/>
            <p:nvPr/>
          </p:nvSpPr>
          <p:spPr>
            <a:xfrm>
              <a:off x="9610327" y="6095610"/>
              <a:ext cx="72000" cy="72000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9" name="Trapezoid 8">
              <a:extLst>
                <a:ext uri="{FF2B5EF4-FFF2-40B4-BE49-F238E27FC236}">
                  <a16:creationId xmlns:a16="http://schemas.microsoft.com/office/drawing/2014/main" id="{A71C6E7E-B0B4-4329-92C0-46FAF5368F15}"/>
                </a:ext>
              </a:extLst>
            </p:cNvPr>
            <p:cNvSpPr/>
            <p:nvPr/>
          </p:nvSpPr>
          <p:spPr>
            <a:xfrm>
              <a:off x="9592327" y="6252714"/>
              <a:ext cx="108000" cy="108000"/>
            </a:xfrm>
            <a:prstGeom prst="trapezoid">
              <a:avLst/>
            </a:prstGeom>
            <a:solidFill>
              <a:srgbClr val="EF19C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7266F391-D29B-4484-AC76-2774A15ADC03}"/>
                </a:ext>
              </a:extLst>
            </p:cNvPr>
            <p:cNvSpPr/>
            <p:nvPr/>
          </p:nvSpPr>
          <p:spPr>
            <a:xfrm>
              <a:off x="9601327" y="5901456"/>
              <a:ext cx="90000" cy="90000"/>
            </a:xfrm>
            <a:prstGeom prst="ellipse">
              <a:avLst/>
            </a:prstGeom>
            <a:solidFill>
              <a:srgbClr val="FA630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7C93D83-D970-495C-9272-B9491759CA56}"/>
                </a:ext>
              </a:extLst>
            </p:cNvPr>
            <p:cNvSpPr txBox="1"/>
            <p:nvPr/>
          </p:nvSpPr>
          <p:spPr>
            <a:xfrm>
              <a:off x="9696449" y="5251410"/>
              <a:ext cx="1038225" cy="1550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AU" sz="800" dirty="0"/>
                <a:t>April 2017 – 9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7 – 12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8 – 16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ne 2018 – 8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ly 2018 – 10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April 2019 – 24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9 – 22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ne 2019 – 11 das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5E12AF3C-5727-4DAE-8017-15B56301C27A}"/>
              </a:ext>
            </a:extLst>
          </p:cNvPr>
          <p:cNvGrpSpPr/>
          <p:nvPr/>
        </p:nvGrpSpPr>
        <p:grpSpPr>
          <a:xfrm>
            <a:off x="917154" y="306399"/>
            <a:ext cx="482959" cy="5516828"/>
            <a:chOff x="9003095" y="188953"/>
            <a:chExt cx="482959" cy="5516828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3FDBEEB0-CD06-4C4D-95B5-20484308EBFA}"/>
                </a:ext>
              </a:extLst>
            </p:cNvPr>
            <p:cNvGrpSpPr/>
            <p:nvPr/>
          </p:nvGrpSpPr>
          <p:grpSpPr>
            <a:xfrm>
              <a:off x="9154574" y="557781"/>
              <a:ext cx="180000" cy="5148000"/>
              <a:chOff x="7378378" y="557781"/>
              <a:chExt cx="504000" cy="5148000"/>
            </a:xfrm>
          </p:grpSpPr>
          <p:sp>
            <p:nvSpPr>
              <p:cNvPr id="15" name="Rectangle: Rounded Corners 14">
                <a:extLst>
                  <a:ext uri="{FF2B5EF4-FFF2-40B4-BE49-F238E27FC236}">
                    <a16:creationId xmlns:a16="http://schemas.microsoft.com/office/drawing/2014/main" id="{8BB6C0F7-322F-4C5D-9536-7854744B5F07}"/>
                  </a:ext>
                </a:extLst>
              </p:cNvPr>
              <p:cNvSpPr/>
              <p:nvPr/>
            </p:nvSpPr>
            <p:spPr>
              <a:xfrm>
                <a:off x="7378378" y="557781"/>
                <a:ext cx="327170" cy="5148000"/>
              </a:xfrm>
              <a:prstGeom prst="round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743CD1E6-08FE-4FE3-955F-B443D09DA450}"/>
                  </a:ext>
                </a:extLst>
              </p:cNvPr>
              <p:cNvCxnSpPr/>
              <p:nvPr/>
            </p:nvCxnSpPr>
            <p:spPr>
              <a:xfrm>
                <a:off x="7378378" y="12668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9C41D22F-8B7F-4CFB-B9A1-AB9CB286F9F8}"/>
                  </a:ext>
                </a:extLst>
              </p:cNvPr>
              <p:cNvCxnSpPr/>
              <p:nvPr/>
            </p:nvCxnSpPr>
            <p:spPr>
              <a:xfrm>
                <a:off x="7378378" y="19907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3B20292E-ED1D-4E54-9F8E-4058FAFA1A76}"/>
                  </a:ext>
                </a:extLst>
              </p:cNvPr>
              <p:cNvCxnSpPr/>
              <p:nvPr/>
            </p:nvCxnSpPr>
            <p:spPr>
              <a:xfrm>
                <a:off x="7378378" y="27051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FAF05133-762F-4950-8FCF-47ACE3AEFFF1}"/>
                  </a:ext>
                </a:extLst>
              </p:cNvPr>
              <p:cNvCxnSpPr/>
              <p:nvPr/>
            </p:nvCxnSpPr>
            <p:spPr>
              <a:xfrm>
                <a:off x="7378378" y="34290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E1236ACE-BCCE-4587-8C2C-0C87A77B7168}"/>
                  </a:ext>
                </a:extLst>
              </p:cNvPr>
              <p:cNvCxnSpPr/>
              <p:nvPr/>
            </p:nvCxnSpPr>
            <p:spPr>
              <a:xfrm>
                <a:off x="7378378" y="41529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21139A70-1C0E-4BF9-871C-847BDB4933B8}"/>
                  </a:ext>
                </a:extLst>
              </p:cNvPr>
              <p:cNvCxnSpPr/>
              <p:nvPr/>
            </p:nvCxnSpPr>
            <p:spPr>
              <a:xfrm>
                <a:off x="7378378" y="486727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4FE2953E-1621-4AB5-8951-C56B78BF792A}"/>
                  </a:ext>
                </a:extLst>
              </p:cNvPr>
              <p:cNvCxnSpPr/>
              <p:nvPr/>
            </p:nvCxnSpPr>
            <p:spPr>
              <a:xfrm>
                <a:off x="7378378" y="559117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F281FD3-ABD5-44C6-A618-442931FD7B5B}"/>
                </a:ext>
              </a:extLst>
            </p:cNvPr>
            <p:cNvSpPr txBox="1"/>
            <p:nvPr/>
          </p:nvSpPr>
          <p:spPr>
            <a:xfrm>
              <a:off x="9003095" y="188953"/>
              <a:ext cx="482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5B</a:t>
              </a: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D2F73735-37BB-4750-B121-3DE3A47D73F1}"/>
              </a:ext>
            </a:extLst>
          </p:cNvPr>
          <p:cNvGrpSpPr/>
          <p:nvPr/>
        </p:nvGrpSpPr>
        <p:grpSpPr>
          <a:xfrm>
            <a:off x="5375133" y="306399"/>
            <a:ext cx="482959" cy="4436828"/>
            <a:chOff x="9965120" y="188953"/>
            <a:chExt cx="482959" cy="4436828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B1163CCD-A0CE-4695-9EAE-946F4402ABD3}"/>
                </a:ext>
              </a:extLst>
            </p:cNvPr>
            <p:cNvGrpSpPr/>
            <p:nvPr/>
          </p:nvGrpSpPr>
          <p:grpSpPr>
            <a:xfrm>
              <a:off x="10116599" y="557781"/>
              <a:ext cx="180000" cy="4068000"/>
              <a:chOff x="8340403" y="557781"/>
              <a:chExt cx="504000" cy="4068000"/>
            </a:xfrm>
          </p:grpSpPr>
          <p:sp>
            <p:nvSpPr>
              <p:cNvPr id="26" name="Rectangle: Rounded Corners 25">
                <a:extLst>
                  <a:ext uri="{FF2B5EF4-FFF2-40B4-BE49-F238E27FC236}">
                    <a16:creationId xmlns:a16="http://schemas.microsoft.com/office/drawing/2014/main" id="{4043392C-B7C2-4C6B-B425-23C4FADC6E58}"/>
                  </a:ext>
                </a:extLst>
              </p:cNvPr>
              <p:cNvSpPr/>
              <p:nvPr/>
            </p:nvSpPr>
            <p:spPr>
              <a:xfrm>
                <a:off x="8340403" y="557781"/>
                <a:ext cx="327170" cy="4068000"/>
              </a:xfrm>
              <a:prstGeom prst="round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AD79CE64-F34A-445D-97DC-31BD56F4E396}"/>
                  </a:ext>
                </a:extLst>
              </p:cNvPr>
              <p:cNvCxnSpPr/>
              <p:nvPr/>
            </p:nvCxnSpPr>
            <p:spPr>
              <a:xfrm>
                <a:off x="8340403" y="12668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6634C341-70F5-4579-B35C-BE4965200EED}"/>
                  </a:ext>
                </a:extLst>
              </p:cNvPr>
              <p:cNvCxnSpPr/>
              <p:nvPr/>
            </p:nvCxnSpPr>
            <p:spPr>
              <a:xfrm>
                <a:off x="8340403" y="19907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7659F229-0F75-4338-92FF-B0CB73C6E516}"/>
                  </a:ext>
                </a:extLst>
              </p:cNvPr>
              <p:cNvCxnSpPr/>
              <p:nvPr/>
            </p:nvCxnSpPr>
            <p:spPr>
              <a:xfrm>
                <a:off x="8340403" y="27051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4D2C60FC-2720-47CC-89FC-2756990DC52B}"/>
                  </a:ext>
                </a:extLst>
              </p:cNvPr>
              <p:cNvCxnSpPr/>
              <p:nvPr/>
            </p:nvCxnSpPr>
            <p:spPr>
              <a:xfrm>
                <a:off x="8340403" y="34290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C98D9401-03E8-4716-8487-EB99D5781CDD}"/>
                  </a:ext>
                </a:extLst>
              </p:cNvPr>
              <p:cNvCxnSpPr/>
              <p:nvPr/>
            </p:nvCxnSpPr>
            <p:spPr>
              <a:xfrm>
                <a:off x="8340403" y="41529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DFC8C70-6A3C-4B8B-938B-A884B7BDE821}"/>
                </a:ext>
              </a:extLst>
            </p:cNvPr>
            <p:cNvSpPr txBox="1"/>
            <p:nvPr/>
          </p:nvSpPr>
          <p:spPr>
            <a:xfrm>
              <a:off x="9965120" y="188953"/>
              <a:ext cx="482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5D</a:t>
              </a:r>
            </a:p>
          </p:txBody>
        </p:sp>
      </p:grp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C8FE92E-6D56-4B29-BA1B-ED2F9B3FDFCB}"/>
              </a:ext>
            </a:extLst>
          </p:cNvPr>
          <p:cNvCxnSpPr/>
          <p:nvPr/>
        </p:nvCxnSpPr>
        <p:spPr>
          <a:xfrm>
            <a:off x="5515022" y="4317595"/>
            <a:ext cx="340739" cy="0"/>
          </a:xfrm>
          <a:prstGeom prst="line">
            <a:avLst/>
          </a:prstGeom>
          <a:ln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22B22B7B-6258-4E28-B003-3C90A313F58E}"/>
              </a:ext>
            </a:extLst>
          </p:cNvPr>
          <p:cNvSpPr/>
          <p:nvPr/>
        </p:nvSpPr>
        <p:spPr>
          <a:xfrm>
            <a:off x="5898381" y="4283323"/>
            <a:ext cx="72000" cy="72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18A6B861-A042-4CED-9E6D-3866BB8C595A}"/>
              </a:ext>
            </a:extLst>
          </p:cNvPr>
          <p:cNvCxnSpPr/>
          <p:nvPr/>
        </p:nvCxnSpPr>
        <p:spPr>
          <a:xfrm>
            <a:off x="1079404" y="5080662"/>
            <a:ext cx="340739" cy="0"/>
          </a:xfrm>
          <a:prstGeom prst="line">
            <a:avLst/>
          </a:prstGeom>
          <a:ln>
            <a:solidFill>
              <a:srgbClr val="FA630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Oval 34">
            <a:extLst>
              <a:ext uri="{FF2B5EF4-FFF2-40B4-BE49-F238E27FC236}">
                <a16:creationId xmlns:a16="http://schemas.microsoft.com/office/drawing/2014/main" id="{17BA54C2-D3D4-4B75-8323-369D6F66ED54}"/>
              </a:ext>
            </a:extLst>
          </p:cNvPr>
          <p:cNvSpPr/>
          <p:nvPr/>
        </p:nvSpPr>
        <p:spPr>
          <a:xfrm>
            <a:off x="1445124" y="5045221"/>
            <a:ext cx="90000" cy="90000"/>
          </a:xfrm>
          <a:prstGeom prst="ellipse">
            <a:avLst/>
          </a:prstGeom>
          <a:solidFill>
            <a:srgbClr val="FA630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DC4B6E04-8564-44E5-B95E-AFF77DD3F0F4}"/>
              </a:ext>
            </a:extLst>
          </p:cNvPr>
          <p:cNvCxnSpPr/>
          <p:nvPr/>
        </p:nvCxnSpPr>
        <p:spPr>
          <a:xfrm>
            <a:off x="1067136" y="4811146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8C1DB723-55C7-43B1-9DC4-BD94DC99E3D3}"/>
              </a:ext>
            </a:extLst>
          </p:cNvPr>
          <p:cNvSpPr txBox="1"/>
          <p:nvPr/>
        </p:nvSpPr>
        <p:spPr>
          <a:xfrm>
            <a:off x="1346727" y="4695297"/>
            <a:ext cx="572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Vrn-B1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CEF6FEF2-2C9E-4872-82D4-D6B11D0D64A3}"/>
              </a:ext>
            </a:extLst>
          </p:cNvPr>
          <p:cNvCxnSpPr/>
          <p:nvPr/>
        </p:nvCxnSpPr>
        <p:spPr>
          <a:xfrm>
            <a:off x="5527400" y="3997518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E0643725-FDD3-497C-9D6F-1997E16C2473}"/>
              </a:ext>
            </a:extLst>
          </p:cNvPr>
          <p:cNvSpPr txBox="1"/>
          <p:nvPr/>
        </p:nvSpPr>
        <p:spPr>
          <a:xfrm>
            <a:off x="5907646" y="4003895"/>
            <a:ext cx="572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Vrn-D1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B9FB9F6A-562D-4632-ACA8-7B37821975EC}"/>
              </a:ext>
            </a:extLst>
          </p:cNvPr>
          <p:cNvGrpSpPr/>
          <p:nvPr/>
        </p:nvGrpSpPr>
        <p:grpSpPr>
          <a:xfrm>
            <a:off x="3193851" y="3875457"/>
            <a:ext cx="287034" cy="1003300"/>
            <a:chOff x="8031292" y="851556"/>
            <a:chExt cx="287034" cy="1003300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0072CA0-6024-4388-8810-4B972DE0477F}"/>
                </a:ext>
              </a:extLst>
            </p:cNvPr>
            <p:cNvSpPr txBox="1"/>
            <p:nvPr/>
          </p:nvSpPr>
          <p:spPr>
            <a:xfrm rot="5400000">
              <a:off x="7685871" y="1222401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dsu-5BL</a:t>
              </a: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1EF34EB1-CDE9-4CC7-B247-BA2E96821571}"/>
                </a:ext>
              </a:extLst>
            </p:cNvPr>
            <p:cNvSpPr/>
            <p:nvPr/>
          </p:nvSpPr>
          <p:spPr>
            <a:xfrm rot="5400000">
              <a:off x="8031292" y="1470187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0C5EE1D0-61C5-4815-AF6D-ABC1130C5257}"/>
              </a:ext>
            </a:extLst>
          </p:cNvPr>
          <p:cNvGrpSpPr/>
          <p:nvPr/>
        </p:nvGrpSpPr>
        <p:grpSpPr>
          <a:xfrm>
            <a:off x="6591201" y="4214788"/>
            <a:ext cx="285158" cy="1003300"/>
            <a:chOff x="8031292" y="625528"/>
            <a:chExt cx="285158" cy="1003300"/>
          </a:xfrm>
        </p:grpSpPr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A0ADE073-44F0-4E60-AA86-21D4FC8A7CCC}"/>
                </a:ext>
              </a:extLst>
            </p:cNvPr>
            <p:cNvSpPr txBox="1"/>
            <p:nvPr/>
          </p:nvSpPr>
          <p:spPr>
            <a:xfrm rot="5400000">
              <a:off x="7683995" y="996373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DA7B9CCA-5276-4AC0-959C-4DA72BF94ADD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23688C97-22A0-4966-846F-501D25C53E2D}"/>
              </a:ext>
            </a:extLst>
          </p:cNvPr>
          <p:cNvGrpSpPr/>
          <p:nvPr/>
        </p:nvGrpSpPr>
        <p:grpSpPr>
          <a:xfrm>
            <a:off x="2267338" y="4458219"/>
            <a:ext cx="270410" cy="1003300"/>
            <a:chOff x="8031292" y="603407"/>
            <a:chExt cx="270410" cy="1003300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179EE2A8-9BB3-4F5B-BCEA-CA35C3240D95}"/>
                </a:ext>
              </a:extLst>
            </p:cNvPr>
            <p:cNvSpPr txBox="1"/>
            <p:nvPr/>
          </p:nvSpPr>
          <p:spPr>
            <a:xfrm rot="5400000">
              <a:off x="7669247" y="974252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W.csiro</a:t>
              </a: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4BABFBCF-69B9-40AF-AA21-F0B759970888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754E5A7C-CCAE-4480-87C2-3628DEA17E10}"/>
              </a:ext>
            </a:extLst>
          </p:cNvPr>
          <p:cNvGrpSpPr/>
          <p:nvPr/>
        </p:nvGrpSpPr>
        <p:grpSpPr>
          <a:xfrm>
            <a:off x="2813773" y="4840646"/>
            <a:ext cx="280116" cy="1186015"/>
            <a:chOff x="8992024" y="5374446"/>
            <a:chExt cx="280116" cy="1186015"/>
          </a:xfrm>
        </p:grpSpPr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921E9F1-50FB-48A0-96C9-3D458EEFC7CF}"/>
                </a:ext>
              </a:extLst>
            </p:cNvPr>
            <p:cNvSpPr txBox="1"/>
            <p:nvPr/>
          </p:nvSpPr>
          <p:spPr>
            <a:xfrm rot="5400000">
              <a:off x="8548327" y="5836649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ahau-5B.2</a:t>
              </a: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E51B127C-FFD4-4A21-8745-18E2352F1C17}"/>
                </a:ext>
              </a:extLst>
            </p:cNvPr>
            <p:cNvSpPr/>
            <p:nvPr/>
          </p:nvSpPr>
          <p:spPr>
            <a:xfrm rot="5400000">
              <a:off x="8987107" y="5526729"/>
              <a:ext cx="63834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5332711F-6D53-44AB-9C7C-673A262D3B52}"/>
              </a:ext>
            </a:extLst>
          </p:cNvPr>
          <p:cNvGrpSpPr/>
          <p:nvPr/>
        </p:nvGrpSpPr>
        <p:grpSpPr>
          <a:xfrm>
            <a:off x="3362206" y="5244979"/>
            <a:ext cx="280116" cy="1186015"/>
            <a:chOff x="8992024" y="5403673"/>
            <a:chExt cx="280116" cy="1186015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2A618BF-E6FD-4C6B-BE34-DD9FA2766CD9}"/>
                </a:ext>
              </a:extLst>
            </p:cNvPr>
            <p:cNvSpPr txBox="1"/>
            <p:nvPr/>
          </p:nvSpPr>
          <p:spPr>
            <a:xfrm rot="5400000">
              <a:off x="8548327" y="5865876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ahau-5B.3</a:t>
              </a:r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1295C4DC-5EE9-4A57-B544-C354B3F2C6AE}"/>
                </a:ext>
              </a:extLst>
            </p:cNvPr>
            <p:cNvSpPr/>
            <p:nvPr/>
          </p:nvSpPr>
          <p:spPr>
            <a:xfrm rot="5400000">
              <a:off x="8987107" y="5526729"/>
              <a:ext cx="63834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2E11AB4F-5702-4749-A026-D1BF5AC70A7E}"/>
              </a:ext>
            </a:extLst>
          </p:cNvPr>
          <p:cNvGrpSpPr/>
          <p:nvPr/>
        </p:nvGrpSpPr>
        <p:grpSpPr>
          <a:xfrm>
            <a:off x="6962433" y="4209141"/>
            <a:ext cx="280116" cy="1186015"/>
            <a:chOff x="8992024" y="5175916"/>
            <a:chExt cx="280116" cy="1186015"/>
          </a:xfrm>
        </p:grpSpPr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FEC3503-2750-4513-8755-BEFFA3CC43BE}"/>
                </a:ext>
              </a:extLst>
            </p:cNvPr>
            <p:cNvSpPr txBox="1"/>
            <p:nvPr/>
          </p:nvSpPr>
          <p:spPr>
            <a:xfrm rot="5400000">
              <a:off x="8548327" y="5638119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ahau-5D</a:t>
              </a: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8F904ECE-38A8-49BD-B350-388735C53E1D}"/>
                </a:ext>
              </a:extLst>
            </p:cNvPr>
            <p:cNvSpPr/>
            <p:nvPr/>
          </p:nvSpPr>
          <p:spPr>
            <a:xfrm rot="5400000">
              <a:off x="8983024" y="5530812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AA4FFA7E-53E2-4217-B9E4-9A1AFE0A1386}"/>
              </a:ext>
            </a:extLst>
          </p:cNvPr>
          <p:cNvGrpSpPr/>
          <p:nvPr/>
        </p:nvGrpSpPr>
        <p:grpSpPr>
          <a:xfrm>
            <a:off x="2541362" y="4456899"/>
            <a:ext cx="269483" cy="1186015"/>
            <a:chOff x="9087721" y="6320363"/>
            <a:chExt cx="269483" cy="1186015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8FAFA1F-F210-4E8F-9A2F-FFF199801385}"/>
                </a:ext>
              </a:extLst>
            </p:cNvPr>
            <p:cNvSpPr txBox="1"/>
            <p:nvPr/>
          </p:nvSpPr>
          <p:spPr>
            <a:xfrm rot="5400000">
              <a:off x="8633391" y="6782566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ahau-5B.1</a:t>
              </a: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C93EF102-32A1-4677-8D28-1404ED2CC6E8}"/>
                </a:ext>
              </a:extLst>
            </p:cNvPr>
            <p:cNvSpPr/>
            <p:nvPr/>
          </p:nvSpPr>
          <p:spPr>
            <a:xfrm rot="5400000">
              <a:off x="9082804" y="6611267"/>
              <a:ext cx="63834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61" name="TextBox 60">
            <a:extLst>
              <a:ext uri="{FF2B5EF4-FFF2-40B4-BE49-F238E27FC236}">
                <a16:creationId xmlns:a16="http://schemas.microsoft.com/office/drawing/2014/main" id="{78917C3B-615A-42A2-BBF5-2C7F43667618}"/>
              </a:ext>
            </a:extLst>
          </p:cNvPr>
          <p:cNvSpPr txBox="1"/>
          <p:nvPr/>
        </p:nvSpPr>
        <p:spPr>
          <a:xfrm>
            <a:off x="1431023" y="5134893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CA602902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D567D478-6A65-4E10-B5BC-46AE85563E99}"/>
              </a:ext>
            </a:extLst>
          </p:cNvPr>
          <p:cNvCxnSpPr/>
          <p:nvPr/>
        </p:nvCxnSpPr>
        <p:spPr>
          <a:xfrm>
            <a:off x="1067136" y="5112247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E7CA681C-F0C4-4D59-946A-C6B8BAA12731}"/>
              </a:ext>
            </a:extLst>
          </p:cNvPr>
          <p:cNvCxnSpPr>
            <a:cxnSpLocks/>
          </p:cNvCxnSpPr>
          <p:nvPr/>
        </p:nvCxnSpPr>
        <p:spPr>
          <a:xfrm rot="-5640000" flipV="1">
            <a:off x="1393761" y="5126820"/>
            <a:ext cx="123844" cy="8897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4" name="Group 63">
            <a:extLst>
              <a:ext uri="{FF2B5EF4-FFF2-40B4-BE49-F238E27FC236}">
                <a16:creationId xmlns:a16="http://schemas.microsoft.com/office/drawing/2014/main" id="{4441DDCB-C43A-41B2-8696-495B63E0CB89}"/>
              </a:ext>
            </a:extLst>
          </p:cNvPr>
          <p:cNvGrpSpPr/>
          <p:nvPr/>
        </p:nvGrpSpPr>
        <p:grpSpPr>
          <a:xfrm>
            <a:off x="2611371" y="3592221"/>
            <a:ext cx="270410" cy="1003300"/>
            <a:chOff x="8031292" y="424420"/>
            <a:chExt cx="270410" cy="1003300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72BB3D93-7815-4E64-9B3D-66AB0AA92706}"/>
                </a:ext>
              </a:extLst>
            </p:cNvPr>
            <p:cNvSpPr txBox="1"/>
            <p:nvPr/>
          </p:nvSpPr>
          <p:spPr>
            <a:xfrm rot="5400000">
              <a:off x="7669247" y="795265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ADF89349-D028-471D-8DCD-5C362E1CACC2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67" name="Group 66">
            <a:extLst>
              <a:ext uri="{FF2B5EF4-FFF2-40B4-BE49-F238E27FC236}">
                <a16:creationId xmlns:a16="http://schemas.microsoft.com/office/drawing/2014/main" id="{4284389E-E22A-402D-8883-D3D1AF26E090}"/>
              </a:ext>
            </a:extLst>
          </p:cNvPr>
          <p:cNvGrpSpPr/>
          <p:nvPr/>
        </p:nvGrpSpPr>
        <p:grpSpPr>
          <a:xfrm>
            <a:off x="3251293" y="663732"/>
            <a:ext cx="270410" cy="1003300"/>
            <a:chOff x="8031292" y="631142"/>
            <a:chExt cx="270410" cy="1003300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C0B9F84C-5C9A-476E-8FCC-069A3AA5FE43}"/>
                </a:ext>
              </a:extLst>
            </p:cNvPr>
            <p:cNvSpPr txBox="1"/>
            <p:nvPr/>
          </p:nvSpPr>
          <p:spPr>
            <a:xfrm rot="5400000">
              <a:off x="7669247" y="1001987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A4B2E67E-9D1E-4466-AE03-B88128E8D255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70" name="Group 69">
            <a:extLst>
              <a:ext uri="{FF2B5EF4-FFF2-40B4-BE49-F238E27FC236}">
                <a16:creationId xmlns:a16="http://schemas.microsoft.com/office/drawing/2014/main" id="{8EE2E270-D0EA-4F03-9FC2-8070B6887D87}"/>
              </a:ext>
            </a:extLst>
          </p:cNvPr>
          <p:cNvGrpSpPr/>
          <p:nvPr/>
        </p:nvGrpSpPr>
        <p:grpSpPr>
          <a:xfrm>
            <a:off x="2824162" y="3028010"/>
            <a:ext cx="270410" cy="1003300"/>
            <a:chOff x="8031292" y="389346"/>
            <a:chExt cx="270410" cy="1003300"/>
          </a:xfrm>
        </p:grpSpPr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1C034C51-B2DA-4936-87DE-9F2FB4DFF913}"/>
                </a:ext>
              </a:extLst>
            </p:cNvPr>
            <p:cNvSpPr txBox="1"/>
            <p:nvPr/>
          </p:nvSpPr>
          <p:spPr>
            <a:xfrm rot="5400000">
              <a:off x="7669247" y="760191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csiro</a:t>
              </a: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C8C08F28-87BF-4CB0-9971-A26C4DDFF051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73" name="Group 72">
            <a:extLst>
              <a:ext uri="{FF2B5EF4-FFF2-40B4-BE49-F238E27FC236}">
                <a16:creationId xmlns:a16="http://schemas.microsoft.com/office/drawing/2014/main" id="{6B5D2002-5586-45DE-81F7-0D7ED376EB49}"/>
              </a:ext>
            </a:extLst>
          </p:cNvPr>
          <p:cNvGrpSpPr/>
          <p:nvPr/>
        </p:nvGrpSpPr>
        <p:grpSpPr>
          <a:xfrm>
            <a:off x="2334729" y="3603835"/>
            <a:ext cx="270410" cy="1003300"/>
            <a:chOff x="8031292" y="494223"/>
            <a:chExt cx="270410" cy="1003300"/>
          </a:xfrm>
        </p:grpSpPr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C77D6010-20E6-4A15-BE61-2BA948040456}"/>
                </a:ext>
              </a:extLst>
            </p:cNvPr>
            <p:cNvSpPr txBox="1"/>
            <p:nvPr/>
          </p:nvSpPr>
          <p:spPr>
            <a:xfrm rot="5400000">
              <a:off x="7669247" y="86506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SL.csiro</a:t>
              </a:r>
            </a:p>
          </p:txBody>
        </p:sp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44727C46-64A1-4F56-88FE-51E5F5CE18C8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76" name="Group 75">
            <a:extLst>
              <a:ext uri="{FF2B5EF4-FFF2-40B4-BE49-F238E27FC236}">
                <a16:creationId xmlns:a16="http://schemas.microsoft.com/office/drawing/2014/main" id="{3D4B74D6-F433-4475-BABA-3CD0D44B6942}"/>
              </a:ext>
            </a:extLst>
          </p:cNvPr>
          <p:cNvGrpSpPr/>
          <p:nvPr/>
        </p:nvGrpSpPr>
        <p:grpSpPr>
          <a:xfrm>
            <a:off x="2578853" y="2987291"/>
            <a:ext cx="270410" cy="1003300"/>
            <a:chOff x="8031292" y="546278"/>
            <a:chExt cx="270410" cy="1003300"/>
          </a:xfrm>
        </p:grpSpPr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375B1505-39A2-4828-8C62-79C294334AB2}"/>
                </a:ext>
              </a:extLst>
            </p:cNvPr>
            <p:cNvSpPr txBox="1"/>
            <p:nvPr/>
          </p:nvSpPr>
          <p:spPr>
            <a:xfrm rot="5400000">
              <a:off x="7669247" y="917123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SL.csiro</a:t>
              </a: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37A92A18-44FA-4B80-A2C2-AEB435B8CEC7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79" name="Group 78">
            <a:extLst>
              <a:ext uri="{FF2B5EF4-FFF2-40B4-BE49-F238E27FC236}">
                <a16:creationId xmlns:a16="http://schemas.microsoft.com/office/drawing/2014/main" id="{1331F6D5-CDA9-47A0-ACB8-34E3CC808093}"/>
              </a:ext>
            </a:extLst>
          </p:cNvPr>
          <p:cNvGrpSpPr/>
          <p:nvPr/>
        </p:nvGrpSpPr>
        <p:grpSpPr>
          <a:xfrm>
            <a:off x="3118583" y="3094260"/>
            <a:ext cx="270410" cy="1003300"/>
            <a:chOff x="8031292" y="409423"/>
            <a:chExt cx="270410" cy="1003300"/>
          </a:xfrm>
        </p:grpSpPr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FF4107F0-C240-40FC-9F02-454E7458EE48}"/>
                </a:ext>
              </a:extLst>
            </p:cNvPr>
            <p:cNvSpPr txBox="1"/>
            <p:nvPr/>
          </p:nvSpPr>
          <p:spPr>
            <a:xfrm rot="5400000">
              <a:off x="7669247" y="78026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SL.csiro</a:t>
              </a:r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8A14850B-0809-49E3-89FE-CD201A6F7D48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82" name="Group 81">
            <a:extLst>
              <a:ext uri="{FF2B5EF4-FFF2-40B4-BE49-F238E27FC236}">
                <a16:creationId xmlns:a16="http://schemas.microsoft.com/office/drawing/2014/main" id="{701F4592-1595-49A4-9A17-CE4F2AB9D12D}"/>
              </a:ext>
            </a:extLst>
          </p:cNvPr>
          <p:cNvGrpSpPr/>
          <p:nvPr/>
        </p:nvGrpSpPr>
        <p:grpSpPr>
          <a:xfrm>
            <a:off x="2731803" y="497596"/>
            <a:ext cx="270410" cy="1003300"/>
            <a:chOff x="8031292" y="628574"/>
            <a:chExt cx="270410" cy="1003300"/>
          </a:xfrm>
        </p:grpSpPr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17F0279C-258B-4A9A-B929-8944E1F4B39B}"/>
                </a:ext>
              </a:extLst>
            </p:cNvPr>
            <p:cNvSpPr txBox="1"/>
            <p:nvPr/>
          </p:nvSpPr>
          <p:spPr>
            <a:xfrm rot="5400000">
              <a:off x="7669247" y="999419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SL.csiro</a:t>
              </a:r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B61493B0-E7A1-486B-A38F-AAB7E9C65B14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85" name="Group 84">
            <a:extLst>
              <a:ext uri="{FF2B5EF4-FFF2-40B4-BE49-F238E27FC236}">
                <a16:creationId xmlns:a16="http://schemas.microsoft.com/office/drawing/2014/main" id="{265CE1FB-7E94-4495-ADB0-621EE58DB960}"/>
              </a:ext>
            </a:extLst>
          </p:cNvPr>
          <p:cNvGrpSpPr/>
          <p:nvPr/>
        </p:nvGrpSpPr>
        <p:grpSpPr>
          <a:xfrm>
            <a:off x="2202607" y="495574"/>
            <a:ext cx="270410" cy="1003300"/>
            <a:chOff x="8031292" y="678908"/>
            <a:chExt cx="270410" cy="1003300"/>
          </a:xfrm>
        </p:grpSpPr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CB827C4A-9E2A-4199-A11C-8DD0A9413576}"/>
                </a:ext>
              </a:extLst>
            </p:cNvPr>
            <p:cNvSpPr txBox="1"/>
            <p:nvPr/>
          </p:nvSpPr>
          <p:spPr>
            <a:xfrm rot="5400000">
              <a:off x="7669247" y="1049753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W.csiro</a:t>
              </a: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79919508-D9D4-445C-8428-BC6A6B14C3AC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88" name="Group 87">
            <a:extLst>
              <a:ext uri="{FF2B5EF4-FFF2-40B4-BE49-F238E27FC236}">
                <a16:creationId xmlns:a16="http://schemas.microsoft.com/office/drawing/2014/main" id="{DCDDD810-92E7-4824-8154-F0597BA4498B}"/>
              </a:ext>
            </a:extLst>
          </p:cNvPr>
          <p:cNvGrpSpPr/>
          <p:nvPr/>
        </p:nvGrpSpPr>
        <p:grpSpPr>
          <a:xfrm>
            <a:off x="2053580" y="3532736"/>
            <a:ext cx="270410" cy="1003300"/>
            <a:chOff x="8031292" y="419159"/>
            <a:chExt cx="270410" cy="1003300"/>
          </a:xfrm>
        </p:grpSpPr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E1403711-0280-4E89-8374-1AECEB93590A}"/>
                </a:ext>
              </a:extLst>
            </p:cNvPr>
            <p:cNvSpPr txBox="1"/>
            <p:nvPr/>
          </p:nvSpPr>
          <p:spPr>
            <a:xfrm rot="5400000">
              <a:off x="7669247" y="790004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W.csiro</a:t>
              </a:r>
            </a:p>
          </p:txBody>
        </p: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07A41147-CF82-4D67-A326-4B9DBFD11D34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91" name="Group 90">
            <a:extLst>
              <a:ext uri="{FF2B5EF4-FFF2-40B4-BE49-F238E27FC236}">
                <a16:creationId xmlns:a16="http://schemas.microsoft.com/office/drawing/2014/main" id="{B3614E75-F7F0-47AF-B960-B3FD143E453A}"/>
              </a:ext>
            </a:extLst>
          </p:cNvPr>
          <p:cNvGrpSpPr/>
          <p:nvPr/>
        </p:nvGrpSpPr>
        <p:grpSpPr>
          <a:xfrm>
            <a:off x="2051971" y="5387351"/>
            <a:ext cx="280116" cy="1186015"/>
            <a:chOff x="8992024" y="5417210"/>
            <a:chExt cx="280116" cy="1186015"/>
          </a:xfrm>
        </p:grpSpPr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EEC35278-5FD1-4EBA-959C-73F305E2D6A0}"/>
                </a:ext>
              </a:extLst>
            </p:cNvPr>
            <p:cNvSpPr txBox="1"/>
            <p:nvPr/>
          </p:nvSpPr>
          <p:spPr>
            <a:xfrm rot="5400000">
              <a:off x="8548327" y="5879413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ahau-5B.4</a:t>
              </a:r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31D42A94-9C69-4EB5-9355-CC46878ECC61}"/>
                </a:ext>
              </a:extLst>
            </p:cNvPr>
            <p:cNvSpPr/>
            <p:nvPr/>
          </p:nvSpPr>
          <p:spPr>
            <a:xfrm rot="5400000">
              <a:off x="8983024" y="5530812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94" name="Group 93">
            <a:extLst>
              <a:ext uri="{FF2B5EF4-FFF2-40B4-BE49-F238E27FC236}">
                <a16:creationId xmlns:a16="http://schemas.microsoft.com/office/drawing/2014/main" id="{016A6C3A-3923-408C-B2A9-14866E347C37}"/>
              </a:ext>
            </a:extLst>
          </p:cNvPr>
          <p:cNvGrpSpPr/>
          <p:nvPr/>
        </p:nvGrpSpPr>
        <p:grpSpPr>
          <a:xfrm>
            <a:off x="3511037" y="811876"/>
            <a:ext cx="274744" cy="1003300"/>
            <a:chOff x="993068" y="2546583"/>
            <a:chExt cx="274744" cy="1003300"/>
          </a:xfrm>
        </p:grpSpPr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BE090548-AE63-49B0-81F2-55827A730D18}"/>
                </a:ext>
              </a:extLst>
            </p:cNvPr>
            <p:cNvSpPr txBox="1"/>
            <p:nvPr/>
          </p:nvSpPr>
          <p:spPr>
            <a:xfrm rot="5400000">
              <a:off x="635357" y="291742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A66C6DFA-FB46-4F2E-B938-1DAAB2BEE0B8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701A1B58-C5BF-42DC-8D3D-9AB6A6169EA8}"/>
              </a:ext>
            </a:extLst>
          </p:cNvPr>
          <p:cNvGrpSpPr/>
          <p:nvPr/>
        </p:nvGrpSpPr>
        <p:grpSpPr>
          <a:xfrm>
            <a:off x="3533784" y="4220790"/>
            <a:ext cx="274744" cy="1003300"/>
            <a:chOff x="993068" y="2546583"/>
            <a:chExt cx="274744" cy="1003300"/>
          </a:xfrm>
        </p:grpSpPr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7AF5B8B0-9131-4AF2-9A72-C6AF228FBE6D}"/>
                </a:ext>
              </a:extLst>
            </p:cNvPr>
            <p:cNvSpPr txBox="1"/>
            <p:nvPr/>
          </p:nvSpPr>
          <p:spPr>
            <a:xfrm rot="5400000">
              <a:off x="635357" y="291742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5DEA0A76-0D97-4CA2-ADFA-91782EBC7C98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ABFAF9CA-F6CE-4B48-AAE9-E44A6DA9B0A8}"/>
              </a:ext>
            </a:extLst>
          </p:cNvPr>
          <p:cNvGrpSpPr/>
          <p:nvPr/>
        </p:nvGrpSpPr>
        <p:grpSpPr>
          <a:xfrm>
            <a:off x="2909712" y="3737623"/>
            <a:ext cx="277604" cy="1186015"/>
            <a:chOff x="8994536" y="5231833"/>
            <a:chExt cx="277604" cy="1186015"/>
          </a:xfrm>
        </p:grpSpPr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C3BC8AD0-0243-4436-9334-1A6A47F4E9DB}"/>
                </a:ext>
              </a:extLst>
            </p:cNvPr>
            <p:cNvSpPr txBox="1"/>
            <p:nvPr/>
          </p:nvSpPr>
          <p:spPr>
            <a:xfrm rot="5400000">
              <a:off x="8548327" y="5694036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fcgr.cas-5B</a:t>
              </a:r>
            </a:p>
          </p:txBody>
        </p:sp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id="{B00F450A-9228-4BC9-B4F8-1DF9AC3F88A9}"/>
                </a:ext>
              </a:extLst>
            </p:cNvPr>
            <p:cNvSpPr/>
            <p:nvPr/>
          </p:nvSpPr>
          <p:spPr>
            <a:xfrm rot="5400000">
              <a:off x="8994536" y="5604206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03" name="Group 102">
            <a:extLst>
              <a:ext uri="{FF2B5EF4-FFF2-40B4-BE49-F238E27FC236}">
                <a16:creationId xmlns:a16="http://schemas.microsoft.com/office/drawing/2014/main" id="{FDED9064-349C-4243-AD4F-20F3524D1240}"/>
              </a:ext>
            </a:extLst>
          </p:cNvPr>
          <p:cNvGrpSpPr/>
          <p:nvPr/>
        </p:nvGrpSpPr>
        <p:grpSpPr>
          <a:xfrm>
            <a:off x="1942862" y="497870"/>
            <a:ext cx="270410" cy="1003300"/>
            <a:chOff x="8031292" y="777584"/>
            <a:chExt cx="270410" cy="1003300"/>
          </a:xfrm>
        </p:grpSpPr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C9C9358E-F217-4D73-854D-5EAEE924DDB2}"/>
                </a:ext>
              </a:extLst>
            </p:cNvPr>
            <p:cNvSpPr txBox="1"/>
            <p:nvPr/>
          </p:nvSpPr>
          <p:spPr>
            <a:xfrm rot="5400000">
              <a:off x="7669247" y="1148429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.Lng.ipk.5B.1</a:t>
              </a:r>
            </a:p>
          </p:txBody>
        </p: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id="{46F19107-5035-4438-8475-6B4309FC4BD6}"/>
                </a:ext>
              </a:extLst>
            </p:cNvPr>
            <p:cNvSpPr/>
            <p:nvPr/>
          </p:nvSpPr>
          <p:spPr>
            <a:xfrm rot="5400000">
              <a:off x="8031292" y="978911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B8BAF566-66DB-4F20-9ED2-3356FE537F7C}"/>
              </a:ext>
            </a:extLst>
          </p:cNvPr>
          <p:cNvGrpSpPr/>
          <p:nvPr/>
        </p:nvGrpSpPr>
        <p:grpSpPr>
          <a:xfrm>
            <a:off x="2021280" y="2204854"/>
            <a:ext cx="278799" cy="1003300"/>
            <a:chOff x="8031292" y="517525"/>
            <a:chExt cx="278799" cy="1003300"/>
          </a:xfrm>
        </p:grpSpPr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DF82A2F0-F2BA-4EF7-8222-CF19D99224EF}"/>
                </a:ext>
              </a:extLst>
            </p:cNvPr>
            <p:cNvSpPr txBox="1"/>
            <p:nvPr/>
          </p:nvSpPr>
          <p:spPr>
            <a:xfrm rot="5400000">
              <a:off x="7677636" y="888370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.Lng.ipk.5B.2</a:t>
              </a:r>
            </a:p>
          </p:txBody>
        </p: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28A8C152-C009-4B03-A22A-54A120EEAA12}"/>
                </a:ext>
              </a:extLst>
            </p:cNvPr>
            <p:cNvSpPr/>
            <p:nvPr/>
          </p:nvSpPr>
          <p:spPr>
            <a:xfrm rot="5400000">
              <a:off x="8031292" y="978911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6205A1B7-D4E2-4651-9977-06D7831F76B4}"/>
              </a:ext>
            </a:extLst>
          </p:cNvPr>
          <p:cNvGrpSpPr/>
          <p:nvPr/>
        </p:nvGrpSpPr>
        <p:grpSpPr>
          <a:xfrm>
            <a:off x="2617358" y="5478709"/>
            <a:ext cx="270410" cy="1003300"/>
            <a:chOff x="8031292" y="777584"/>
            <a:chExt cx="270410" cy="1003300"/>
          </a:xfrm>
        </p:grpSpPr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D8652601-3214-4246-A6D0-81416587CF3C}"/>
                </a:ext>
              </a:extLst>
            </p:cNvPr>
            <p:cNvSpPr txBox="1"/>
            <p:nvPr/>
          </p:nvSpPr>
          <p:spPr>
            <a:xfrm rot="5400000">
              <a:off x="7669247" y="1148429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.Lng.ipk.5B.3</a:t>
              </a:r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F7E7D8AC-DEA8-4CBB-9D93-8184024667B1}"/>
                </a:ext>
              </a:extLst>
            </p:cNvPr>
            <p:cNvSpPr/>
            <p:nvPr/>
          </p:nvSpPr>
          <p:spPr>
            <a:xfrm rot="5400000">
              <a:off x="8031292" y="978911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21" name="Group 120">
            <a:extLst>
              <a:ext uri="{FF2B5EF4-FFF2-40B4-BE49-F238E27FC236}">
                <a16:creationId xmlns:a16="http://schemas.microsoft.com/office/drawing/2014/main" id="{FF39718D-CED4-4E71-B79E-EEA853AD4926}"/>
              </a:ext>
            </a:extLst>
          </p:cNvPr>
          <p:cNvGrpSpPr/>
          <p:nvPr/>
        </p:nvGrpSpPr>
        <p:grpSpPr>
          <a:xfrm>
            <a:off x="2330229" y="1675270"/>
            <a:ext cx="274743" cy="2025421"/>
            <a:chOff x="993068" y="1472469"/>
            <a:chExt cx="274743" cy="2025421"/>
          </a:xfrm>
        </p:grpSpPr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D4C6914F-E2FC-43E4-841C-36C05B21E1D1}"/>
                </a:ext>
              </a:extLst>
            </p:cNvPr>
            <p:cNvSpPr txBox="1"/>
            <p:nvPr/>
          </p:nvSpPr>
          <p:spPr>
            <a:xfrm rot="5400000">
              <a:off x="124295" y="2354375"/>
              <a:ext cx="20254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TL11.PHS. Albrecht et al. 2015</a:t>
              </a:r>
            </a:p>
          </p:txBody>
        </p:sp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id="{F21D93CC-AAF5-4D00-84FE-2B666B3D2E8A}"/>
                </a:ext>
              </a:extLst>
            </p:cNvPr>
            <p:cNvSpPr/>
            <p:nvPr/>
          </p:nvSpPr>
          <p:spPr>
            <a:xfrm rot="5400000">
              <a:off x="984068" y="2883528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24" name="Group 123">
            <a:extLst>
              <a:ext uri="{FF2B5EF4-FFF2-40B4-BE49-F238E27FC236}">
                <a16:creationId xmlns:a16="http://schemas.microsoft.com/office/drawing/2014/main" id="{758A612C-0447-432C-9665-38DE58D4B6A7}"/>
              </a:ext>
            </a:extLst>
          </p:cNvPr>
          <p:cNvGrpSpPr/>
          <p:nvPr/>
        </p:nvGrpSpPr>
        <p:grpSpPr>
          <a:xfrm>
            <a:off x="3844771" y="3800653"/>
            <a:ext cx="274743" cy="2025421"/>
            <a:chOff x="993068" y="2232059"/>
            <a:chExt cx="274743" cy="2025421"/>
          </a:xfrm>
        </p:grpSpPr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41C4D013-6718-4358-B3C6-36A6B694AF4F}"/>
                </a:ext>
              </a:extLst>
            </p:cNvPr>
            <p:cNvSpPr txBox="1"/>
            <p:nvPr/>
          </p:nvSpPr>
          <p:spPr>
            <a:xfrm rot="5400000">
              <a:off x="124295" y="3113965"/>
              <a:ext cx="20254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TL12.PHS. Albrecht et al. 2015</a:t>
              </a:r>
            </a:p>
          </p:txBody>
        </p:sp>
        <p:sp>
          <p:nvSpPr>
            <p:cNvPr id="126" name="Rectangle 125">
              <a:extLst>
                <a:ext uri="{FF2B5EF4-FFF2-40B4-BE49-F238E27FC236}">
                  <a16:creationId xmlns:a16="http://schemas.microsoft.com/office/drawing/2014/main" id="{DDCA209D-16F2-4C82-8F87-C189247EE5A7}"/>
                </a:ext>
              </a:extLst>
            </p:cNvPr>
            <p:cNvSpPr/>
            <p:nvPr/>
          </p:nvSpPr>
          <p:spPr>
            <a:xfrm rot="5400000">
              <a:off x="984068" y="2883528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27" name="Group 126">
            <a:extLst>
              <a:ext uri="{FF2B5EF4-FFF2-40B4-BE49-F238E27FC236}">
                <a16:creationId xmlns:a16="http://schemas.microsoft.com/office/drawing/2014/main" id="{1C604557-C117-4F34-80CB-ADBB53DA64D7}"/>
              </a:ext>
            </a:extLst>
          </p:cNvPr>
          <p:cNvGrpSpPr/>
          <p:nvPr/>
        </p:nvGrpSpPr>
        <p:grpSpPr>
          <a:xfrm>
            <a:off x="3641723" y="4880146"/>
            <a:ext cx="274743" cy="2025421"/>
            <a:chOff x="993068" y="2454302"/>
            <a:chExt cx="274743" cy="2025421"/>
          </a:xfrm>
        </p:grpSpPr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5A1C6EC2-D7C6-4F74-A5BD-2298385E2D98}"/>
                </a:ext>
              </a:extLst>
            </p:cNvPr>
            <p:cNvSpPr txBox="1"/>
            <p:nvPr/>
          </p:nvSpPr>
          <p:spPr>
            <a:xfrm rot="5400000">
              <a:off x="124295" y="3336208"/>
              <a:ext cx="20254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TL13.PHS. Albrecht et al. 2015</a:t>
              </a:r>
            </a:p>
          </p:txBody>
        </p:sp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id="{11CB9666-49B0-49F4-BD14-CB4EAFB39453}"/>
                </a:ext>
              </a:extLst>
            </p:cNvPr>
            <p:cNvSpPr/>
            <p:nvPr/>
          </p:nvSpPr>
          <p:spPr>
            <a:xfrm rot="5400000">
              <a:off x="822068" y="3045528"/>
              <a:ext cx="396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FF03E501-4621-4CFB-86B5-51B02CDD9219}"/>
              </a:ext>
            </a:extLst>
          </p:cNvPr>
          <p:cNvCxnSpPr/>
          <p:nvPr/>
        </p:nvCxnSpPr>
        <p:spPr>
          <a:xfrm>
            <a:off x="480325" y="5852572"/>
            <a:ext cx="0" cy="72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FEBC8242-40E1-44F2-9027-7B1A13B924B2}"/>
              </a:ext>
            </a:extLst>
          </p:cNvPr>
          <p:cNvSpPr txBox="1"/>
          <p:nvPr/>
        </p:nvSpPr>
        <p:spPr>
          <a:xfrm>
            <a:off x="489930" y="6062651"/>
            <a:ext cx="1178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/>
              <a:t>100 Mb</a:t>
            </a:r>
          </a:p>
        </p:txBody>
      </p:sp>
      <p:grpSp>
        <p:nvGrpSpPr>
          <p:cNvPr id="132" name="Group 131">
            <a:extLst>
              <a:ext uri="{FF2B5EF4-FFF2-40B4-BE49-F238E27FC236}">
                <a16:creationId xmlns:a16="http://schemas.microsoft.com/office/drawing/2014/main" id="{51BC617C-55DA-432D-B390-2AD35729615E}"/>
              </a:ext>
            </a:extLst>
          </p:cNvPr>
          <p:cNvGrpSpPr/>
          <p:nvPr/>
        </p:nvGrpSpPr>
        <p:grpSpPr>
          <a:xfrm>
            <a:off x="7293475" y="4219358"/>
            <a:ext cx="280116" cy="1186015"/>
            <a:chOff x="8992024" y="5125116"/>
            <a:chExt cx="280116" cy="1186015"/>
          </a:xfrm>
        </p:grpSpPr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54F53C63-2F34-4439-B6EF-0D7E095CC28E}"/>
                </a:ext>
              </a:extLst>
            </p:cNvPr>
            <p:cNvSpPr txBox="1"/>
            <p:nvPr/>
          </p:nvSpPr>
          <p:spPr>
            <a:xfrm rot="5400000">
              <a:off x="8548327" y="5587319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FN.wsu-5D</a:t>
              </a:r>
            </a:p>
          </p:txBody>
        </p: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1859E4A5-EAE4-4067-9206-704D189E110F}"/>
                </a:ext>
              </a:extLst>
            </p:cNvPr>
            <p:cNvSpPr/>
            <p:nvPr/>
          </p:nvSpPr>
          <p:spPr>
            <a:xfrm rot="5400000">
              <a:off x="8983024" y="5530812"/>
              <a:ext cx="72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8A8EF19E-E2B6-4987-AAD0-5BA26FC7B334}"/>
              </a:ext>
            </a:extLst>
          </p:cNvPr>
          <p:cNvGrpSpPr/>
          <p:nvPr/>
        </p:nvGrpSpPr>
        <p:grpSpPr>
          <a:xfrm>
            <a:off x="2462352" y="493606"/>
            <a:ext cx="280116" cy="1186015"/>
            <a:chOff x="8992024" y="5213783"/>
            <a:chExt cx="280116" cy="1186015"/>
          </a:xfrm>
        </p:grpSpPr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898EF7FD-BAA0-4EE2-9972-9B2BFBD14439}"/>
                </a:ext>
              </a:extLst>
            </p:cNvPr>
            <p:cNvSpPr txBox="1"/>
            <p:nvPr/>
          </p:nvSpPr>
          <p:spPr>
            <a:xfrm rot="5400000">
              <a:off x="8548327" y="5675986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5B.1</a:t>
              </a:r>
            </a:p>
          </p:txBody>
        </p:sp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10E6C09A-6391-4EFD-BDE1-8648587FC231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38" name="Group 137">
            <a:extLst>
              <a:ext uri="{FF2B5EF4-FFF2-40B4-BE49-F238E27FC236}">
                <a16:creationId xmlns:a16="http://schemas.microsoft.com/office/drawing/2014/main" id="{01E0C2EF-531B-4762-80A3-C13B03BFE78A}"/>
              </a:ext>
            </a:extLst>
          </p:cNvPr>
          <p:cNvGrpSpPr/>
          <p:nvPr/>
        </p:nvGrpSpPr>
        <p:grpSpPr>
          <a:xfrm>
            <a:off x="3090538" y="4921578"/>
            <a:ext cx="280116" cy="1186015"/>
            <a:chOff x="8992024" y="5255728"/>
            <a:chExt cx="280116" cy="1186015"/>
          </a:xfrm>
        </p:grpSpPr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6A39D36F-18D5-47B6-B8DB-EA25E0906503}"/>
                </a:ext>
              </a:extLst>
            </p:cNvPr>
            <p:cNvSpPr txBox="1"/>
            <p:nvPr/>
          </p:nvSpPr>
          <p:spPr>
            <a:xfrm rot="5400000">
              <a:off x="8548327" y="5717931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wsu-5B.3</a:t>
              </a:r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6CCF7986-51CC-4542-A1D5-F591470C5097}"/>
                </a:ext>
              </a:extLst>
            </p:cNvPr>
            <p:cNvSpPr/>
            <p:nvPr/>
          </p:nvSpPr>
          <p:spPr>
            <a:xfrm rot="5400000">
              <a:off x="8992024" y="552181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41" name="Group 140">
            <a:extLst>
              <a:ext uri="{FF2B5EF4-FFF2-40B4-BE49-F238E27FC236}">
                <a16:creationId xmlns:a16="http://schemas.microsoft.com/office/drawing/2014/main" id="{58278682-7B88-4968-9AEE-B74D8EA90440}"/>
              </a:ext>
            </a:extLst>
          </p:cNvPr>
          <p:cNvGrpSpPr/>
          <p:nvPr/>
        </p:nvGrpSpPr>
        <p:grpSpPr>
          <a:xfrm>
            <a:off x="2991548" y="657149"/>
            <a:ext cx="270410" cy="1003300"/>
            <a:chOff x="8031292" y="631142"/>
            <a:chExt cx="270410" cy="1003300"/>
          </a:xfrm>
        </p:grpSpPr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163530E0-17A5-4D3C-A59B-27E83B65BF54}"/>
                </a:ext>
              </a:extLst>
            </p:cNvPr>
            <p:cNvSpPr txBox="1"/>
            <p:nvPr/>
          </p:nvSpPr>
          <p:spPr>
            <a:xfrm rot="5400000">
              <a:off x="7669247" y="1001987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 err="1">
                  <a:solidFill>
                    <a:schemeClr val="bg1">
                      <a:lumMod val="50000"/>
                    </a:schemeClr>
                  </a:solidFill>
                </a:rPr>
                <a:t>QSL.csiro</a:t>
              </a:r>
              <a:endParaRPr lang="en-AU" sz="11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31E77820-857A-4F9E-8DE5-D64446FF3753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44" name="Group 143">
            <a:extLst>
              <a:ext uri="{FF2B5EF4-FFF2-40B4-BE49-F238E27FC236}">
                <a16:creationId xmlns:a16="http://schemas.microsoft.com/office/drawing/2014/main" id="{B378C9A1-D685-42D8-B368-BCCDDB141192}"/>
              </a:ext>
            </a:extLst>
          </p:cNvPr>
          <p:cNvGrpSpPr/>
          <p:nvPr/>
        </p:nvGrpSpPr>
        <p:grpSpPr>
          <a:xfrm>
            <a:off x="2337454" y="5438162"/>
            <a:ext cx="270410" cy="1003300"/>
            <a:chOff x="8031292" y="777584"/>
            <a:chExt cx="270410" cy="1003300"/>
          </a:xfrm>
        </p:grpSpPr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D7CF4A29-5E7D-4C21-8457-6848EBACC7D1}"/>
                </a:ext>
              </a:extLst>
            </p:cNvPr>
            <p:cNvSpPr txBox="1"/>
            <p:nvPr/>
          </p:nvSpPr>
          <p:spPr>
            <a:xfrm rot="5400000">
              <a:off x="7669247" y="1148429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tars.5BL1</a:t>
              </a:r>
            </a:p>
          </p:txBody>
        </p:sp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id="{D24FF799-6485-4BC0-98DA-D91E6ACFF159}"/>
                </a:ext>
              </a:extLst>
            </p:cNvPr>
            <p:cNvSpPr/>
            <p:nvPr/>
          </p:nvSpPr>
          <p:spPr>
            <a:xfrm rot="5400000">
              <a:off x="8031292" y="978911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2CFD1560-6508-4675-8859-96DB7DB9D622}"/>
              </a:ext>
            </a:extLst>
          </p:cNvPr>
          <p:cNvCxnSpPr/>
          <p:nvPr/>
        </p:nvCxnSpPr>
        <p:spPr>
          <a:xfrm>
            <a:off x="1067136" y="3448561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TextBox 149">
            <a:extLst>
              <a:ext uri="{FF2B5EF4-FFF2-40B4-BE49-F238E27FC236}">
                <a16:creationId xmlns:a16="http://schemas.microsoft.com/office/drawing/2014/main" id="{2C7101DC-6127-4225-879C-3F9D3D01DD48}"/>
              </a:ext>
            </a:extLst>
          </p:cNvPr>
          <p:cNvSpPr txBox="1"/>
          <p:nvPr/>
        </p:nvSpPr>
        <p:spPr>
          <a:xfrm>
            <a:off x="1341871" y="3332712"/>
            <a:ext cx="781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AIP2B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89529432-F62D-4CC8-8F54-3E35732FBF82}"/>
              </a:ext>
            </a:extLst>
          </p:cNvPr>
          <p:cNvSpPr txBox="1"/>
          <p:nvPr/>
        </p:nvSpPr>
        <p:spPr>
          <a:xfrm>
            <a:off x="1345739" y="5267111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CHI</a:t>
            </a:r>
          </a:p>
        </p:txBody>
      </p: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6090AEE8-E3C5-4B65-8642-791C0EE9E5FA}"/>
              </a:ext>
            </a:extLst>
          </p:cNvPr>
          <p:cNvCxnSpPr/>
          <p:nvPr/>
        </p:nvCxnSpPr>
        <p:spPr>
          <a:xfrm>
            <a:off x="1067136" y="5391855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>
            <a:extLst>
              <a:ext uri="{FF2B5EF4-FFF2-40B4-BE49-F238E27FC236}">
                <a16:creationId xmlns:a16="http://schemas.microsoft.com/office/drawing/2014/main" id="{79A96092-B177-4D69-9695-459BF889DCCF}"/>
              </a:ext>
            </a:extLst>
          </p:cNvPr>
          <p:cNvSpPr txBox="1"/>
          <p:nvPr/>
        </p:nvSpPr>
        <p:spPr>
          <a:xfrm>
            <a:off x="5887247" y="3885296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IAA1</a:t>
            </a:r>
          </a:p>
        </p:txBody>
      </p: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id="{3BC20345-5738-4A88-A4DF-2DB1B14E43EE}"/>
              </a:ext>
            </a:extLst>
          </p:cNvPr>
          <p:cNvCxnSpPr/>
          <p:nvPr/>
        </p:nvCxnSpPr>
        <p:spPr>
          <a:xfrm>
            <a:off x="5527400" y="3979503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7A0F9B50-920E-4CA3-BEDC-D7322953F2EA}"/>
              </a:ext>
            </a:extLst>
          </p:cNvPr>
          <p:cNvSpPr txBox="1"/>
          <p:nvPr/>
        </p:nvSpPr>
        <p:spPr>
          <a:xfrm>
            <a:off x="5784467" y="1102878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IAA1</a:t>
            </a:r>
          </a:p>
        </p:txBody>
      </p: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id="{6BF6FF85-5236-4F39-B353-D378E66B42D4}"/>
              </a:ext>
            </a:extLst>
          </p:cNvPr>
          <p:cNvCxnSpPr/>
          <p:nvPr/>
        </p:nvCxnSpPr>
        <p:spPr>
          <a:xfrm>
            <a:off x="5527400" y="1239487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TextBox 164">
            <a:extLst>
              <a:ext uri="{FF2B5EF4-FFF2-40B4-BE49-F238E27FC236}">
                <a16:creationId xmlns:a16="http://schemas.microsoft.com/office/drawing/2014/main" id="{76706B24-5590-4D83-AA57-91E4629CCD67}"/>
              </a:ext>
            </a:extLst>
          </p:cNvPr>
          <p:cNvSpPr txBox="1"/>
          <p:nvPr/>
        </p:nvSpPr>
        <p:spPr>
          <a:xfrm>
            <a:off x="1324917" y="1003534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IAA1</a:t>
            </a:r>
          </a:p>
        </p:txBody>
      </p: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2042E0E9-E0D9-44FF-A941-22D4C0F80DF8}"/>
              </a:ext>
            </a:extLst>
          </p:cNvPr>
          <p:cNvCxnSpPr/>
          <p:nvPr/>
        </p:nvCxnSpPr>
        <p:spPr>
          <a:xfrm>
            <a:off x="1067136" y="1140143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xtBox 166">
            <a:extLst>
              <a:ext uri="{FF2B5EF4-FFF2-40B4-BE49-F238E27FC236}">
                <a16:creationId xmlns:a16="http://schemas.microsoft.com/office/drawing/2014/main" id="{B265F390-C8DD-4D5E-99A9-D48D9E3940CD}"/>
              </a:ext>
            </a:extLst>
          </p:cNvPr>
          <p:cNvSpPr txBox="1"/>
          <p:nvPr/>
        </p:nvSpPr>
        <p:spPr>
          <a:xfrm>
            <a:off x="5824270" y="2454926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CK212552</a:t>
            </a:r>
          </a:p>
        </p:txBody>
      </p: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E4BB0447-F19A-43AB-B3B8-19D223207352}"/>
              </a:ext>
            </a:extLst>
          </p:cNvPr>
          <p:cNvCxnSpPr/>
          <p:nvPr/>
        </p:nvCxnSpPr>
        <p:spPr>
          <a:xfrm>
            <a:off x="5527400" y="2583908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TextBox 170">
            <a:extLst>
              <a:ext uri="{FF2B5EF4-FFF2-40B4-BE49-F238E27FC236}">
                <a16:creationId xmlns:a16="http://schemas.microsoft.com/office/drawing/2014/main" id="{7C8EA285-0B38-493F-A2A1-72BFC0BE9047}"/>
              </a:ext>
            </a:extLst>
          </p:cNvPr>
          <p:cNvSpPr txBox="1"/>
          <p:nvPr/>
        </p:nvSpPr>
        <p:spPr>
          <a:xfrm>
            <a:off x="1358646" y="2507732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J296643</a:t>
            </a:r>
          </a:p>
        </p:txBody>
      </p:sp>
      <p:cxnSp>
        <p:nvCxnSpPr>
          <p:cNvPr id="172" name="Straight Connector 171">
            <a:extLst>
              <a:ext uri="{FF2B5EF4-FFF2-40B4-BE49-F238E27FC236}">
                <a16:creationId xmlns:a16="http://schemas.microsoft.com/office/drawing/2014/main" id="{5D2F0D9C-C666-4029-BB50-18C0FA85D5ED}"/>
              </a:ext>
            </a:extLst>
          </p:cNvPr>
          <p:cNvCxnSpPr/>
          <p:nvPr/>
        </p:nvCxnSpPr>
        <p:spPr>
          <a:xfrm>
            <a:off x="1067136" y="2636714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Straight Connector 173">
            <a:extLst>
              <a:ext uri="{FF2B5EF4-FFF2-40B4-BE49-F238E27FC236}">
                <a16:creationId xmlns:a16="http://schemas.microsoft.com/office/drawing/2014/main" id="{FAACA875-EC5F-417B-AF8C-51FBFE72DAB6}"/>
              </a:ext>
            </a:extLst>
          </p:cNvPr>
          <p:cNvCxnSpPr/>
          <p:nvPr/>
        </p:nvCxnSpPr>
        <p:spPr>
          <a:xfrm>
            <a:off x="1067136" y="4711038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TextBox 174">
            <a:extLst>
              <a:ext uri="{FF2B5EF4-FFF2-40B4-BE49-F238E27FC236}">
                <a16:creationId xmlns:a16="http://schemas.microsoft.com/office/drawing/2014/main" id="{7D32E132-58FF-4727-BC90-00E26B24E603}"/>
              </a:ext>
            </a:extLst>
          </p:cNvPr>
          <p:cNvSpPr txBox="1"/>
          <p:nvPr/>
        </p:nvSpPr>
        <p:spPr>
          <a:xfrm>
            <a:off x="1358646" y="2753360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J266589</a:t>
            </a:r>
          </a:p>
        </p:txBody>
      </p: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5BAB4AAB-C2DB-4322-B1ED-F195B3FA0BA4}"/>
              </a:ext>
            </a:extLst>
          </p:cNvPr>
          <p:cNvCxnSpPr/>
          <p:nvPr/>
        </p:nvCxnSpPr>
        <p:spPr>
          <a:xfrm>
            <a:off x="1067136" y="2882342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Connector 177">
            <a:extLst>
              <a:ext uri="{FF2B5EF4-FFF2-40B4-BE49-F238E27FC236}">
                <a16:creationId xmlns:a16="http://schemas.microsoft.com/office/drawing/2014/main" id="{29457D84-91B0-4920-93FE-57A62FBFADD9}"/>
              </a:ext>
            </a:extLst>
          </p:cNvPr>
          <p:cNvCxnSpPr/>
          <p:nvPr/>
        </p:nvCxnSpPr>
        <p:spPr>
          <a:xfrm>
            <a:off x="1067136" y="4846071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id="{944FBD8F-9A17-46AB-95F9-7A359EC10C1E}"/>
              </a:ext>
            </a:extLst>
          </p:cNvPr>
          <p:cNvSpPr txBox="1"/>
          <p:nvPr/>
        </p:nvSpPr>
        <p:spPr>
          <a:xfrm>
            <a:off x="1384827" y="4796897"/>
            <a:ext cx="6803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ST1</a:t>
            </a:r>
          </a:p>
        </p:txBody>
      </p: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E96B1688-D86B-4494-B83D-4EDD3D61B079}"/>
              </a:ext>
            </a:extLst>
          </p:cNvPr>
          <p:cNvCxnSpPr>
            <a:cxnSpLocks/>
          </p:cNvCxnSpPr>
          <p:nvPr/>
        </p:nvCxnSpPr>
        <p:spPr>
          <a:xfrm rot="5220000" flipH="1">
            <a:off x="1407906" y="4849100"/>
            <a:ext cx="64560" cy="649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TextBox 180">
            <a:extLst>
              <a:ext uri="{FF2B5EF4-FFF2-40B4-BE49-F238E27FC236}">
                <a16:creationId xmlns:a16="http://schemas.microsoft.com/office/drawing/2014/main" id="{76CC7302-8DA4-48AA-B50A-9F5FB6279FAD}"/>
              </a:ext>
            </a:extLst>
          </p:cNvPr>
          <p:cNvSpPr txBox="1"/>
          <p:nvPr/>
        </p:nvSpPr>
        <p:spPr>
          <a:xfrm>
            <a:off x="5782480" y="3782899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NCED2</a:t>
            </a:r>
          </a:p>
        </p:txBody>
      </p:sp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id="{1C19C221-EDEE-4B13-A5E7-E6A195BEC271}"/>
              </a:ext>
            </a:extLst>
          </p:cNvPr>
          <p:cNvCxnSpPr/>
          <p:nvPr/>
        </p:nvCxnSpPr>
        <p:spPr>
          <a:xfrm>
            <a:off x="5527400" y="3926654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>
            <a:extLst>
              <a:ext uri="{FF2B5EF4-FFF2-40B4-BE49-F238E27FC236}">
                <a16:creationId xmlns:a16="http://schemas.microsoft.com/office/drawing/2014/main" id="{62517308-7351-405E-A530-D3A8E82A15E6}"/>
              </a:ext>
            </a:extLst>
          </p:cNvPr>
          <p:cNvSpPr txBox="1"/>
          <p:nvPr/>
        </p:nvSpPr>
        <p:spPr>
          <a:xfrm>
            <a:off x="5780099" y="799067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NCED1</a:t>
            </a:r>
          </a:p>
        </p:txBody>
      </p:sp>
      <p:cxnSp>
        <p:nvCxnSpPr>
          <p:cNvPr id="184" name="Straight Connector 183">
            <a:extLst>
              <a:ext uri="{FF2B5EF4-FFF2-40B4-BE49-F238E27FC236}">
                <a16:creationId xmlns:a16="http://schemas.microsoft.com/office/drawing/2014/main" id="{1BD8A201-95A4-4F73-B125-8418D3E48F90}"/>
              </a:ext>
            </a:extLst>
          </p:cNvPr>
          <p:cNvCxnSpPr/>
          <p:nvPr/>
        </p:nvCxnSpPr>
        <p:spPr>
          <a:xfrm>
            <a:off x="5527400" y="935676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>
            <a:extLst>
              <a:ext uri="{FF2B5EF4-FFF2-40B4-BE49-F238E27FC236}">
                <a16:creationId xmlns:a16="http://schemas.microsoft.com/office/drawing/2014/main" id="{AB6D83D5-37A4-4309-B4A2-7C9FD17625F3}"/>
              </a:ext>
            </a:extLst>
          </p:cNvPr>
          <p:cNvCxnSpPr>
            <a:cxnSpLocks/>
          </p:cNvCxnSpPr>
          <p:nvPr/>
        </p:nvCxnSpPr>
        <p:spPr>
          <a:xfrm rot="-5640000" flipV="1">
            <a:off x="5853875" y="4010989"/>
            <a:ext cx="123844" cy="8897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Connector 186">
            <a:extLst>
              <a:ext uri="{FF2B5EF4-FFF2-40B4-BE49-F238E27FC236}">
                <a16:creationId xmlns:a16="http://schemas.microsoft.com/office/drawing/2014/main" id="{57A5C354-20C5-4F36-B7B2-19CF4FAF7E0D}"/>
              </a:ext>
            </a:extLst>
          </p:cNvPr>
          <p:cNvCxnSpPr>
            <a:cxnSpLocks/>
          </p:cNvCxnSpPr>
          <p:nvPr/>
        </p:nvCxnSpPr>
        <p:spPr>
          <a:xfrm flipH="1" flipV="1">
            <a:off x="5867101" y="3980139"/>
            <a:ext cx="108000" cy="237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TextBox 187">
            <a:extLst>
              <a:ext uri="{FF2B5EF4-FFF2-40B4-BE49-F238E27FC236}">
                <a16:creationId xmlns:a16="http://schemas.microsoft.com/office/drawing/2014/main" id="{5F05CEF8-E52A-491A-B30A-3E320C5D0FFE}"/>
              </a:ext>
            </a:extLst>
          </p:cNvPr>
          <p:cNvSpPr txBox="1"/>
          <p:nvPr/>
        </p:nvSpPr>
        <p:spPr>
          <a:xfrm>
            <a:off x="1336507" y="754252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NCED1</a:t>
            </a:r>
          </a:p>
        </p:txBody>
      </p: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568893EC-2067-470E-B7EC-7CAF272175B8}"/>
              </a:ext>
            </a:extLst>
          </p:cNvPr>
          <p:cNvCxnSpPr/>
          <p:nvPr/>
        </p:nvCxnSpPr>
        <p:spPr>
          <a:xfrm>
            <a:off x="1067136" y="890861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xtBox 189">
            <a:extLst>
              <a:ext uri="{FF2B5EF4-FFF2-40B4-BE49-F238E27FC236}">
                <a16:creationId xmlns:a16="http://schemas.microsoft.com/office/drawing/2014/main" id="{AB51BB36-F055-4F08-B3EE-F58856871B45}"/>
              </a:ext>
            </a:extLst>
          </p:cNvPr>
          <p:cNvSpPr txBox="1"/>
          <p:nvPr/>
        </p:nvSpPr>
        <p:spPr>
          <a:xfrm>
            <a:off x="1326488" y="3536724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CYP707A2</a:t>
            </a:r>
          </a:p>
        </p:txBody>
      </p: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926B3662-1152-47FD-85B9-ACDC2D78D7FD}"/>
              </a:ext>
            </a:extLst>
          </p:cNvPr>
          <p:cNvCxnSpPr/>
          <p:nvPr/>
        </p:nvCxnSpPr>
        <p:spPr>
          <a:xfrm>
            <a:off x="1067136" y="3673333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TextBox 193">
            <a:extLst>
              <a:ext uri="{FF2B5EF4-FFF2-40B4-BE49-F238E27FC236}">
                <a16:creationId xmlns:a16="http://schemas.microsoft.com/office/drawing/2014/main" id="{E134DC15-69BA-4C88-AEAE-CF755D6D22AB}"/>
              </a:ext>
            </a:extLst>
          </p:cNvPr>
          <p:cNvSpPr txBox="1"/>
          <p:nvPr/>
        </p:nvSpPr>
        <p:spPr>
          <a:xfrm>
            <a:off x="5794937" y="3046693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CYP707A2</a:t>
            </a:r>
          </a:p>
        </p:txBody>
      </p: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470093A5-146C-4EE8-9749-A2AC33E5DBEF}"/>
              </a:ext>
            </a:extLst>
          </p:cNvPr>
          <p:cNvCxnSpPr/>
          <p:nvPr/>
        </p:nvCxnSpPr>
        <p:spPr>
          <a:xfrm>
            <a:off x="5527400" y="3183302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TextBox 176">
            <a:extLst>
              <a:ext uri="{FF2B5EF4-FFF2-40B4-BE49-F238E27FC236}">
                <a16:creationId xmlns:a16="http://schemas.microsoft.com/office/drawing/2014/main" id="{5979674A-C5E3-40C2-A7D7-CCCF283BA60E}"/>
              </a:ext>
            </a:extLst>
          </p:cNvPr>
          <p:cNvSpPr txBox="1"/>
          <p:nvPr/>
        </p:nvSpPr>
        <p:spPr>
          <a:xfrm>
            <a:off x="5801331" y="4613039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0ox1D</a:t>
            </a:r>
          </a:p>
        </p:txBody>
      </p:sp>
      <p:cxnSp>
        <p:nvCxnSpPr>
          <p:cNvPr id="186" name="Straight Connector 185">
            <a:extLst>
              <a:ext uri="{FF2B5EF4-FFF2-40B4-BE49-F238E27FC236}">
                <a16:creationId xmlns:a16="http://schemas.microsoft.com/office/drawing/2014/main" id="{9233DD9E-185D-45C4-9F29-DEACCF6F9854}"/>
              </a:ext>
            </a:extLst>
          </p:cNvPr>
          <p:cNvCxnSpPr/>
          <p:nvPr/>
        </p:nvCxnSpPr>
        <p:spPr>
          <a:xfrm>
            <a:off x="5527400" y="4749648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TextBox 191">
            <a:extLst>
              <a:ext uri="{FF2B5EF4-FFF2-40B4-BE49-F238E27FC236}">
                <a16:creationId xmlns:a16="http://schemas.microsoft.com/office/drawing/2014/main" id="{F134E7E2-395C-44B6-A14D-015127CFE62F}"/>
              </a:ext>
            </a:extLst>
          </p:cNvPr>
          <p:cNvSpPr txBox="1"/>
          <p:nvPr/>
        </p:nvSpPr>
        <p:spPr>
          <a:xfrm>
            <a:off x="1322270" y="5614541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0ox1B</a:t>
            </a:r>
          </a:p>
        </p:txBody>
      </p:sp>
      <p:cxnSp>
        <p:nvCxnSpPr>
          <p:cNvPr id="193" name="Straight Connector 192">
            <a:extLst>
              <a:ext uri="{FF2B5EF4-FFF2-40B4-BE49-F238E27FC236}">
                <a16:creationId xmlns:a16="http://schemas.microsoft.com/office/drawing/2014/main" id="{4CB6580C-BD6C-4EC5-AD8D-B8A797B8E89D}"/>
              </a:ext>
            </a:extLst>
          </p:cNvPr>
          <p:cNvCxnSpPr/>
          <p:nvPr/>
        </p:nvCxnSpPr>
        <p:spPr>
          <a:xfrm>
            <a:off x="1067136" y="5751150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TextBox 197">
            <a:extLst>
              <a:ext uri="{FF2B5EF4-FFF2-40B4-BE49-F238E27FC236}">
                <a16:creationId xmlns:a16="http://schemas.microsoft.com/office/drawing/2014/main" id="{E7A86F05-FE9A-4936-98B5-BF7B79D6C166}"/>
              </a:ext>
            </a:extLst>
          </p:cNvPr>
          <p:cNvSpPr txBox="1"/>
          <p:nvPr/>
        </p:nvSpPr>
        <p:spPr>
          <a:xfrm>
            <a:off x="5782385" y="4299338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CHS</a:t>
            </a:r>
          </a:p>
        </p:txBody>
      </p: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3A21CDA3-CE3C-4D45-B944-7BB4247C931D}"/>
              </a:ext>
            </a:extLst>
          </p:cNvPr>
          <p:cNvCxnSpPr/>
          <p:nvPr/>
        </p:nvCxnSpPr>
        <p:spPr>
          <a:xfrm>
            <a:off x="5527400" y="4435947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237793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TextBox 62">
            <a:extLst>
              <a:ext uri="{FF2B5EF4-FFF2-40B4-BE49-F238E27FC236}">
                <a16:creationId xmlns:a16="http://schemas.microsoft.com/office/drawing/2014/main" id="{27045252-5240-4967-9D56-FA7478661AB8}"/>
              </a:ext>
            </a:extLst>
          </p:cNvPr>
          <p:cNvSpPr txBox="1"/>
          <p:nvPr/>
        </p:nvSpPr>
        <p:spPr>
          <a:xfrm>
            <a:off x="1323282" y="1205584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J207229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FF15C648-598D-4444-B4E0-0B75A790C1B8}"/>
              </a:ext>
            </a:extLst>
          </p:cNvPr>
          <p:cNvGrpSpPr/>
          <p:nvPr/>
        </p:nvGrpSpPr>
        <p:grpSpPr>
          <a:xfrm>
            <a:off x="9592327" y="5251410"/>
            <a:ext cx="1142347" cy="1550617"/>
            <a:chOff x="9592327" y="5251410"/>
            <a:chExt cx="1142347" cy="1550617"/>
          </a:xfrm>
        </p:grpSpPr>
        <p:sp>
          <p:nvSpPr>
            <p:cNvPr id="3" name="Oval 2">
              <a:extLst>
                <a:ext uri="{FF2B5EF4-FFF2-40B4-BE49-F238E27FC236}">
                  <a16:creationId xmlns:a16="http://schemas.microsoft.com/office/drawing/2014/main" id="{4078231D-AADA-46C9-9F97-BA2D1E2F1C08}"/>
                </a:ext>
              </a:extLst>
            </p:cNvPr>
            <p:cNvSpPr/>
            <p:nvPr/>
          </p:nvSpPr>
          <p:spPr>
            <a:xfrm>
              <a:off x="9601327" y="5359194"/>
              <a:ext cx="90000" cy="90000"/>
            </a:xfrm>
            <a:prstGeom prst="ellipse">
              <a:avLst/>
            </a:prstGeom>
            <a:solidFill>
              <a:srgbClr val="70474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4" name="Isosceles Triangle 3">
              <a:extLst>
                <a:ext uri="{FF2B5EF4-FFF2-40B4-BE49-F238E27FC236}">
                  <a16:creationId xmlns:a16="http://schemas.microsoft.com/office/drawing/2014/main" id="{C261B7A6-F07C-40D2-B849-A3F7A22CCF0D}"/>
                </a:ext>
              </a:extLst>
            </p:cNvPr>
            <p:cNvSpPr/>
            <p:nvPr/>
          </p:nvSpPr>
          <p:spPr>
            <a:xfrm>
              <a:off x="9592327" y="6436293"/>
              <a:ext cx="108000" cy="108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5" name="Diamond 4">
              <a:extLst>
                <a:ext uri="{FF2B5EF4-FFF2-40B4-BE49-F238E27FC236}">
                  <a16:creationId xmlns:a16="http://schemas.microsoft.com/office/drawing/2014/main" id="{11EBEA7B-1DE5-40E3-A5F5-5A15AAD031A5}"/>
                </a:ext>
              </a:extLst>
            </p:cNvPr>
            <p:cNvSpPr/>
            <p:nvPr/>
          </p:nvSpPr>
          <p:spPr>
            <a:xfrm>
              <a:off x="9592327" y="5534298"/>
              <a:ext cx="108000" cy="108000"/>
            </a:xfrm>
            <a:prstGeom prst="diamond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6" name="Pentagon 5">
              <a:extLst>
                <a:ext uri="{FF2B5EF4-FFF2-40B4-BE49-F238E27FC236}">
                  <a16:creationId xmlns:a16="http://schemas.microsoft.com/office/drawing/2014/main" id="{8AD046DB-B469-4E97-82F6-4F6442E519AE}"/>
                </a:ext>
              </a:extLst>
            </p:cNvPr>
            <p:cNvSpPr/>
            <p:nvPr/>
          </p:nvSpPr>
          <p:spPr>
            <a:xfrm>
              <a:off x="9592327" y="6619875"/>
              <a:ext cx="108000" cy="108000"/>
            </a:xfrm>
            <a:prstGeom prst="pentagon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7" name="Hexagon 6">
              <a:extLst>
                <a:ext uri="{FF2B5EF4-FFF2-40B4-BE49-F238E27FC236}">
                  <a16:creationId xmlns:a16="http://schemas.microsoft.com/office/drawing/2014/main" id="{85F0D2DA-9919-4BED-B103-6D9DA6C49F2E}"/>
                </a:ext>
              </a:extLst>
            </p:cNvPr>
            <p:cNvSpPr/>
            <p:nvPr/>
          </p:nvSpPr>
          <p:spPr>
            <a:xfrm>
              <a:off x="9592327" y="5717877"/>
              <a:ext cx="108000" cy="93600"/>
            </a:xfrm>
            <a:prstGeom prst="hexagon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387FBFEC-6194-438D-B6D2-784788F755F7}"/>
                </a:ext>
              </a:extLst>
            </p:cNvPr>
            <p:cNvSpPr/>
            <p:nvPr/>
          </p:nvSpPr>
          <p:spPr>
            <a:xfrm>
              <a:off x="9610327" y="6095610"/>
              <a:ext cx="72000" cy="72000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9" name="Trapezoid 8">
              <a:extLst>
                <a:ext uri="{FF2B5EF4-FFF2-40B4-BE49-F238E27FC236}">
                  <a16:creationId xmlns:a16="http://schemas.microsoft.com/office/drawing/2014/main" id="{E226B5BD-739A-43F4-AE05-223803A245BB}"/>
                </a:ext>
              </a:extLst>
            </p:cNvPr>
            <p:cNvSpPr/>
            <p:nvPr/>
          </p:nvSpPr>
          <p:spPr>
            <a:xfrm>
              <a:off x="9592327" y="6252714"/>
              <a:ext cx="108000" cy="108000"/>
            </a:xfrm>
            <a:prstGeom prst="trapezoid">
              <a:avLst/>
            </a:prstGeom>
            <a:solidFill>
              <a:srgbClr val="EF19C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B0DBAAB5-EA41-4339-AF71-F10B59FDDC1B}"/>
                </a:ext>
              </a:extLst>
            </p:cNvPr>
            <p:cNvSpPr/>
            <p:nvPr/>
          </p:nvSpPr>
          <p:spPr>
            <a:xfrm>
              <a:off x="9601327" y="5901456"/>
              <a:ext cx="90000" cy="90000"/>
            </a:xfrm>
            <a:prstGeom prst="ellipse">
              <a:avLst/>
            </a:prstGeom>
            <a:solidFill>
              <a:srgbClr val="FA630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8284812-2197-4944-BDC0-1BCD38CF75CC}"/>
                </a:ext>
              </a:extLst>
            </p:cNvPr>
            <p:cNvSpPr txBox="1"/>
            <p:nvPr/>
          </p:nvSpPr>
          <p:spPr>
            <a:xfrm>
              <a:off x="9696449" y="5251410"/>
              <a:ext cx="1038225" cy="1550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AU" sz="800" dirty="0"/>
                <a:t>April 2017 – 9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7 – 12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8 – 16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ne 2018 – 8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ly 2018 – 10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April 2019 – 24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May 2019 – 22 das</a:t>
              </a:r>
            </a:p>
            <a:p>
              <a:pPr>
                <a:lnSpc>
                  <a:spcPct val="150000"/>
                </a:lnSpc>
              </a:pPr>
              <a:r>
                <a:rPr lang="en-AU" sz="800" dirty="0"/>
                <a:t>June 2019 – 11 das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404EDBDE-056B-42BD-AFBA-EA1667544150}"/>
              </a:ext>
            </a:extLst>
          </p:cNvPr>
          <p:cNvGrpSpPr/>
          <p:nvPr/>
        </p:nvGrpSpPr>
        <p:grpSpPr>
          <a:xfrm>
            <a:off x="913405" y="432234"/>
            <a:ext cx="482959" cy="4940828"/>
            <a:chOff x="10822370" y="188953"/>
            <a:chExt cx="482959" cy="4940828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67DF45FD-42AD-49D2-9256-7BC58A7EEBC3}"/>
                </a:ext>
              </a:extLst>
            </p:cNvPr>
            <p:cNvGrpSpPr/>
            <p:nvPr/>
          </p:nvGrpSpPr>
          <p:grpSpPr>
            <a:xfrm>
              <a:off x="10973849" y="557781"/>
              <a:ext cx="180000" cy="4572000"/>
              <a:chOff x="9197653" y="557781"/>
              <a:chExt cx="504000" cy="4572000"/>
            </a:xfrm>
          </p:grpSpPr>
          <p:sp>
            <p:nvSpPr>
              <p:cNvPr id="15" name="Rectangle: Rounded Corners 14">
                <a:extLst>
                  <a:ext uri="{FF2B5EF4-FFF2-40B4-BE49-F238E27FC236}">
                    <a16:creationId xmlns:a16="http://schemas.microsoft.com/office/drawing/2014/main" id="{66B4CB58-2A01-483B-B42A-BA7A3A1DA744}"/>
                  </a:ext>
                </a:extLst>
              </p:cNvPr>
              <p:cNvSpPr/>
              <p:nvPr/>
            </p:nvSpPr>
            <p:spPr>
              <a:xfrm>
                <a:off x="9197653" y="557781"/>
                <a:ext cx="327170" cy="4572000"/>
              </a:xfrm>
              <a:prstGeom prst="round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F95C1EAD-F7A0-4B7F-90D5-7DBC6CD793C1}"/>
                  </a:ext>
                </a:extLst>
              </p:cNvPr>
              <p:cNvCxnSpPr/>
              <p:nvPr/>
            </p:nvCxnSpPr>
            <p:spPr>
              <a:xfrm>
                <a:off x="9197653" y="12668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001C4108-CCB1-4099-B287-43AF5D36B4EC}"/>
                  </a:ext>
                </a:extLst>
              </p:cNvPr>
              <p:cNvCxnSpPr/>
              <p:nvPr/>
            </p:nvCxnSpPr>
            <p:spPr>
              <a:xfrm>
                <a:off x="9197653" y="199072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3DB5AC08-9F8D-42FA-944F-DE5224995ED8}"/>
                  </a:ext>
                </a:extLst>
              </p:cNvPr>
              <p:cNvCxnSpPr/>
              <p:nvPr/>
            </p:nvCxnSpPr>
            <p:spPr>
              <a:xfrm>
                <a:off x="9197653" y="27051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AA1AD3D5-B916-4596-8C35-848A89E3E0CA}"/>
                  </a:ext>
                </a:extLst>
              </p:cNvPr>
              <p:cNvCxnSpPr/>
              <p:nvPr/>
            </p:nvCxnSpPr>
            <p:spPr>
              <a:xfrm>
                <a:off x="9197653" y="34290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0D48EA4A-B8DB-443C-BCD9-73280D1C3D66}"/>
                  </a:ext>
                </a:extLst>
              </p:cNvPr>
              <p:cNvCxnSpPr/>
              <p:nvPr/>
            </p:nvCxnSpPr>
            <p:spPr>
              <a:xfrm>
                <a:off x="9197653" y="4152900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A40CD57F-2900-40E9-9C83-80D8EEA9C58F}"/>
                  </a:ext>
                </a:extLst>
              </p:cNvPr>
              <p:cNvCxnSpPr/>
              <p:nvPr/>
            </p:nvCxnSpPr>
            <p:spPr>
              <a:xfrm>
                <a:off x="9197653" y="4867275"/>
                <a:ext cx="50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A15870F-68A5-401C-9532-C309DABAAC15}"/>
                </a:ext>
              </a:extLst>
            </p:cNvPr>
            <p:cNvSpPr txBox="1"/>
            <p:nvPr/>
          </p:nvSpPr>
          <p:spPr>
            <a:xfrm>
              <a:off x="10822370" y="188953"/>
              <a:ext cx="482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7D</a:t>
              </a:r>
            </a:p>
          </p:txBody>
        </p:sp>
      </p:grp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0D54C26-2BA0-47F9-8F8E-E830B0229FBF}"/>
              </a:ext>
            </a:extLst>
          </p:cNvPr>
          <p:cNvCxnSpPr/>
          <p:nvPr/>
        </p:nvCxnSpPr>
        <p:spPr>
          <a:xfrm>
            <a:off x="1074514" y="5195905"/>
            <a:ext cx="340739" cy="0"/>
          </a:xfrm>
          <a:prstGeom prst="line">
            <a:avLst/>
          </a:prstGeom>
          <a:ln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D3215A74-C4D6-4DFE-9C76-F31B46C57431}"/>
              </a:ext>
            </a:extLst>
          </p:cNvPr>
          <p:cNvSpPr/>
          <p:nvPr/>
        </p:nvSpPr>
        <p:spPr>
          <a:xfrm>
            <a:off x="1457873" y="5161633"/>
            <a:ext cx="72000" cy="7200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5281794-3B48-4E53-B7DE-3EC1B25C18D4}"/>
              </a:ext>
            </a:extLst>
          </p:cNvPr>
          <p:cNvCxnSpPr/>
          <p:nvPr/>
        </p:nvCxnSpPr>
        <p:spPr>
          <a:xfrm>
            <a:off x="1062516" y="1281828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863F9AD1-8236-43B8-A7DB-2757AB51C90C}"/>
              </a:ext>
            </a:extLst>
          </p:cNvPr>
          <p:cNvSpPr txBox="1"/>
          <p:nvPr/>
        </p:nvSpPr>
        <p:spPr>
          <a:xfrm>
            <a:off x="1384622" y="1047869"/>
            <a:ext cx="572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Vrn-D3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F79AC5D2-F6A5-4D6A-89A4-ADA71877249F}"/>
              </a:ext>
            </a:extLst>
          </p:cNvPr>
          <p:cNvGrpSpPr/>
          <p:nvPr/>
        </p:nvGrpSpPr>
        <p:grpSpPr>
          <a:xfrm>
            <a:off x="2399068" y="4774031"/>
            <a:ext cx="280116" cy="1186015"/>
            <a:chOff x="8992024" y="5171912"/>
            <a:chExt cx="280116" cy="1186015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5D35270-EF8F-4560-8EA1-976E9019B75E}"/>
                </a:ext>
              </a:extLst>
            </p:cNvPr>
            <p:cNvSpPr txBox="1"/>
            <p:nvPr/>
          </p:nvSpPr>
          <p:spPr>
            <a:xfrm rot="5400000">
              <a:off x="8548327" y="5634115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phs.ahau-7D</a:t>
              </a: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FD9DAF91-3D6C-42BA-9327-A4FD69C53077}"/>
                </a:ext>
              </a:extLst>
            </p:cNvPr>
            <p:cNvSpPr/>
            <p:nvPr/>
          </p:nvSpPr>
          <p:spPr>
            <a:xfrm rot="5400000">
              <a:off x="8941624" y="5572212"/>
              <a:ext cx="1548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544050EE-8A5E-4158-B8E1-6D9E00B80ACC}"/>
              </a:ext>
            </a:extLst>
          </p:cNvPr>
          <p:cNvGrpSpPr/>
          <p:nvPr/>
        </p:nvGrpSpPr>
        <p:grpSpPr>
          <a:xfrm>
            <a:off x="1896414" y="4843403"/>
            <a:ext cx="274744" cy="1003300"/>
            <a:chOff x="993068" y="2546583"/>
            <a:chExt cx="274744" cy="1003300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8CD1877-4D86-422B-8D83-2FE25C6B7E8D}"/>
                </a:ext>
              </a:extLst>
            </p:cNvPr>
            <p:cNvSpPr txBox="1"/>
            <p:nvPr/>
          </p:nvSpPr>
          <p:spPr>
            <a:xfrm rot="5400000">
              <a:off x="635357" y="291742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E356E06A-04E2-44EF-9BC7-9B9AF1EE5AF5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F8FC33F5-7340-464C-8FF1-6A66CB68959B}"/>
              </a:ext>
            </a:extLst>
          </p:cNvPr>
          <p:cNvGrpSpPr/>
          <p:nvPr/>
        </p:nvGrpSpPr>
        <p:grpSpPr>
          <a:xfrm>
            <a:off x="2134264" y="4795484"/>
            <a:ext cx="296537" cy="1003300"/>
            <a:chOff x="8031292" y="604235"/>
            <a:chExt cx="296537" cy="1003300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C47B540-9B33-490F-93DB-8D3955FECCB9}"/>
                </a:ext>
              </a:extLst>
            </p:cNvPr>
            <p:cNvSpPr txBox="1"/>
            <p:nvPr/>
          </p:nvSpPr>
          <p:spPr>
            <a:xfrm rot="5400000">
              <a:off x="7695374" y="975080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.Lng.ipk.7D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E477D251-AE12-4E4C-AE25-921DFE5AA32C}"/>
                </a:ext>
              </a:extLst>
            </p:cNvPr>
            <p:cNvSpPr/>
            <p:nvPr/>
          </p:nvSpPr>
          <p:spPr>
            <a:xfrm rot="5400000">
              <a:off x="8031292" y="978911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2297C9A1-17BB-4BC1-B9EA-51F6AB11576E}"/>
              </a:ext>
            </a:extLst>
          </p:cNvPr>
          <p:cNvGrpSpPr/>
          <p:nvPr/>
        </p:nvGrpSpPr>
        <p:grpSpPr>
          <a:xfrm>
            <a:off x="1819942" y="529809"/>
            <a:ext cx="270410" cy="1003300"/>
            <a:chOff x="8031292" y="586629"/>
            <a:chExt cx="270410" cy="1003300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E7047E6-D265-4287-AC2A-5F65D3D17209}"/>
                </a:ext>
              </a:extLst>
            </p:cNvPr>
            <p:cNvSpPr txBox="1"/>
            <p:nvPr/>
          </p:nvSpPr>
          <p:spPr>
            <a:xfrm rot="5400000">
              <a:off x="7669247" y="957474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SL.csiro</a:t>
              </a: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09786E89-641B-4165-BDC3-D14C92665F93}"/>
                </a:ext>
              </a:extLst>
            </p:cNvPr>
            <p:cNvSpPr/>
            <p:nvPr/>
          </p:nvSpPr>
          <p:spPr>
            <a:xfrm rot="5400000">
              <a:off x="8031292" y="931352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F9F2CB57-8C2E-4996-8017-915E3BD0387B}"/>
              </a:ext>
            </a:extLst>
          </p:cNvPr>
          <p:cNvGrpSpPr/>
          <p:nvPr/>
        </p:nvGrpSpPr>
        <p:grpSpPr>
          <a:xfrm>
            <a:off x="2394621" y="960470"/>
            <a:ext cx="274744" cy="1003300"/>
            <a:chOff x="993068" y="2546583"/>
            <a:chExt cx="274744" cy="1003300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77178F5-9FC8-46DB-9D4C-880BA06D164B}"/>
                </a:ext>
              </a:extLst>
            </p:cNvPr>
            <p:cNvSpPr txBox="1"/>
            <p:nvPr/>
          </p:nvSpPr>
          <p:spPr>
            <a:xfrm rot="5400000">
              <a:off x="635357" y="2917428"/>
              <a:ext cx="1003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TG_Ga_C</a:t>
              </a: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E817F0AD-D76E-4EE4-9FFF-E5464BBB40EE}"/>
                </a:ext>
              </a:extLst>
            </p:cNvPr>
            <p:cNvSpPr/>
            <p:nvPr/>
          </p:nvSpPr>
          <p:spPr>
            <a:xfrm rot="5400000">
              <a:off x="993068" y="2874528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6DBC1AB7-F4E2-4098-BB11-432E7230DEF8}"/>
              </a:ext>
            </a:extLst>
          </p:cNvPr>
          <p:cNvGrpSpPr/>
          <p:nvPr/>
        </p:nvGrpSpPr>
        <p:grpSpPr>
          <a:xfrm>
            <a:off x="1815057" y="3904392"/>
            <a:ext cx="277604" cy="1186015"/>
            <a:chOff x="8994536" y="5348061"/>
            <a:chExt cx="277604" cy="1186015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CC58765-EDA0-4F25-9D20-07FB2FAB2875}"/>
                </a:ext>
              </a:extLst>
            </p:cNvPr>
            <p:cNvSpPr txBox="1"/>
            <p:nvPr/>
          </p:nvSpPr>
          <p:spPr>
            <a:xfrm rot="5400000">
              <a:off x="8548327" y="5810264"/>
              <a:ext cx="1186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gr.cas-7DL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A2CE2AE6-3845-43BE-8437-27F02D12E6AE}"/>
                </a:ext>
              </a:extLst>
            </p:cNvPr>
            <p:cNvSpPr/>
            <p:nvPr/>
          </p:nvSpPr>
          <p:spPr>
            <a:xfrm rot="5400000">
              <a:off x="8994536" y="5943410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CC8B39D1-3095-4FC6-BB74-C43E326FAEF1}"/>
              </a:ext>
            </a:extLst>
          </p:cNvPr>
          <p:cNvGrpSpPr/>
          <p:nvPr/>
        </p:nvGrpSpPr>
        <p:grpSpPr>
          <a:xfrm>
            <a:off x="2102515" y="525999"/>
            <a:ext cx="289173" cy="1250371"/>
            <a:chOff x="8355475" y="584489"/>
            <a:chExt cx="289173" cy="1051392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7DCA87A4-6002-4D9D-AA3C-210109002522}"/>
                </a:ext>
              </a:extLst>
            </p:cNvPr>
            <p:cNvSpPr txBox="1"/>
            <p:nvPr/>
          </p:nvSpPr>
          <p:spPr>
            <a:xfrm rot="5400000">
              <a:off x="7988147" y="979380"/>
              <a:ext cx="105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QCl.sicau-7D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305F5393-FEEC-4DCD-A433-50DE099C8376}"/>
                </a:ext>
              </a:extLst>
            </p:cNvPr>
            <p:cNvSpPr/>
            <p:nvPr/>
          </p:nvSpPr>
          <p:spPr>
            <a:xfrm rot="5400000">
              <a:off x="8359771" y="935368"/>
              <a:ext cx="45407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498D813C-930C-46BC-88D3-A985BBD7CEE9}"/>
              </a:ext>
            </a:extLst>
          </p:cNvPr>
          <p:cNvCxnSpPr/>
          <p:nvPr/>
        </p:nvCxnSpPr>
        <p:spPr>
          <a:xfrm>
            <a:off x="480325" y="5852572"/>
            <a:ext cx="0" cy="72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A2461DB7-6134-44A0-B113-0771FE0033B7}"/>
              </a:ext>
            </a:extLst>
          </p:cNvPr>
          <p:cNvSpPr txBox="1"/>
          <p:nvPr/>
        </p:nvSpPr>
        <p:spPr>
          <a:xfrm>
            <a:off x="489930" y="6062651"/>
            <a:ext cx="1178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/>
              <a:t>100 Mb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797E0EF-BAFC-4FC1-A598-63D2654E07E0}"/>
              </a:ext>
            </a:extLst>
          </p:cNvPr>
          <p:cNvSpPr txBox="1"/>
          <p:nvPr/>
        </p:nvSpPr>
        <p:spPr>
          <a:xfrm>
            <a:off x="1323164" y="1405987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UFGT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381B9229-420B-487A-A073-9F5A951D224F}"/>
              </a:ext>
            </a:extLst>
          </p:cNvPr>
          <p:cNvCxnSpPr/>
          <p:nvPr/>
        </p:nvCxnSpPr>
        <p:spPr>
          <a:xfrm>
            <a:off x="1062516" y="1547145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73DE1E12-F374-43A4-B318-184E5FFE751C}"/>
              </a:ext>
            </a:extLst>
          </p:cNvPr>
          <p:cNvSpPr txBox="1"/>
          <p:nvPr/>
        </p:nvSpPr>
        <p:spPr>
          <a:xfrm>
            <a:off x="1323164" y="1527171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Mpc1-D1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4381228C-11D4-4D5E-9724-6DBDB234D9FC}"/>
              </a:ext>
            </a:extLst>
          </p:cNvPr>
          <p:cNvCxnSpPr/>
          <p:nvPr/>
        </p:nvCxnSpPr>
        <p:spPr>
          <a:xfrm>
            <a:off x="1062516" y="1641035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A2C66A26-88DA-4C24-B545-E34A65F69EBE}"/>
              </a:ext>
            </a:extLst>
          </p:cNvPr>
          <p:cNvSpPr txBox="1"/>
          <p:nvPr/>
        </p:nvSpPr>
        <p:spPr>
          <a:xfrm>
            <a:off x="1354142" y="4681683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2ox2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540E6190-8D41-4F9E-A644-437135E321D1}"/>
              </a:ext>
            </a:extLst>
          </p:cNvPr>
          <p:cNvCxnSpPr/>
          <p:nvPr/>
        </p:nvCxnSpPr>
        <p:spPr>
          <a:xfrm>
            <a:off x="1062516" y="482826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5108BA20-35B9-4983-93C1-B860ED3E00F1}"/>
              </a:ext>
            </a:extLst>
          </p:cNvPr>
          <p:cNvCxnSpPr/>
          <p:nvPr/>
        </p:nvCxnSpPr>
        <p:spPr>
          <a:xfrm>
            <a:off x="1062516" y="1311706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F750BC4E-8F21-426B-9C56-992982F08DE1}"/>
              </a:ext>
            </a:extLst>
          </p:cNvPr>
          <p:cNvSpPr txBox="1"/>
          <p:nvPr/>
        </p:nvSpPr>
        <p:spPr>
          <a:xfrm>
            <a:off x="1320975" y="1315880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J214272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FB6C06C8-65AD-4158-8670-23869DD8EDB8}"/>
              </a:ext>
            </a:extLst>
          </p:cNvPr>
          <p:cNvCxnSpPr/>
          <p:nvPr/>
        </p:nvCxnSpPr>
        <p:spPr>
          <a:xfrm>
            <a:off x="1060687" y="1448672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164E1670-292D-4295-B804-D4A065E594A4}"/>
              </a:ext>
            </a:extLst>
          </p:cNvPr>
          <p:cNvSpPr txBox="1"/>
          <p:nvPr/>
        </p:nvSpPr>
        <p:spPr>
          <a:xfrm>
            <a:off x="1365192" y="4790807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BJ291458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15588A85-8775-4608-B32B-95035DB57F28}"/>
              </a:ext>
            </a:extLst>
          </p:cNvPr>
          <p:cNvCxnSpPr/>
          <p:nvPr/>
        </p:nvCxnSpPr>
        <p:spPr>
          <a:xfrm>
            <a:off x="1062516" y="4911626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D227E35B-E0D9-48BD-B45F-C5FE6BBD017D}"/>
              </a:ext>
            </a:extLst>
          </p:cNvPr>
          <p:cNvSpPr txBox="1"/>
          <p:nvPr/>
        </p:nvSpPr>
        <p:spPr>
          <a:xfrm>
            <a:off x="1354142" y="2532687"/>
            <a:ext cx="821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solidFill>
                  <a:schemeClr val="accent1">
                    <a:lumMod val="75000"/>
                  </a:schemeClr>
                </a:solidFill>
              </a:rPr>
              <a:t>CK208119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FC3DD819-EE98-4E89-8A95-BA17609AE57B}"/>
              </a:ext>
            </a:extLst>
          </p:cNvPr>
          <p:cNvCxnSpPr/>
          <p:nvPr/>
        </p:nvCxnSpPr>
        <p:spPr>
          <a:xfrm>
            <a:off x="1062516" y="2661669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29A0FABE-CDBB-4901-8BCF-1D9D43382564}"/>
              </a:ext>
            </a:extLst>
          </p:cNvPr>
          <p:cNvCxnSpPr>
            <a:cxnSpLocks/>
          </p:cNvCxnSpPr>
          <p:nvPr/>
        </p:nvCxnSpPr>
        <p:spPr>
          <a:xfrm flipH="1">
            <a:off x="1404866" y="1215882"/>
            <a:ext cx="64560" cy="649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36FA96AF-7BF6-4007-9C99-56BFB723EC3E}"/>
              </a:ext>
            </a:extLst>
          </p:cNvPr>
          <p:cNvSpPr txBox="1"/>
          <p:nvPr/>
        </p:nvSpPr>
        <p:spPr>
          <a:xfrm>
            <a:off x="1321173" y="1888276"/>
            <a:ext cx="911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TaGAST3</a:t>
            </a: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0206AF50-CFA7-492A-8772-40E08F0FC34C}"/>
              </a:ext>
            </a:extLst>
          </p:cNvPr>
          <p:cNvCxnSpPr/>
          <p:nvPr/>
        </p:nvCxnSpPr>
        <p:spPr>
          <a:xfrm>
            <a:off x="1062516" y="2002140"/>
            <a:ext cx="3407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90817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83970B7059A4A4AA4776DD28FEC0024" ma:contentTypeVersion="9" ma:contentTypeDescription="Create a new document." ma:contentTypeScope="" ma:versionID="9f3034c1b4d539eeee4185a72fc32e9e">
  <xsd:schema xmlns:xsd="http://www.w3.org/2001/XMLSchema" xmlns:xs="http://www.w3.org/2001/XMLSchema" xmlns:p="http://schemas.microsoft.com/office/2006/metadata/properties" xmlns:ns3="c6810c5f-e758-43f7-aa67-7ed79b357e17" targetNamespace="http://schemas.microsoft.com/office/2006/metadata/properties" ma:root="true" ma:fieldsID="6f8abb98bd4baff85674d9c6bb2c7cf2" ns3:_="">
    <xsd:import namespace="c6810c5f-e758-43f7-aa67-7ed79b357e1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6810c5f-e758-43f7-aa67-7ed79b357e1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C37F76D-2BAE-4979-A6D0-62A42F99540F}">
  <ds:schemaRefs>
    <ds:schemaRef ds:uri="http://schemas.microsoft.com/office/2006/documentManagement/types"/>
    <ds:schemaRef ds:uri="http://purl.org/dc/dcmitype/"/>
    <ds:schemaRef ds:uri="http://www.w3.org/XML/1998/namespace"/>
    <ds:schemaRef ds:uri="http://purl.org/dc/elements/1.1/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c6810c5f-e758-43f7-aa67-7ed79b357e17"/>
    <ds:schemaRef ds:uri="http://schemas.microsoft.com/office/2006/metadata/properties"/>
  </ds:schemaRefs>
</ds:datastoreItem>
</file>

<file path=customXml/itemProps2.xml><?xml version="1.0" encoding="utf-8"?>
<ds:datastoreItem xmlns:ds="http://schemas.openxmlformats.org/officeDocument/2006/customXml" ds:itemID="{C62FB7C8-49CD-440D-A2DE-2146D9F0712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6810c5f-e758-43f7-aa67-7ed79b357e1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228EEAEE-D585-4952-A3DC-0273969570FC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8193</TotalTime>
  <Words>1048</Words>
  <Application>Microsoft Office PowerPoint</Application>
  <PresentationFormat>Widescreen</PresentationFormat>
  <Paragraphs>31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ther Walker</dc:creator>
  <cp:lastModifiedBy>Michael Francki</cp:lastModifiedBy>
  <cp:revision>15</cp:revision>
  <cp:lastPrinted>2020-12-02T01:38:35Z</cp:lastPrinted>
  <dcterms:created xsi:type="dcterms:W3CDTF">2020-06-17T06:01:25Z</dcterms:created>
  <dcterms:modified xsi:type="dcterms:W3CDTF">2021-09-29T06:36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83970B7059A4A4AA4776DD28FEC0024</vt:lpwstr>
  </property>
</Properties>
</file>